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9144000" cy="6858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30" d="100"/>
          <a:sy n="130" d="100"/>
        </p:scale>
        <p:origin x="-1517" y="-23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2A728-04A7-4135-B995-5090106B2A4B}" type="datetimeFigureOut">
              <a:rPr lang="ko-KR" altLang="en-US" smtClean="0"/>
              <a:t>2013-11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DBCF5-138B-4935-A115-752A2FF48D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4349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2A728-04A7-4135-B995-5090106B2A4B}" type="datetimeFigureOut">
              <a:rPr lang="ko-KR" altLang="en-US" smtClean="0"/>
              <a:t>2013-11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DBCF5-138B-4935-A115-752A2FF48D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3798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2A728-04A7-4135-B995-5090106B2A4B}" type="datetimeFigureOut">
              <a:rPr lang="ko-KR" altLang="en-US" smtClean="0"/>
              <a:t>2013-11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DBCF5-138B-4935-A115-752A2FF48D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8182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2A728-04A7-4135-B995-5090106B2A4B}" type="datetimeFigureOut">
              <a:rPr lang="ko-KR" altLang="en-US" smtClean="0"/>
              <a:t>2013-11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DBCF5-138B-4935-A115-752A2FF48D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51512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2A728-04A7-4135-B995-5090106B2A4B}" type="datetimeFigureOut">
              <a:rPr lang="ko-KR" altLang="en-US" smtClean="0"/>
              <a:t>2013-11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DBCF5-138B-4935-A115-752A2FF48D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41344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2A728-04A7-4135-B995-5090106B2A4B}" type="datetimeFigureOut">
              <a:rPr lang="ko-KR" altLang="en-US" smtClean="0"/>
              <a:t>2013-11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DBCF5-138B-4935-A115-752A2FF48D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7526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2A728-04A7-4135-B995-5090106B2A4B}" type="datetimeFigureOut">
              <a:rPr lang="ko-KR" altLang="en-US" smtClean="0"/>
              <a:t>2013-11-0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DBCF5-138B-4935-A115-752A2FF48D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35369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2A728-04A7-4135-B995-5090106B2A4B}" type="datetimeFigureOut">
              <a:rPr lang="ko-KR" altLang="en-US" smtClean="0"/>
              <a:t>2013-11-0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DBCF5-138B-4935-A115-752A2FF48D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4761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2A728-04A7-4135-B995-5090106B2A4B}" type="datetimeFigureOut">
              <a:rPr lang="ko-KR" altLang="en-US" smtClean="0"/>
              <a:t>2013-11-0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DBCF5-138B-4935-A115-752A2FF48D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21076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2A728-04A7-4135-B995-5090106B2A4B}" type="datetimeFigureOut">
              <a:rPr lang="ko-KR" altLang="en-US" smtClean="0"/>
              <a:t>2013-11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DBCF5-138B-4935-A115-752A2FF48D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8169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E2A728-04A7-4135-B995-5090106B2A4B}" type="datetimeFigureOut">
              <a:rPr lang="ko-KR" altLang="en-US" smtClean="0"/>
              <a:t>2013-11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DBCF5-138B-4935-A115-752A2FF48D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53525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E2A728-04A7-4135-B995-5090106B2A4B}" type="datetimeFigureOut">
              <a:rPr lang="ko-KR" altLang="en-US" smtClean="0"/>
              <a:t>2013-11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DDBCF5-138B-4935-A115-752A2FF48D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1498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62" name="그룹 1061"/>
          <p:cNvGrpSpPr/>
          <p:nvPr/>
        </p:nvGrpSpPr>
        <p:grpSpPr>
          <a:xfrm>
            <a:off x="2829098" y="1052736"/>
            <a:ext cx="3816493" cy="2001321"/>
            <a:chOff x="2755584" y="2285234"/>
            <a:chExt cx="3816493" cy="2001321"/>
          </a:xfrm>
        </p:grpSpPr>
        <p:grpSp>
          <p:nvGrpSpPr>
            <p:cNvPr id="1058" name="그룹 1057"/>
            <p:cNvGrpSpPr/>
            <p:nvPr/>
          </p:nvGrpSpPr>
          <p:grpSpPr>
            <a:xfrm>
              <a:off x="2755584" y="2285234"/>
              <a:ext cx="3816493" cy="2001321"/>
              <a:chOff x="1614331" y="1992313"/>
              <a:chExt cx="5893138" cy="2751137"/>
            </a:xfrm>
          </p:grpSpPr>
          <p:sp>
            <p:nvSpPr>
              <p:cNvPr id="3" name="AutoShape 4"/>
              <p:cNvSpPr>
                <a:spLocks noChangeAspect="1" noChangeArrowheads="1" noTextEdit="1"/>
              </p:cNvSpPr>
              <p:nvPr/>
            </p:nvSpPr>
            <p:spPr bwMode="auto">
              <a:xfrm>
                <a:off x="1665015" y="1992313"/>
                <a:ext cx="5734050" cy="27511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" name="Rectangle 8"/>
              <p:cNvSpPr>
                <a:spLocks noChangeArrowheads="1"/>
              </p:cNvSpPr>
              <p:nvPr/>
            </p:nvSpPr>
            <p:spPr bwMode="auto">
              <a:xfrm>
                <a:off x="2598738" y="2506663"/>
                <a:ext cx="176213" cy="18891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" name="Freeform 9"/>
              <p:cNvSpPr>
                <a:spLocks noEditPoints="1"/>
              </p:cNvSpPr>
              <p:nvPr/>
            </p:nvSpPr>
            <p:spPr bwMode="auto">
              <a:xfrm>
                <a:off x="2593975" y="2501900"/>
                <a:ext cx="184150" cy="1897062"/>
              </a:xfrm>
              <a:custGeom>
                <a:avLst/>
                <a:gdLst>
                  <a:gd name="T0" fmla="*/ 0 w 1936"/>
                  <a:gd name="T1" fmla="*/ 48 h 19920"/>
                  <a:gd name="T2" fmla="*/ 48 w 1936"/>
                  <a:gd name="T3" fmla="*/ 0 h 19920"/>
                  <a:gd name="T4" fmla="*/ 1888 w 1936"/>
                  <a:gd name="T5" fmla="*/ 0 h 19920"/>
                  <a:gd name="T6" fmla="*/ 1936 w 1936"/>
                  <a:gd name="T7" fmla="*/ 48 h 19920"/>
                  <a:gd name="T8" fmla="*/ 1936 w 1936"/>
                  <a:gd name="T9" fmla="*/ 19872 h 19920"/>
                  <a:gd name="T10" fmla="*/ 1888 w 1936"/>
                  <a:gd name="T11" fmla="*/ 19920 h 19920"/>
                  <a:gd name="T12" fmla="*/ 48 w 1936"/>
                  <a:gd name="T13" fmla="*/ 19920 h 19920"/>
                  <a:gd name="T14" fmla="*/ 0 w 1936"/>
                  <a:gd name="T15" fmla="*/ 19872 h 19920"/>
                  <a:gd name="T16" fmla="*/ 0 w 1936"/>
                  <a:gd name="T17" fmla="*/ 48 h 19920"/>
                  <a:gd name="T18" fmla="*/ 96 w 1936"/>
                  <a:gd name="T19" fmla="*/ 19872 h 19920"/>
                  <a:gd name="T20" fmla="*/ 48 w 1936"/>
                  <a:gd name="T21" fmla="*/ 19824 h 19920"/>
                  <a:gd name="T22" fmla="*/ 1888 w 1936"/>
                  <a:gd name="T23" fmla="*/ 19824 h 19920"/>
                  <a:gd name="T24" fmla="*/ 1840 w 1936"/>
                  <a:gd name="T25" fmla="*/ 19872 h 19920"/>
                  <a:gd name="T26" fmla="*/ 1840 w 1936"/>
                  <a:gd name="T27" fmla="*/ 48 h 19920"/>
                  <a:gd name="T28" fmla="*/ 1888 w 1936"/>
                  <a:gd name="T29" fmla="*/ 96 h 19920"/>
                  <a:gd name="T30" fmla="*/ 48 w 1936"/>
                  <a:gd name="T31" fmla="*/ 96 h 19920"/>
                  <a:gd name="T32" fmla="*/ 96 w 1936"/>
                  <a:gd name="T33" fmla="*/ 48 h 19920"/>
                  <a:gd name="T34" fmla="*/ 96 w 1936"/>
                  <a:gd name="T35" fmla="*/ 19872 h 199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936" h="19920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1888" y="0"/>
                    </a:lnTo>
                    <a:cubicBezTo>
                      <a:pt x="1915" y="0"/>
                      <a:pt x="1936" y="22"/>
                      <a:pt x="1936" y="48"/>
                    </a:cubicBezTo>
                    <a:lnTo>
                      <a:pt x="1936" y="19872"/>
                    </a:lnTo>
                    <a:cubicBezTo>
                      <a:pt x="1936" y="19899"/>
                      <a:pt x="1915" y="19920"/>
                      <a:pt x="1888" y="19920"/>
                    </a:cubicBezTo>
                    <a:lnTo>
                      <a:pt x="48" y="19920"/>
                    </a:lnTo>
                    <a:cubicBezTo>
                      <a:pt x="22" y="19920"/>
                      <a:pt x="0" y="19899"/>
                      <a:pt x="0" y="19872"/>
                    </a:cubicBezTo>
                    <a:lnTo>
                      <a:pt x="0" y="48"/>
                    </a:lnTo>
                    <a:close/>
                    <a:moveTo>
                      <a:pt x="96" y="19872"/>
                    </a:moveTo>
                    <a:lnTo>
                      <a:pt x="48" y="19824"/>
                    </a:lnTo>
                    <a:lnTo>
                      <a:pt x="1888" y="19824"/>
                    </a:lnTo>
                    <a:lnTo>
                      <a:pt x="1840" y="19872"/>
                    </a:lnTo>
                    <a:lnTo>
                      <a:pt x="1840" y="48"/>
                    </a:lnTo>
                    <a:lnTo>
                      <a:pt x="1888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19872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" name="Rectangle 10"/>
              <p:cNvSpPr>
                <a:spLocks noChangeArrowheads="1"/>
              </p:cNvSpPr>
              <p:nvPr/>
            </p:nvSpPr>
            <p:spPr bwMode="auto">
              <a:xfrm>
                <a:off x="3036888" y="4298950"/>
                <a:ext cx="176213" cy="9683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" name="Freeform 11"/>
              <p:cNvSpPr>
                <a:spLocks noEditPoints="1"/>
              </p:cNvSpPr>
              <p:nvPr/>
            </p:nvSpPr>
            <p:spPr bwMode="auto">
              <a:xfrm>
                <a:off x="3032125" y="4294188"/>
                <a:ext cx="185738" cy="104775"/>
              </a:xfrm>
              <a:custGeom>
                <a:avLst/>
                <a:gdLst>
                  <a:gd name="T0" fmla="*/ 0 w 1952"/>
                  <a:gd name="T1" fmla="*/ 48 h 1104"/>
                  <a:gd name="T2" fmla="*/ 48 w 1952"/>
                  <a:gd name="T3" fmla="*/ 0 h 1104"/>
                  <a:gd name="T4" fmla="*/ 1904 w 1952"/>
                  <a:gd name="T5" fmla="*/ 0 h 1104"/>
                  <a:gd name="T6" fmla="*/ 1952 w 1952"/>
                  <a:gd name="T7" fmla="*/ 48 h 1104"/>
                  <a:gd name="T8" fmla="*/ 1952 w 1952"/>
                  <a:gd name="T9" fmla="*/ 1056 h 1104"/>
                  <a:gd name="T10" fmla="*/ 1904 w 1952"/>
                  <a:gd name="T11" fmla="*/ 1104 h 1104"/>
                  <a:gd name="T12" fmla="*/ 48 w 1952"/>
                  <a:gd name="T13" fmla="*/ 1104 h 1104"/>
                  <a:gd name="T14" fmla="*/ 0 w 1952"/>
                  <a:gd name="T15" fmla="*/ 1056 h 1104"/>
                  <a:gd name="T16" fmla="*/ 0 w 1952"/>
                  <a:gd name="T17" fmla="*/ 48 h 1104"/>
                  <a:gd name="T18" fmla="*/ 96 w 1952"/>
                  <a:gd name="T19" fmla="*/ 1056 h 1104"/>
                  <a:gd name="T20" fmla="*/ 48 w 1952"/>
                  <a:gd name="T21" fmla="*/ 1008 h 1104"/>
                  <a:gd name="T22" fmla="*/ 1904 w 1952"/>
                  <a:gd name="T23" fmla="*/ 1008 h 1104"/>
                  <a:gd name="T24" fmla="*/ 1856 w 1952"/>
                  <a:gd name="T25" fmla="*/ 1056 h 1104"/>
                  <a:gd name="T26" fmla="*/ 1856 w 1952"/>
                  <a:gd name="T27" fmla="*/ 48 h 1104"/>
                  <a:gd name="T28" fmla="*/ 1904 w 1952"/>
                  <a:gd name="T29" fmla="*/ 96 h 1104"/>
                  <a:gd name="T30" fmla="*/ 48 w 1952"/>
                  <a:gd name="T31" fmla="*/ 96 h 1104"/>
                  <a:gd name="T32" fmla="*/ 96 w 1952"/>
                  <a:gd name="T33" fmla="*/ 48 h 1104"/>
                  <a:gd name="T34" fmla="*/ 96 w 1952"/>
                  <a:gd name="T35" fmla="*/ 1056 h 11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952" h="1104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1904" y="0"/>
                    </a:lnTo>
                    <a:cubicBezTo>
                      <a:pt x="1931" y="0"/>
                      <a:pt x="1952" y="22"/>
                      <a:pt x="1952" y="48"/>
                    </a:cubicBezTo>
                    <a:lnTo>
                      <a:pt x="1952" y="1056"/>
                    </a:lnTo>
                    <a:cubicBezTo>
                      <a:pt x="1952" y="1083"/>
                      <a:pt x="1931" y="1104"/>
                      <a:pt x="1904" y="1104"/>
                    </a:cubicBezTo>
                    <a:lnTo>
                      <a:pt x="48" y="1104"/>
                    </a:lnTo>
                    <a:cubicBezTo>
                      <a:pt x="22" y="1104"/>
                      <a:pt x="0" y="1083"/>
                      <a:pt x="0" y="1056"/>
                    </a:cubicBezTo>
                    <a:lnTo>
                      <a:pt x="0" y="48"/>
                    </a:lnTo>
                    <a:close/>
                    <a:moveTo>
                      <a:pt x="96" y="1056"/>
                    </a:moveTo>
                    <a:lnTo>
                      <a:pt x="48" y="1008"/>
                    </a:lnTo>
                    <a:lnTo>
                      <a:pt x="1904" y="1008"/>
                    </a:lnTo>
                    <a:lnTo>
                      <a:pt x="1856" y="1056"/>
                    </a:lnTo>
                    <a:lnTo>
                      <a:pt x="1856" y="48"/>
                    </a:lnTo>
                    <a:lnTo>
                      <a:pt x="1904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1056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" name="Rectangle 12"/>
              <p:cNvSpPr>
                <a:spLocks noChangeArrowheads="1"/>
              </p:cNvSpPr>
              <p:nvPr/>
            </p:nvSpPr>
            <p:spPr bwMode="auto">
              <a:xfrm>
                <a:off x="3475038" y="3081338"/>
                <a:ext cx="177800" cy="1314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Freeform 13"/>
              <p:cNvSpPr>
                <a:spLocks noEditPoints="1"/>
              </p:cNvSpPr>
              <p:nvPr/>
            </p:nvSpPr>
            <p:spPr bwMode="auto">
              <a:xfrm>
                <a:off x="3470275" y="3076575"/>
                <a:ext cx="185738" cy="1322387"/>
              </a:xfrm>
              <a:custGeom>
                <a:avLst/>
                <a:gdLst>
                  <a:gd name="T0" fmla="*/ 0 w 1952"/>
                  <a:gd name="T1" fmla="*/ 48 h 13888"/>
                  <a:gd name="T2" fmla="*/ 48 w 1952"/>
                  <a:gd name="T3" fmla="*/ 0 h 13888"/>
                  <a:gd name="T4" fmla="*/ 1904 w 1952"/>
                  <a:gd name="T5" fmla="*/ 0 h 13888"/>
                  <a:gd name="T6" fmla="*/ 1952 w 1952"/>
                  <a:gd name="T7" fmla="*/ 48 h 13888"/>
                  <a:gd name="T8" fmla="*/ 1952 w 1952"/>
                  <a:gd name="T9" fmla="*/ 13840 h 13888"/>
                  <a:gd name="T10" fmla="*/ 1904 w 1952"/>
                  <a:gd name="T11" fmla="*/ 13888 h 13888"/>
                  <a:gd name="T12" fmla="*/ 48 w 1952"/>
                  <a:gd name="T13" fmla="*/ 13888 h 13888"/>
                  <a:gd name="T14" fmla="*/ 0 w 1952"/>
                  <a:gd name="T15" fmla="*/ 13840 h 13888"/>
                  <a:gd name="T16" fmla="*/ 0 w 1952"/>
                  <a:gd name="T17" fmla="*/ 48 h 13888"/>
                  <a:gd name="T18" fmla="*/ 96 w 1952"/>
                  <a:gd name="T19" fmla="*/ 13840 h 13888"/>
                  <a:gd name="T20" fmla="*/ 48 w 1952"/>
                  <a:gd name="T21" fmla="*/ 13792 h 13888"/>
                  <a:gd name="T22" fmla="*/ 1904 w 1952"/>
                  <a:gd name="T23" fmla="*/ 13792 h 13888"/>
                  <a:gd name="T24" fmla="*/ 1856 w 1952"/>
                  <a:gd name="T25" fmla="*/ 13840 h 13888"/>
                  <a:gd name="T26" fmla="*/ 1856 w 1952"/>
                  <a:gd name="T27" fmla="*/ 48 h 13888"/>
                  <a:gd name="T28" fmla="*/ 1904 w 1952"/>
                  <a:gd name="T29" fmla="*/ 96 h 13888"/>
                  <a:gd name="T30" fmla="*/ 48 w 1952"/>
                  <a:gd name="T31" fmla="*/ 96 h 13888"/>
                  <a:gd name="T32" fmla="*/ 96 w 1952"/>
                  <a:gd name="T33" fmla="*/ 48 h 13888"/>
                  <a:gd name="T34" fmla="*/ 96 w 1952"/>
                  <a:gd name="T35" fmla="*/ 13840 h 138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952" h="13888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1904" y="0"/>
                    </a:lnTo>
                    <a:cubicBezTo>
                      <a:pt x="1931" y="0"/>
                      <a:pt x="1952" y="22"/>
                      <a:pt x="1952" y="48"/>
                    </a:cubicBezTo>
                    <a:lnTo>
                      <a:pt x="1952" y="13840"/>
                    </a:lnTo>
                    <a:cubicBezTo>
                      <a:pt x="1952" y="13867"/>
                      <a:pt x="1931" y="13888"/>
                      <a:pt x="1904" y="13888"/>
                    </a:cubicBezTo>
                    <a:lnTo>
                      <a:pt x="48" y="13888"/>
                    </a:lnTo>
                    <a:cubicBezTo>
                      <a:pt x="22" y="13888"/>
                      <a:pt x="0" y="13867"/>
                      <a:pt x="0" y="13840"/>
                    </a:cubicBezTo>
                    <a:lnTo>
                      <a:pt x="0" y="48"/>
                    </a:lnTo>
                    <a:close/>
                    <a:moveTo>
                      <a:pt x="96" y="13840"/>
                    </a:moveTo>
                    <a:lnTo>
                      <a:pt x="48" y="13792"/>
                    </a:lnTo>
                    <a:lnTo>
                      <a:pt x="1904" y="13792"/>
                    </a:lnTo>
                    <a:lnTo>
                      <a:pt x="1856" y="13840"/>
                    </a:lnTo>
                    <a:lnTo>
                      <a:pt x="1856" y="48"/>
                    </a:lnTo>
                    <a:lnTo>
                      <a:pt x="1904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1384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Rectangle 14"/>
              <p:cNvSpPr>
                <a:spLocks noChangeArrowheads="1"/>
              </p:cNvSpPr>
              <p:nvPr/>
            </p:nvSpPr>
            <p:spPr bwMode="auto">
              <a:xfrm>
                <a:off x="3914775" y="4056063"/>
                <a:ext cx="176213" cy="33972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Freeform 15"/>
              <p:cNvSpPr>
                <a:spLocks noEditPoints="1"/>
              </p:cNvSpPr>
              <p:nvPr/>
            </p:nvSpPr>
            <p:spPr bwMode="auto">
              <a:xfrm>
                <a:off x="3910013" y="4052888"/>
                <a:ext cx="185738" cy="346075"/>
              </a:xfrm>
              <a:custGeom>
                <a:avLst/>
                <a:gdLst>
                  <a:gd name="T0" fmla="*/ 0 w 1952"/>
                  <a:gd name="T1" fmla="*/ 48 h 3648"/>
                  <a:gd name="T2" fmla="*/ 48 w 1952"/>
                  <a:gd name="T3" fmla="*/ 0 h 3648"/>
                  <a:gd name="T4" fmla="*/ 1904 w 1952"/>
                  <a:gd name="T5" fmla="*/ 0 h 3648"/>
                  <a:gd name="T6" fmla="*/ 1952 w 1952"/>
                  <a:gd name="T7" fmla="*/ 48 h 3648"/>
                  <a:gd name="T8" fmla="*/ 1952 w 1952"/>
                  <a:gd name="T9" fmla="*/ 3600 h 3648"/>
                  <a:gd name="T10" fmla="*/ 1904 w 1952"/>
                  <a:gd name="T11" fmla="*/ 3648 h 3648"/>
                  <a:gd name="T12" fmla="*/ 48 w 1952"/>
                  <a:gd name="T13" fmla="*/ 3648 h 3648"/>
                  <a:gd name="T14" fmla="*/ 0 w 1952"/>
                  <a:gd name="T15" fmla="*/ 3600 h 3648"/>
                  <a:gd name="T16" fmla="*/ 0 w 1952"/>
                  <a:gd name="T17" fmla="*/ 48 h 3648"/>
                  <a:gd name="T18" fmla="*/ 96 w 1952"/>
                  <a:gd name="T19" fmla="*/ 3600 h 3648"/>
                  <a:gd name="T20" fmla="*/ 48 w 1952"/>
                  <a:gd name="T21" fmla="*/ 3552 h 3648"/>
                  <a:gd name="T22" fmla="*/ 1904 w 1952"/>
                  <a:gd name="T23" fmla="*/ 3552 h 3648"/>
                  <a:gd name="T24" fmla="*/ 1856 w 1952"/>
                  <a:gd name="T25" fmla="*/ 3600 h 3648"/>
                  <a:gd name="T26" fmla="*/ 1856 w 1952"/>
                  <a:gd name="T27" fmla="*/ 48 h 3648"/>
                  <a:gd name="T28" fmla="*/ 1904 w 1952"/>
                  <a:gd name="T29" fmla="*/ 96 h 3648"/>
                  <a:gd name="T30" fmla="*/ 48 w 1952"/>
                  <a:gd name="T31" fmla="*/ 96 h 3648"/>
                  <a:gd name="T32" fmla="*/ 96 w 1952"/>
                  <a:gd name="T33" fmla="*/ 48 h 3648"/>
                  <a:gd name="T34" fmla="*/ 96 w 1952"/>
                  <a:gd name="T35" fmla="*/ 3600 h 36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952" h="3648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1904" y="0"/>
                    </a:lnTo>
                    <a:cubicBezTo>
                      <a:pt x="1931" y="0"/>
                      <a:pt x="1952" y="22"/>
                      <a:pt x="1952" y="48"/>
                    </a:cubicBezTo>
                    <a:lnTo>
                      <a:pt x="1952" y="3600"/>
                    </a:lnTo>
                    <a:cubicBezTo>
                      <a:pt x="1952" y="3627"/>
                      <a:pt x="1931" y="3648"/>
                      <a:pt x="1904" y="3648"/>
                    </a:cubicBezTo>
                    <a:lnTo>
                      <a:pt x="48" y="3648"/>
                    </a:lnTo>
                    <a:cubicBezTo>
                      <a:pt x="22" y="3648"/>
                      <a:pt x="0" y="3627"/>
                      <a:pt x="0" y="3600"/>
                    </a:cubicBezTo>
                    <a:lnTo>
                      <a:pt x="0" y="48"/>
                    </a:lnTo>
                    <a:close/>
                    <a:moveTo>
                      <a:pt x="96" y="3600"/>
                    </a:moveTo>
                    <a:lnTo>
                      <a:pt x="48" y="3552"/>
                    </a:lnTo>
                    <a:lnTo>
                      <a:pt x="1904" y="3552"/>
                    </a:lnTo>
                    <a:lnTo>
                      <a:pt x="1856" y="3600"/>
                    </a:lnTo>
                    <a:lnTo>
                      <a:pt x="1856" y="48"/>
                    </a:lnTo>
                    <a:lnTo>
                      <a:pt x="1904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360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" name="Rectangle 16"/>
              <p:cNvSpPr>
                <a:spLocks noChangeArrowheads="1"/>
              </p:cNvSpPr>
              <p:nvPr/>
            </p:nvSpPr>
            <p:spPr bwMode="auto">
              <a:xfrm>
                <a:off x="4352925" y="4313238"/>
                <a:ext cx="177800" cy="825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Freeform 17"/>
              <p:cNvSpPr>
                <a:spLocks noEditPoints="1"/>
              </p:cNvSpPr>
              <p:nvPr/>
            </p:nvSpPr>
            <p:spPr bwMode="auto">
              <a:xfrm>
                <a:off x="4348163" y="4308475"/>
                <a:ext cx="185738" cy="90487"/>
              </a:xfrm>
              <a:custGeom>
                <a:avLst/>
                <a:gdLst>
                  <a:gd name="T0" fmla="*/ 0 w 1952"/>
                  <a:gd name="T1" fmla="*/ 48 h 960"/>
                  <a:gd name="T2" fmla="*/ 48 w 1952"/>
                  <a:gd name="T3" fmla="*/ 0 h 960"/>
                  <a:gd name="T4" fmla="*/ 1904 w 1952"/>
                  <a:gd name="T5" fmla="*/ 0 h 960"/>
                  <a:gd name="T6" fmla="*/ 1952 w 1952"/>
                  <a:gd name="T7" fmla="*/ 48 h 960"/>
                  <a:gd name="T8" fmla="*/ 1952 w 1952"/>
                  <a:gd name="T9" fmla="*/ 912 h 960"/>
                  <a:gd name="T10" fmla="*/ 1904 w 1952"/>
                  <a:gd name="T11" fmla="*/ 960 h 960"/>
                  <a:gd name="T12" fmla="*/ 48 w 1952"/>
                  <a:gd name="T13" fmla="*/ 960 h 960"/>
                  <a:gd name="T14" fmla="*/ 0 w 1952"/>
                  <a:gd name="T15" fmla="*/ 912 h 960"/>
                  <a:gd name="T16" fmla="*/ 0 w 1952"/>
                  <a:gd name="T17" fmla="*/ 48 h 960"/>
                  <a:gd name="T18" fmla="*/ 96 w 1952"/>
                  <a:gd name="T19" fmla="*/ 912 h 960"/>
                  <a:gd name="T20" fmla="*/ 48 w 1952"/>
                  <a:gd name="T21" fmla="*/ 864 h 960"/>
                  <a:gd name="T22" fmla="*/ 1904 w 1952"/>
                  <a:gd name="T23" fmla="*/ 864 h 960"/>
                  <a:gd name="T24" fmla="*/ 1856 w 1952"/>
                  <a:gd name="T25" fmla="*/ 912 h 960"/>
                  <a:gd name="T26" fmla="*/ 1856 w 1952"/>
                  <a:gd name="T27" fmla="*/ 48 h 960"/>
                  <a:gd name="T28" fmla="*/ 1904 w 1952"/>
                  <a:gd name="T29" fmla="*/ 96 h 960"/>
                  <a:gd name="T30" fmla="*/ 48 w 1952"/>
                  <a:gd name="T31" fmla="*/ 96 h 960"/>
                  <a:gd name="T32" fmla="*/ 96 w 1952"/>
                  <a:gd name="T33" fmla="*/ 48 h 960"/>
                  <a:gd name="T34" fmla="*/ 96 w 1952"/>
                  <a:gd name="T35" fmla="*/ 912 h 9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952" h="960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1904" y="0"/>
                    </a:lnTo>
                    <a:cubicBezTo>
                      <a:pt x="1931" y="0"/>
                      <a:pt x="1952" y="22"/>
                      <a:pt x="1952" y="48"/>
                    </a:cubicBezTo>
                    <a:lnTo>
                      <a:pt x="1952" y="912"/>
                    </a:lnTo>
                    <a:cubicBezTo>
                      <a:pt x="1952" y="939"/>
                      <a:pt x="1931" y="960"/>
                      <a:pt x="1904" y="960"/>
                    </a:cubicBezTo>
                    <a:lnTo>
                      <a:pt x="48" y="960"/>
                    </a:lnTo>
                    <a:cubicBezTo>
                      <a:pt x="22" y="960"/>
                      <a:pt x="0" y="939"/>
                      <a:pt x="0" y="912"/>
                    </a:cubicBezTo>
                    <a:lnTo>
                      <a:pt x="0" y="48"/>
                    </a:lnTo>
                    <a:close/>
                    <a:moveTo>
                      <a:pt x="96" y="912"/>
                    </a:moveTo>
                    <a:lnTo>
                      <a:pt x="48" y="864"/>
                    </a:lnTo>
                    <a:lnTo>
                      <a:pt x="1904" y="864"/>
                    </a:lnTo>
                    <a:lnTo>
                      <a:pt x="1856" y="912"/>
                    </a:lnTo>
                    <a:lnTo>
                      <a:pt x="1856" y="48"/>
                    </a:lnTo>
                    <a:lnTo>
                      <a:pt x="1904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912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" name="Rectangle 18"/>
              <p:cNvSpPr>
                <a:spLocks noChangeArrowheads="1"/>
              </p:cNvSpPr>
              <p:nvPr/>
            </p:nvSpPr>
            <p:spPr bwMode="auto">
              <a:xfrm>
                <a:off x="4792663" y="4284663"/>
                <a:ext cx="174625" cy="11112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" name="Freeform 19"/>
              <p:cNvSpPr>
                <a:spLocks noEditPoints="1"/>
              </p:cNvSpPr>
              <p:nvPr/>
            </p:nvSpPr>
            <p:spPr bwMode="auto">
              <a:xfrm>
                <a:off x="4787900" y="4281488"/>
                <a:ext cx="184150" cy="117475"/>
              </a:xfrm>
              <a:custGeom>
                <a:avLst/>
                <a:gdLst>
                  <a:gd name="T0" fmla="*/ 0 w 968"/>
                  <a:gd name="T1" fmla="*/ 24 h 624"/>
                  <a:gd name="T2" fmla="*/ 24 w 968"/>
                  <a:gd name="T3" fmla="*/ 0 h 624"/>
                  <a:gd name="T4" fmla="*/ 944 w 968"/>
                  <a:gd name="T5" fmla="*/ 0 h 624"/>
                  <a:gd name="T6" fmla="*/ 968 w 968"/>
                  <a:gd name="T7" fmla="*/ 24 h 624"/>
                  <a:gd name="T8" fmla="*/ 968 w 968"/>
                  <a:gd name="T9" fmla="*/ 600 h 624"/>
                  <a:gd name="T10" fmla="*/ 944 w 968"/>
                  <a:gd name="T11" fmla="*/ 624 h 624"/>
                  <a:gd name="T12" fmla="*/ 24 w 968"/>
                  <a:gd name="T13" fmla="*/ 624 h 624"/>
                  <a:gd name="T14" fmla="*/ 0 w 968"/>
                  <a:gd name="T15" fmla="*/ 600 h 624"/>
                  <a:gd name="T16" fmla="*/ 0 w 968"/>
                  <a:gd name="T17" fmla="*/ 24 h 624"/>
                  <a:gd name="T18" fmla="*/ 48 w 968"/>
                  <a:gd name="T19" fmla="*/ 600 h 624"/>
                  <a:gd name="T20" fmla="*/ 24 w 968"/>
                  <a:gd name="T21" fmla="*/ 576 h 624"/>
                  <a:gd name="T22" fmla="*/ 944 w 968"/>
                  <a:gd name="T23" fmla="*/ 576 h 624"/>
                  <a:gd name="T24" fmla="*/ 920 w 968"/>
                  <a:gd name="T25" fmla="*/ 600 h 624"/>
                  <a:gd name="T26" fmla="*/ 920 w 968"/>
                  <a:gd name="T27" fmla="*/ 24 h 624"/>
                  <a:gd name="T28" fmla="*/ 944 w 968"/>
                  <a:gd name="T29" fmla="*/ 48 h 624"/>
                  <a:gd name="T30" fmla="*/ 24 w 968"/>
                  <a:gd name="T31" fmla="*/ 48 h 624"/>
                  <a:gd name="T32" fmla="*/ 48 w 968"/>
                  <a:gd name="T33" fmla="*/ 24 h 624"/>
                  <a:gd name="T34" fmla="*/ 48 w 968"/>
                  <a:gd name="T35" fmla="*/ 600 h 6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968" h="624">
                    <a:moveTo>
                      <a:pt x="0" y="24"/>
                    </a:moveTo>
                    <a:cubicBezTo>
                      <a:pt x="0" y="11"/>
                      <a:pt x="11" y="0"/>
                      <a:pt x="24" y="0"/>
                    </a:cubicBezTo>
                    <a:lnTo>
                      <a:pt x="944" y="0"/>
                    </a:lnTo>
                    <a:cubicBezTo>
                      <a:pt x="958" y="0"/>
                      <a:pt x="968" y="11"/>
                      <a:pt x="968" y="24"/>
                    </a:cubicBezTo>
                    <a:lnTo>
                      <a:pt x="968" y="600"/>
                    </a:lnTo>
                    <a:cubicBezTo>
                      <a:pt x="968" y="614"/>
                      <a:pt x="958" y="624"/>
                      <a:pt x="944" y="624"/>
                    </a:cubicBezTo>
                    <a:lnTo>
                      <a:pt x="24" y="624"/>
                    </a:lnTo>
                    <a:cubicBezTo>
                      <a:pt x="11" y="624"/>
                      <a:pt x="0" y="614"/>
                      <a:pt x="0" y="600"/>
                    </a:cubicBezTo>
                    <a:lnTo>
                      <a:pt x="0" y="24"/>
                    </a:lnTo>
                    <a:close/>
                    <a:moveTo>
                      <a:pt x="48" y="600"/>
                    </a:moveTo>
                    <a:lnTo>
                      <a:pt x="24" y="576"/>
                    </a:lnTo>
                    <a:lnTo>
                      <a:pt x="944" y="576"/>
                    </a:lnTo>
                    <a:lnTo>
                      <a:pt x="920" y="600"/>
                    </a:lnTo>
                    <a:lnTo>
                      <a:pt x="920" y="24"/>
                    </a:lnTo>
                    <a:lnTo>
                      <a:pt x="944" y="48"/>
                    </a:lnTo>
                    <a:lnTo>
                      <a:pt x="24" y="48"/>
                    </a:lnTo>
                    <a:lnTo>
                      <a:pt x="48" y="24"/>
                    </a:lnTo>
                    <a:lnTo>
                      <a:pt x="48" y="60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" name="Rectangle 20"/>
              <p:cNvSpPr>
                <a:spLocks noChangeArrowheads="1"/>
              </p:cNvSpPr>
              <p:nvPr/>
            </p:nvSpPr>
            <p:spPr bwMode="auto">
              <a:xfrm>
                <a:off x="5230813" y="4264025"/>
                <a:ext cx="176213" cy="131762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" name="Freeform 21"/>
              <p:cNvSpPr>
                <a:spLocks noEditPoints="1"/>
              </p:cNvSpPr>
              <p:nvPr/>
            </p:nvSpPr>
            <p:spPr bwMode="auto">
              <a:xfrm>
                <a:off x="5226050" y="4259263"/>
                <a:ext cx="184150" cy="139700"/>
              </a:xfrm>
              <a:custGeom>
                <a:avLst/>
                <a:gdLst>
                  <a:gd name="T0" fmla="*/ 0 w 968"/>
                  <a:gd name="T1" fmla="*/ 24 h 736"/>
                  <a:gd name="T2" fmla="*/ 24 w 968"/>
                  <a:gd name="T3" fmla="*/ 0 h 736"/>
                  <a:gd name="T4" fmla="*/ 944 w 968"/>
                  <a:gd name="T5" fmla="*/ 0 h 736"/>
                  <a:gd name="T6" fmla="*/ 968 w 968"/>
                  <a:gd name="T7" fmla="*/ 24 h 736"/>
                  <a:gd name="T8" fmla="*/ 968 w 968"/>
                  <a:gd name="T9" fmla="*/ 712 h 736"/>
                  <a:gd name="T10" fmla="*/ 944 w 968"/>
                  <a:gd name="T11" fmla="*/ 736 h 736"/>
                  <a:gd name="T12" fmla="*/ 24 w 968"/>
                  <a:gd name="T13" fmla="*/ 736 h 736"/>
                  <a:gd name="T14" fmla="*/ 0 w 968"/>
                  <a:gd name="T15" fmla="*/ 712 h 736"/>
                  <a:gd name="T16" fmla="*/ 0 w 968"/>
                  <a:gd name="T17" fmla="*/ 24 h 736"/>
                  <a:gd name="T18" fmla="*/ 48 w 968"/>
                  <a:gd name="T19" fmla="*/ 712 h 736"/>
                  <a:gd name="T20" fmla="*/ 24 w 968"/>
                  <a:gd name="T21" fmla="*/ 688 h 736"/>
                  <a:gd name="T22" fmla="*/ 944 w 968"/>
                  <a:gd name="T23" fmla="*/ 688 h 736"/>
                  <a:gd name="T24" fmla="*/ 920 w 968"/>
                  <a:gd name="T25" fmla="*/ 712 h 736"/>
                  <a:gd name="T26" fmla="*/ 920 w 968"/>
                  <a:gd name="T27" fmla="*/ 24 h 736"/>
                  <a:gd name="T28" fmla="*/ 944 w 968"/>
                  <a:gd name="T29" fmla="*/ 48 h 736"/>
                  <a:gd name="T30" fmla="*/ 24 w 968"/>
                  <a:gd name="T31" fmla="*/ 48 h 736"/>
                  <a:gd name="T32" fmla="*/ 48 w 968"/>
                  <a:gd name="T33" fmla="*/ 24 h 736"/>
                  <a:gd name="T34" fmla="*/ 48 w 968"/>
                  <a:gd name="T35" fmla="*/ 712 h 7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968" h="736">
                    <a:moveTo>
                      <a:pt x="0" y="24"/>
                    </a:moveTo>
                    <a:cubicBezTo>
                      <a:pt x="0" y="11"/>
                      <a:pt x="11" y="0"/>
                      <a:pt x="24" y="0"/>
                    </a:cubicBezTo>
                    <a:lnTo>
                      <a:pt x="944" y="0"/>
                    </a:lnTo>
                    <a:cubicBezTo>
                      <a:pt x="958" y="0"/>
                      <a:pt x="968" y="11"/>
                      <a:pt x="968" y="24"/>
                    </a:cubicBezTo>
                    <a:lnTo>
                      <a:pt x="968" y="712"/>
                    </a:lnTo>
                    <a:cubicBezTo>
                      <a:pt x="968" y="726"/>
                      <a:pt x="958" y="736"/>
                      <a:pt x="944" y="736"/>
                    </a:cubicBezTo>
                    <a:lnTo>
                      <a:pt x="24" y="736"/>
                    </a:lnTo>
                    <a:cubicBezTo>
                      <a:pt x="11" y="736"/>
                      <a:pt x="0" y="726"/>
                      <a:pt x="0" y="712"/>
                    </a:cubicBezTo>
                    <a:lnTo>
                      <a:pt x="0" y="24"/>
                    </a:lnTo>
                    <a:close/>
                    <a:moveTo>
                      <a:pt x="48" y="712"/>
                    </a:moveTo>
                    <a:lnTo>
                      <a:pt x="24" y="688"/>
                    </a:lnTo>
                    <a:lnTo>
                      <a:pt x="944" y="688"/>
                    </a:lnTo>
                    <a:lnTo>
                      <a:pt x="920" y="712"/>
                    </a:lnTo>
                    <a:lnTo>
                      <a:pt x="920" y="24"/>
                    </a:lnTo>
                    <a:lnTo>
                      <a:pt x="944" y="48"/>
                    </a:lnTo>
                    <a:lnTo>
                      <a:pt x="24" y="48"/>
                    </a:lnTo>
                    <a:lnTo>
                      <a:pt x="48" y="24"/>
                    </a:lnTo>
                    <a:lnTo>
                      <a:pt x="48" y="712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" name="Rectangle 22"/>
              <p:cNvSpPr>
                <a:spLocks noChangeArrowheads="1"/>
              </p:cNvSpPr>
              <p:nvPr/>
            </p:nvSpPr>
            <p:spPr bwMode="auto">
              <a:xfrm>
                <a:off x="5670550" y="3524250"/>
                <a:ext cx="174625" cy="87153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" name="Freeform 23"/>
              <p:cNvSpPr>
                <a:spLocks noEditPoints="1"/>
              </p:cNvSpPr>
              <p:nvPr/>
            </p:nvSpPr>
            <p:spPr bwMode="auto">
              <a:xfrm>
                <a:off x="5665788" y="3519488"/>
                <a:ext cx="184150" cy="879475"/>
              </a:xfrm>
              <a:custGeom>
                <a:avLst/>
                <a:gdLst>
                  <a:gd name="T0" fmla="*/ 0 w 968"/>
                  <a:gd name="T1" fmla="*/ 24 h 4616"/>
                  <a:gd name="T2" fmla="*/ 24 w 968"/>
                  <a:gd name="T3" fmla="*/ 0 h 4616"/>
                  <a:gd name="T4" fmla="*/ 944 w 968"/>
                  <a:gd name="T5" fmla="*/ 0 h 4616"/>
                  <a:gd name="T6" fmla="*/ 968 w 968"/>
                  <a:gd name="T7" fmla="*/ 24 h 4616"/>
                  <a:gd name="T8" fmla="*/ 968 w 968"/>
                  <a:gd name="T9" fmla="*/ 4592 h 4616"/>
                  <a:gd name="T10" fmla="*/ 944 w 968"/>
                  <a:gd name="T11" fmla="*/ 4616 h 4616"/>
                  <a:gd name="T12" fmla="*/ 24 w 968"/>
                  <a:gd name="T13" fmla="*/ 4616 h 4616"/>
                  <a:gd name="T14" fmla="*/ 0 w 968"/>
                  <a:gd name="T15" fmla="*/ 4592 h 4616"/>
                  <a:gd name="T16" fmla="*/ 0 w 968"/>
                  <a:gd name="T17" fmla="*/ 24 h 4616"/>
                  <a:gd name="T18" fmla="*/ 48 w 968"/>
                  <a:gd name="T19" fmla="*/ 4592 h 4616"/>
                  <a:gd name="T20" fmla="*/ 24 w 968"/>
                  <a:gd name="T21" fmla="*/ 4568 h 4616"/>
                  <a:gd name="T22" fmla="*/ 944 w 968"/>
                  <a:gd name="T23" fmla="*/ 4568 h 4616"/>
                  <a:gd name="T24" fmla="*/ 920 w 968"/>
                  <a:gd name="T25" fmla="*/ 4592 h 4616"/>
                  <a:gd name="T26" fmla="*/ 920 w 968"/>
                  <a:gd name="T27" fmla="*/ 24 h 4616"/>
                  <a:gd name="T28" fmla="*/ 944 w 968"/>
                  <a:gd name="T29" fmla="*/ 48 h 4616"/>
                  <a:gd name="T30" fmla="*/ 24 w 968"/>
                  <a:gd name="T31" fmla="*/ 48 h 4616"/>
                  <a:gd name="T32" fmla="*/ 48 w 968"/>
                  <a:gd name="T33" fmla="*/ 24 h 4616"/>
                  <a:gd name="T34" fmla="*/ 48 w 968"/>
                  <a:gd name="T35" fmla="*/ 4592 h 46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968" h="4616">
                    <a:moveTo>
                      <a:pt x="0" y="24"/>
                    </a:moveTo>
                    <a:cubicBezTo>
                      <a:pt x="0" y="11"/>
                      <a:pt x="11" y="0"/>
                      <a:pt x="24" y="0"/>
                    </a:cubicBezTo>
                    <a:lnTo>
                      <a:pt x="944" y="0"/>
                    </a:lnTo>
                    <a:cubicBezTo>
                      <a:pt x="958" y="0"/>
                      <a:pt x="968" y="11"/>
                      <a:pt x="968" y="24"/>
                    </a:cubicBezTo>
                    <a:lnTo>
                      <a:pt x="968" y="4592"/>
                    </a:lnTo>
                    <a:cubicBezTo>
                      <a:pt x="968" y="4606"/>
                      <a:pt x="958" y="4616"/>
                      <a:pt x="944" y="4616"/>
                    </a:cubicBezTo>
                    <a:lnTo>
                      <a:pt x="24" y="4616"/>
                    </a:lnTo>
                    <a:cubicBezTo>
                      <a:pt x="11" y="4616"/>
                      <a:pt x="0" y="4606"/>
                      <a:pt x="0" y="4592"/>
                    </a:cubicBezTo>
                    <a:lnTo>
                      <a:pt x="0" y="24"/>
                    </a:lnTo>
                    <a:close/>
                    <a:moveTo>
                      <a:pt x="48" y="4592"/>
                    </a:moveTo>
                    <a:lnTo>
                      <a:pt x="24" y="4568"/>
                    </a:lnTo>
                    <a:lnTo>
                      <a:pt x="944" y="4568"/>
                    </a:lnTo>
                    <a:lnTo>
                      <a:pt x="920" y="4592"/>
                    </a:lnTo>
                    <a:lnTo>
                      <a:pt x="920" y="24"/>
                    </a:lnTo>
                    <a:lnTo>
                      <a:pt x="944" y="48"/>
                    </a:lnTo>
                    <a:lnTo>
                      <a:pt x="24" y="48"/>
                    </a:lnTo>
                    <a:lnTo>
                      <a:pt x="48" y="24"/>
                    </a:lnTo>
                    <a:lnTo>
                      <a:pt x="48" y="4592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Rectangle 24"/>
              <p:cNvSpPr>
                <a:spLocks noChangeArrowheads="1"/>
              </p:cNvSpPr>
              <p:nvPr/>
            </p:nvSpPr>
            <p:spPr bwMode="auto">
              <a:xfrm>
                <a:off x="6108700" y="3402013"/>
                <a:ext cx="176213" cy="99377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Freeform 25"/>
              <p:cNvSpPr>
                <a:spLocks noEditPoints="1"/>
              </p:cNvSpPr>
              <p:nvPr/>
            </p:nvSpPr>
            <p:spPr bwMode="auto">
              <a:xfrm>
                <a:off x="6103938" y="3397250"/>
                <a:ext cx="185738" cy="1001712"/>
              </a:xfrm>
              <a:custGeom>
                <a:avLst/>
                <a:gdLst>
                  <a:gd name="T0" fmla="*/ 0 w 968"/>
                  <a:gd name="T1" fmla="*/ 24 h 5264"/>
                  <a:gd name="T2" fmla="*/ 24 w 968"/>
                  <a:gd name="T3" fmla="*/ 0 h 5264"/>
                  <a:gd name="T4" fmla="*/ 944 w 968"/>
                  <a:gd name="T5" fmla="*/ 0 h 5264"/>
                  <a:gd name="T6" fmla="*/ 968 w 968"/>
                  <a:gd name="T7" fmla="*/ 24 h 5264"/>
                  <a:gd name="T8" fmla="*/ 968 w 968"/>
                  <a:gd name="T9" fmla="*/ 5240 h 5264"/>
                  <a:gd name="T10" fmla="*/ 944 w 968"/>
                  <a:gd name="T11" fmla="*/ 5264 h 5264"/>
                  <a:gd name="T12" fmla="*/ 24 w 968"/>
                  <a:gd name="T13" fmla="*/ 5264 h 5264"/>
                  <a:gd name="T14" fmla="*/ 0 w 968"/>
                  <a:gd name="T15" fmla="*/ 5240 h 5264"/>
                  <a:gd name="T16" fmla="*/ 0 w 968"/>
                  <a:gd name="T17" fmla="*/ 24 h 5264"/>
                  <a:gd name="T18" fmla="*/ 48 w 968"/>
                  <a:gd name="T19" fmla="*/ 5240 h 5264"/>
                  <a:gd name="T20" fmla="*/ 24 w 968"/>
                  <a:gd name="T21" fmla="*/ 5216 h 5264"/>
                  <a:gd name="T22" fmla="*/ 944 w 968"/>
                  <a:gd name="T23" fmla="*/ 5216 h 5264"/>
                  <a:gd name="T24" fmla="*/ 920 w 968"/>
                  <a:gd name="T25" fmla="*/ 5240 h 5264"/>
                  <a:gd name="T26" fmla="*/ 920 w 968"/>
                  <a:gd name="T27" fmla="*/ 24 h 5264"/>
                  <a:gd name="T28" fmla="*/ 944 w 968"/>
                  <a:gd name="T29" fmla="*/ 48 h 5264"/>
                  <a:gd name="T30" fmla="*/ 24 w 968"/>
                  <a:gd name="T31" fmla="*/ 48 h 5264"/>
                  <a:gd name="T32" fmla="*/ 48 w 968"/>
                  <a:gd name="T33" fmla="*/ 24 h 5264"/>
                  <a:gd name="T34" fmla="*/ 48 w 968"/>
                  <a:gd name="T35" fmla="*/ 5240 h 52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968" h="5264">
                    <a:moveTo>
                      <a:pt x="0" y="24"/>
                    </a:moveTo>
                    <a:cubicBezTo>
                      <a:pt x="0" y="11"/>
                      <a:pt x="11" y="0"/>
                      <a:pt x="24" y="0"/>
                    </a:cubicBezTo>
                    <a:lnTo>
                      <a:pt x="944" y="0"/>
                    </a:lnTo>
                    <a:cubicBezTo>
                      <a:pt x="958" y="0"/>
                      <a:pt x="968" y="11"/>
                      <a:pt x="968" y="24"/>
                    </a:cubicBezTo>
                    <a:lnTo>
                      <a:pt x="968" y="5240"/>
                    </a:lnTo>
                    <a:cubicBezTo>
                      <a:pt x="968" y="5254"/>
                      <a:pt x="958" y="5264"/>
                      <a:pt x="944" y="5264"/>
                    </a:cubicBezTo>
                    <a:lnTo>
                      <a:pt x="24" y="5264"/>
                    </a:lnTo>
                    <a:cubicBezTo>
                      <a:pt x="11" y="5264"/>
                      <a:pt x="0" y="5254"/>
                      <a:pt x="0" y="5240"/>
                    </a:cubicBezTo>
                    <a:lnTo>
                      <a:pt x="0" y="24"/>
                    </a:lnTo>
                    <a:close/>
                    <a:moveTo>
                      <a:pt x="48" y="5240"/>
                    </a:moveTo>
                    <a:lnTo>
                      <a:pt x="24" y="5216"/>
                    </a:lnTo>
                    <a:lnTo>
                      <a:pt x="944" y="5216"/>
                    </a:lnTo>
                    <a:lnTo>
                      <a:pt x="920" y="5240"/>
                    </a:lnTo>
                    <a:lnTo>
                      <a:pt x="920" y="24"/>
                    </a:lnTo>
                    <a:lnTo>
                      <a:pt x="944" y="48"/>
                    </a:lnTo>
                    <a:lnTo>
                      <a:pt x="24" y="48"/>
                    </a:lnTo>
                    <a:lnTo>
                      <a:pt x="48" y="24"/>
                    </a:lnTo>
                    <a:lnTo>
                      <a:pt x="48" y="524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Rectangle 26"/>
              <p:cNvSpPr>
                <a:spLocks noChangeArrowheads="1"/>
              </p:cNvSpPr>
              <p:nvPr/>
            </p:nvSpPr>
            <p:spPr bwMode="auto">
              <a:xfrm>
                <a:off x="6548438" y="4038600"/>
                <a:ext cx="174625" cy="35718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Freeform 27"/>
              <p:cNvSpPr>
                <a:spLocks noEditPoints="1"/>
              </p:cNvSpPr>
              <p:nvPr/>
            </p:nvSpPr>
            <p:spPr bwMode="auto">
              <a:xfrm>
                <a:off x="6543675" y="4033838"/>
                <a:ext cx="184150" cy="365125"/>
              </a:xfrm>
              <a:custGeom>
                <a:avLst/>
                <a:gdLst>
                  <a:gd name="T0" fmla="*/ 0 w 968"/>
                  <a:gd name="T1" fmla="*/ 24 h 1920"/>
                  <a:gd name="T2" fmla="*/ 24 w 968"/>
                  <a:gd name="T3" fmla="*/ 0 h 1920"/>
                  <a:gd name="T4" fmla="*/ 944 w 968"/>
                  <a:gd name="T5" fmla="*/ 0 h 1920"/>
                  <a:gd name="T6" fmla="*/ 968 w 968"/>
                  <a:gd name="T7" fmla="*/ 24 h 1920"/>
                  <a:gd name="T8" fmla="*/ 968 w 968"/>
                  <a:gd name="T9" fmla="*/ 1896 h 1920"/>
                  <a:gd name="T10" fmla="*/ 944 w 968"/>
                  <a:gd name="T11" fmla="*/ 1920 h 1920"/>
                  <a:gd name="T12" fmla="*/ 24 w 968"/>
                  <a:gd name="T13" fmla="*/ 1920 h 1920"/>
                  <a:gd name="T14" fmla="*/ 0 w 968"/>
                  <a:gd name="T15" fmla="*/ 1896 h 1920"/>
                  <a:gd name="T16" fmla="*/ 0 w 968"/>
                  <a:gd name="T17" fmla="*/ 24 h 1920"/>
                  <a:gd name="T18" fmla="*/ 48 w 968"/>
                  <a:gd name="T19" fmla="*/ 1896 h 1920"/>
                  <a:gd name="T20" fmla="*/ 24 w 968"/>
                  <a:gd name="T21" fmla="*/ 1872 h 1920"/>
                  <a:gd name="T22" fmla="*/ 944 w 968"/>
                  <a:gd name="T23" fmla="*/ 1872 h 1920"/>
                  <a:gd name="T24" fmla="*/ 920 w 968"/>
                  <a:gd name="T25" fmla="*/ 1896 h 1920"/>
                  <a:gd name="T26" fmla="*/ 920 w 968"/>
                  <a:gd name="T27" fmla="*/ 24 h 1920"/>
                  <a:gd name="T28" fmla="*/ 944 w 968"/>
                  <a:gd name="T29" fmla="*/ 48 h 1920"/>
                  <a:gd name="T30" fmla="*/ 24 w 968"/>
                  <a:gd name="T31" fmla="*/ 48 h 1920"/>
                  <a:gd name="T32" fmla="*/ 48 w 968"/>
                  <a:gd name="T33" fmla="*/ 24 h 1920"/>
                  <a:gd name="T34" fmla="*/ 48 w 968"/>
                  <a:gd name="T35" fmla="*/ 1896 h 19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968" h="1920">
                    <a:moveTo>
                      <a:pt x="0" y="24"/>
                    </a:moveTo>
                    <a:cubicBezTo>
                      <a:pt x="0" y="11"/>
                      <a:pt x="11" y="0"/>
                      <a:pt x="24" y="0"/>
                    </a:cubicBezTo>
                    <a:lnTo>
                      <a:pt x="944" y="0"/>
                    </a:lnTo>
                    <a:cubicBezTo>
                      <a:pt x="958" y="0"/>
                      <a:pt x="968" y="11"/>
                      <a:pt x="968" y="24"/>
                    </a:cubicBezTo>
                    <a:lnTo>
                      <a:pt x="968" y="1896"/>
                    </a:lnTo>
                    <a:cubicBezTo>
                      <a:pt x="968" y="1910"/>
                      <a:pt x="958" y="1920"/>
                      <a:pt x="944" y="1920"/>
                    </a:cubicBezTo>
                    <a:lnTo>
                      <a:pt x="24" y="1920"/>
                    </a:lnTo>
                    <a:cubicBezTo>
                      <a:pt x="11" y="1920"/>
                      <a:pt x="0" y="1910"/>
                      <a:pt x="0" y="1896"/>
                    </a:cubicBezTo>
                    <a:lnTo>
                      <a:pt x="0" y="24"/>
                    </a:lnTo>
                    <a:close/>
                    <a:moveTo>
                      <a:pt x="48" y="1896"/>
                    </a:moveTo>
                    <a:lnTo>
                      <a:pt x="24" y="1872"/>
                    </a:lnTo>
                    <a:lnTo>
                      <a:pt x="944" y="1872"/>
                    </a:lnTo>
                    <a:lnTo>
                      <a:pt x="920" y="1896"/>
                    </a:lnTo>
                    <a:lnTo>
                      <a:pt x="920" y="24"/>
                    </a:lnTo>
                    <a:lnTo>
                      <a:pt x="944" y="48"/>
                    </a:lnTo>
                    <a:lnTo>
                      <a:pt x="24" y="48"/>
                    </a:lnTo>
                    <a:lnTo>
                      <a:pt x="48" y="24"/>
                    </a:lnTo>
                    <a:lnTo>
                      <a:pt x="48" y="1896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" name="Rectangle 28"/>
              <p:cNvSpPr>
                <a:spLocks noChangeArrowheads="1"/>
              </p:cNvSpPr>
              <p:nvPr/>
            </p:nvSpPr>
            <p:spPr bwMode="auto">
              <a:xfrm>
                <a:off x="6986588" y="4362450"/>
                <a:ext cx="176213" cy="3333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" name="Freeform 29"/>
              <p:cNvSpPr>
                <a:spLocks noEditPoints="1"/>
              </p:cNvSpPr>
              <p:nvPr/>
            </p:nvSpPr>
            <p:spPr bwMode="auto">
              <a:xfrm>
                <a:off x="6981825" y="4359275"/>
                <a:ext cx="185738" cy="39687"/>
              </a:xfrm>
              <a:custGeom>
                <a:avLst/>
                <a:gdLst>
                  <a:gd name="T0" fmla="*/ 0 w 968"/>
                  <a:gd name="T1" fmla="*/ 24 h 216"/>
                  <a:gd name="T2" fmla="*/ 24 w 968"/>
                  <a:gd name="T3" fmla="*/ 0 h 216"/>
                  <a:gd name="T4" fmla="*/ 944 w 968"/>
                  <a:gd name="T5" fmla="*/ 0 h 216"/>
                  <a:gd name="T6" fmla="*/ 968 w 968"/>
                  <a:gd name="T7" fmla="*/ 24 h 216"/>
                  <a:gd name="T8" fmla="*/ 968 w 968"/>
                  <a:gd name="T9" fmla="*/ 192 h 216"/>
                  <a:gd name="T10" fmla="*/ 944 w 968"/>
                  <a:gd name="T11" fmla="*/ 216 h 216"/>
                  <a:gd name="T12" fmla="*/ 24 w 968"/>
                  <a:gd name="T13" fmla="*/ 216 h 216"/>
                  <a:gd name="T14" fmla="*/ 0 w 968"/>
                  <a:gd name="T15" fmla="*/ 192 h 216"/>
                  <a:gd name="T16" fmla="*/ 0 w 968"/>
                  <a:gd name="T17" fmla="*/ 24 h 216"/>
                  <a:gd name="T18" fmla="*/ 48 w 968"/>
                  <a:gd name="T19" fmla="*/ 192 h 216"/>
                  <a:gd name="T20" fmla="*/ 24 w 968"/>
                  <a:gd name="T21" fmla="*/ 168 h 216"/>
                  <a:gd name="T22" fmla="*/ 944 w 968"/>
                  <a:gd name="T23" fmla="*/ 168 h 216"/>
                  <a:gd name="T24" fmla="*/ 920 w 968"/>
                  <a:gd name="T25" fmla="*/ 192 h 216"/>
                  <a:gd name="T26" fmla="*/ 920 w 968"/>
                  <a:gd name="T27" fmla="*/ 24 h 216"/>
                  <a:gd name="T28" fmla="*/ 944 w 968"/>
                  <a:gd name="T29" fmla="*/ 48 h 216"/>
                  <a:gd name="T30" fmla="*/ 24 w 968"/>
                  <a:gd name="T31" fmla="*/ 48 h 216"/>
                  <a:gd name="T32" fmla="*/ 48 w 968"/>
                  <a:gd name="T33" fmla="*/ 24 h 216"/>
                  <a:gd name="T34" fmla="*/ 48 w 968"/>
                  <a:gd name="T35" fmla="*/ 192 h 2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968" h="216">
                    <a:moveTo>
                      <a:pt x="0" y="24"/>
                    </a:moveTo>
                    <a:cubicBezTo>
                      <a:pt x="0" y="11"/>
                      <a:pt x="11" y="0"/>
                      <a:pt x="24" y="0"/>
                    </a:cubicBezTo>
                    <a:lnTo>
                      <a:pt x="944" y="0"/>
                    </a:lnTo>
                    <a:cubicBezTo>
                      <a:pt x="958" y="0"/>
                      <a:pt x="968" y="11"/>
                      <a:pt x="968" y="24"/>
                    </a:cubicBezTo>
                    <a:lnTo>
                      <a:pt x="968" y="192"/>
                    </a:lnTo>
                    <a:cubicBezTo>
                      <a:pt x="968" y="206"/>
                      <a:pt x="958" y="216"/>
                      <a:pt x="944" y="216"/>
                    </a:cubicBezTo>
                    <a:lnTo>
                      <a:pt x="24" y="216"/>
                    </a:lnTo>
                    <a:cubicBezTo>
                      <a:pt x="11" y="216"/>
                      <a:pt x="0" y="206"/>
                      <a:pt x="0" y="192"/>
                    </a:cubicBezTo>
                    <a:lnTo>
                      <a:pt x="0" y="24"/>
                    </a:lnTo>
                    <a:close/>
                    <a:moveTo>
                      <a:pt x="48" y="192"/>
                    </a:moveTo>
                    <a:lnTo>
                      <a:pt x="24" y="168"/>
                    </a:lnTo>
                    <a:lnTo>
                      <a:pt x="944" y="168"/>
                    </a:lnTo>
                    <a:lnTo>
                      <a:pt x="920" y="192"/>
                    </a:lnTo>
                    <a:lnTo>
                      <a:pt x="920" y="24"/>
                    </a:lnTo>
                    <a:lnTo>
                      <a:pt x="944" y="48"/>
                    </a:lnTo>
                    <a:lnTo>
                      <a:pt x="24" y="48"/>
                    </a:lnTo>
                    <a:lnTo>
                      <a:pt x="48" y="24"/>
                    </a:lnTo>
                    <a:lnTo>
                      <a:pt x="48" y="192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" name="Freeform 30"/>
              <p:cNvSpPr>
                <a:spLocks noEditPoints="1"/>
              </p:cNvSpPr>
              <p:nvPr/>
            </p:nvSpPr>
            <p:spPr bwMode="auto">
              <a:xfrm>
                <a:off x="2657475" y="2435225"/>
                <a:ext cx="57150" cy="71437"/>
              </a:xfrm>
              <a:custGeom>
                <a:avLst/>
                <a:gdLst>
                  <a:gd name="T0" fmla="*/ 15 w 36"/>
                  <a:gd name="T1" fmla="*/ 45 h 45"/>
                  <a:gd name="T2" fmla="*/ 15 w 36"/>
                  <a:gd name="T3" fmla="*/ 3 h 45"/>
                  <a:gd name="T4" fmla="*/ 21 w 36"/>
                  <a:gd name="T5" fmla="*/ 3 h 45"/>
                  <a:gd name="T6" fmla="*/ 21 w 36"/>
                  <a:gd name="T7" fmla="*/ 45 h 45"/>
                  <a:gd name="T8" fmla="*/ 15 w 36"/>
                  <a:gd name="T9" fmla="*/ 45 h 45"/>
                  <a:gd name="T10" fmla="*/ 0 w 36"/>
                  <a:gd name="T11" fmla="*/ 0 h 45"/>
                  <a:gd name="T12" fmla="*/ 36 w 36"/>
                  <a:gd name="T13" fmla="*/ 0 h 45"/>
                  <a:gd name="T14" fmla="*/ 36 w 36"/>
                  <a:gd name="T15" fmla="*/ 6 h 45"/>
                  <a:gd name="T16" fmla="*/ 0 w 36"/>
                  <a:gd name="T17" fmla="*/ 6 h 45"/>
                  <a:gd name="T18" fmla="*/ 0 w 36"/>
                  <a:gd name="T19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45">
                    <a:moveTo>
                      <a:pt x="15" y="45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45"/>
                    </a:lnTo>
                    <a:lnTo>
                      <a:pt x="15" y="45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" name="Freeform 31"/>
              <p:cNvSpPr>
                <a:spLocks noEditPoints="1"/>
              </p:cNvSpPr>
              <p:nvPr/>
            </p:nvSpPr>
            <p:spPr bwMode="auto">
              <a:xfrm>
                <a:off x="3095625" y="4262438"/>
                <a:ext cx="58738" cy="36512"/>
              </a:xfrm>
              <a:custGeom>
                <a:avLst/>
                <a:gdLst>
                  <a:gd name="T0" fmla="*/ 15 w 37"/>
                  <a:gd name="T1" fmla="*/ 23 h 23"/>
                  <a:gd name="T2" fmla="*/ 15 w 37"/>
                  <a:gd name="T3" fmla="*/ 3 h 23"/>
                  <a:gd name="T4" fmla="*/ 21 w 37"/>
                  <a:gd name="T5" fmla="*/ 3 h 23"/>
                  <a:gd name="T6" fmla="*/ 21 w 37"/>
                  <a:gd name="T7" fmla="*/ 23 h 23"/>
                  <a:gd name="T8" fmla="*/ 15 w 37"/>
                  <a:gd name="T9" fmla="*/ 23 h 23"/>
                  <a:gd name="T10" fmla="*/ 0 w 37"/>
                  <a:gd name="T11" fmla="*/ 0 h 23"/>
                  <a:gd name="T12" fmla="*/ 37 w 37"/>
                  <a:gd name="T13" fmla="*/ 0 h 23"/>
                  <a:gd name="T14" fmla="*/ 37 w 37"/>
                  <a:gd name="T15" fmla="*/ 6 h 23"/>
                  <a:gd name="T16" fmla="*/ 0 w 37"/>
                  <a:gd name="T17" fmla="*/ 6 h 23"/>
                  <a:gd name="T18" fmla="*/ 0 w 37"/>
                  <a:gd name="T19" fmla="*/ 0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7" h="23">
                    <a:moveTo>
                      <a:pt x="15" y="23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23"/>
                    </a:lnTo>
                    <a:lnTo>
                      <a:pt x="15" y="23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" name="Freeform 32"/>
              <p:cNvSpPr>
                <a:spLocks noEditPoints="1"/>
              </p:cNvSpPr>
              <p:nvPr/>
            </p:nvSpPr>
            <p:spPr bwMode="auto">
              <a:xfrm>
                <a:off x="3535363" y="3000375"/>
                <a:ext cx="57150" cy="80962"/>
              </a:xfrm>
              <a:custGeom>
                <a:avLst/>
                <a:gdLst>
                  <a:gd name="T0" fmla="*/ 15 w 36"/>
                  <a:gd name="T1" fmla="*/ 51 h 51"/>
                  <a:gd name="T2" fmla="*/ 15 w 36"/>
                  <a:gd name="T3" fmla="*/ 3 h 51"/>
                  <a:gd name="T4" fmla="*/ 21 w 36"/>
                  <a:gd name="T5" fmla="*/ 3 h 51"/>
                  <a:gd name="T6" fmla="*/ 21 w 36"/>
                  <a:gd name="T7" fmla="*/ 51 h 51"/>
                  <a:gd name="T8" fmla="*/ 15 w 36"/>
                  <a:gd name="T9" fmla="*/ 51 h 51"/>
                  <a:gd name="T10" fmla="*/ 0 w 36"/>
                  <a:gd name="T11" fmla="*/ 0 h 51"/>
                  <a:gd name="T12" fmla="*/ 36 w 36"/>
                  <a:gd name="T13" fmla="*/ 0 h 51"/>
                  <a:gd name="T14" fmla="*/ 36 w 36"/>
                  <a:gd name="T15" fmla="*/ 6 h 51"/>
                  <a:gd name="T16" fmla="*/ 0 w 36"/>
                  <a:gd name="T17" fmla="*/ 6 h 51"/>
                  <a:gd name="T18" fmla="*/ 0 w 36"/>
                  <a:gd name="T1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51">
                    <a:moveTo>
                      <a:pt x="15" y="51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51"/>
                    </a:lnTo>
                    <a:lnTo>
                      <a:pt x="15" y="51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Freeform 33"/>
              <p:cNvSpPr>
                <a:spLocks noEditPoints="1"/>
              </p:cNvSpPr>
              <p:nvPr/>
            </p:nvSpPr>
            <p:spPr bwMode="auto">
              <a:xfrm>
                <a:off x="3973513" y="4049713"/>
                <a:ext cx="58738" cy="7937"/>
              </a:xfrm>
              <a:custGeom>
                <a:avLst/>
                <a:gdLst>
                  <a:gd name="T0" fmla="*/ 15 w 37"/>
                  <a:gd name="T1" fmla="*/ 4 h 5"/>
                  <a:gd name="T2" fmla="*/ 15 w 37"/>
                  <a:gd name="T3" fmla="*/ 3 h 5"/>
                  <a:gd name="T4" fmla="*/ 21 w 37"/>
                  <a:gd name="T5" fmla="*/ 3 h 5"/>
                  <a:gd name="T6" fmla="*/ 21 w 37"/>
                  <a:gd name="T7" fmla="*/ 4 h 5"/>
                  <a:gd name="T8" fmla="*/ 15 w 37"/>
                  <a:gd name="T9" fmla="*/ 4 h 5"/>
                  <a:gd name="T10" fmla="*/ 0 w 37"/>
                  <a:gd name="T11" fmla="*/ 0 h 5"/>
                  <a:gd name="T12" fmla="*/ 37 w 37"/>
                  <a:gd name="T13" fmla="*/ 0 h 5"/>
                  <a:gd name="T14" fmla="*/ 37 w 37"/>
                  <a:gd name="T15" fmla="*/ 5 h 5"/>
                  <a:gd name="T16" fmla="*/ 0 w 37"/>
                  <a:gd name="T17" fmla="*/ 5 h 5"/>
                  <a:gd name="T18" fmla="*/ 0 w 37"/>
                  <a:gd name="T19" fmla="*/ 0 h 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7" h="5">
                    <a:moveTo>
                      <a:pt x="15" y="4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4"/>
                    </a:lnTo>
                    <a:lnTo>
                      <a:pt x="15" y="4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4" name="Freeform 34"/>
              <p:cNvSpPr>
                <a:spLocks noEditPoints="1"/>
              </p:cNvSpPr>
              <p:nvPr/>
            </p:nvSpPr>
            <p:spPr bwMode="auto">
              <a:xfrm>
                <a:off x="4413250" y="4298950"/>
                <a:ext cx="57150" cy="14287"/>
              </a:xfrm>
              <a:custGeom>
                <a:avLst/>
                <a:gdLst>
                  <a:gd name="T0" fmla="*/ 15 w 36"/>
                  <a:gd name="T1" fmla="*/ 9 h 9"/>
                  <a:gd name="T2" fmla="*/ 15 w 36"/>
                  <a:gd name="T3" fmla="*/ 3 h 9"/>
                  <a:gd name="T4" fmla="*/ 21 w 36"/>
                  <a:gd name="T5" fmla="*/ 3 h 9"/>
                  <a:gd name="T6" fmla="*/ 21 w 36"/>
                  <a:gd name="T7" fmla="*/ 9 h 9"/>
                  <a:gd name="T8" fmla="*/ 15 w 36"/>
                  <a:gd name="T9" fmla="*/ 9 h 9"/>
                  <a:gd name="T10" fmla="*/ 0 w 36"/>
                  <a:gd name="T11" fmla="*/ 0 h 9"/>
                  <a:gd name="T12" fmla="*/ 36 w 36"/>
                  <a:gd name="T13" fmla="*/ 0 h 9"/>
                  <a:gd name="T14" fmla="*/ 36 w 36"/>
                  <a:gd name="T15" fmla="*/ 6 h 9"/>
                  <a:gd name="T16" fmla="*/ 0 w 36"/>
                  <a:gd name="T17" fmla="*/ 6 h 9"/>
                  <a:gd name="T18" fmla="*/ 0 w 36"/>
                  <a:gd name="T19" fmla="*/ 0 h 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9">
                    <a:moveTo>
                      <a:pt x="15" y="9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9"/>
                    </a:lnTo>
                    <a:lnTo>
                      <a:pt x="15" y="9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5" name="Freeform 35"/>
              <p:cNvSpPr>
                <a:spLocks noEditPoints="1"/>
              </p:cNvSpPr>
              <p:nvPr/>
            </p:nvSpPr>
            <p:spPr bwMode="auto">
              <a:xfrm>
                <a:off x="4851400" y="4260850"/>
                <a:ext cx="58738" cy="23812"/>
              </a:xfrm>
              <a:custGeom>
                <a:avLst/>
                <a:gdLst>
                  <a:gd name="T0" fmla="*/ 15 w 37"/>
                  <a:gd name="T1" fmla="*/ 15 h 15"/>
                  <a:gd name="T2" fmla="*/ 15 w 37"/>
                  <a:gd name="T3" fmla="*/ 3 h 15"/>
                  <a:gd name="T4" fmla="*/ 21 w 37"/>
                  <a:gd name="T5" fmla="*/ 3 h 15"/>
                  <a:gd name="T6" fmla="*/ 21 w 37"/>
                  <a:gd name="T7" fmla="*/ 15 h 15"/>
                  <a:gd name="T8" fmla="*/ 15 w 37"/>
                  <a:gd name="T9" fmla="*/ 15 h 15"/>
                  <a:gd name="T10" fmla="*/ 0 w 37"/>
                  <a:gd name="T11" fmla="*/ 0 h 15"/>
                  <a:gd name="T12" fmla="*/ 37 w 37"/>
                  <a:gd name="T13" fmla="*/ 0 h 15"/>
                  <a:gd name="T14" fmla="*/ 37 w 37"/>
                  <a:gd name="T15" fmla="*/ 6 h 15"/>
                  <a:gd name="T16" fmla="*/ 0 w 37"/>
                  <a:gd name="T17" fmla="*/ 6 h 15"/>
                  <a:gd name="T18" fmla="*/ 0 w 37"/>
                  <a:gd name="T19" fmla="*/ 0 h 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7" h="15">
                    <a:moveTo>
                      <a:pt x="15" y="15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15"/>
                    </a:lnTo>
                    <a:lnTo>
                      <a:pt x="15" y="15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7" name="Freeform 36"/>
              <p:cNvSpPr>
                <a:spLocks noEditPoints="1"/>
              </p:cNvSpPr>
              <p:nvPr/>
            </p:nvSpPr>
            <p:spPr bwMode="auto">
              <a:xfrm>
                <a:off x="5291138" y="4241800"/>
                <a:ext cx="57150" cy="22225"/>
              </a:xfrm>
              <a:custGeom>
                <a:avLst/>
                <a:gdLst>
                  <a:gd name="T0" fmla="*/ 15 w 36"/>
                  <a:gd name="T1" fmla="*/ 14 h 14"/>
                  <a:gd name="T2" fmla="*/ 15 w 36"/>
                  <a:gd name="T3" fmla="*/ 3 h 14"/>
                  <a:gd name="T4" fmla="*/ 21 w 36"/>
                  <a:gd name="T5" fmla="*/ 3 h 14"/>
                  <a:gd name="T6" fmla="*/ 21 w 36"/>
                  <a:gd name="T7" fmla="*/ 14 h 14"/>
                  <a:gd name="T8" fmla="*/ 15 w 36"/>
                  <a:gd name="T9" fmla="*/ 14 h 14"/>
                  <a:gd name="T10" fmla="*/ 0 w 36"/>
                  <a:gd name="T11" fmla="*/ 0 h 14"/>
                  <a:gd name="T12" fmla="*/ 36 w 36"/>
                  <a:gd name="T13" fmla="*/ 0 h 14"/>
                  <a:gd name="T14" fmla="*/ 36 w 36"/>
                  <a:gd name="T15" fmla="*/ 5 h 14"/>
                  <a:gd name="T16" fmla="*/ 0 w 36"/>
                  <a:gd name="T17" fmla="*/ 5 h 14"/>
                  <a:gd name="T18" fmla="*/ 0 w 36"/>
                  <a:gd name="T19" fmla="*/ 0 h 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14">
                    <a:moveTo>
                      <a:pt x="15" y="14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14"/>
                    </a:lnTo>
                    <a:lnTo>
                      <a:pt x="15" y="14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8" name="Freeform 37"/>
              <p:cNvSpPr>
                <a:spLocks noEditPoints="1"/>
              </p:cNvSpPr>
              <p:nvPr/>
            </p:nvSpPr>
            <p:spPr bwMode="auto">
              <a:xfrm>
                <a:off x="5729288" y="3467100"/>
                <a:ext cx="58738" cy="57150"/>
              </a:xfrm>
              <a:custGeom>
                <a:avLst/>
                <a:gdLst>
                  <a:gd name="T0" fmla="*/ 16 w 37"/>
                  <a:gd name="T1" fmla="*/ 36 h 36"/>
                  <a:gd name="T2" fmla="*/ 16 w 37"/>
                  <a:gd name="T3" fmla="*/ 3 h 36"/>
                  <a:gd name="T4" fmla="*/ 21 w 37"/>
                  <a:gd name="T5" fmla="*/ 3 h 36"/>
                  <a:gd name="T6" fmla="*/ 21 w 37"/>
                  <a:gd name="T7" fmla="*/ 36 h 36"/>
                  <a:gd name="T8" fmla="*/ 16 w 37"/>
                  <a:gd name="T9" fmla="*/ 36 h 36"/>
                  <a:gd name="T10" fmla="*/ 0 w 37"/>
                  <a:gd name="T11" fmla="*/ 0 h 36"/>
                  <a:gd name="T12" fmla="*/ 37 w 37"/>
                  <a:gd name="T13" fmla="*/ 0 h 36"/>
                  <a:gd name="T14" fmla="*/ 37 w 37"/>
                  <a:gd name="T15" fmla="*/ 6 h 36"/>
                  <a:gd name="T16" fmla="*/ 0 w 37"/>
                  <a:gd name="T17" fmla="*/ 6 h 36"/>
                  <a:gd name="T18" fmla="*/ 0 w 37"/>
                  <a:gd name="T19" fmla="*/ 0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7" h="36">
                    <a:moveTo>
                      <a:pt x="16" y="36"/>
                    </a:moveTo>
                    <a:lnTo>
                      <a:pt x="16" y="3"/>
                    </a:lnTo>
                    <a:lnTo>
                      <a:pt x="21" y="3"/>
                    </a:lnTo>
                    <a:lnTo>
                      <a:pt x="21" y="36"/>
                    </a:lnTo>
                    <a:lnTo>
                      <a:pt x="16" y="36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9" name="Freeform 38"/>
              <p:cNvSpPr>
                <a:spLocks noEditPoints="1"/>
              </p:cNvSpPr>
              <p:nvPr/>
            </p:nvSpPr>
            <p:spPr bwMode="auto">
              <a:xfrm>
                <a:off x="6169025" y="3368675"/>
                <a:ext cx="55563" cy="33337"/>
              </a:xfrm>
              <a:custGeom>
                <a:avLst/>
                <a:gdLst>
                  <a:gd name="T0" fmla="*/ 15 w 35"/>
                  <a:gd name="T1" fmla="*/ 21 h 21"/>
                  <a:gd name="T2" fmla="*/ 15 w 35"/>
                  <a:gd name="T3" fmla="*/ 3 h 21"/>
                  <a:gd name="T4" fmla="*/ 21 w 35"/>
                  <a:gd name="T5" fmla="*/ 3 h 21"/>
                  <a:gd name="T6" fmla="*/ 21 w 35"/>
                  <a:gd name="T7" fmla="*/ 21 h 21"/>
                  <a:gd name="T8" fmla="*/ 15 w 35"/>
                  <a:gd name="T9" fmla="*/ 21 h 21"/>
                  <a:gd name="T10" fmla="*/ 0 w 35"/>
                  <a:gd name="T11" fmla="*/ 0 h 21"/>
                  <a:gd name="T12" fmla="*/ 35 w 35"/>
                  <a:gd name="T13" fmla="*/ 0 h 21"/>
                  <a:gd name="T14" fmla="*/ 35 w 35"/>
                  <a:gd name="T15" fmla="*/ 6 h 21"/>
                  <a:gd name="T16" fmla="*/ 0 w 35"/>
                  <a:gd name="T17" fmla="*/ 6 h 21"/>
                  <a:gd name="T18" fmla="*/ 0 w 35"/>
                  <a:gd name="T19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5" h="21">
                    <a:moveTo>
                      <a:pt x="15" y="21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21"/>
                    </a:lnTo>
                    <a:lnTo>
                      <a:pt x="15" y="21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0" name="Freeform 39"/>
              <p:cNvSpPr>
                <a:spLocks noEditPoints="1"/>
              </p:cNvSpPr>
              <p:nvPr/>
            </p:nvSpPr>
            <p:spPr bwMode="auto">
              <a:xfrm>
                <a:off x="6607175" y="4016375"/>
                <a:ext cx="57150" cy="22225"/>
              </a:xfrm>
              <a:custGeom>
                <a:avLst/>
                <a:gdLst>
                  <a:gd name="T0" fmla="*/ 16 w 36"/>
                  <a:gd name="T1" fmla="*/ 14 h 14"/>
                  <a:gd name="T2" fmla="*/ 16 w 36"/>
                  <a:gd name="T3" fmla="*/ 2 h 14"/>
                  <a:gd name="T4" fmla="*/ 21 w 36"/>
                  <a:gd name="T5" fmla="*/ 2 h 14"/>
                  <a:gd name="T6" fmla="*/ 21 w 36"/>
                  <a:gd name="T7" fmla="*/ 14 h 14"/>
                  <a:gd name="T8" fmla="*/ 16 w 36"/>
                  <a:gd name="T9" fmla="*/ 14 h 14"/>
                  <a:gd name="T10" fmla="*/ 0 w 36"/>
                  <a:gd name="T11" fmla="*/ 0 h 14"/>
                  <a:gd name="T12" fmla="*/ 36 w 36"/>
                  <a:gd name="T13" fmla="*/ 0 h 14"/>
                  <a:gd name="T14" fmla="*/ 36 w 36"/>
                  <a:gd name="T15" fmla="*/ 5 h 14"/>
                  <a:gd name="T16" fmla="*/ 0 w 36"/>
                  <a:gd name="T17" fmla="*/ 5 h 14"/>
                  <a:gd name="T18" fmla="*/ 0 w 36"/>
                  <a:gd name="T19" fmla="*/ 0 h 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14">
                    <a:moveTo>
                      <a:pt x="16" y="14"/>
                    </a:moveTo>
                    <a:lnTo>
                      <a:pt x="16" y="2"/>
                    </a:lnTo>
                    <a:lnTo>
                      <a:pt x="21" y="2"/>
                    </a:lnTo>
                    <a:lnTo>
                      <a:pt x="21" y="14"/>
                    </a:lnTo>
                    <a:lnTo>
                      <a:pt x="16" y="14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1" name="Freeform 40"/>
              <p:cNvSpPr>
                <a:spLocks noEditPoints="1"/>
              </p:cNvSpPr>
              <p:nvPr/>
            </p:nvSpPr>
            <p:spPr bwMode="auto">
              <a:xfrm>
                <a:off x="7046913" y="4352925"/>
                <a:ext cx="55563" cy="9525"/>
              </a:xfrm>
              <a:custGeom>
                <a:avLst/>
                <a:gdLst>
                  <a:gd name="T0" fmla="*/ 15 w 35"/>
                  <a:gd name="T1" fmla="*/ 6 h 6"/>
                  <a:gd name="T2" fmla="*/ 15 w 35"/>
                  <a:gd name="T3" fmla="*/ 3 h 6"/>
                  <a:gd name="T4" fmla="*/ 21 w 35"/>
                  <a:gd name="T5" fmla="*/ 3 h 6"/>
                  <a:gd name="T6" fmla="*/ 21 w 35"/>
                  <a:gd name="T7" fmla="*/ 6 h 6"/>
                  <a:gd name="T8" fmla="*/ 15 w 35"/>
                  <a:gd name="T9" fmla="*/ 6 h 6"/>
                  <a:gd name="T10" fmla="*/ 0 w 35"/>
                  <a:gd name="T11" fmla="*/ 0 h 6"/>
                  <a:gd name="T12" fmla="*/ 35 w 35"/>
                  <a:gd name="T13" fmla="*/ 0 h 6"/>
                  <a:gd name="T14" fmla="*/ 35 w 35"/>
                  <a:gd name="T15" fmla="*/ 5 h 6"/>
                  <a:gd name="T16" fmla="*/ 0 w 35"/>
                  <a:gd name="T17" fmla="*/ 5 h 6"/>
                  <a:gd name="T18" fmla="*/ 0 w 35"/>
                  <a:gd name="T19" fmla="*/ 0 h 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5" h="6">
                    <a:moveTo>
                      <a:pt x="15" y="6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6"/>
                    </a:lnTo>
                    <a:lnTo>
                      <a:pt x="15" y="6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2" name="Rectangle 41"/>
              <p:cNvSpPr>
                <a:spLocks noChangeArrowheads="1"/>
              </p:cNvSpPr>
              <p:nvPr/>
            </p:nvSpPr>
            <p:spPr bwMode="auto">
              <a:xfrm>
                <a:off x="2462213" y="2144713"/>
                <a:ext cx="7938" cy="2251075"/>
              </a:xfrm>
              <a:prstGeom prst="rect">
                <a:avLst/>
              </a:prstGeom>
              <a:solidFill>
                <a:srgbClr val="868686"/>
              </a:solidFill>
              <a:ln w="1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3" name="Freeform 42"/>
              <p:cNvSpPr>
                <a:spLocks noEditPoints="1"/>
              </p:cNvSpPr>
              <p:nvPr/>
            </p:nvSpPr>
            <p:spPr bwMode="auto">
              <a:xfrm>
                <a:off x="2420938" y="2141538"/>
                <a:ext cx="46038" cy="2257425"/>
              </a:xfrm>
              <a:custGeom>
                <a:avLst/>
                <a:gdLst>
                  <a:gd name="T0" fmla="*/ 0 w 29"/>
                  <a:gd name="T1" fmla="*/ 1417 h 1422"/>
                  <a:gd name="T2" fmla="*/ 29 w 29"/>
                  <a:gd name="T3" fmla="*/ 1417 h 1422"/>
                  <a:gd name="T4" fmla="*/ 29 w 29"/>
                  <a:gd name="T5" fmla="*/ 1422 h 1422"/>
                  <a:gd name="T6" fmla="*/ 0 w 29"/>
                  <a:gd name="T7" fmla="*/ 1422 h 1422"/>
                  <a:gd name="T8" fmla="*/ 0 w 29"/>
                  <a:gd name="T9" fmla="*/ 1417 h 1422"/>
                  <a:gd name="T10" fmla="*/ 0 w 29"/>
                  <a:gd name="T11" fmla="*/ 1259 h 1422"/>
                  <a:gd name="T12" fmla="*/ 29 w 29"/>
                  <a:gd name="T13" fmla="*/ 1259 h 1422"/>
                  <a:gd name="T14" fmla="*/ 29 w 29"/>
                  <a:gd name="T15" fmla="*/ 1265 h 1422"/>
                  <a:gd name="T16" fmla="*/ 0 w 29"/>
                  <a:gd name="T17" fmla="*/ 1265 h 1422"/>
                  <a:gd name="T18" fmla="*/ 0 w 29"/>
                  <a:gd name="T19" fmla="*/ 1259 h 1422"/>
                  <a:gd name="T20" fmla="*/ 0 w 29"/>
                  <a:gd name="T21" fmla="*/ 1102 h 1422"/>
                  <a:gd name="T22" fmla="*/ 29 w 29"/>
                  <a:gd name="T23" fmla="*/ 1102 h 1422"/>
                  <a:gd name="T24" fmla="*/ 29 w 29"/>
                  <a:gd name="T25" fmla="*/ 1108 h 1422"/>
                  <a:gd name="T26" fmla="*/ 0 w 29"/>
                  <a:gd name="T27" fmla="*/ 1108 h 1422"/>
                  <a:gd name="T28" fmla="*/ 0 w 29"/>
                  <a:gd name="T29" fmla="*/ 1102 h 1422"/>
                  <a:gd name="T30" fmla="*/ 0 w 29"/>
                  <a:gd name="T31" fmla="*/ 944 h 1422"/>
                  <a:gd name="T32" fmla="*/ 29 w 29"/>
                  <a:gd name="T33" fmla="*/ 944 h 1422"/>
                  <a:gd name="T34" fmla="*/ 29 w 29"/>
                  <a:gd name="T35" fmla="*/ 950 h 1422"/>
                  <a:gd name="T36" fmla="*/ 0 w 29"/>
                  <a:gd name="T37" fmla="*/ 950 h 1422"/>
                  <a:gd name="T38" fmla="*/ 0 w 29"/>
                  <a:gd name="T39" fmla="*/ 944 h 1422"/>
                  <a:gd name="T40" fmla="*/ 0 w 29"/>
                  <a:gd name="T41" fmla="*/ 787 h 1422"/>
                  <a:gd name="T42" fmla="*/ 29 w 29"/>
                  <a:gd name="T43" fmla="*/ 787 h 1422"/>
                  <a:gd name="T44" fmla="*/ 29 w 29"/>
                  <a:gd name="T45" fmla="*/ 793 h 1422"/>
                  <a:gd name="T46" fmla="*/ 0 w 29"/>
                  <a:gd name="T47" fmla="*/ 793 h 1422"/>
                  <a:gd name="T48" fmla="*/ 0 w 29"/>
                  <a:gd name="T49" fmla="*/ 787 h 1422"/>
                  <a:gd name="T50" fmla="*/ 0 w 29"/>
                  <a:gd name="T51" fmla="*/ 629 h 1422"/>
                  <a:gd name="T52" fmla="*/ 29 w 29"/>
                  <a:gd name="T53" fmla="*/ 629 h 1422"/>
                  <a:gd name="T54" fmla="*/ 29 w 29"/>
                  <a:gd name="T55" fmla="*/ 635 h 1422"/>
                  <a:gd name="T56" fmla="*/ 0 w 29"/>
                  <a:gd name="T57" fmla="*/ 635 h 1422"/>
                  <a:gd name="T58" fmla="*/ 0 w 29"/>
                  <a:gd name="T59" fmla="*/ 629 h 1422"/>
                  <a:gd name="T60" fmla="*/ 0 w 29"/>
                  <a:gd name="T61" fmla="*/ 472 h 1422"/>
                  <a:gd name="T62" fmla="*/ 29 w 29"/>
                  <a:gd name="T63" fmla="*/ 472 h 1422"/>
                  <a:gd name="T64" fmla="*/ 29 w 29"/>
                  <a:gd name="T65" fmla="*/ 478 h 1422"/>
                  <a:gd name="T66" fmla="*/ 0 w 29"/>
                  <a:gd name="T67" fmla="*/ 478 h 1422"/>
                  <a:gd name="T68" fmla="*/ 0 w 29"/>
                  <a:gd name="T69" fmla="*/ 472 h 1422"/>
                  <a:gd name="T70" fmla="*/ 0 w 29"/>
                  <a:gd name="T71" fmla="*/ 315 h 1422"/>
                  <a:gd name="T72" fmla="*/ 29 w 29"/>
                  <a:gd name="T73" fmla="*/ 315 h 1422"/>
                  <a:gd name="T74" fmla="*/ 29 w 29"/>
                  <a:gd name="T75" fmla="*/ 320 h 1422"/>
                  <a:gd name="T76" fmla="*/ 0 w 29"/>
                  <a:gd name="T77" fmla="*/ 320 h 1422"/>
                  <a:gd name="T78" fmla="*/ 0 w 29"/>
                  <a:gd name="T79" fmla="*/ 315 h 1422"/>
                  <a:gd name="T80" fmla="*/ 0 w 29"/>
                  <a:gd name="T81" fmla="*/ 157 h 1422"/>
                  <a:gd name="T82" fmla="*/ 29 w 29"/>
                  <a:gd name="T83" fmla="*/ 157 h 1422"/>
                  <a:gd name="T84" fmla="*/ 29 w 29"/>
                  <a:gd name="T85" fmla="*/ 163 h 1422"/>
                  <a:gd name="T86" fmla="*/ 0 w 29"/>
                  <a:gd name="T87" fmla="*/ 163 h 1422"/>
                  <a:gd name="T88" fmla="*/ 0 w 29"/>
                  <a:gd name="T89" fmla="*/ 157 h 1422"/>
                  <a:gd name="T90" fmla="*/ 0 w 29"/>
                  <a:gd name="T91" fmla="*/ 0 h 1422"/>
                  <a:gd name="T92" fmla="*/ 29 w 29"/>
                  <a:gd name="T93" fmla="*/ 0 h 1422"/>
                  <a:gd name="T94" fmla="*/ 29 w 29"/>
                  <a:gd name="T95" fmla="*/ 5 h 1422"/>
                  <a:gd name="T96" fmla="*/ 0 w 29"/>
                  <a:gd name="T97" fmla="*/ 5 h 1422"/>
                  <a:gd name="T98" fmla="*/ 0 w 29"/>
                  <a:gd name="T99" fmla="*/ 0 h 14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29" h="1422">
                    <a:moveTo>
                      <a:pt x="0" y="1417"/>
                    </a:moveTo>
                    <a:lnTo>
                      <a:pt x="29" y="1417"/>
                    </a:lnTo>
                    <a:lnTo>
                      <a:pt x="29" y="1422"/>
                    </a:lnTo>
                    <a:lnTo>
                      <a:pt x="0" y="1422"/>
                    </a:lnTo>
                    <a:lnTo>
                      <a:pt x="0" y="1417"/>
                    </a:lnTo>
                    <a:close/>
                    <a:moveTo>
                      <a:pt x="0" y="1259"/>
                    </a:moveTo>
                    <a:lnTo>
                      <a:pt x="29" y="1259"/>
                    </a:lnTo>
                    <a:lnTo>
                      <a:pt x="29" y="1265"/>
                    </a:lnTo>
                    <a:lnTo>
                      <a:pt x="0" y="1265"/>
                    </a:lnTo>
                    <a:lnTo>
                      <a:pt x="0" y="1259"/>
                    </a:lnTo>
                    <a:close/>
                    <a:moveTo>
                      <a:pt x="0" y="1102"/>
                    </a:moveTo>
                    <a:lnTo>
                      <a:pt x="29" y="1102"/>
                    </a:lnTo>
                    <a:lnTo>
                      <a:pt x="29" y="1108"/>
                    </a:lnTo>
                    <a:lnTo>
                      <a:pt x="0" y="1108"/>
                    </a:lnTo>
                    <a:lnTo>
                      <a:pt x="0" y="1102"/>
                    </a:lnTo>
                    <a:close/>
                    <a:moveTo>
                      <a:pt x="0" y="944"/>
                    </a:moveTo>
                    <a:lnTo>
                      <a:pt x="29" y="944"/>
                    </a:lnTo>
                    <a:lnTo>
                      <a:pt x="29" y="950"/>
                    </a:lnTo>
                    <a:lnTo>
                      <a:pt x="0" y="950"/>
                    </a:lnTo>
                    <a:lnTo>
                      <a:pt x="0" y="944"/>
                    </a:lnTo>
                    <a:close/>
                    <a:moveTo>
                      <a:pt x="0" y="787"/>
                    </a:moveTo>
                    <a:lnTo>
                      <a:pt x="29" y="787"/>
                    </a:lnTo>
                    <a:lnTo>
                      <a:pt x="29" y="793"/>
                    </a:lnTo>
                    <a:lnTo>
                      <a:pt x="0" y="793"/>
                    </a:lnTo>
                    <a:lnTo>
                      <a:pt x="0" y="787"/>
                    </a:lnTo>
                    <a:close/>
                    <a:moveTo>
                      <a:pt x="0" y="629"/>
                    </a:moveTo>
                    <a:lnTo>
                      <a:pt x="29" y="629"/>
                    </a:lnTo>
                    <a:lnTo>
                      <a:pt x="29" y="635"/>
                    </a:lnTo>
                    <a:lnTo>
                      <a:pt x="0" y="635"/>
                    </a:lnTo>
                    <a:lnTo>
                      <a:pt x="0" y="629"/>
                    </a:lnTo>
                    <a:close/>
                    <a:moveTo>
                      <a:pt x="0" y="472"/>
                    </a:moveTo>
                    <a:lnTo>
                      <a:pt x="29" y="472"/>
                    </a:lnTo>
                    <a:lnTo>
                      <a:pt x="29" y="478"/>
                    </a:lnTo>
                    <a:lnTo>
                      <a:pt x="0" y="478"/>
                    </a:lnTo>
                    <a:lnTo>
                      <a:pt x="0" y="472"/>
                    </a:lnTo>
                    <a:close/>
                    <a:moveTo>
                      <a:pt x="0" y="315"/>
                    </a:moveTo>
                    <a:lnTo>
                      <a:pt x="29" y="315"/>
                    </a:lnTo>
                    <a:lnTo>
                      <a:pt x="29" y="320"/>
                    </a:lnTo>
                    <a:lnTo>
                      <a:pt x="0" y="320"/>
                    </a:lnTo>
                    <a:lnTo>
                      <a:pt x="0" y="315"/>
                    </a:lnTo>
                    <a:close/>
                    <a:moveTo>
                      <a:pt x="0" y="157"/>
                    </a:moveTo>
                    <a:lnTo>
                      <a:pt x="29" y="157"/>
                    </a:lnTo>
                    <a:lnTo>
                      <a:pt x="29" y="163"/>
                    </a:lnTo>
                    <a:lnTo>
                      <a:pt x="0" y="163"/>
                    </a:lnTo>
                    <a:lnTo>
                      <a:pt x="0" y="157"/>
                    </a:lnTo>
                    <a:close/>
                    <a:moveTo>
                      <a:pt x="0" y="0"/>
                    </a:moveTo>
                    <a:lnTo>
                      <a:pt x="29" y="0"/>
                    </a:lnTo>
                    <a:lnTo>
                      <a:pt x="29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4" name="Rectangle 43"/>
              <p:cNvSpPr>
                <a:spLocks noChangeArrowheads="1"/>
              </p:cNvSpPr>
              <p:nvPr/>
            </p:nvSpPr>
            <p:spPr bwMode="auto">
              <a:xfrm>
                <a:off x="2466975" y="4391025"/>
                <a:ext cx="4827588" cy="7937"/>
              </a:xfrm>
              <a:prstGeom prst="rect">
                <a:avLst/>
              </a:prstGeom>
              <a:solidFill>
                <a:srgbClr val="868686"/>
              </a:solidFill>
              <a:ln w="1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5" name="Rectangle 44"/>
              <p:cNvSpPr>
                <a:spLocks noChangeArrowheads="1"/>
              </p:cNvSpPr>
              <p:nvPr/>
            </p:nvSpPr>
            <p:spPr bwMode="auto">
              <a:xfrm>
                <a:off x="2189589" y="4306888"/>
                <a:ext cx="131189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0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36" name="Rectangle 45"/>
              <p:cNvSpPr>
                <a:spLocks noChangeArrowheads="1"/>
              </p:cNvSpPr>
              <p:nvPr/>
            </p:nvSpPr>
            <p:spPr bwMode="auto">
              <a:xfrm>
                <a:off x="2080752" y="4057650"/>
                <a:ext cx="262374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20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37" name="Rectangle 46"/>
              <p:cNvSpPr>
                <a:spLocks noChangeArrowheads="1"/>
              </p:cNvSpPr>
              <p:nvPr/>
            </p:nvSpPr>
            <p:spPr bwMode="auto">
              <a:xfrm>
                <a:off x="2080752" y="3806825"/>
                <a:ext cx="262374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40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38" name="Rectangle 47"/>
              <p:cNvSpPr>
                <a:spLocks noChangeArrowheads="1"/>
              </p:cNvSpPr>
              <p:nvPr/>
            </p:nvSpPr>
            <p:spPr bwMode="auto">
              <a:xfrm>
                <a:off x="2080752" y="3557588"/>
                <a:ext cx="262374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60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39" name="Rectangle 48"/>
              <p:cNvSpPr>
                <a:spLocks noChangeArrowheads="1"/>
              </p:cNvSpPr>
              <p:nvPr/>
            </p:nvSpPr>
            <p:spPr bwMode="auto">
              <a:xfrm>
                <a:off x="2080752" y="3306763"/>
                <a:ext cx="262374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80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40" name="Rectangle 49"/>
              <p:cNvSpPr>
                <a:spLocks noChangeArrowheads="1"/>
              </p:cNvSpPr>
              <p:nvPr/>
            </p:nvSpPr>
            <p:spPr bwMode="auto">
              <a:xfrm>
                <a:off x="1973499" y="3057525"/>
                <a:ext cx="393563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100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41" name="Rectangle 50"/>
              <p:cNvSpPr>
                <a:spLocks noChangeArrowheads="1"/>
              </p:cNvSpPr>
              <p:nvPr/>
            </p:nvSpPr>
            <p:spPr bwMode="auto">
              <a:xfrm>
                <a:off x="1973499" y="2808288"/>
                <a:ext cx="393563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120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42" name="Rectangle 51"/>
              <p:cNvSpPr>
                <a:spLocks noChangeArrowheads="1"/>
              </p:cNvSpPr>
              <p:nvPr/>
            </p:nvSpPr>
            <p:spPr bwMode="auto">
              <a:xfrm>
                <a:off x="1973499" y="2557463"/>
                <a:ext cx="393563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140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43" name="Rectangle 52"/>
              <p:cNvSpPr>
                <a:spLocks noChangeArrowheads="1"/>
              </p:cNvSpPr>
              <p:nvPr/>
            </p:nvSpPr>
            <p:spPr bwMode="auto">
              <a:xfrm>
                <a:off x="1973499" y="2308225"/>
                <a:ext cx="393563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160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44" name="Rectangle 53"/>
              <p:cNvSpPr>
                <a:spLocks noChangeArrowheads="1"/>
              </p:cNvSpPr>
              <p:nvPr/>
            </p:nvSpPr>
            <p:spPr bwMode="auto">
              <a:xfrm>
                <a:off x="1973499" y="2057400"/>
                <a:ext cx="393563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180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45" name="Rectangle 54"/>
              <p:cNvSpPr>
                <a:spLocks noChangeArrowheads="1"/>
              </p:cNvSpPr>
              <p:nvPr/>
            </p:nvSpPr>
            <p:spPr bwMode="auto">
              <a:xfrm>
                <a:off x="2439204" y="4489450"/>
                <a:ext cx="499999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Cont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46" name="Rectangle 55"/>
              <p:cNvSpPr>
                <a:spLocks noChangeArrowheads="1"/>
              </p:cNvSpPr>
              <p:nvPr/>
            </p:nvSpPr>
            <p:spPr bwMode="auto">
              <a:xfrm>
                <a:off x="2975744" y="4489450"/>
                <a:ext cx="301980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C1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47" name="Rectangle 56"/>
              <p:cNvSpPr>
                <a:spLocks noChangeArrowheads="1"/>
              </p:cNvSpPr>
              <p:nvPr/>
            </p:nvSpPr>
            <p:spPr bwMode="auto">
              <a:xfrm>
                <a:off x="3413893" y="4489450"/>
                <a:ext cx="301980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C2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48" name="Rectangle 57"/>
              <p:cNvSpPr>
                <a:spLocks noChangeArrowheads="1"/>
              </p:cNvSpPr>
              <p:nvPr/>
            </p:nvSpPr>
            <p:spPr bwMode="auto">
              <a:xfrm>
                <a:off x="3853632" y="4489450"/>
                <a:ext cx="301980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C3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49" name="Rectangle 58"/>
              <p:cNvSpPr>
                <a:spLocks noChangeArrowheads="1"/>
              </p:cNvSpPr>
              <p:nvPr/>
            </p:nvSpPr>
            <p:spPr bwMode="auto">
              <a:xfrm>
                <a:off x="4291781" y="4489450"/>
                <a:ext cx="301980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C4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50" name="Rectangle 59"/>
              <p:cNvSpPr>
                <a:spLocks noChangeArrowheads="1"/>
              </p:cNvSpPr>
              <p:nvPr/>
            </p:nvSpPr>
            <p:spPr bwMode="auto">
              <a:xfrm>
                <a:off x="4731520" y="4489450"/>
                <a:ext cx="301980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C5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51" name="Rectangle 60"/>
              <p:cNvSpPr>
                <a:spLocks noChangeArrowheads="1"/>
              </p:cNvSpPr>
              <p:nvPr/>
            </p:nvSpPr>
            <p:spPr bwMode="auto">
              <a:xfrm>
                <a:off x="5169669" y="4489450"/>
                <a:ext cx="301980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C6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52" name="Rectangle 61"/>
              <p:cNvSpPr>
                <a:spLocks noChangeArrowheads="1"/>
              </p:cNvSpPr>
              <p:nvPr/>
            </p:nvSpPr>
            <p:spPr bwMode="auto">
              <a:xfrm>
                <a:off x="5609408" y="4489450"/>
                <a:ext cx="301980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C7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53" name="Rectangle 62"/>
              <p:cNvSpPr>
                <a:spLocks noChangeArrowheads="1"/>
              </p:cNvSpPr>
              <p:nvPr/>
            </p:nvSpPr>
            <p:spPr bwMode="auto">
              <a:xfrm>
                <a:off x="6047557" y="4489450"/>
                <a:ext cx="301980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C8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54" name="Rectangle 63"/>
              <p:cNvSpPr>
                <a:spLocks noChangeArrowheads="1"/>
              </p:cNvSpPr>
              <p:nvPr/>
            </p:nvSpPr>
            <p:spPr bwMode="auto">
              <a:xfrm>
                <a:off x="6487294" y="4489450"/>
                <a:ext cx="301980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C9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55" name="Rectangle 64"/>
              <p:cNvSpPr>
                <a:spLocks noChangeArrowheads="1"/>
              </p:cNvSpPr>
              <p:nvPr/>
            </p:nvSpPr>
            <p:spPr bwMode="auto">
              <a:xfrm>
                <a:off x="6834203" y="4489450"/>
                <a:ext cx="673266" cy="2538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GCSE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  <p:sp>
            <p:nvSpPr>
              <p:cNvPr id="1056" name="Rectangle 65"/>
              <p:cNvSpPr>
                <a:spLocks noChangeArrowheads="1"/>
              </p:cNvSpPr>
              <p:nvPr/>
            </p:nvSpPr>
            <p:spPr bwMode="auto">
              <a:xfrm rot="16200000">
                <a:off x="1240164" y="3083892"/>
                <a:ext cx="1033481" cy="2851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rPr>
                  <a:t>IgE (ng/ml)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굴림" pitchFamily="50" charset="-127"/>
                  <a:cs typeface="Arial" pitchFamily="34" charset="0"/>
                </a:endParaRPr>
              </a:p>
            </p:txBody>
          </p:sp>
        </p:grpSp>
        <p:cxnSp>
          <p:nvCxnSpPr>
            <p:cNvPr id="67" name="꺾인 연결선 66"/>
            <p:cNvCxnSpPr/>
            <p:nvPr/>
          </p:nvCxnSpPr>
          <p:spPr>
            <a:xfrm rot="5400000" flipH="1">
              <a:off x="2971376" y="3058162"/>
              <a:ext cx="1260000" cy="288000"/>
            </a:xfrm>
            <a:prstGeom prst="bentConnector3">
              <a:avLst>
                <a:gd name="adj1" fmla="val 103162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꺾인 연결선 67"/>
            <p:cNvCxnSpPr/>
            <p:nvPr/>
          </p:nvCxnSpPr>
          <p:spPr>
            <a:xfrm rot="5400000" flipH="1">
              <a:off x="4255002" y="1771544"/>
              <a:ext cx="1260000" cy="2844000"/>
            </a:xfrm>
            <a:prstGeom prst="bentConnector3">
              <a:avLst>
                <a:gd name="adj1" fmla="val 114801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꺾인 연결선 70"/>
            <p:cNvCxnSpPr/>
            <p:nvPr/>
          </p:nvCxnSpPr>
          <p:spPr>
            <a:xfrm rot="5400000" flipH="1">
              <a:off x="3564032" y="2503034"/>
              <a:ext cx="1188000" cy="1404000"/>
            </a:xfrm>
            <a:prstGeom prst="bentConnector3">
              <a:avLst>
                <a:gd name="adj1" fmla="val 114801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꺾인 연결선 71"/>
            <p:cNvCxnSpPr/>
            <p:nvPr/>
          </p:nvCxnSpPr>
          <p:spPr>
            <a:xfrm rot="5400000" flipH="1">
              <a:off x="4201002" y="1801026"/>
              <a:ext cx="1080000" cy="2556000"/>
            </a:xfrm>
            <a:prstGeom prst="bentConnector3">
              <a:avLst>
                <a:gd name="adj1" fmla="val 114801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꺾인 연결선 72"/>
            <p:cNvCxnSpPr/>
            <p:nvPr/>
          </p:nvCxnSpPr>
          <p:spPr>
            <a:xfrm rot="5400000" flipH="1">
              <a:off x="3439376" y="2629034"/>
              <a:ext cx="1188000" cy="1152000"/>
            </a:xfrm>
            <a:prstGeom prst="bentConnector3">
              <a:avLst>
                <a:gd name="adj1" fmla="val 114801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꺾인 연결선 73"/>
            <p:cNvCxnSpPr/>
            <p:nvPr/>
          </p:nvCxnSpPr>
          <p:spPr>
            <a:xfrm rot="5400000" flipH="1">
              <a:off x="3708064" y="2357666"/>
              <a:ext cx="1188000" cy="1692000"/>
            </a:xfrm>
            <a:prstGeom prst="bentConnector3">
              <a:avLst>
                <a:gd name="adj1" fmla="val 114801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1" name="TextBox 1060"/>
            <p:cNvSpPr txBox="1"/>
            <p:nvPr/>
          </p:nvSpPr>
          <p:spPr>
            <a:xfrm>
              <a:off x="3577672" y="3779821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itchFamily="34" charset="0"/>
                  <a:cs typeface="Arial" pitchFamily="34" charset="0"/>
                </a:rPr>
                <a:t>***</a:t>
              </a:r>
              <a:endParaRPr lang="ko-KR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4416798" y="3797666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itchFamily="34" charset="0"/>
                  <a:cs typeface="Arial" pitchFamily="34" charset="0"/>
                </a:rPr>
                <a:t>***</a:t>
              </a:r>
              <a:endParaRPr lang="ko-KR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4693204" y="3789040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itchFamily="34" charset="0"/>
                  <a:cs typeface="Arial" pitchFamily="34" charset="0"/>
                </a:rPr>
                <a:t>***</a:t>
              </a:r>
              <a:endParaRPr lang="ko-KR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4969544" y="3780414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itchFamily="34" charset="0"/>
                  <a:cs typeface="Arial" pitchFamily="34" charset="0"/>
                </a:rPr>
                <a:t>***</a:t>
              </a:r>
              <a:endParaRPr lang="ko-KR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5831080" y="3607520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itchFamily="34" charset="0"/>
                  <a:cs typeface="Arial" pitchFamily="34" charset="0"/>
                </a:rPr>
                <a:t>***</a:t>
              </a:r>
              <a:endParaRPr lang="ko-KR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6119112" y="3852422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itchFamily="34" charset="0"/>
                  <a:cs typeface="Arial" pitchFamily="34" charset="0"/>
                </a:rPr>
                <a:t>***</a:t>
              </a:r>
              <a:endParaRPr lang="ko-KR" alt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82" name="TextBox 81"/>
          <p:cNvSpPr txBox="1"/>
          <p:nvPr/>
        </p:nvSpPr>
        <p:spPr>
          <a:xfrm>
            <a:off x="179512" y="188640"/>
            <a:ext cx="18722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Supplement Fig 1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7812360" y="260648"/>
            <a:ext cx="10374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Hwang et al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699793" y="3302982"/>
            <a:ext cx="4392488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ment </a:t>
            </a:r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Figure 1. Effect of GCSE and its 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components </a:t>
            </a:r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on IgE production.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Draining lymph node CD19+ B cells isolated from AD-induced mice were stimulated with LPS (10 </a:t>
            </a:r>
            <a:r>
              <a:rPr lang="en-US" altLang="ko-KR" sz="1200" dirty="0">
                <a:latin typeface="Symbol"/>
                <a:ea typeface="바탕"/>
                <a:cs typeface="Arial"/>
              </a:rPr>
              <a:t>m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g/ml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)/IL-4 (5 </a:t>
            </a:r>
            <a:r>
              <a:rPr lang="en-US" altLang="ko-KR" sz="1200" dirty="0" err="1">
                <a:latin typeface="Arial" pitchFamily="34" charset="0"/>
                <a:cs typeface="Arial" pitchFamily="34" charset="0"/>
              </a:rPr>
              <a:t>ng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/ml) in the presence of each individual component (0.25 mg/ml) of GCSE or a mixture of them (GCSE) for 72 hrs. C1 (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Angelicae Gigantis Radix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), C2 (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Astragali Radix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), C3 (</a:t>
            </a:r>
            <a:r>
              <a:rPr lang="en-US" altLang="ko-KR" sz="1200" i="1" dirty="0" err="1">
                <a:latin typeface="Arial" pitchFamily="34" charset="0"/>
                <a:cs typeface="Arial" pitchFamily="34" charset="0"/>
              </a:rPr>
              <a:t>Atractylodis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1200" i="1" dirty="0" err="1">
                <a:latin typeface="Arial" pitchFamily="34" charset="0"/>
                <a:cs typeface="Arial" pitchFamily="34" charset="0"/>
              </a:rPr>
              <a:t>Rhizoma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 Alba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), C4 (</a:t>
            </a:r>
            <a:r>
              <a:rPr lang="en-US" altLang="ko-KR" sz="1200" i="1" dirty="0" err="1">
                <a:latin typeface="Arial" pitchFamily="34" charset="0"/>
                <a:cs typeface="Arial" pitchFamily="34" charset="0"/>
              </a:rPr>
              <a:t>Coptidis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1200" i="1" dirty="0" err="1">
                <a:latin typeface="Arial" pitchFamily="34" charset="0"/>
                <a:cs typeface="Arial" pitchFamily="34" charset="0"/>
              </a:rPr>
              <a:t>Rhizoma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), C5 (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Forsythiae Fructus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), C6 (</a:t>
            </a:r>
            <a:r>
              <a:rPr lang="en-US" altLang="ko-KR" sz="1200" i="1" dirty="0" err="1">
                <a:latin typeface="Arial" pitchFamily="34" charset="0"/>
                <a:cs typeface="Arial" pitchFamily="34" charset="0"/>
              </a:rPr>
              <a:t>Glycyrrhizae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 Radix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), C7 (</a:t>
            </a:r>
            <a:r>
              <a:rPr lang="en-US" altLang="ko-KR" sz="1200" i="1" dirty="0" err="1">
                <a:latin typeface="Arial" pitchFamily="34" charset="0"/>
                <a:cs typeface="Arial" pitchFamily="34" charset="0"/>
              </a:rPr>
              <a:t>Lonicerae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1200" i="1" dirty="0" err="1">
                <a:latin typeface="Arial" pitchFamily="34" charset="0"/>
                <a:cs typeface="Arial" pitchFamily="34" charset="0"/>
              </a:rPr>
              <a:t>Flos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), C8 (</a:t>
            </a:r>
            <a:r>
              <a:rPr lang="en-US" altLang="ko-KR" sz="1200" i="1" dirty="0" err="1">
                <a:latin typeface="Arial" pitchFamily="34" charset="0"/>
                <a:cs typeface="Arial" pitchFamily="34" charset="0"/>
              </a:rPr>
              <a:t>Portulacae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1200" i="1" dirty="0" err="1">
                <a:latin typeface="Arial" pitchFamily="34" charset="0"/>
                <a:cs typeface="Arial" pitchFamily="34" charset="0"/>
              </a:rPr>
              <a:t>Herba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), C9 (</a:t>
            </a:r>
            <a:r>
              <a:rPr lang="en-US" altLang="ko-KR" sz="1200" i="1" dirty="0" err="1">
                <a:latin typeface="Arial" pitchFamily="34" charset="0"/>
                <a:cs typeface="Arial" pitchFamily="34" charset="0"/>
              </a:rPr>
              <a:t>Scutellariae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 Radix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), GCSE (1:1 mass ratio of each component). Mouse IgE levels in the culture supernatant of B cells were measured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using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ELISA. Same volume of 70% alcohol was treated as a control. Error bars indicate SD. One (*), two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(**),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and three (***) indicate p&lt;0.05,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p&lt;0.01,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and p&lt;0.001 respectively. Data are representative of three independent experiments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14017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999033" y="188640"/>
            <a:ext cx="10374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Hwang et al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5496" y="44624"/>
            <a:ext cx="18722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Supplement Fig 2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13" name="그룹 212"/>
          <p:cNvGrpSpPr/>
          <p:nvPr/>
        </p:nvGrpSpPr>
        <p:grpSpPr>
          <a:xfrm>
            <a:off x="748060" y="684726"/>
            <a:ext cx="7712372" cy="4406836"/>
            <a:chOff x="667426" y="1115284"/>
            <a:chExt cx="7712372" cy="4406836"/>
          </a:xfrm>
        </p:grpSpPr>
        <p:grpSp>
          <p:nvGrpSpPr>
            <p:cNvPr id="261" name="그룹 260"/>
            <p:cNvGrpSpPr/>
            <p:nvPr/>
          </p:nvGrpSpPr>
          <p:grpSpPr>
            <a:xfrm>
              <a:off x="667426" y="1153200"/>
              <a:ext cx="3563183" cy="1861730"/>
              <a:chOff x="1322728" y="1579863"/>
              <a:chExt cx="3563183" cy="1861730"/>
            </a:xfrm>
          </p:grpSpPr>
          <p:grpSp>
            <p:nvGrpSpPr>
              <p:cNvPr id="262" name="그룹 261"/>
              <p:cNvGrpSpPr/>
              <p:nvPr/>
            </p:nvGrpSpPr>
            <p:grpSpPr>
              <a:xfrm>
                <a:off x="1322728" y="1579863"/>
                <a:ext cx="3563183" cy="1861730"/>
                <a:chOff x="1636436" y="2135664"/>
                <a:chExt cx="5817650" cy="2746904"/>
              </a:xfrm>
            </p:grpSpPr>
            <p:sp>
              <p:nvSpPr>
                <p:cNvPr id="279" name="Rectangle 8"/>
                <p:cNvSpPr>
                  <a:spLocks noChangeArrowheads="1"/>
                </p:cNvSpPr>
                <p:nvPr/>
              </p:nvSpPr>
              <p:spPr bwMode="auto">
                <a:xfrm>
                  <a:off x="2609850" y="3265488"/>
                  <a:ext cx="174625" cy="12509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80" name="Freeform 9"/>
                <p:cNvSpPr>
                  <a:spLocks noEditPoints="1"/>
                </p:cNvSpPr>
                <p:nvPr/>
              </p:nvSpPr>
              <p:spPr bwMode="auto">
                <a:xfrm>
                  <a:off x="2605088" y="3260725"/>
                  <a:ext cx="184150" cy="1258887"/>
                </a:xfrm>
                <a:custGeom>
                  <a:avLst/>
                  <a:gdLst>
                    <a:gd name="T0" fmla="*/ 0 w 1920"/>
                    <a:gd name="T1" fmla="*/ 48 h 13216"/>
                    <a:gd name="T2" fmla="*/ 48 w 1920"/>
                    <a:gd name="T3" fmla="*/ 0 h 13216"/>
                    <a:gd name="T4" fmla="*/ 1872 w 1920"/>
                    <a:gd name="T5" fmla="*/ 0 h 13216"/>
                    <a:gd name="T6" fmla="*/ 1920 w 1920"/>
                    <a:gd name="T7" fmla="*/ 48 h 13216"/>
                    <a:gd name="T8" fmla="*/ 1920 w 1920"/>
                    <a:gd name="T9" fmla="*/ 13168 h 13216"/>
                    <a:gd name="T10" fmla="*/ 1872 w 1920"/>
                    <a:gd name="T11" fmla="*/ 13216 h 13216"/>
                    <a:gd name="T12" fmla="*/ 48 w 1920"/>
                    <a:gd name="T13" fmla="*/ 13216 h 13216"/>
                    <a:gd name="T14" fmla="*/ 0 w 1920"/>
                    <a:gd name="T15" fmla="*/ 13168 h 13216"/>
                    <a:gd name="T16" fmla="*/ 0 w 1920"/>
                    <a:gd name="T17" fmla="*/ 48 h 13216"/>
                    <a:gd name="T18" fmla="*/ 96 w 1920"/>
                    <a:gd name="T19" fmla="*/ 13168 h 13216"/>
                    <a:gd name="T20" fmla="*/ 48 w 1920"/>
                    <a:gd name="T21" fmla="*/ 13120 h 13216"/>
                    <a:gd name="T22" fmla="*/ 1872 w 1920"/>
                    <a:gd name="T23" fmla="*/ 13120 h 13216"/>
                    <a:gd name="T24" fmla="*/ 1824 w 1920"/>
                    <a:gd name="T25" fmla="*/ 13168 h 13216"/>
                    <a:gd name="T26" fmla="*/ 1824 w 1920"/>
                    <a:gd name="T27" fmla="*/ 48 h 13216"/>
                    <a:gd name="T28" fmla="*/ 1872 w 1920"/>
                    <a:gd name="T29" fmla="*/ 96 h 13216"/>
                    <a:gd name="T30" fmla="*/ 48 w 1920"/>
                    <a:gd name="T31" fmla="*/ 96 h 13216"/>
                    <a:gd name="T32" fmla="*/ 96 w 1920"/>
                    <a:gd name="T33" fmla="*/ 48 h 13216"/>
                    <a:gd name="T34" fmla="*/ 96 w 1920"/>
                    <a:gd name="T35" fmla="*/ 13168 h 1321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920" h="13216">
                      <a:moveTo>
                        <a:pt x="0" y="48"/>
                      </a:moveTo>
                      <a:cubicBezTo>
                        <a:pt x="0" y="22"/>
                        <a:pt x="22" y="0"/>
                        <a:pt x="48" y="0"/>
                      </a:cubicBezTo>
                      <a:lnTo>
                        <a:pt x="1872" y="0"/>
                      </a:lnTo>
                      <a:cubicBezTo>
                        <a:pt x="1899" y="0"/>
                        <a:pt x="1920" y="22"/>
                        <a:pt x="1920" y="48"/>
                      </a:cubicBezTo>
                      <a:lnTo>
                        <a:pt x="1920" y="13168"/>
                      </a:lnTo>
                      <a:cubicBezTo>
                        <a:pt x="1920" y="13195"/>
                        <a:pt x="1899" y="13216"/>
                        <a:pt x="1872" y="13216"/>
                      </a:cubicBezTo>
                      <a:lnTo>
                        <a:pt x="48" y="13216"/>
                      </a:lnTo>
                      <a:cubicBezTo>
                        <a:pt x="22" y="13216"/>
                        <a:pt x="0" y="13195"/>
                        <a:pt x="0" y="13168"/>
                      </a:cubicBezTo>
                      <a:lnTo>
                        <a:pt x="0" y="48"/>
                      </a:lnTo>
                      <a:close/>
                      <a:moveTo>
                        <a:pt x="96" y="13168"/>
                      </a:moveTo>
                      <a:lnTo>
                        <a:pt x="48" y="13120"/>
                      </a:lnTo>
                      <a:lnTo>
                        <a:pt x="1872" y="13120"/>
                      </a:lnTo>
                      <a:lnTo>
                        <a:pt x="1824" y="13168"/>
                      </a:lnTo>
                      <a:lnTo>
                        <a:pt x="1824" y="48"/>
                      </a:lnTo>
                      <a:lnTo>
                        <a:pt x="1872" y="96"/>
                      </a:lnTo>
                      <a:lnTo>
                        <a:pt x="48" y="96"/>
                      </a:lnTo>
                      <a:lnTo>
                        <a:pt x="96" y="48"/>
                      </a:lnTo>
                      <a:lnTo>
                        <a:pt x="96" y="13168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81" name="Rectangle 10"/>
                <p:cNvSpPr>
                  <a:spLocks noChangeArrowheads="1"/>
                </p:cNvSpPr>
                <p:nvPr/>
              </p:nvSpPr>
              <p:spPr bwMode="auto">
                <a:xfrm>
                  <a:off x="3043238" y="4360863"/>
                  <a:ext cx="173038" cy="155575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82" name="Freeform 11"/>
                <p:cNvSpPr>
                  <a:spLocks noEditPoints="1"/>
                </p:cNvSpPr>
                <p:nvPr/>
              </p:nvSpPr>
              <p:spPr bwMode="auto">
                <a:xfrm>
                  <a:off x="3038475" y="4356100"/>
                  <a:ext cx="182563" cy="163512"/>
                </a:xfrm>
                <a:custGeom>
                  <a:avLst/>
                  <a:gdLst>
                    <a:gd name="T0" fmla="*/ 0 w 1920"/>
                    <a:gd name="T1" fmla="*/ 48 h 1728"/>
                    <a:gd name="T2" fmla="*/ 48 w 1920"/>
                    <a:gd name="T3" fmla="*/ 0 h 1728"/>
                    <a:gd name="T4" fmla="*/ 1872 w 1920"/>
                    <a:gd name="T5" fmla="*/ 0 h 1728"/>
                    <a:gd name="T6" fmla="*/ 1920 w 1920"/>
                    <a:gd name="T7" fmla="*/ 48 h 1728"/>
                    <a:gd name="T8" fmla="*/ 1920 w 1920"/>
                    <a:gd name="T9" fmla="*/ 1680 h 1728"/>
                    <a:gd name="T10" fmla="*/ 1872 w 1920"/>
                    <a:gd name="T11" fmla="*/ 1728 h 1728"/>
                    <a:gd name="T12" fmla="*/ 48 w 1920"/>
                    <a:gd name="T13" fmla="*/ 1728 h 1728"/>
                    <a:gd name="T14" fmla="*/ 0 w 1920"/>
                    <a:gd name="T15" fmla="*/ 1680 h 1728"/>
                    <a:gd name="T16" fmla="*/ 0 w 1920"/>
                    <a:gd name="T17" fmla="*/ 48 h 1728"/>
                    <a:gd name="T18" fmla="*/ 96 w 1920"/>
                    <a:gd name="T19" fmla="*/ 1680 h 1728"/>
                    <a:gd name="T20" fmla="*/ 48 w 1920"/>
                    <a:gd name="T21" fmla="*/ 1632 h 1728"/>
                    <a:gd name="T22" fmla="*/ 1872 w 1920"/>
                    <a:gd name="T23" fmla="*/ 1632 h 1728"/>
                    <a:gd name="T24" fmla="*/ 1824 w 1920"/>
                    <a:gd name="T25" fmla="*/ 1680 h 1728"/>
                    <a:gd name="T26" fmla="*/ 1824 w 1920"/>
                    <a:gd name="T27" fmla="*/ 48 h 1728"/>
                    <a:gd name="T28" fmla="*/ 1872 w 1920"/>
                    <a:gd name="T29" fmla="*/ 96 h 1728"/>
                    <a:gd name="T30" fmla="*/ 48 w 1920"/>
                    <a:gd name="T31" fmla="*/ 96 h 1728"/>
                    <a:gd name="T32" fmla="*/ 96 w 1920"/>
                    <a:gd name="T33" fmla="*/ 48 h 1728"/>
                    <a:gd name="T34" fmla="*/ 96 w 1920"/>
                    <a:gd name="T35" fmla="*/ 1680 h 17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920" h="1728">
                      <a:moveTo>
                        <a:pt x="0" y="48"/>
                      </a:moveTo>
                      <a:cubicBezTo>
                        <a:pt x="0" y="22"/>
                        <a:pt x="22" y="0"/>
                        <a:pt x="48" y="0"/>
                      </a:cubicBezTo>
                      <a:lnTo>
                        <a:pt x="1872" y="0"/>
                      </a:lnTo>
                      <a:cubicBezTo>
                        <a:pt x="1899" y="0"/>
                        <a:pt x="1920" y="22"/>
                        <a:pt x="1920" y="48"/>
                      </a:cubicBezTo>
                      <a:lnTo>
                        <a:pt x="1920" y="1680"/>
                      </a:lnTo>
                      <a:cubicBezTo>
                        <a:pt x="1920" y="1707"/>
                        <a:pt x="1899" y="1728"/>
                        <a:pt x="1872" y="1728"/>
                      </a:cubicBezTo>
                      <a:lnTo>
                        <a:pt x="48" y="1728"/>
                      </a:lnTo>
                      <a:cubicBezTo>
                        <a:pt x="22" y="1728"/>
                        <a:pt x="0" y="1707"/>
                        <a:pt x="0" y="1680"/>
                      </a:cubicBezTo>
                      <a:lnTo>
                        <a:pt x="0" y="48"/>
                      </a:lnTo>
                      <a:close/>
                      <a:moveTo>
                        <a:pt x="96" y="1680"/>
                      </a:moveTo>
                      <a:lnTo>
                        <a:pt x="48" y="1632"/>
                      </a:lnTo>
                      <a:lnTo>
                        <a:pt x="1872" y="1632"/>
                      </a:lnTo>
                      <a:lnTo>
                        <a:pt x="1824" y="1680"/>
                      </a:lnTo>
                      <a:lnTo>
                        <a:pt x="1824" y="48"/>
                      </a:lnTo>
                      <a:lnTo>
                        <a:pt x="1872" y="96"/>
                      </a:lnTo>
                      <a:lnTo>
                        <a:pt x="48" y="96"/>
                      </a:lnTo>
                      <a:lnTo>
                        <a:pt x="96" y="48"/>
                      </a:lnTo>
                      <a:lnTo>
                        <a:pt x="96" y="168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83" name="Rectangle 12"/>
                <p:cNvSpPr>
                  <a:spLocks noChangeArrowheads="1"/>
                </p:cNvSpPr>
                <p:nvPr/>
              </p:nvSpPr>
              <p:spPr bwMode="auto">
                <a:xfrm>
                  <a:off x="3476625" y="3236913"/>
                  <a:ext cx="171450" cy="1279525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84" name="Freeform 13"/>
                <p:cNvSpPr>
                  <a:spLocks noEditPoints="1"/>
                </p:cNvSpPr>
                <p:nvPr/>
              </p:nvSpPr>
              <p:spPr bwMode="auto">
                <a:xfrm>
                  <a:off x="3471863" y="3232150"/>
                  <a:ext cx="180975" cy="1287462"/>
                </a:xfrm>
                <a:custGeom>
                  <a:avLst/>
                  <a:gdLst>
                    <a:gd name="T0" fmla="*/ 0 w 1904"/>
                    <a:gd name="T1" fmla="*/ 48 h 13520"/>
                    <a:gd name="T2" fmla="*/ 48 w 1904"/>
                    <a:gd name="T3" fmla="*/ 0 h 13520"/>
                    <a:gd name="T4" fmla="*/ 1856 w 1904"/>
                    <a:gd name="T5" fmla="*/ 0 h 13520"/>
                    <a:gd name="T6" fmla="*/ 1904 w 1904"/>
                    <a:gd name="T7" fmla="*/ 48 h 13520"/>
                    <a:gd name="T8" fmla="*/ 1904 w 1904"/>
                    <a:gd name="T9" fmla="*/ 13472 h 13520"/>
                    <a:gd name="T10" fmla="*/ 1856 w 1904"/>
                    <a:gd name="T11" fmla="*/ 13520 h 13520"/>
                    <a:gd name="T12" fmla="*/ 48 w 1904"/>
                    <a:gd name="T13" fmla="*/ 13520 h 13520"/>
                    <a:gd name="T14" fmla="*/ 0 w 1904"/>
                    <a:gd name="T15" fmla="*/ 13472 h 13520"/>
                    <a:gd name="T16" fmla="*/ 0 w 1904"/>
                    <a:gd name="T17" fmla="*/ 48 h 13520"/>
                    <a:gd name="T18" fmla="*/ 96 w 1904"/>
                    <a:gd name="T19" fmla="*/ 13472 h 13520"/>
                    <a:gd name="T20" fmla="*/ 48 w 1904"/>
                    <a:gd name="T21" fmla="*/ 13424 h 13520"/>
                    <a:gd name="T22" fmla="*/ 1856 w 1904"/>
                    <a:gd name="T23" fmla="*/ 13424 h 13520"/>
                    <a:gd name="T24" fmla="*/ 1808 w 1904"/>
                    <a:gd name="T25" fmla="*/ 13472 h 13520"/>
                    <a:gd name="T26" fmla="*/ 1808 w 1904"/>
                    <a:gd name="T27" fmla="*/ 48 h 13520"/>
                    <a:gd name="T28" fmla="*/ 1856 w 1904"/>
                    <a:gd name="T29" fmla="*/ 96 h 13520"/>
                    <a:gd name="T30" fmla="*/ 48 w 1904"/>
                    <a:gd name="T31" fmla="*/ 96 h 13520"/>
                    <a:gd name="T32" fmla="*/ 96 w 1904"/>
                    <a:gd name="T33" fmla="*/ 48 h 13520"/>
                    <a:gd name="T34" fmla="*/ 96 w 1904"/>
                    <a:gd name="T35" fmla="*/ 13472 h 1352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904" h="13520">
                      <a:moveTo>
                        <a:pt x="0" y="48"/>
                      </a:moveTo>
                      <a:cubicBezTo>
                        <a:pt x="0" y="22"/>
                        <a:pt x="22" y="0"/>
                        <a:pt x="48" y="0"/>
                      </a:cubicBezTo>
                      <a:lnTo>
                        <a:pt x="1856" y="0"/>
                      </a:lnTo>
                      <a:cubicBezTo>
                        <a:pt x="1883" y="0"/>
                        <a:pt x="1904" y="22"/>
                        <a:pt x="1904" y="48"/>
                      </a:cubicBezTo>
                      <a:lnTo>
                        <a:pt x="1904" y="13472"/>
                      </a:lnTo>
                      <a:cubicBezTo>
                        <a:pt x="1904" y="13499"/>
                        <a:pt x="1883" y="13520"/>
                        <a:pt x="1856" y="13520"/>
                      </a:cubicBezTo>
                      <a:lnTo>
                        <a:pt x="48" y="13520"/>
                      </a:lnTo>
                      <a:cubicBezTo>
                        <a:pt x="22" y="13520"/>
                        <a:pt x="0" y="13499"/>
                        <a:pt x="0" y="13472"/>
                      </a:cubicBezTo>
                      <a:lnTo>
                        <a:pt x="0" y="48"/>
                      </a:lnTo>
                      <a:close/>
                      <a:moveTo>
                        <a:pt x="96" y="13472"/>
                      </a:moveTo>
                      <a:lnTo>
                        <a:pt x="48" y="13424"/>
                      </a:lnTo>
                      <a:lnTo>
                        <a:pt x="1856" y="13424"/>
                      </a:lnTo>
                      <a:lnTo>
                        <a:pt x="1808" y="13472"/>
                      </a:lnTo>
                      <a:lnTo>
                        <a:pt x="1808" y="48"/>
                      </a:lnTo>
                      <a:lnTo>
                        <a:pt x="1856" y="96"/>
                      </a:lnTo>
                      <a:lnTo>
                        <a:pt x="48" y="96"/>
                      </a:lnTo>
                      <a:lnTo>
                        <a:pt x="96" y="48"/>
                      </a:lnTo>
                      <a:lnTo>
                        <a:pt x="96" y="1347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85" name="Rectangle 14"/>
                <p:cNvSpPr>
                  <a:spLocks noChangeArrowheads="1"/>
                </p:cNvSpPr>
                <p:nvPr/>
              </p:nvSpPr>
              <p:spPr bwMode="auto">
                <a:xfrm>
                  <a:off x="3906838" y="4119563"/>
                  <a:ext cx="174625" cy="396875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86" name="Freeform 15"/>
                <p:cNvSpPr>
                  <a:spLocks noEditPoints="1"/>
                </p:cNvSpPr>
                <p:nvPr/>
              </p:nvSpPr>
              <p:spPr bwMode="auto">
                <a:xfrm>
                  <a:off x="3902075" y="4114800"/>
                  <a:ext cx="184150" cy="404812"/>
                </a:xfrm>
                <a:custGeom>
                  <a:avLst/>
                  <a:gdLst>
                    <a:gd name="T0" fmla="*/ 0 w 1920"/>
                    <a:gd name="T1" fmla="*/ 48 h 4256"/>
                    <a:gd name="T2" fmla="*/ 48 w 1920"/>
                    <a:gd name="T3" fmla="*/ 0 h 4256"/>
                    <a:gd name="T4" fmla="*/ 1872 w 1920"/>
                    <a:gd name="T5" fmla="*/ 0 h 4256"/>
                    <a:gd name="T6" fmla="*/ 1920 w 1920"/>
                    <a:gd name="T7" fmla="*/ 48 h 4256"/>
                    <a:gd name="T8" fmla="*/ 1920 w 1920"/>
                    <a:gd name="T9" fmla="*/ 4208 h 4256"/>
                    <a:gd name="T10" fmla="*/ 1872 w 1920"/>
                    <a:gd name="T11" fmla="*/ 4256 h 4256"/>
                    <a:gd name="T12" fmla="*/ 48 w 1920"/>
                    <a:gd name="T13" fmla="*/ 4256 h 4256"/>
                    <a:gd name="T14" fmla="*/ 0 w 1920"/>
                    <a:gd name="T15" fmla="*/ 4208 h 4256"/>
                    <a:gd name="T16" fmla="*/ 0 w 1920"/>
                    <a:gd name="T17" fmla="*/ 48 h 4256"/>
                    <a:gd name="T18" fmla="*/ 96 w 1920"/>
                    <a:gd name="T19" fmla="*/ 4208 h 4256"/>
                    <a:gd name="T20" fmla="*/ 48 w 1920"/>
                    <a:gd name="T21" fmla="*/ 4160 h 4256"/>
                    <a:gd name="T22" fmla="*/ 1872 w 1920"/>
                    <a:gd name="T23" fmla="*/ 4160 h 4256"/>
                    <a:gd name="T24" fmla="*/ 1824 w 1920"/>
                    <a:gd name="T25" fmla="*/ 4208 h 4256"/>
                    <a:gd name="T26" fmla="*/ 1824 w 1920"/>
                    <a:gd name="T27" fmla="*/ 48 h 4256"/>
                    <a:gd name="T28" fmla="*/ 1872 w 1920"/>
                    <a:gd name="T29" fmla="*/ 96 h 4256"/>
                    <a:gd name="T30" fmla="*/ 48 w 1920"/>
                    <a:gd name="T31" fmla="*/ 96 h 4256"/>
                    <a:gd name="T32" fmla="*/ 96 w 1920"/>
                    <a:gd name="T33" fmla="*/ 48 h 4256"/>
                    <a:gd name="T34" fmla="*/ 96 w 1920"/>
                    <a:gd name="T35" fmla="*/ 4208 h 42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920" h="4256">
                      <a:moveTo>
                        <a:pt x="0" y="48"/>
                      </a:moveTo>
                      <a:cubicBezTo>
                        <a:pt x="0" y="22"/>
                        <a:pt x="22" y="0"/>
                        <a:pt x="48" y="0"/>
                      </a:cubicBezTo>
                      <a:lnTo>
                        <a:pt x="1872" y="0"/>
                      </a:lnTo>
                      <a:cubicBezTo>
                        <a:pt x="1899" y="0"/>
                        <a:pt x="1920" y="22"/>
                        <a:pt x="1920" y="48"/>
                      </a:cubicBezTo>
                      <a:lnTo>
                        <a:pt x="1920" y="4208"/>
                      </a:lnTo>
                      <a:cubicBezTo>
                        <a:pt x="1920" y="4235"/>
                        <a:pt x="1899" y="4256"/>
                        <a:pt x="1872" y="4256"/>
                      </a:cubicBezTo>
                      <a:lnTo>
                        <a:pt x="48" y="4256"/>
                      </a:lnTo>
                      <a:cubicBezTo>
                        <a:pt x="22" y="4256"/>
                        <a:pt x="0" y="4235"/>
                        <a:pt x="0" y="4208"/>
                      </a:cubicBezTo>
                      <a:lnTo>
                        <a:pt x="0" y="48"/>
                      </a:lnTo>
                      <a:close/>
                      <a:moveTo>
                        <a:pt x="96" y="4208"/>
                      </a:moveTo>
                      <a:lnTo>
                        <a:pt x="48" y="4160"/>
                      </a:lnTo>
                      <a:lnTo>
                        <a:pt x="1872" y="4160"/>
                      </a:lnTo>
                      <a:lnTo>
                        <a:pt x="1824" y="4208"/>
                      </a:lnTo>
                      <a:lnTo>
                        <a:pt x="1824" y="48"/>
                      </a:lnTo>
                      <a:lnTo>
                        <a:pt x="1872" y="96"/>
                      </a:lnTo>
                      <a:lnTo>
                        <a:pt x="48" y="96"/>
                      </a:lnTo>
                      <a:lnTo>
                        <a:pt x="96" y="48"/>
                      </a:lnTo>
                      <a:lnTo>
                        <a:pt x="96" y="4208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87" name="Rectangle 16"/>
                <p:cNvSpPr>
                  <a:spLocks noChangeArrowheads="1"/>
                </p:cNvSpPr>
                <p:nvPr/>
              </p:nvSpPr>
              <p:spPr bwMode="auto">
                <a:xfrm>
                  <a:off x="4340225" y="4291013"/>
                  <a:ext cx="173038" cy="225425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88" name="Freeform 17"/>
                <p:cNvSpPr>
                  <a:spLocks noEditPoints="1"/>
                </p:cNvSpPr>
                <p:nvPr/>
              </p:nvSpPr>
              <p:spPr bwMode="auto">
                <a:xfrm>
                  <a:off x="4335463" y="4287838"/>
                  <a:ext cx="182563" cy="231775"/>
                </a:xfrm>
                <a:custGeom>
                  <a:avLst/>
                  <a:gdLst>
                    <a:gd name="T0" fmla="*/ 0 w 1920"/>
                    <a:gd name="T1" fmla="*/ 48 h 2448"/>
                    <a:gd name="T2" fmla="*/ 48 w 1920"/>
                    <a:gd name="T3" fmla="*/ 0 h 2448"/>
                    <a:gd name="T4" fmla="*/ 1872 w 1920"/>
                    <a:gd name="T5" fmla="*/ 0 h 2448"/>
                    <a:gd name="T6" fmla="*/ 1920 w 1920"/>
                    <a:gd name="T7" fmla="*/ 48 h 2448"/>
                    <a:gd name="T8" fmla="*/ 1920 w 1920"/>
                    <a:gd name="T9" fmla="*/ 2400 h 2448"/>
                    <a:gd name="T10" fmla="*/ 1872 w 1920"/>
                    <a:gd name="T11" fmla="*/ 2448 h 2448"/>
                    <a:gd name="T12" fmla="*/ 48 w 1920"/>
                    <a:gd name="T13" fmla="*/ 2448 h 2448"/>
                    <a:gd name="T14" fmla="*/ 0 w 1920"/>
                    <a:gd name="T15" fmla="*/ 2400 h 2448"/>
                    <a:gd name="T16" fmla="*/ 0 w 1920"/>
                    <a:gd name="T17" fmla="*/ 48 h 2448"/>
                    <a:gd name="T18" fmla="*/ 96 w 1920"/>
                    <a:gd name="T19" fmla="*/ 2400 h 2448"/>
                    <a:gd name="T20" fmla="*/ 48 w 1920"/>
                    <a:gd name="T21" fmla="*/ 2352 h 2448"/>
                    <a:gd name="T22" fmla="*/ 1872 w 1920"/>
                    <a:gd name="T23" fmla="*/ 2352 h 2448"/>
                    <a:gd name="T24" fmla="*/ 1824 w 1920"/>
                    <a:gd name="T25" fmla="*/ 2400 h 2448"/>
                    <a:gd name="T26" fmla="*/ 1824 w 1920"/>
                    <a:gd name="T27" fmla="*/ 48 h 2448"/>
                    <a:gd name="T28" fmla="*/ 1872 w 1920"/>
                    <a:gd name="T29" fmla="*/ 96 h 2448"/>
                    <a:gd name="T30" fmla="*/ 48 w 1920"/>
                    <a:gd name="T31" fmla="*/ 96 h 2448"/>
                    <a:gd name="T32" fmla="*/ 96 w 1920"/>
                    <a:gd name="T33" fmla="*/ 48 h 2448"/>
                    <a:gd name="T34" fmla="*/ 96 w 1920"/>
                    <a:gd name="T35" fmla="*/ 2400 h 24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920" h="2448">
                      <a:moveTo>
                        <a:pt x="0" y="48"/>
                      </a:moveTo>
                      <a:cubicBezTo>
                        <a:pt x="0" y="22"/>
                        <a:pt x="22" y="0"/>
                        <a:pt x="48" y="0"/>
                      </a:cubicBezTo>
                      <a:lnTo>
                        <a:pt x="1872" y="0"/>
                      </a:lnTo>
                      <a:cubicBezTo>
                        <a:pt x="1899" y="0"/>
                        <a:pt x="1920" y="22"/>
                        <a:pt x="1920" y="48"/>
                      </a:cubicBezTo>
                      <a:lnTo>
                        <a:pt x="1920" y="2400"/>
                      </a:lnTo>
                      <a:cubicBezTo>
                        <a:pt x="1920" y="2427"/>
                        <a:pt x="1899" y="2448"/>
                        <a:pt x="1872" y="2448"/>
                      </a:cubicBezTo>
                      <a:lnTo>
                        <a:pt x="48" y="2448"/>
                      </a:lnTo>
                      <a:cubicBezTo>
                        <a:pt x="22" y="2448"/>
                        <a:pt x="0" y="2427"/>
                        <a:pt x="0" y="2400"/>
                      </a:cubicBezTo>
                      <a:lnTo>
                        <a:pt x="0" y="48"/>
                      </a:lnTo>
                      <a:close/>
                      <a:moveTo>
                        <a:pt x="96" y="2400"/>
                      </a:moveTo>
                      <a:lnTo>
                        <a:pt x="48" y="2352"/>
                      </a:lnTo>
                      <a:lnTo>
                        <a:pt x="1872" y="2352"/>
                      </a:lnTo>
                      <a:lnTo>
                        <a:pt x="1824" y="2400"/>
                      </a:lnTo>
                      <a:lnTo>
                        <a:pt x="1824" y="48"/>
                      </a:lnTo>
                      <a:lnTo>
                        <a:pt x="1872" y="96"/>
                      </a:lnTo>
                      <a:lnTo>
                        <a:pt x="48" y="96"/>
                      </a:lnTo>
                      <a:lnTo>
                        <a:pt x="96" y="48"/>
                      </a:lnTo>
                      <a:lnTo>
                        <a:pt x="96" y="240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89" name="Rectangle 18"/>
                <p:cNvSpPr>
                  <a:spLocks noChangeArrowheads="1"/>
                </p:cNvSpPr>
                <p:nvPr/>
              </p:nvSpPr>
              <p:spPr bwMode="auto">
                <a:xfrm>
                  <a:off x="4773613" y="4281488"/>
                  <a:ext cx="171450" cy="23495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0" name="Freeform 19"/>
                <p:cNvSpPr>
                  <a:spLocks noEditPoints="1"/>
                </p:cNvSpPr>
                <p:nvPr/>
              </p:nvSpPr>
              <p:spPr bwMode="auto">
                <a:xfrm>
                  <a:off x="4768850" y="4276725"/>
                  <a:ext cx="180975" cy="242887"/>
                </a:xfrm>
                <a:custGeom>
                  <a:avLst/>
                  <a:gdLst>
                    <a:gd name="T0" fmla="*/ 0 w 952"/>
                    <a:gd name="T1" fmla="*/ 24 h 1280"/>
                    <a:gd name="T2" fmla="*/ 24 w 952"/>
                    <a:gd name="T3" fmla="*/ 0 h 1280"/>
                    <a:gd name="T4" fmla="*/ 928 w 952"/>
                    <a:gd name="T5" fmla="*/ 0 h 1280"/>
                    <a:gd name="T6" fmla="*/ 952 w 952"/>
                    <a:gd name="T7" fmla="*/ 24 h 1280"/>
                    <a:gd name="T8" fmla="*/ 952 w 952"/>
                    <a:gd name="T9" fmla="*/ 1256 h 1280"/>
                    <a:gd name="T10" fmla="*/ 928 w 952"/>
                    <a:gd name="T11" fmla="*/ 1280 h 1280"/>
                    <a:gd name="T12" fmla="*/ 24 w 952"/>
                    <a:gd name="T13" fmla="*/ 1280 h 1280"/>
                    <a:gd name="T14" fmla="*/ 0 w 952"/>
                    <a:gd name="T15" fmla="*/ 1256 h 1280"/>
                    <a:gd name="T16" fmla="*/ 0 w 952"/>
                    <a:gd name="T17" fmla="*/ 24 h 1280"/>
                    <a:gd name="T18" fmla="*/ 48 w 952"/>
                    <a:gd name="T19" fmla="*/ 1256 h 1280"/>
                    <a:gd name="T20" fmla="*/ 24 w 952"/>
                    <a:gd name="T21" fmla="*/ 1232 h 1280"/>
                    <a:gd name="T22" fmla="*/ 928 w 952"/>
                    <a:gd name="T23" fmla="*/ 1232 h 1280"/>
                    <a:gd name="T24" fmla="*/ 904 w 952"/>
                    <a:gd name="T25" fmla="*/ 1256 h 1280"/>
                    <a:gd name="T26" fmla="*/ 904 w 952"/>
                    <a:gd name="T27" fmla="*/ 24 h 1280"/>
                    <a:gd name="T28" fmla="*/ 928 w 952"/>
                    <a:gd name="T29" fmla="*/ 48 h 1280"/>
                    <a:gd name="T30" fmla="*/ 24 w 952"/>
                    <a:gd name="T31" fmla="*/ 48 h 1280"/>
                    <a:gd name="T32" fmla="*/ 48 w 952"/>
                    <a:gd name="T33" fmla="*/ 24 h 1280"/>
                    <a:gd name="T34" fmla="*/ 48 w 952"/>
                    <a:gd name="T35" fmla="*/ 1256 h 128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952" h="1280">
                      <a:moveTo>
                        <a:pt x="0" y="24"/>
                      </a:moveTo>
                      <a:cubicBezTo>
                        <a:pt x="0" y="11"/>
                        <a:pt x="11" y="0"/>
                        <a:pt x="24" y="0"/>
                      </a:cubicBezTo>
                      <a:lnTo>
                        <a:pt x="928" y="0"/>
                      </a:lnTo>
                      <a:cubicBezTo>
                        <a:pt x="942" y="0"/>
                        <a:pt x="952" y="11"/>
                        <a:pt x="952" y="24"/>
                      </a:cubicBezTo>
                      <a:lnTo>
                        <a:pt x="952" y="1256"/>
                      </a:lnTo>
                      <a:cubicBezTo>
                        <a:pt x="952" y="1270"/>
                        <a:pt x="942" y="1280"/>
                        <a:pt x="928" y="1280"/>
                      </a:cubicBezTo>
                      <a:lnTo>
                        <a:pt x="24" y="1280"/>
                      </a:lnTo>
                      <a:cubicBezTo>
                        <a:pt x="11" y="1280"/>
                        <a:pt x="0" y="1270"/>
                        <a:pt x="0" y="1256"/>
                      </a:cubicBezTo>
                      <a:lnTo>
                        <a:pt x="0" y="24"/>
                      </a:lnTo>
                      <a:close/>
                      <a:moveTo>
                        <a:pt x="48" y="1256"/>
                      </a:moveTo>
                      <a:lnTo>
                        <a:pt x="24" y="1232"/>
                      </a:lnTo>
                      <a:lnTo>
                        <a:pt x="928" y="1232"/>
                      </a:lnTo>
                      <a:lnTo>
                        <a:pt x="904" y="1256"/>
                      </a:lnTo>
                      <a:lnTo>
                        <a:pt x="904" y="24"/>
                      </a:lnTo>
                      <a:lnTo>
                        <a:pt x="928" y="48"/>
                      </a:lnTo>
                      <a:lnTo>
                        <a:pt x="24" y="48"/>
                      </a:lnTo>
                      <a:lnTo>
                        <a:pt x="48" y="24"/>
                      </a:lnTo>
                      <a:lnTo>
                        <a:pt x="48" y="1256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1" name="Rectangle 20"/>
                <p:cNvSpPr>
                  <a:spLocks noChangeArrowheads="1"/>
                </p:cNvSpPr>
                <p:nvPr/>
              </p:nvSpPr>
              <p:spPr bwMode="auto">
                <a:xfrm>
                  <a:off x="5203825" y="4237038"/>
                  <a:ext cx="174625" cy="2794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2" name="Freeform 21"/>
                <p:cNvSpPr>
                  <a:spLocks noEditPoints="1"/>
                </p:cNvSpPr>
                <p:nvPr/>
              </p:nvSpPr>
              <p:spPr bwMode="auto">
                <a:xfrm>
                  <a:off x="5200650" y="4232275"/>
                  <a:ext cx="182563" cy="287337"/>
                </a:xfrm>
                <a:custGeom>
                  <a:avLst/>
                  <a:gdLst>
                    <a:gd name="T0" fmla="*/ 0 w 960"/>
                    <a:gd name="T1" fmla="*/ 24 h 1512"/>
                    <a:gd name="T2" fmla="*/ 24 w 960"/>
                    <a:gd name="T3" fmla="*/ 0 h 1512"/>
                    <a:gd name="T4" fmla="*/ 936 w 960"/>
                    <a:gd name="T5" fmla="*/ 0 h 1512"/>
                    <a:gd name="T6" fmla="*/ 960 w 960"/>
                    <a:gd name="T7" fmla="*/ 24 h 1512"/>
                    <a:gd name="T8" fmla="*/ 960 w 960"/>
                    <a:gd name="T9" fmla="*/ 1488 h 1512"/>
                    <a:gd name="T10" fmla="*/ 936 w 960"/>
                    <a:gd name="T11" fmla="*/ 1512 h 1512"/>
                    <a:gd name="T12" fmla="*/ 24 w 960"/>
                    <a:gd name="T13" fmla="*/ 1512 h 1512"/>
                    <a:gd name="T14" fmla="*/ 0 w 960"/>
                    <a:gd name="T15" fmla="*/ 1488 h 1512"/>
                    <a:gd name="T16" fmla="*/ 0 w 960"/>
                    <a:gd name="T17" fmla="*/ 24 h 1512"/>
                    <a:gd name="T18" fmla="*/ 48 w 960"/>
                    <a:gd name="T19" fmla="*/ 1488 h 1512"/>
                    <a:gd name="T20" fmla="*/ 24 w 960"/>
                    <a:gd name="T21" fmla="*/ 1464 h 1512"/>
                    <a:gd name="T22" fmla="*/ 936 w 960"/>
                    <a:gd name="T23" fmla="*/ 1464 h 1512"/>
                    <a:gd name="T24" fmla="*/ 912 w 960"/>
                    <a:gd name="T25" fmla="*/ 1488 h 1512"/>
                    <a:gd name="T26" fmla="*/ 912 w 960"/>
                    <a:gd name="T27" fmla="*/ 24 h 1512"/>
                    <a:gd name="T28" fmla="*/ 936 w 960"/>
                    <a:gd name="T29" fmla="*/ 48 h 1512"/>
                    <a:gd name="T30" fmla="*/ 24 w 960"/>
                    <a:gd name="T31" fmla="*/ 48 h 1512"/>
                    <a:gd name="T32" fmla="*/ 48 w 960"/>
                    <a:gd name="T33" fmla="*/ 24 h 1512"/>
                    <a:gd name="T34" fmla="*/ 48 w 960"/>
                    <a:gd name="T35" fmla="*/ 1488 h 15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960" h="1512">
                      <a:moveTo>
                        <a:pt x="0" y="24"/>
                      </a:moveTo>
                      <a:cubicBezTo>
                        <a:pt x="0" y="11"/>
                        <a:pt x="11" y="0"/>
                        <a:pt x="24" y="0"/>
                      </a:cubicBezTo>
                      <a:lnTo>
                        <a:pt x="936" y="0"/>
                      </a:lnTo>
                      <a:cubicBezTo>
                        <a:pt x="950" y="0"/>
                        <a:pt x="960" y="11"/>
                        <a:pt x="960" y="24"/>
                      </a:cubicBezTo>
                      <a:lnTo>
                        <a:pt x="960" y="1488"/>
                      </a:lnTo>
                      <a:cubicBezTo>
                        <a:pt x="960" y="1502"/>
                        <a:pt x="950" y="1512"/>
                        <a:pt x="936" y="1512"/>
                      </a:cubicBezTo>
                      <a:lnTo>
                        <a:pt x="24" y="1512"/>
                      </a:lnTo>
                      <a:cubicBezTo>
                        <a:pt x="11" y="1512"/>
                        <a:pt x="0" y="1502"/>
                        <a:pt x="0" y="1488"/>
                      </a:cubicBezTo>
                      <a:lnTo>
                        <a:pt x="0" y="24"/>
                      </a:lnTo>
                      <a:close/>
                      <a:moveTo>
                        <a:pt x="48" y="1488"/>
                      </a:moveTo>
                      <a:lnTo>
                        <a:pt x="24" y="1464"/>
                      </a:lnTo>
                      <a:lnTo>
                        <a:pt x="936" y="1464"/>
                      </a:lnTo>
                      <a:lnTo>
                        <a:pt x="912" y="1488"/>
                      </a:lnTo>
                      <a:lnTo>
                        <a:pt x="912" y="24"/>
                      </a:lnTo>
                      <a:lnTo>
                        <a:pt x="936" y="48"/>
                      </a:lnTo>
                      <a:lnTo>
                        <a:pt x="24" y="48"/>
                      </a:lnTo>
                      <a:lnTo>
                        <a:pt x="48" y="24"/>
                      </a:lnTo>
                      <a:lnTo>
                        <a:pt x="48" y="1488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3" name="Rectangle 22"/>
                <p:cNvSpPr>
                  <a:spLocks noChangeArrowheads="1"/>
                </p:cNvSpPr>
                <p:nvPr/>
              </p:nvSpPr>
              <p:spPr bwMode="auto">
                <a:xfrm>
                  <a:off x="5637213" y="3135313"/>
                  <a:ext cx="174625" cy="1381125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4" name="Freeform 23"/>
                <p:cNvSpPr>
                  <a:spLocks noEditPoints="1"/>
                </p:cNvSpPr>
                <p:nvPr/>
              </p:nvSpPr>
              <p:spPr bwMode="auto">
                <a:xfrm>
                  <a:off x="5632450" y="3130550"/>
                  <a:ext cx="182563" cy="1389062"/>
                </a:xfrm>
                <a:custGeom>
                  <a:avLst/>
                  <a:gdLst>
                    <a:gd name="T0" fmla="*/ 0 w 960"/>
                    <a:gd name="T1" fmla="*/ 24 h 7296"/>
                    <a:gd name="T2" fmla="*/ 24 w 960"/>
                    <a:gd name="T3" fmla="*/ 0 h 7296"/>
                    <a:gd name="T4" fmla="*/ 936 w 960"/>
                    <a:gd name="T5" fmla="*/ 0 h 7296"/>
                    <a:gd name="T6" fmla="*/ 960 w 960"/>
                    <a:gd name="T7" fmla="*/ 24 h 7296"/>
                    <a:gd name="T8" fmla="*/ 960 w 960"/>
                    <a:gd name="T9" fmla="*/ 7272 h 7296"/>
                    <a:gd name="T10" fmla="*/ 936 w 960"/>
                    <a:gd name="T11" fmla="*/ 7296 h 7296"/>
                    <a:gd name="T12" fmla="*/ 24 w 960"/>
                    <a:gd name="T13" fmla="*/ 7296 h 7296"/>
                    <a:gd name="T14" fmla="*/ 0 w 960"/>
                    <a:gd name="T15" fmla="*/ 7272 h 7296"/>
                    <a:gd name="T16" fmla="*/ 0 w 960"/>
                    <a:gd name="T17" fmla="*/ 24 h 7296"/>
                    <a:gd name="T18" fmla="*/ 48 w 960"/>
                    <a:gd name="T19" fmla="*/ 7272 h 7296"/>
                    <a:gd name="T20" fmla="*/ 24 w 960"/>
                    <a:gd name="T21" fmla="*/ 7248 h 7296"/>
                    <a:gd name="T22" fmla="*/ 936 w 960"/>
                    <a:gd name="T23" fmla="*/ 7248 h 7296"/>
                    <a:gd name="T24" fmla="*/ 912 w 960"/>
                    <a:gd name="T25" fmla="*/ 7272 h 7296"/>
                    <a:gd name="T26" fmla="*/ 912 w 960"/>
                    <a:gd name="T27" fmla="*/ 24 h 7296"/>
                    <a:gd name="T28" fmla="*/ 936 w 960"/>
                    <a:gd name="T29" fmla="*/ 48 h 7296"/>
                    <a:gd name="T30" fmla="*/ 24 w 960"/>
                    <a:gd name="T31" fmla="*/ 48 h 7296"/>
                    <a:gd name="T32" fmla="*/ 48 w 960"/>
                    <a:gd name="T33" fmla="*/ 24 h 7296"/>
                    <a:gd name="T34" fmla="*/ 48 w 960"/>
                    <a:gd name="T35" fmla="*/ 7272 h 729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960" h="7296">
                      <a:moveTo>
                        <a:pt x="0" y="24"/>
                      </a:moveTo>
                      <a:cubicBezTo>
                        <a:pt x="0" y="11"/>
                        <a:pt x="11" y="0"/>
                        <a:pt x="24" y="0"/>
                      </a:cubicBezTo>
                      <a:lnTo>
                        <a:pt x="936" y="0"/>
                      </a:lnTo>
                      <a:cubicBezTo>
                        <a:pt x="950" y="0"/>
                        <a:pt x="960" y="11"/>
                        <a:pt x="960" y="24"/>
                      </a:cubicBezTo>
                      <a:lnTo>
                        <a:pt x="960" y="7272"/>
                      </a:lnTo>
                      <a:cubicBezTo>
                        <a:pt x="960" y="7286"/>
                        <a:pt x="950" y="7296"/>
                        <a:pt x="936" y="7296"/>
                      </a:cubicBezTo>
                      <a:lnTo>
                        <a:pt x="24" y="7296"/>
                      </a:lnTo>
                      <a:cubicBezTo>
                        <a:pt x="11" y="7296"/>
                        <a:pt x="0" y="7286"/>
                        <a:pt x="0" y="7272"/>
                      </a:cubicBezTo>
                      <a:lnTo>
                        <a:pt x="0" y="24"/>
                      </a:lnTo>
                      <a:close/>
                      <a:moveTo>
                        <a:pt x="48" y="7272"/>
                      </a:moveTo>
                      <a:lnTo>
                        <a:pt x="24" y="7248"/>
                      </a:lnTo>
                      <a:lnTo>
                        <a:pt x="936" y="7248"/>
                      </a:lnTo>
                      <a:lnTo>
                        <a:pt x="912" y="7272"/>
                      </a:lnTo>
                      <a:lnTo>
                        <a:pt x="912" y="24"/>
                      </a:lnTo>
                      <a:lnTo>
                        <a:pt x="936" y="48"/>
                      </a:lnTo>
                      <a:lnTo>
                        <a:pt x="24" y="48"/>
                      </a:lnTo>
                      <a:lnTo>
                        <a:pt x="48" y="24"/>
                      </a:lnTo>
                      <a:lnTo>
                        <a:pt x="48" y="727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5" name="Rectangle 24"/>
                <p:cNvSpPr>
                  <a:spLocks noChangeArrowheads="1"/>
                </p:cNvSpPr>
                <p:nvPr/>
              </p:nvSpPr>
              <p:spPr bwMode="auto">
                <a:xfrm>
                  <a:off x="6070600" y="2449513"/>
                  <a:ext cx="171450" cy="2066925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6" name="Freeform 25"/>
                <p:cNvSpPr>
                  <a:spLocks noEditPoints="1"/>
                </p:cNvSpPr>
                <p:nvPr/>
              </p:nvSpPr>
              <p:spPr bwMode="auto">
                <a:xfrm>
                  <a:off x="6065838" y="2444750"/>
                  <a:ext cx="180975" cy="2074862"/>
                </a:xfrm>
                <a:custGeom>
                  <a:avLst/>
                  <a:gdLst>
                    <a:gd name="T0" fmla="*/ 0 w 952"/>
                    <a:gd name="T1" fmla="*/ 24 h 10896"/>
                    <a:gd name="T2" fmla="*/ 24 w 952"/>
                    <a:gd name="T3" fmla="*/ 0 h 10896"/>
                    <a:gd name="T4" fmla="*/ 928 w 952"/>
                    <a:gd name="T5" fmla="*/ 0 h 10896"/>
                    <a:gd name="T6" fmla="*/ 952 w 952"/>
                    <a:gd name="T7" fmla="*/ 24 h 10896"/>
                    <a:gd name="T8" fmla="*/ 952 w 952"/>
                    <a:gd name="T9" fmla="*/ 10872 h 10896"/>
                    <a:gd name="T10" fmla="*/ 928 w 952"/>
                    <a:gd name="T11" fmla="*/ 10896 h 10896"/>
                    <a:gd name="T12" fmla="*/ 24 w 952"/>
                    <a:gd name="T13" fmla="*/ 10896 h 10896"/>
                    <a:gd name="T14" fmla="*/ 0 w 952"/>
                    <a:gd name="T15" fmla="*/ 10872 h 10896"/>
                    <a:gd name="T16" fmla="*/ 0 w 952"/>
                    <a:gd name="T17" fmla="*/ 24 h 10896"/>
                    <a:gd name="T18" fmla="*/ 48 w 952"/>
                    <a:gd name="T19" fmla="*/ 10872 h 10896"/>
                    <a:gd name="T20" fmla="*/ 24 w 952"/>
                    <a:gd name="T21" fmla="*/ 10848 h 10896"/>
                    <a:gd name="T22" fmla="*/ 928 w 952"/>
                    <a:gd name="T23" fmla="*/ 10848 h 10896"/>
                    <a:gd name="T24" fmla="*/ 904 w 952"/>
                    <a:gd name="T25" fmla="*/ 10872 h 10896"/>
                    <a:gd name="T26" fmla="*/ 904 w 952"/>
                    <a:gd name="T27" fmla="*/ 24 h 10896"/>
                    <a:gd name="T28" fmla="*/ 928 w 952"/>
                    <a:gd name="T29" fmla="*/ 48 h 10896"/>
                    <a:gd name="T30" fmla="*/ 24 w 952"/>
                    <a:gd name="T31" fmla="*/ 48 h 10896"/>
                    <a:gd name="T32" fmla="*/ 48 w 952"/>
                    <a:gd name="T33" fmla="*/ 24 h 10896"/>
                    <a:gd name="T34" fmla="*/ 48 w 952"/>
                    <a:gd name="T35" fmla="*/ 10872 h 1089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952" h="10896">
                      <a:moveTo>
                        <a:pt x="0" y="24"/>
                      </a:moveTo>
                      <a:cubicBezTo>
                        <a:pt x="0" y="11"/>
                        <a:pt x="11" y="0"/>
                        <a:pt x="24" y="0"/>
                      </a:cubicBezTo>
                      <a:lnTo>
                        <a:pt x="928" y="0"/>
                      </a:lnTo>
                      <a:cubicBezTo>
                        <a:pt x="942" y="0"/>
                        <a:pt x="952" y="11"/>
                        <a:pt x="952" y="24"/>
                      </a:cubicBezTo>
                      <a:lnTo>
                        <a:pt x="952" y="10872"/>
                      </a:lnTo>
                      <a:cubicBezTo>
                        <a:pt x="952" y="10886"/>
                        <a:pt x="942" y="10896"/>
                        <a:pt x="928" y="10896"/>
                      </a:cubicBezTo>
                      <a:lnTo>
                        <a:pt x="24" y="10896"/>
                      </a:lnTo>
                      <a:cubicBezTo>
                        <a:pt x="11" y="10896"/>
                        <a:pt x="0" y="10886"/>
                        <a:pt x="0" y="10872"/>
                      </a:cubicBezTo>
                      <a:lnTo>
                        <a:pt x="0" y="24"/>
                      </a:lnTo>
                      <a:close/>
                      <a:moveTo>
                        <a:pt x="48" y="10872"/>
                      </a:moveTo>
                      <a:lnTo>
                        <a:pt x="24" y="10848"/>
                      </a:lnTo>
                      <a:lnTo>
                        <a:pt x="928" y="10848"/>
                      </a:lnTo>
                      <a:lnTo>
                        <a:pt x="904" y="10872"/>
                      </a:lnTo>
                      <a:lnTo>
                        <a:pt x="904" y="24"/>
                      </a:lnTo>
                      <a:lnTo>
                        <a:pt x="928" y="48"/>
                      </a:lnTo>
                      <a:lnTo>
                        <a:pt x="24" y="48"/>
                      </a:lnTo>
                      <a:lnTo>
                        <a:pt x="48" y="24"/>
                      </a:lnTo>
                      <a:lnTo>
                        <a:pt x="48" y="1087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7" name="Rectangle 26"/>
                <p:cNvSpPr>
                  <a:spLocks noChangeArrowheads="1"/>
                </p:cNvSpPr>
                <p:nvPr/>
              </p:nvSpPr>
              <p:spPr bwMode="auto">
                <a:xfrm>
                  <a:off x="6500813" y="3765550"/>
                  <a:ext cx="174625" cy="75088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8" name="Freeform 27"/>
                <p:cNvSpPr>
                  <a:spLocks noEditPoints="1"/>
                </p:cNvSpPr>
                <p:nvPr/>
              </p:nvSpPr>
              <p:spPr bwMode="auto">
                <a:xfrm>
                  <a:off x="6497638" y="3760788"/>
                  <a:ext cx="182563" cy="758825"/>
                </a:xfrm>
                <a:custGeom>
                  <a:avLst/>
                  <a:gdLst>
                    <a:gd name="T0" fmla="*/ 0 w 960"/>
                    <a:gd name="T1" fmla="*/ 24 h 3984"/>
                    <a:gd name="T2" fmla="*/ 24 w 960"/>
                    <a:gd name="T3" fmla="*/ 0 h 3984"/>
                    <a:gd name="T4" fmla="*/ 936 w 960"/>
                    <a:gd name="T5" fmla="*/ 0 h 3984"/>
                    <a:gd name="T6" fmla="*/ 960 w 960"/>
                    <a:gd name="T7" fmla="*/ 24 h 3984"/>
                    <a:gd name="T8" fmla="*/ 960 w 960"/>
                    <a:gd name="T9" fmla="*/ 3960 h 3984"/>
                    <a:gd name="T10" fmla="*/ 936 w 960"/>
                    <a:gd name="T11" fmla="*/ 3984 h 3984"/>
                    <a:gd name="T12" fmla="*/ 24 w 960"/>
                    <a:gd name="T13" fmla="*/ 3984 h 3984"/>
                    <a:gd name="T14" fmla="*/ 0 w 960"/>
                    <a:gd name="T15" fmla="*/ 3960 h 3984"/>
                    <a:gd name="T16" fmla="*/ 0 w 960"/>
                    <a:gd name="T17" fmla="*/ 24 h 3984"/>
                    <a:gd name="T18" fmla="*/ 48 w 960"/>
                    <a:gd name="T19" fmla="*/ 3960 h 3984"/>
                    <a:gd name="T20" fmla="*/ 24 w 960"/>
                    <a:gd name="T21" fmla="*/ 3936 h 3984"/>
                    <a:gd name="T22" fmla="*/ 936 w 960"/>
                    <a:gd name="T23" fmla="*/ 3936 h 3984"/>
                    <a:gd name="T24" fmla="*/ 912 w 960"/>
                    <a:gd name="T25" fmla="*/ 3960 h 3984"/>
                    <a:gd name="T26" fmla="*/ 912 w 960"/>
                    <a:gd name="T27" fmla="*/ 24 h 3984"/>
                    <a:gd name="T28" fmla="*/ 936 w 960"/>
                    <a:gd name="T29" fmla="*/ 48 h 3984"/>
                    <a:gd name="T30" fmla="*/ 24 w 960"/>
                    <a:gd name="T31" fmla="*/ 48 h 3984"/>
                    <a:gd name="T32" fmla="*/ 48 w 960"/>
                    <a:gd name="T33" fmla="*/ 24 h 3984"/>
                    <a:gd name="T34" fmla="*/ 48 w 960"/>
                    <a:gd name="T35" fmla="*/ 3960 h 39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960" h="3984">
                      <a:moveTo>
                        <a:pt x="0" y="24"/>
                      </a:moveTo>
                      <a:cubicBezTo>
                        <a:pt x="0" y="11"/>
                        <a:pt x="11" y="0"/>
                        <a:pt x="24" y="0"/>
                      </a:cubicBezTo>
                      <a:lnTo>
                        <a:pt x="936" y="0"/>
                      </a:lnTo>
                      <a:cubicBezTo>
                        <a:pt x="950" y="0"/>
                        <a:pt x="960" y="11"/>
                        <a:pt x="960" y="24"/>
                      </a:cubicBezTo>
                      <a:lnTo>
                        <a:pt x="960" y="3960"/>
                      </a:lnTo>
                      <a:cubicBezTo>
                        <a:pt x="960" y="3974"/>
                        <a:pt x="950" y="3984"/>
                        <a:pt x="936" y="3984"/>
                      </a:cubicBezTo>
                      <a:lnTo>
                        <a:pt x="24" y="3984"/>
                      </a:lnTo>
                      <a:cubicBezTo>
                        <a:pt x="11" y="3984"/>
                        <a:pt x="0" y="3974"/>
                        <a:pt x="0" y="3960"/>
                      </a:cubicBezTo>
                      <a:lnTo>
                        <a:pt x="0" y="24"/>
                      </a:lnTo>
                      <a:close/>
                      <a:moveTo>
                        <a:pt x="48" y="3960"/>
                      </a:moveTo>
                      <a:lnTo>
                        <a:pt x="24" y="3936"/>
                      </a:lnTo>
                      <a:lnTo>
                        <a:pt x="936" y="3936"/>
                      </a:lnTo>
                      <a:lnTo>
                        <a:pt x="912" y="3960"/>
                      </a:lnTo>
                      <a:lnTo>
                        <a:pt x="912" y="24"/>
                      </a:lnTo>
                      <a:lnTo>
                        <a:pt x="936" y="48"/>
                      </a:lnTo>
                      <a:lnTo>
                        <a:pt x="24" y="48"/>
                      </a:lnTo>
                      <a:lnTo>
                        <a:pt x="48" y="24"/>
                      </a:lnTo>
                      <a:lnTo>
                        <a:pt x="48" y="396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9" name="Rectangle 28"/>
                <p:cNvSpPr>
                  <a:spLocks noChangeArrowheads="1"/>
                </p:cNvSpPr>
                <p:nvPr/>
              </p:nvSpPr>
              <p:spPr bwMode="auto">
                <a:xfrm>
                  <a:off x="6934200" y="4443413"/>
                  <a:ext cx="173038" cy="73025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0" name="Freeform 29"/>
                <p:cNvSpPr>
                  <a:spLocks noEditPoints="1"/>
                </p:cNvSpPr>
                <p:nvPr/>
              </p:nvSpPr>
              <p:spPr bwMode="auto">
                <a:xfrm>
                  <a:off x="6929438" y="4438650"/>
                  <a:ext cx="182563" cy="80962"/>
                </a:xfrm>
                <a:custGeom>
                  <a:avLst/>
                  <a:gdLst>
                    <a:gd name="T0" fmla="*/ 0 w 952"/>
                    <a:gd name="T1" fmla="*/ 24 h 432"/>
                    <a:gd name="T2" fmla="*/ 24 w 952"/>
                    <a:gd name="T3" fmla="*/ 0 h 432"/>
                    <a:gd name="T4" fmla="*/ 928 w 952"/>
                    <a:gd name="T5" fmla="*/ 0 h 432"/>
                    <a:gd name="T6" fmla="*/ 952 w 952"/>
                    <a:gd name="T7" fmla="*/ 24 h 432"/>
                    <a:gd name="T8" fmla="*/ 952 w 952"/>
                    <a:gd name="T9" fmla="*/ 408 h 432"/>
                    <a:gd name="T10" fmla="*/ 928 w 952"/>
                    <a:gd name="T11" fmla="*/ 432 h 432"/>
                    <a:gd name="T12" fmla="*/ 24 w 952"/>
                    <a:gd name="T13" fmla="*/ 432 h 432"/>
                    <a:gd name="T14" fmla="*/ 0 w 952"/>
                    <a:gd name="T15" fmla="*/ 408 h 432"/>
                    <a:gd name="T16" fmla="*/ 0 w 952"/>
                    <a:gd name="T17" fmla="*/ 24 h 432"/>
                    <a:gd name="T18" fmla="*/ 48 w 952"/>
                    <a:gd name="T19" fmla="*/ 408 h 432"/>
                    <a:gd name="T20" fmla="*/ 24 w 952"/>
                    <a:gd name="T21" fmla="*/ 384 h 432"/>
                    <a:gd name="T22" fmla="*/ 928 w 952"/>
                    <a:gd name="T23" fmla="*/ 384 h 432"/>
                    <a:gd name="T24" fmla="*/ 904 w 952"/>
                    <a:gd name="T25" fmla="*/ 408 h 432"/>
                    <a:gd name="T26" fmla="*/ 904 w 952"/>
                    <a:gd name="T27" fmla="*/ 24 h 432"/>
                    <a:gd name="T28" fmla="*/ 928 w 952"/>
                    <a:gd name="T29" fmla="*/ 48 h 432"/>
                    <a:gd name="T30" fmla="*/ 24 w 952"/>
                    <a:gd name="T31" fmla="*/ 48 h 432"/>
                    <a:gd name="T32" fmla="*/ 48 w 952"/>
                    <a:gd name="T33" fmla="*/ 24 h 432"/>
                    <a:gd name="T34" fmla="*/ 48 w 952"/>
                    <a:gd name="T35" fmla="*/ 408 h 4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952" h="432">
                      <a:moveTo>
                        <a:pt x="0" y="24"/>
                      </a:moveTo>
                      <a:cubicBezTo>
                        <a:pt x="0" y="11"/>
                        <a:pt x="11" y="0"/>
                        <a:pt x="24" y="0"/>
                      </a:cubicBezTo>
                      <a:lnTo>
                        <a:pt x="928" y="0"/>
                      </a:lnTo>
                      <a:cubicBezTo>
                        <a:pt x="942" y="0"/>
                        <a:pt x="952" y="11"/>
                        <a:pt x="952" y="24"/>
                      </a:cubicBezTo>
                      <a:lnTo>
                        <a:pt x="952" y="408"/>
                      </a:lnTo>
                      <a:cubicBezTo>
                        <a:pt x="952" y="422"/>
                        <a:pt x="942" y="432"/>
                        <a:pt x="928" y="432"/>
                      </a:cubicBezTo>
                      <a:lnTo>
                        <a:pt x="24" y="432"/>
                      </a:lnTo>
                      <a:cubicBezTo>
                        <a:pt x="11" y="432"/>
                        <a:pt x="0" y="422"/>
                        <a:pt x="0" y="408"/>
                      </a:cubicBezTo>
                      <a:lnTo>
                        <a:pt x="0" y="24"/>
                      </a:lnTo>
                      <a:close/>
                      <a:moveTo>
                        <a:pt x="48" y="408"/>
                      </a:moveTo>
                      <a:lnTo>
                        <a:pt x="24" y="384"/>
                      </a:lnTo>
                      <a:lnTo>
                        <a:pt x="928" y="384"/>
                      </a:lnTo>
                      <a:lnTo>
                        <a:pt x="904" y="408"/>
                      </a:lnTo>
                      <a:lnTo>
                        <a:pt x="904" y="24"/>
                      </a:lnTo>
                      <a:lnTo>
                        <a:pt x="928" y="48"/>
                      </a:lnTo>
                      <a:lnTo>
                        <a:pt x="24" y="48"/>
                      </a:lnTo>
                      <a:lnTo>
                        <a:pt x="48" y="24"/>
                      </a:lnTo>
                      <a:lnTo>
                        <a:pt x="48" y="408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1" name="Rectangle 30"/>
                <p:cNvSpPr>
                  <a:spLocks noChangeArrowheads="1"/>
                </p:cNvSpPr>
                <p:nvPr/>
              </p:nvSpPr>
              <p:spPr bwMode="auto">
                <a:xfrm>
                  <a:off x="2668588" y="3260725"/>
                  <a:ext cx="57150" cy="9525"/>
                </a:xfrm>
                <a:prstGeom prst="rect">
                  <a:avLst/>
                </a:pr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2" name="Freeform 31"/>
                <p:cNvSpPr>
                  <a:spLocks noEditPoints="1"/>
                </p:cNvSpPr>
                <p:nvPr/>
              </p:nvSpPr>
              <p:spPr bwMode="auto">
                <a:xfrm>
                  <a:off x="3100388" y="4354513"/>
                  <a:ext cx="58738" cy="9525"/>
                </a:xfrm>
                <a:custGeom>
                  <a:avLst/>
                  <a:gdLst>
                    <a:gd name="T0" fmla="*/ 16 w 37"/>
                    <a:gd name="T1" fmla="*/ 4 h 6"/>
                    <a:gd name="T2" fmla="*/ 16 w 37"/>
                    <a:gd name="T3" fmla="*/ 3 h 6"/>
                    <a:gd name="T4" fmla="*/ 22 w 37"/>
                    <a:gd name="T5" fmla="*/ 3 h 6"/>
                    <a:gd name="T6" fmla="*/ 22 w 37"/>
                    <a:gd name="T7" fmla="*/ 4 h 6"/>
                    <a:gd name="T8" fmla="*/ 16 w 37"/>
                    <a:gd name="T9" fmla="*/ 4 h 6"/>
                    <a:gd name="T10" fmla="*/ 0 w 37"/>
                    <a:gd name="T11" fmla="*/ 0 h 6"/>
                    <a:gd name="T12" fmla="*/ 37 w 37"/>
                    <a:gd name="T13" fmla="*/ 0 h 6"/>
                    <a:gd name="T14" fmla="*/ 37 w 37"/>
                    <a:gd name="T15" fmla="*/ 6 h 6"/>
                    <a:gd name="T16" fmla="*/ 0 w 37"/>
                    <a:gd name="T17" fmla="*/ 6 h 6"/>
                    <a:gd name="T18" fmla="*/ 0 w 37"/>
                    <a:gd name="T19" fmla="*/ 0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37" h="6">
                      <a:moveTo>
                        <a:pt x="16" y="4"/>
                      </a:moveTo>
                      <a:lnTo>
                        <a:pt x="16" y="3"/>
                      </a:lnTo>
                      <a:lnTo>
                        <a:pt x="22" y="3"/>
                      </a:lnTo>
                      <a:lnTo>
                        <a:pt x="22" y="4"/>
                      </a:lnTo>
                      <a:lnTo>
                        <a:pt x="16" y="4"/>
                      </a:lnTo>
                      <a:close/>
                      <a:moveTo>
                        <a:pt x="0" y="0"/>
                      </a:moveTo>
                      <a:lnTo>
                        <a:pt x="37" y="0"/>
                      </a:lnTo>
                      <a:lnTo>
                        <a:pt x="37" y="6"/>
                      </a:lnTo>
                      <a:lnTo>
                        <a:pt x="0" y="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3" name="Freeform 32"/>
                <p:cNvSpPr>
                  <a:spLocks noEditPoints="1"/>
                </p:cNvSpPr>
                <p:nvPr/>
              </p:nvSpPr>
              <p:spPr bwMode="auto">
                <a:xfrm>
                  <a:off x="3533775" y="3051175"/>
                  <a:ext cx="57150" cy="185737"/>
                </a:xfrm>
                <a:custGeom>
                  <a:avLst/>
                  <a:gdLst>
                    <a:gd name="T0" fmla="*/ 15 w 36"/>
                    <a:gd name="T1" fmla="*/ 117 h 117"/>
                    <a:gd name="T2" fmla="*/ 15 w 36"/>
                    <a:gd name="T3" fmla="*/ 3 h 117"/>
                    <a:gd name="T4" fmla="*/ 20 w 36"/>
                    <a:gd name="T5" fmla="*/ 3 h 117"/>
                    <a:gd name="T6" fmla="*/ 20 w 36"/>
                    <a:gd name="T7" fmla="*/ 117 h 117"/>
                    <a:gd name="T8" fmla="*/ 15 w 36"/>
                    <a:gd name="T9" fmla="*/ 117 h 117"/>
                    <a:gd name="T10" fmla="*/ 0 w 36"/>
                    <a:gd name="T11" fmla="*/ 0 h 117"/>
                    <a:gd name="T12" fmla="*/ 36 w 36"/>
                    <a:gd name="T13" fmla="*/ 0 h 117"/>
                    <a:gd name="T14" fmla="*/ 36 w 36"/>
                    <a:gd name="T15" fmla="*/ 6 h 117"/>
                    <a:gd name="T16" fmla="*/ 0 w 36"/>
                    <a:gd name="T17" fmla="*/ 6 h 117"/>
                    <a:gd name="T18" fmla="*/ 0 w 36"/>
                    <a:gd name="T19" fmla="*/ 0 h 11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36" h="117">
                      <a:moveTo>
                        <a:pt x="15" y="117"/>
                      </a:moveTo>
                      <a:lnTo>
                        <a:pt x="15" y="3"/>
                      </a:lnTo>
                      <a:lnTo>
                        <a:pt x="20" y="3"/>
                      </a:lnTo>
                      <a:lnTo>
                        <a:pt x="20" y="117"/>
                      </a:lnTo>
                      <a:lnTo>
                        <a:pt x="15" y="117"/>
                      </a:lnTo>
                      <a:close/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36" y="6"/>
                      </a:lnTo>
                      <a:lnTo>
                        <a:pt x="0" y="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4" name="Freeform 33"/>
                <p:cNvSpPr>
                  <a:spLocks noEditPoints="1"/>
                </p:cNvSpPr>
                <p:nvPr/>
              </p:nvSpPr>
              <p:spPr bwMode="auto">
                <a:xfrm>
                  <a:off x="3965575" y="4022725"/>
                  <a:ext cx="57150" cy="96837"/>
                </a:xfrm>
                <a:custGeom>
                  <a:avLst/>
                  <a:gdLst>
                    <a:gd name="T0" fmla="*/ 15 w 36"/>
                    <a:gd name="T1" fmla="*/ 61 h 61"/>
                    <a:gd name="T2" fmla="*/ 15 w 36"/>
                    <a:gd name="T3" fmla="*/ 3 h 61"/>
                    <a:gd name="T4" fmla="*/ 21 w 36"/>
                    <a:gd name="T5" fmla="*/ 3 h 61"/>
                    <a:gd name="T6" fmla="*/ 21 w 36"/>
                    <a:gd name="T7" fmla="*/ 61 h 61"/>
                    <a:gd name="T8" fmla="*/ 15 w 36"/>
                    <a:gd name="T9" fmla="*/ 61 h 61"/>
                    <a:gd name="T10" fmla="*/ 0 w 36"/>
                    <a:gd name="T11" fmla="*/ 0 h 61"/>
                    <a:gd name="T12" fmla="*/ 36 w 36"/>
                    <a:gd name="T13" fmla="*/ 0 h 61"/>
                    <a:gd name="T14" fmla="*/ 36 w 36"/>
                    <a:gd name="T15" fmla="*/ 6 h 61"/>
                    <a:gd name="T16" fmla="*/ 0 w 36"/>
                    <a:gd name="T17" fmla="*/ 6 h 61"/>
                    <a:gd name="T18" fmla="*/ 0 w 36"/>
                    <a:gd name="T19" fmla="*/ 0 h 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36" h="61">
                      <a:moveTo>
                        <a:pt x="15" y="61"/>
                      </a:moveTo>
                      <a:lnTo>
                        <a:pt x="15" y="3"/>
                      </a:lnTo>
                      <a:lnTo>
                        <a:pt x="21" y="3"/>
                      </a:lnTo>
                      <a:lnTo>
                        <a:pt x="21" y="61"/>
                      </a:lnTo>
                      <a:lnTo>
                        <a:pt x="15" y="61"/>
                      </a:lnTo>
                      <a:close/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36" y="6"/>
                      </a:lnTo>
                      <a:lnTo>
                        <a:pt x="0" y="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5" name="Freeform 34"/>
                <p:cNvSpPr>
                  <a:spLocks noEditPoints="1"/>
                </p:cNvSpPr>
                <p:nvPr/>
              </p:nvSpPr>
              <p:spPr bwMode="auto">
                <a:xfrm>
                  <a:off x="4398963" y="4283075"/>
                  <a:ext cx="57150" cy="7937"/>
                </a:xfrm>
                <a:custGeom>
                  <a:avLst/>
                  <a:gdLst>
                    <a:gd name="T0" fmla="*/ 15 w 36"/>
                    <a:gd name="T1" fmla="*/ 5 h 5"/>
                    <a:gd name="T2" fmla="*/ 15 w 36"/>
                    <a:gd name="T3" fmla="*/ 3 h 5"/>
                    <a:gd name="T4" fmla="*/ 21 w 36"/>
                    <a:gd name="T5" fmla="*/ 3 h 5"/>
                    <a:gd name="T6" fmla="*/ 21 w 36"/>
                    <a:gd name="T7" fmla="*/ 5 h 5"/>
                    <a:gd name="T8" fmla="*/ 15 w 36"/>
                    <a:gd name="T9" fmla="*/ 5 h 5"/>
                    <a:gd name="T10" fmla="*/ 0 w 36"/>
                    <a:gd name="T11" fmla="*/ 0 h 5"/>
                    <a:gd name="T12" fmla="*/ 36 w 36"/>
                    <a:gd name="T13" fmla="*/ 0 h 5"/>
                    <a:gd name="T14" fmla="*/ 36 w 36"/>
                    <a:gd name="T15" fmla="*/ 5 h 5"/>
                    <a:gd name="T16" fmla="*/ 0 w 36"/>
                    <a:gd name="T17" fmla="*/ 5 h 5"/>
                    <a:gd name="T18" fmla="*/ 0 w 36"/>
                    <a:gd name="T19" fmla="*/ 0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36" h="5">
                      <a:moveTo>
                        <a:pt x="15" y="5"/>
                      </a:moveTo>
                      <a:lnTo>
                        <a:pt x="15" y="3"/>
                      </a:lnTo>
                      <a:lnTo>
                        <a:pt x="21" y="3"/>
                      </a:lnTo>
                      <a:lnTo>
                        <a:pt x="21" y="5"/>
                      </a:lnTo>
                      <a:lnTo>
                        <a:pt x="15" y="5"/>
                      </a:lnTo>
                      <a:close/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36" y="5"/>
                      </a:lnTo>
                      <a:lnTo>
                        <a:pt x="0" y="5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6" name="Freeform 35"/>
                <p:cNvSpPr>
                  <a:spLocks noEditPoints="1"/>
                </p:cNvSpPr>
                <p:nvPr/>
              </p:nvSpPr>
              <p:spPr bwMode="auto">
                <a:xfrm>
                  <a:off x="4830763" y="4195763"/>
                  <a:ext cx="57150" cy="85725"/>
                </a:xfrm>
                <a:custGeom>
                  <a:avLst/>
                  <a:gdLst>
                    <a:gd name="T0" fmla="*/ 15 w 36"/>
                    <a:gd name="T1" fmla="*/ 54 h 54"/>
                    <a:gd name="T2" fmla="*/ 15 w 36"/>
                    <a:gd name="T3" fmla="*/ 3 h 54"/>
                    <a:gd name="T4" fmla="*/ 20 w 36"/>
                    <a:gd name="T5" fmla="*/ 3 h 54"/>
                    <a:gd name="T6" fmla="*/ 20 w 36"/>
                    <a:gd name="T7" fmla="*/ 54 h 54"/>
                    <a:gd name="T8" fmla="*/ 15 w 36"/>
                    <a:gd name="T9" fmla="*/ 54 h 54"/>
                    <a:gd name="T10" fmla="*/ 0 w 36"/>
                    <a:gd name="T11" fmla="*/ 0 h 54"/>
                    <a:gd name="T12" fmla="*/ 36 w 36"/>
                    <a:gd name="T13" fmla="*/ 0 h 54"/>
                    <a:gd name="T14" fmla="*/ 36 w 36"/>
                    <a:gd name="T15" fmla="*/ 6 h 54"/>
                    <a:gd name="T16" fmla="*/ 0 w 36"/>
                    <a:gd name="T17" fmla="*/ 6 h 54"/>
                    <a:gd name="T18" fmla="*/ 0 w 36"/>
                    <a:gd name="T19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36" h="54">
                      <a:moveTo>
                        <a:pt x="15" y="54"/>
                      </a:moveTo>
                      <a:lnTo>
                        <a:pt x="15" y="3"/>
                      </a:lnTo>
                      <a:lnTo>
                        <a:pt x="20" y="3"/>
                      </a:lnTo>
                      <a:lnTo>
                        <a:pt x="20" y="54"/>
                      </a:lnTo>
                      <a:lnTo>
                        <a:pt x="15" y="54"/>
                      </a:lnTo>
                      <a:close/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36" y="6"/>
                      </a:lnTo>
                      <a:lnTo>
                        <a:pt x="0" y="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7" name="Freeform 36"/>
                <p:cNvSpPr>
                  <a:spLocks noEditPoints="1"/>
                </p:cNvSpPr>
                <p:nvPr/>
              </p:nvSpPr>
              <p:spPr bwMode="auto">
                <a:xfrm>
                  <a:off x="5262563" y="4165600"/>
                  <a:ext cx="57150" cy="71437"/>
                </a:xfrm>
                <a:custGeom>
                  <a:avLst/>
                  <a:gdLst>
                    <a:gd name="T0" fmla="*/ 15 w 36"/>
                    <a:gd name="T1" fmla="*/ 45 h 45"/>
                    <a:gd name="T2" fmla="*/ 15 w 36"/>
                    <a:gd name="T3" fmla="*/ 3 h 45"/>
                    <a:gd name="T4" fmla="*/ 21 w 36"/>
                    <a:gd name="T5" fmla="*/ 3 h 45"/>
                    <a:gd name="T6" fmla="*/ 21 w 36"/>
                    <a:gd name="T7" fmla="*/ 45 h 45"/>
                    <a:gd name="T8" fmla="*/ 15 w 36"/>
                    <a:gd name="T9" fmla="*/ 45 h 45"/>
                    <a:gd name="T10" fmla="*/ 0 w 36"/>
                    <a:gd name="T11" fmla="*/ 0 h 45"/>
                    <a:gd name="T12" fmla="*/ 36 w 36"/>
                    <a:gd name="T13" fmla="*/ 0 h 45"/>
                    <a:gd name="T14" fmla="*/ 36 w 36"/>
                    <a:gd name="T15" fmla="*/ 6 h 45"/>
                    <a:gd name="T16" fmla="*/ 0 w 36"/>
                    <a:gd name="T17" fmla="*/ 6 h 45"/>
                    <a:gd name="T18" fmla="*/ 0 w 36"/>
                    <a:gd name="T19" fmla="*/ 0 h 4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36" h="45">
                      <a:moveTo>
                        <a:pt x="15" y="45"/>
                      </a:moveTo>
                      <a:lnTo>
                        <a:pt x="15" y="3"/>
                      </a:lnTo>
                      <a:lnTo>
                        <a:pt x="21" y="3"/>
                      </a:lnTo>
                      <a:lnTo>
                        <a:pt x="21" y="45"/>
                      </a:lnTo>
                      <a:lnTo>
                        <a:pt x="15" y="45"/>
                      </a:lnTo>
                      <a:close/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36" y="6"/>
                      </a:lnTo>
                      <a:lnTo>
                        <a:pt x="0" y="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8" name="Freeform 37"/>
                <p:cNvSpPr>
                  <a:spLocks noEditPoints="1"/>
                </p:cNvSpPr>
                <p:nvPr/>
              </p:nvSpPr>
              <p:spPr bwMode="auto">
                <a:xfrm>
                  <a:off x="5695950" y="2814638"/>
                  <a:ext cx="57150" cy="320675"/>
                </a:xfrm>
                <a:custGeom>
                  <a:avLst/>
                  <a:gdLst>
                    <a:gd name="T0" fmla="*/ 15 w 36"/>
                    <a:gd name="T1" fmla="*/ 202 h 202"/>
                    <a:gd name="T2" fmla="*/ 15 w 36"/>
                    <a:gd name="T3" fmla="*/ 3 h 202"/>
                    <a:gd name="T4" fmla="*/ 21 w 36"/>
                    <a:gd name="T5" fmla="*/ 3 h 202"/>
                    <a:gd name="T6" fmla="*/ 21 w 36"/>
                    <a:gd name="T7" fmla="*/ 202 h 202"/>
                    <a:gd name="T8" fmla="*/ 15 w 36"/>
                    <a:gd name="T9" fmla="*/ 202 h 202"/>
                    <a:gd name="T10" fmla="*/ 0 w 36"/>
                    <a:gd name="T11" fmla="*/ 0 h 202"/>
                    <a:gd name="T12" fmla="*/ 36 w 36"/>
                    <a:gd name="T13" fmla="*/ 0 h 202"/>
                    <a:gd name="T14" fmla="*/ 36 w 36"/>
                    <a:gd name="T15" fmla="*/ 6 h 202"/>
                    <a:gd name="T16" fmla="*/ 0 w 36"/>
                    <a:gd name="T17" fmla="*/ 6 h 202"/>
                    <a:gd name="T18" fmla="*/ 0 w 36"/>
                    <a:gd name="T19" fmla="*/ 0 h 20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36" h="202">
                      <a:moveTo>
                        <a:pt x="15" y="202"/>
                      </a:moveTo>
                      <a:lnTo>
                        <a:pt x="15" y="3"/>
                      </a:lnTo>
                      <a:lnTo>
                        <a:pt x="21" y="3"/>
                      </a:lnTo>
                      <a:lnTo>
                        <a:pt x="21" y="202"/>
                      </a:lnTo>
                      <a:lnTo>
                        <a:pt x="15" y="202"/>
                      </a:lnTo>
                      <a:close/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36" y="6"/>
                      </a:lnTo>
                      <a:lnTo>
                        <a:pt x="0" y="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9" name="Freeform 38"/>
                <p:cNvSpPr>
                  <a:spLocks noEditPoints="1"/>
                </p:cNvSpPr>
                <p:nvPr/>
              </p:nvSpPr>
              <p:spPr bwMode="auto">
                <a:xfrm>
                  <a:off x="6127750" y="2373313"/>
                  <a:ext cx="57150" cy="76200"/>
                </a:xfrm>
                <a:custGeom>
                  <a:avLst/>
                  <a:gdLst>
                    <a:gd name="T0" fmla="*/ 15 w 36"/>
                    <a:gd name="T1" fmla="*/ 48 h 48"/>
                    <a:gd name="T2" fmla="*/ 15 w 36"/>
                    <a:gd name="T3" fmla="*/ 3 h 48"/>
                    <a:gd name="T4" fmla="*/ 20 w 36"/>
                    <a:gd name="T5" fmla="*/ 3 h 48"/>
                    <a:gd name="T6" fmla="*/ 20 w 36"/>
                    <a:gd name="T7" fmla="*/ 48 h 48"/>
                    <a:gd name="T8" fmla="*/ 15 w 36"/>
                    <a:gd name="T9" fmla="*/ 48 h 48"/>
                    <a:gd name="T10" fmla="*/ 0 w 36"/>
                    <a:gd name="T11" fmla="*/ 0 h 48"/>
                    <a:gd name="T12" fmla="*/ 36 w 36"/>
                    <a:gd name="T13" fmla="*/ 0 h 48"/>
                    <a:gd name="T14" fmla="*/ 36 w 36"/>
                    <a:gd name="T15" fmla="*/ 5 h 48"/>
                    <a:gd name="T16" fmla="*/ 0 w 36"/>
                    <a:gd name="T17" fmla="*/ 5 h 48"/>
                    <a:gd name="T18" fmla="*/ 0 w 36"/>
                    <a:gd name="T19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36" h="48">
                      <a:moveTo>
                        <a:pt x="15" y="48"/>
                      </a:moveTo>
                      <a:lnTo>
                        <a:pt x="15" y="3"/>
                      </a:lnTo>
                      <a:lnTo>
                        <a:pt x="20" y="3"/>
                      </a:lnTo>
                      <a:lnTo>
                        <a:pt x="20" y="48"/>
                      </a:lnTo>
                      <a:lnTo>
                        <a:pt x="15" y="48"/>
                      </a:lnTo>
                      <a:close/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36" y="5"/>
                      </a:lnTo>
                      <a:lnTo>
                        <a:pt x="0" y="5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0" name="Freeform 39"/>
                <p:cNvSpPr>
                  <a:spLocks noEditPoints="1"/>
                </p:cNvSpPr>
                <p:nvPr/>
              </p:nvSpPr>
              <p:spPr bwMode="auto">
                <a:xfrm>
                  <a:off x="6559550" y="3694113"/>
                  <a:ext cx="57150" cy="71437"/>
                </a:xfrm>
                <a:custGeom>
                  <a:avLst/>
                  <a:gdLst>
                    <a:gd name="T0" fmla="*/ 15 w 36"/>
                    <a:gd name="T1" fmla="*/ 45 h 45"/>
                    <a:gd name="T2" fmla="*/ 15 w 36"/>
                    <a:gd name="T3" fmla="*/ 3 h 45"/>
                    <a:gd name="T4" fmla="*/ 21 w 36"/>
                    <a:gd name="T5" fmla="*/ 3 h 45"/>
                    <a:gd name="T6" fmla="*/ 21 w 36"/>
                    <a:gd name="T7" fmla="*/ 45 h 45"/>
                    <a:gd name="T8" fmla="*/ 15 w 36"/>
                    <a:gd name="T9" fmla="*/ 45 h 45"/>
                    <a:gd name="T10" fmla="*/ 0 w 36"/>
                    <a:gd name="T11" fmla="*/ 0 h 45"/>
                    <a:gd name="T12" fmla="*/ 36 w 36"/>
                    <a:gd name="T13" fmla="*/ 0 h 45"/>
                    <a:gd name="T14" fmla="*/ 36 w 36"/>
                    <a:gd name="T15" fmla="*/ 6 h 45"/>
                    <a:gd name="T16" fmla="*/ 0 w 36"/>
                    <a:gd name="T17" fmla="*/ 6 h 45"/>
                    <a:gd name="T18" fmla="*/ 0 w 36"/>
                    <a:gd name="T19" fmla="*/ 0 h 4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36" h="45">
                      <a:moveTo>
                        <a:pt x="15" y="45"/>
                      </a:moveTo>
                      <a:lnTo>
                        <a:pt x="15" y="3"/>
                      </a:lnTo>
                      <a:lnTo>
                        <a:pt x="21" y="3"/>
                      </a:lnTo>
                      <a:lnTo>
                        <a:pt x="21" y="45"/>
                      </a:lnTo>
                      <a:lnTo>
                        <a:pt x="15" y="45"/>
                      </a:lnTo>
                      <a:close/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36" y="6"/>
                      </a:lnTo>
                      <a:lnTo>
                        <a:pt x="0" y="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1" name="Freeform 40"/>
                <p:cNvSpPr>
                  <a:spLocks noEditPoints="1"/>
                </p:cNvSpPr>
                <p:nvPr/>
              </p:nvSpPr>
              <p:spPr bwMode="auto">
                <a:xfrm>
                  <a:off x="6992938" y="4418013"/>
                  <a:ext cx="57150" cy="25400"/>
                </a:xfrm>
                <a:custGeom>
                  <a:avLst/>
                  <a:gdLst>
                    <a:gd name="T0" fmla="*/ 15 w 36"/>
                    <a:gd name="T1" fmla="*/ 16 h 16"/>
                    <a:gd name="T2" fmla="*/ 15 w 36"/>
                    <a:gd name="T3" fmla="*/ 3 h 16"/>
                    <a:gd name="T4" fmla="*/ 21 w 36"/>
                    <a:gd name="T5" fmla="*/ 3 h 16"/>
                    <a:gd name="T6" fmla="*/ 21 w 36"/>
                    <a:gd name="T7" fmla="*/ 16 h 16"/>
                    <a:gd name="T8" fmla="*/ 15 w 36"/>
                    <a:gd name="T9" fmla="*/ 16 h 16"/>
                    <a:gd name="T10" fmla="*/ 0 w 36"/>
                    <a:gd name="T11" fmla="*/ 0 h 16"/>
                    <a:gd name="T12" fmla="*/ 36 w 36"/>
                    <a:gd name="T13" fmla="*/ 0 h 16"/>
                    <a:gd name="T14" fmla="*/ 36 w 36"/>
                    <a:gd name="T15" fmla="*/ 6 h 16"/>
                    <a:gd name="T16" fmla="*/ 0 w 36"/>
                    <a:gd name="T17" fmla="*/ 6 h 16"/>
                    <a:gd name="T18" fmla="*/ 0 w 36"/>
                    <a:gd name="T19" fmla="*/ 0 h 1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36" h="16">
                      <a:moveTo>
                        <a:pt x="15" y="16"/>
                      </a:moveTo>
                      <a:lnTo>
                        <a:pt x="15" y="3"/>
                      </a:lnTo>
                      <a:lnTo>
                        <a:pt x="21" y="3"/>
                      </a:lnTo>
                      <a:lnTo>
                        <a:pt x="21" y="16"/>
                      </a:lnTo>
                      <a:lnTo>
                        <a:pt x="15" y="16"/>
                      </a:lnTo>
                      <a:close/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36" y="6"/>
                      </a:lnTo>
                      <a:lnTo>
                        <a:pt x="0" y="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2" name="Rectangle 41"/>
                <p:cNvSpPr>
                  <a:spLocks noChangeArrowheads="1"/>
                </p:cNvSpPr>
                <p:nvPr/>
              </p:nvSpPr>
              <p:spPr bwMode="auto">
                <a:xfrm>
                  <a:off x="2476500" y="2265363"/>
                  <a:ext cx="9525" cy="2251075"/>
                </a:xfrm>
                <a:prstGeom prst="rect">
                  <a:avLst/>
                </a:prstGeom>
                <a:solidFill>
                  <a:srgbClr val="868686"/>
                </a:solidFill>
                <a:ln w="1" cap="flat">
                  <a:solidFill>
                    <a:schemeClr val="tx1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3" name="Freeform 42"/>
                <p:cNvSpPr>
                  <a:spLocks noEditPoints="1"/>
                </p:cNvSpPr>
                <p:nvPr/>
              </p:nvSpPr>
              <p:spPr bwMode="auto">
                <a:xfrm>
                  <a:off x="2435225" y="2262188"/>
                  <a:ext cx="46038" cy="2257425"/>
                </a:xfrm>
                <a:custGeom>
                  <a:avLst/>
                  <a:gdLst>
                    <a:gd name="T0" fmla="*/ 0 w 29"/>
                    <a:gd name="T1" fmla="*/ 1417 h 1422"/>
                    <a:gd name="T2" fmla="*/ 29 w 29"/>
                    <a:gd name="T3" fmla="*/ 1417 h 1422"/>
                    <a:gd name="T4" fmla="*/ 29 w 29"/>
                    <a:gd name="T5" fmla="*/ 1422 h 1422"/>
                    <a:gd name="T6" fmla="*/ 0 w 29"/>
                    <a:gd name="T7" fmla="*/ 1422 h 1422"/>
                    <a:gd name="T8" fmla="*/ 0 w 29"/>
                    <a:gd name="T9" fmla="*/ 1417 h 1422"/>
                    <a:gd name="T10" fmla="*/ 0 w 29"/>
                    <a:gd name="T11" fmla="*/ 1259 h 1422"/>
                    <a:gd name="T12" fmla="*/ 29 w 29"/>
                    <a:gd name="T13" fmla="*/ 1259 h 1422"/>
                    <a:gd name="T14" fmla="*/ 29 w 29"/>
                    <a:gd name="T15" fmla="*/ 1265 h 1422"/>
                    <a:gd name="T16" fmla="*/ 0 w 29"/>
                    <a:gd name="T17" fmla="*/ 1265 h 1422"/>
                    <a:gd name="T18" fmla="*/ 0 w 29"/>
                    <a:gd name="T19" fmla="*/ 1259 h 1422"/>
                    <a:gd name="T20" fmla="*/ 0 w 29"/>
                    <a:gd name="T21" fmla="*/ 1102 h 1422"/>
                    <a:gd name="T22" fmla="*/ 29 w 29"/>
                    <a:gd name="T23" fmla="*/ 1102 h 1422"/>
                    <a:gd name="T24" fmla="*/ 29 w 29"/>
                    <a:gd name="T25" fmla="*/ 1108 h 1422"/>
                    <a:gd name="T26" fmla="*/ 0 w 29"/>
                    <a:gd name="T27" fmla="*/ 1108 h 1422"/>
                    <a:gd name="T28" fmla="*/ 0 w 29"/>
                    <a:gd name="T29" fmla="*/ 1102 h 1422"/>
                    <a:gd name="T30" fmla="*/ 0 w 29"/>
                    <a:gd name="T31" fmla="*/ 944 h 1422"/>
                    <a:gd name="T32" fmla="*/ 29 w 29"/>
                    <a:gd name="T33" fmla="*/ 944 h 1422"/>
                    <a:gd name="T34" fmla="*/ 29 w 29"/>
                    <a:gd name="T35" fmla="*/ 950 h 1422"/>
                    <a:gd name="T36" fmla="*/ 0 w 29"/>
                    <a:gd name="T37" fmla="*/ 950 h 1422"/>
                    <a:gd name="T38" fmla="*/ 0 w 29"/>
                    <a:gd name="T39" fmla="*/ 944 h 1422"/>
                    <a:gd name="T40" fmla="*/ 0 w 29"/>
                    <a:gd name="T41" fmla="*/ 787 h 1422"/>
                    <a:gd name="T42" fmla="*/ 29 w 29"/>
                    <a:gd name="T43" fmla="*/ 787 h 1422"/>
                    <a:gd name="T44" fmla="*/ 29 w 29"/>
                    <a:gd name="T45" fmla="*/ 793 h 1422"/>
                    <a:gd name="T46" fmla="*/ 0 w 29"/>
                    <a:gd name="T47" fmla="*/ 793 h 1422"/>
                    <a:gd name="T48" fmla="*/ 0 w 29"/>
                    <a:gd name="T49" fmla="*/ 787 h 1422"/>
                    <a:gd name="T50" fmla="*/ 0 w 29"/>
                    <a:gd name="T51" fmla="*/ 629 h 1422"/>
                    <a:gd name="T52" fmla="*/ 29 w 29"/>
                    <a:gd name="T53" fmla="*/ 629 h 1422"/>
                    <a:gd name="T54" fmla="*/ 29 w 29"/>
                    <a:gd name="T55" fmla="*/ 635 h 1422"/>
                    <a:gd name="T56" fmla="*/ 0 w 29"/>
                    <a:gd name="T57" fmla="*/ 635 h 1422"/>
                    <a:gd name="T58" fmla="*/ 0 w 29"/>
                    <a:gd name="T59" fmla="*/ 629 h 1422"/>
                    <a:gd name="T60" fmla="*/ 0 w 29"/>
                    <a:gd name="T61" fmla="*/ 472 h 1422"/>
                    <a:gd name="T62" fmla="*/ 29 w 29"/>
                    <a:gd name="T63" fmla="*/ 472 h 1422"/>
                    <a:gd name="T64" fmla="*/ 29 w 29"/>
                    <a:gd name="T65" fmla="*/ 478 h 1422"/>
                    <a:gd name="T66" fmla="*/ 0 w 29"/>
                    <a:gd name="T67" fmla="*/ 478 h 1422"/>
                    <a:gd name="T68" fmla="*/ 0 w 29"/>
                    <a:gd name="T69" fmla="*/ 472 h 1422"/>
                    <a:gd name="T70" fmla="*/ 0 w 29"/>
                    <a:gd name="T71" fmla="*/ 315 h 1422"/>
                    <a:gd name="T72" fmla="*/ 29 w 29"/>
                    <a:gd name="T73" fmla="*/ 315 h 1422"/>
                    <a:gd name="T74" fmla="*/ 29 w 29"/>
                    <a:gd name="T75" fmla="*/ 320 h 1422"/>
                    <a:gd name="T76" fmla="*/ 0 w 29"/>
                    <a:gd name="T77" fmla="*/ 320 h 1422"/>
                    <a:gd name="T78" fmla="*/ 0 w 29"/>
                    <a:gd name="T79" fmla="*/ 315 h 1422"/>
                    <a:gd name="T80" fmla="*/ 0 w 29"/>
                    <a:gd name="T81" fmla="*/ 157 h 1422"/>
                    <a:gd name="T82" fmla="*/ 29 w 29"/>
                    <a:gd name="T83" fmla="*/ 157 h 1422"/>
                    <a:gd name="T84" fmla="*/ 29 w 29"/>
                    <a:gd name="T85" fmla="*/ 163 h 1422"/>
                    <a:gd name="T86" fmla="*/ 0 w 29"/>
                    <a:gd name="T87" fmla="*/ 163 h 1422"/>
                    <a:gd name="T88" fmla="*/ 0 w 29"/>
                    <a:gd name="T89" fmla="*/ 157 h 1422"/>
                    <a:gd name="T90" fmla="*/ 0 w 29"/>
                    <a:gd name="T91" fmla="*/ 0 h 1422"/>
                    <a:gd name="T92" fmla="*/ 29 w 29"/>
                    <a:gd name="T93" fmla="*/ 0 h 1422"/>
                    <a:gd name="T94" fmla="*/ 29 w 29"/>
                    <a:gd name="T95" fmla="*/ 5 h 1422"/>
                    <a:gd name="T96" fmla="*/ 0 w 29"/>
                    <a:gd name="T97" fmla="*/ 5 h 1422"/>
                    <a:gd name="T98" fmla="*/ 0 w 29"/>
                    <a:gd name="T99" fmla="*/ 0 h 142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</a:cxnLst>
                  <a:rect l="0" t="0" r="r" b="b"/>
                  <a:pathLst>
                    <a:path w="29" h="1422">
                      <a:moveTo>
                        <a:pt x="0" y="1417"/>
                      </a:moveTo>
                      <a:lnTo>
                        <a:pt x="29" y="1417"/>
                      </a:lnTo>
                      <a:lnTo>
                        <a:pt x="29" y="1422"/>
                      </a:lnTo>
                      <a:lnTo>
                        <a:pt x="0" y="1422"/>
                      </a:lnTo>
                      <a:lnTo>
                        <a:pt x="0" y="1417"/>
                      </a:lnTo>
                      <a:close/>
                      <a:moveTo>
                        <a:pt x="0" y="1259"/>
                      </a:moveTo>
                      <a:lnTo>
                        <a:pt x="29" y="1259"/>
                      </a:lnTo>
                      <a:lnTo>
                        <a:pt x="29" y="1265"/>
                      </a:lnTo>
                      <a:lnTo>
                        <a:pt x="0" y="1265"/>
                      </a:lnTo>
                      <a:lnTo>
                        <a:pt x="0" y="1259"/>
                      </a:lnTo>
                      <a:close/>
                      <a:moveTo>
                        <a:pt x="0" y="1102"/>
                      </a:moveTo>
                      <a:lnTo>
                        <a:pt x="29" y="1102"/>
                      </a:lnTo>
                      <a:lnTo>
                        <a:pt x="29" y="1108"/>
                      </a:lnTo>
                      <a:lnTo>
                        <a:pt x="0" y="1108"/>
                      </a:lnTo>
                      <a:lnTo>
                        <a:pt x="0" y="1102"/>
                      </a:lnTo>
                      <a:close/>
                      <a:moveTo>
                        <a:pt x="0" y="944"/>
                      </a:moveTo>
                      <a:lnTo>
                        <a:pt x="29" y="944"/>
                      </a:lnTo>
                      <a:lnTo>
                        <a:pt x="29" y="950"/>
                      </a:lnTo>
                      <a:lnTo>
                        <a:pt x="0" y="950"/>
                      </a:lnTo>
                      <a:lnTo>
                        <a:pt x="0" y="944"/>
                      </a:lnTo>
                      <a:close/>
                      <a:moveTo>
                        <a:pt x="0" y="787"/>
                      </a:moveTo>
                      <a:lnTo>
                        <a:pt x="29" y="787"/>
                      </a:lnTo>
                      <a:lnTo>
                        <a:pt x="29" y="793"/>
                      </a:lnTo>
                      <a:lnTo>
                        <a:pt x="0" y="793"/>
                      </a:lnTo>
                      <a:lnTo>
                        <a:pt x="0" y="787"/>
                      </a:lnTo>
                      <a:close/>
                      <a:moveTo>
                        <a:pt x="0" y="629"/>
                      </a:moveTo>
                      <a:lnTo>
                        <a:pt x="29" y="629"/>
                      </a:lnTo>
                      <a:lnTo>
                        <a:pt x="29" y="635"/>
                      </a:lnTo>
                      <a:lnTo>
                        <a:pt x="0" y="635"/>
                      </a:lnTo>
                      <a:lnTo>
                        <a:pt x="0" y="629"/>
                      </a:lnTo>
                      <a:close/>
                      <a:moveTo>
                        <a:pt x="0" y="472"/>
                      </a:moveTo>
                      <a:lnTo>
                        <a:pt x="29" y="472"/>
                      </a:lnTo>
                      <a:lnTo>
                        <a:pt x="29" y="478"/>
                      </a:lnTo>
                      <a:lnTo>
                        <a:pt x="0" y="478"/>
                      </a:lnTo>
                      <a:lnTo>
                        <a:pt x="0" y="472"/>
                      </a:lnTo>
                      <a:close/>
                      <a:moveTo>
                        <a:pt x="0" y="315"/>
                      </a:moveTo>
                      <a:lnTo>
                        <a:pt x="29" y="315"/>
                      </a:lnTo>
                      <a:lnTo>
                        <a:pt x="29" y="320"/>
                      </a:lnTo>
                      <a:lnTo>
                        <a:pt x="0" y="320"/>
                      </a:lnTo>
                      <a:lnTo>
                        <a:pt x="0" y="315"/>
                      </a:lnTo>
                      <a:close/>
                      <a:moveTo>
                        <a:pt x="0" y="157"/>
                      </a:moveTo>
                      <a:lnTo>
                        <a:pt x="29" y="157"/>
                      </a:lnTo>
                      <a:lnTo>
                        <a:pt x="29" y="163"/>
                      </a:lnTo>
                      <a:lnTo>
                        <a:pt x="0" y="163"/>
                      </a:lnTo>
                      <a:lnTo>
                        <a:pt x="0" y="157"/>
                      </a:lnTo>
                      <a:close/>
                      <a:moveTo>
                        <a:pt x="0" y="0"/>
                      </a:moveTo>
                      <a:lnTo>
                        <a:pt x="29" y="0"/>
                      </a:lnTo>
                      <a:lnTo>
                        <a:pt x="29" y="5"/>
                      </a:lnTo>
                      <a:lnTo>
                        <a:pt x="0" y="5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1" cap="flat">
                  <a:solidFill>
                    <a:schemeClr val="tx1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4" name="Rectangle 43"/>
                <p:cNvSpPr>
                  <a:spLocks noChangeArrowheads="1"/>
                </p:cNvSpPr>
                <p:nvPr/>
              </p:nvSpPr>
              <p:spPr bwMode="auto">
                <a:xfrm>
                  <a:off x="2481263" y="4511675"/>
                  <a:ext cx="4756150" cy="7937"/>
                </a:xfrm>
                <a:prstGeom prst="rect">
                  <a:avLst/>
                </a:prstGeom>
                <a:solidFill>
                  <a:srgbClr val="868686"/>
                </a:solidFill>
                <a:ln w="1" cap="flat">
                  <a:solidFill>
                    <a:schemeClr val="tx1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5" name="Rectangle 44"/>
                <p:cNvSpPr>
                  <a:spLocks noChangeArrowheads="1"/>
                </p:cNvSpPr>
                <p:nvPr/>
              </p:nvSpPr>
              <p:spPr bwMode="auto">
                <a:xfrm>
                  <a:off x="2187796" y="4429126"/>
                  <a:ext cx="127422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0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16" name="Rectangle 45"/>
                <p:cNvSpPr>
                  <a:spLocks noChangeArrowheads="1"/>
                </p:cNvSpPr>
                <p:nvPr/>
              </p:nvSpPr>
              <p:spPr bwMode="auto">
                <a:xfrm>
                  <a:off x="2028750" y="4176714"/>
                  <a:ext cx="319757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0.2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17" name="Rectangle 46"/>
                <p:cNvSpPr>
                  <a:spLocks noChangeArrowheads="1"/>
                </p:cNvSpPr>
                <p:nvPr/>
              </p:nvSpPr>
              <p:spPr bwMode="auto">
                <a:xfrm>
                  <a:off x="2028750" y="3929064"/>
                  <a:ext cx="319757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0.4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18" name="Rectangle 47"/>
                <p:cNvSpPr>
                  <a:spLocks noChangeArrowheads="1"/>
                </p:cNvSpPr>
                <p:nvPr/>
              </p:nvSpPr>
              <p:spPr bwMode="auto">
                <a:xfrm>
                  <a:off x="2028750" y="3678238"/>
                  <a:ext cx="319757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0.6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19" name="Rectangle 48"/>
                <p:cNvSpPr>
                  <a:spLocks noChangeArrowheads="1"/>
                </p:cNvSpPr>
                <p:nvPr/>
              </p:nvSpPr>
              <p:spPr bwMode="auto">
                <a:xfrm>
                  <a:off x="2028750" y="3429000"/>
                  <a:ext cx="319757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0.8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20" name="Rectangle 49"/>
                <p:cNvSpPr>
                  <a:spLocks noChangeArrowheads="1"/>
                </p:cNvSpPr>
                <p:nvPr/>
              </p:nvSpPr>
              <p:spPr bwMode="auto">
                <a:xfrm>
                  <a:off x="2187796" y="3178176"/>
                  <a:ext cx="127422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1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21" name="Rectangle 50"/>
                <p:cNvSpPr>
                  <a:spLocks noChangeArrowheads="1"/>
                </p:cNvSpPr>
                <p:nvPr/>
              </p:nvSpPr>
              <p:spPr bwMode="auto">
                <a:xfrm>
                  <a:off x="2028750" y="2928938"/>
                  <a:ext cx="319757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1.2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22" name="Rectangle 51"/>
                <p:cNvSpPr>
                  <a:spLocks noChangeArrowheads="1"/>
                </p:cNvSpPr>
                <p:nvPr/>
              </p:nvSpPr>
              <p:spPr bwMode="auto">
                <a:xfrm>
                  <a:off x="2028750" y="2678114"/>
                  <a:ext cx="319757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1.4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23" name="Rectangle 52"/>
                <p:cNvSpPr>
                  <a:spLocks noChangeArrowheads="1"/>
                </p:cNvSpPr>
                <p:nvPr/>
              </p:nvSpPr>
              <p:spPr bwMode="auto">
                <a:xfrm>
                  <a:off x="2028750" y="2428875"/>
                  <a:ext cx="319757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1.6</a:t>
                  </a:r>
                  <a:endPara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24" name="Rectangle 53"/>
                <p:cNvSpPr>
                  <a:spLocks noChangeArrowheads="1"/>
                </p:cNvSpPr>
                <p:nvPr/>
              </p:nvSpPr>
              <p:spPr bwMode="auto">
                <a:xfrm>
                  <a:off x="2028750" y="2178050"/>
                  <a:ext cx="319757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1.8</a:t>
                  </a:r>
                  <a:endPara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25" name="Rectangle 54"/>
                <p:cNvSpPr>
                  <a:spLocks noChangeArrowheads="1"/>
                </p:cNvSpPr>
                <p:nvPr/>
              </p:nvSpPr>
              <p:spPr bwMode="auto">
                <a:xfrm>
                  <a:off x="2455907" y="4610101"/>
                  <a:ext cx="485645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ont</a:t>
                  </a:r>
                  <a:endPara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26" name="Rectangle 55"/>
                <p:cNvSpPr>
                  <a:spLocks noChangeArrowheads="1"/>
                </p:cNvSpPr>
                <p:nvPr/>
              </p:nvSpPr>
              <p:spPr bwMode="auto">
                <a:xfrm>
                  <a:off x="2984842" y="4610100"/>
                  <a:ext cx="293309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1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27" name="Rectangle 56"/>
                <p:cNvSpPr>
                  <a:spLocks noChangeArrowheads="1"/>
                </p:cNvSpPr>
                <p:nvPr/>
              </p:nvSpPr>
              <p:spPr bwMode="auto">
                <a:xfrm>
                  <a:off x="3416642" y="4610100"/>
                  <a:ext cx="293309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2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28" name="Rectangle 57"/>
                <p:cNvSpPr>
                  <a:spLocks noChangeArrowheads="1"/>
                </p:cNvSpPr>
                <p:nvPr/>
              </p:nvSpPr>
              <p:spPr bwMode="auto">
                <a:xfrm>
                  <a:off x="3848443" y="4610100"/>
                  <a:ext cx="293309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3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29" name="Rectangle 58"/>
                <p:cNvSpPr>
                  <a:spLocks noChangeArrowheads="1"/>
                </p:cNvSpPr>
                <p:nvPr/>
              </p:nvSpPr>
              <p:spPr bwMode="auto">
                <a:xfrm>
                  <a:off x="4281829" y="4610100"/>
                  <a:ext cx="293309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4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30" name="Rectangle 59"/>
                <p:cNvSpPr>
                  <a:spLocks noChangeArrowheads="1"/>
                </p:cNvSpPr>
                <p:nvPr/>
              </p:nvSpPr>
              <p:spPr bwMode="auto">
                <a:xfrm>
                  <a:off x="4713630" y="4610100"/>
                  <a:ext cx="293309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5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31" name="Rectangle 60"/>
                <p:cNvSpPr>
                  <a:spLocks noChangeArrowheads="1"/>
                </p:cNvSpPr>
                <p:nvPr/>
              </p:nvSpPr>
              <p:spPr bwMode="auto">
                <a:xfrm>
                  <a:off x="5145429" y="4610100"/>
                  <a:ext cx="293309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6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32" name="Rectangle 61"/>
                <p:cNvSpPr>
                  <a:spLocks noChangeArrowheads="1"/>
                </p:cNvSpPr>
                <p:nvPr/>
              </p:nvSpPr>
              <p:spPr bwMode="auto">
                <a:xfrm>
                  <a:off x="5578817" y="4610100"/>
                  <a:ext cx="293309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7</a:t>
                  </a:r>
                  <a:endPara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33" name="Rectangle 62"/>
                <p:cNvSpPr>
                  <a:spLocks noChangeArrowheads="1"/>
                </p:cNvSpPr>
                <p:nvPr/>
              </p:nvSpPr>
              <p:spPr bwMode="auto">
                <a:xfrm>
                  <a:off x="6010618" y="4610100"/>
                  <a:ext cx="293309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8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34" name="Rectangle 63"/>
                <p:cNvSpPr>
                  <a:spLocks noChangeArrowheads="1"/>
                </p:cNvSpPr>
                <p:nvPr/>
              </p:nvSpPr>
              <p:spPr bwMode="auto">
                <a:xfrm>
                  <a:off x="6442417" y="4610100"/>
                  <a:ext cx="293309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9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35" name="Rectangle 64"/>
                <p:cNvSpPr>
                  <a:spLocks noChangeArrowheads="1"/>
                </p:cNvSpPr>
                <p:nvPr/>
              </p:nvSpPr>
              <p:spPr bwMode="auto">
                <a:xfrm>
                  <a:off x="6800151" y="4610100"/>
                  <a:ext cx="653935" cy="2724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GCSE</a:t>
                  </a:r>
                  <a:endPara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36" name="Rectangle 65"/>
                <p:cNvSpPr>
                  <a:spLocks noChangeArrowheads="1"/>
                </p:cNvSpPr>
                <p:nvPr/>
              </p:nvSpPr>
              <p:spPr bwMode="auto">
                <a:xfrm rot="16200000">
                  <a:off x="573860" y="3198240"/>
                  <a:ext cx="2426657" cy="30150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Relative IL</a:t>
                  </a:r>
                  <a:r>
                    <a:rPr kumimoji="1" lang="en-US" altLang="ko-K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-</a:t>
                  </a:r>
                  <a:r>
                    <a:rPr kumimoji="1" lang="ko-KR" altLang="ko-K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4 </a:t>
                  </a:r>
                  <a:r>
                    <a:rPr kumimoji="1" lang="en-US" altLang="ko-K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expression</a:t>
                  </a:r>
                  <a:endPara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</p:grpSp>
          <p:cxnSp>
            <p:nvCxnSpPr>
              <p:cNvPr id="263" name="꺾인 연결선 262"/>
              <p:cNvCxnSpPr/>
              <p:nvPr/>
            </p:nvCxnSpPr>
            <p:spPr>
              <a:xfrm rot="5400000" flipH="1">
                <a:off x="2943086" y="1308478"/>
                <a:ext cx="720000" cy="2664000"/>
              </a:xfrm>
              <a:prstGeom prst="bentConnector3">
                <a:avLst>
                  <a:gd name="adj1" fmla="val 189023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4" name="꺾인 연결선 263"/>
              <p:cNvCxnSpPr/>
              <p:nvPr/>
            </p:nvCxnSpPr>
            <p:spPr>
              <a:xfrm rot="5400000" flipH="1">
                <a:off x="2916724" y="1026214"/>
                <a:ext cx="468000" cy="2376000"/>
              </a:xfrm>
              <a:prstGeom prst="bentConnector3">
                <a:avLst>
                  <a:gd name="adj1" fmla="val 173724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5" name="꺾인 연결선 264"/>
              <p:cNvCxnSpPr/>
              <p:nvPr/>
            </p:nvCxnSpPr>
            <p:spPr>
              <a:xfrm rot="5400000" flipH="1">
                <a:off x="2997086" y="640312"/>
                <a:ext cx="72000" cy="2124000"/>
              </a:xfrm>
              <a:prstGeom prst="bentConnector3">
                <a:avLst>
                  <a:gd name="adj1" fmla="val 138704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6" name="꺾인 연결선 265"/>
              <p:cNvCxnSpPr/>
              <p:nvPr/>
            </p:nvCxnSpPr>
            <p:spPr>
              <a:xfrm rot="5400000" flipH="1">
                <a:off x="1743086" y="2481620"/>
                <a:ext cx="720000" cy="270000"/>
              </a:xfrm>
              <a:prstGeom prst="bentConnector3">
                <a:avLst>
                  <a:gd name="adj1" fmla="val 12027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7" name="꺾인 연결선 266"/>
              <p:cNvCxnSpPr/>
              <p:nvPr/>
            </p:nvCxnSpPr>
            <p:spPr>
              <a:xfrm rot="5400000" flipH="1">
                <a:off x="2142580" y="1944230"/>
                <a:ext cx="720000" cy="1080000"/>
              </a:xfrm>
              <a:prstGeom prst="bentConnector3">
                <a:avLst>
                  <a:gd name="adj1" fmla="val 12027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8" name="꺾인 연결선 267"/>
              <p:cNvCxnSpPr/>
              <p:nvPr/>
            </p:nvCxnSpPr>
            <p:spPr>
              <a:xfrm rot="5400000" flipH="1">
                <a:off x="2079086" y="2045188"/>
                <a:ext cx="576000" cy="792000"/>
              </a:xfrm>
              <a:prstGeom prst="bentConnector3">
                <a:avLst>
                  <a:gd name="adj1" fmla="val 12027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9" name="TextBox 268"/>
              <p:cNvSpPr txBox="1"/>
              <p:nvPr/>
            </p:nvSpPr>
            <p:spPr>
              <a:xfrm>
                <a:off x="2067034" y="2939098"/>
                <a:ext cx="3626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0" name="TextBox 269"/>
              <p:cNvSpPr txBox="1"/>
              <p:nvPr/>
            </p:nvSpPr>
            <p:spPr>
              <a:xfrm>
                <a:off x="2616598" y="2711327"/>
                <a:ext cx="3032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1" name="TextBox 270"/>
              <p:cNvSpPr txBox="1"/>
              <p:nvPr/>
            </p:nvSpPr>
            <p:spPr>
              <a:xfrm>
                <a:off x="2867126" y="2881221"/>
                <a:ext cx="3626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2" name="TextBox 271"/>
              <p:cNvSpPr txBox="1"/>
              <p:nvPr/>
            </p:nvSpPr>
            <p:spPr>
              <a:xfrm>
                <a:off x="3946176" y="1605329"/>
                <a:ext cx="3032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3" name="TextBox 272"/>
              <p:cNvSpPr txBox="1"/>
              <p:nvPr/>
            </p:nvSpPr>
            <p:spPr>
              <a:xfrm>
                <a:off x="4210714" y="2495303"/>
                <a:ext cx="3032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4" name="TextBox 273"/>
              <p:cNvSpPr txBox="1"/>
              <p:nvPr/>
            </p:nvSpPr>
            <p:spPr>
              <a:xfrm>
                <a:off x="4456862" y="2970481"/>
                <a:ext cx="3626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75" name="꺾인 연결선 274"/>
              <p:cNvCxnSpPr/>
              <p:nvPr/>
            </p:nvCxnSpPr>
            <p:spPr>
              <a:xfrm rot="5400000" flipH="1">
                <a:off x="2234108" y="1799474"/>
                <a:ext cx="792000" cy="1332000"/>
              </a:xfrm>
              <a:prstGeom prst="bentConnector3">
                <a:avLst>
                  <a:gd name="adj1" fmla="val 12027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6" name="꺾인 연결선 275"/>
              <p:cNvCxnSpPr/>
              <p:nvPr/>
            </p:nvCxnSpPr>
            <p:spPr>
              <a:xfrm rot="5400000" flipH="1">
                <a:off x="2358636" y="1673562"/>
                <a:ext cx="792000" cy="1584000"/>
              </a:xfrm>
              <a:prstGeom prst="bentConnector3">
                <a:avLst>
                  <a:gd name="adj1" fmla="val 12027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7" name="TextBox 276"/>
              <p:cNvSpPr txBox="1"/>
              <p:nvPr/>
            </p:nvSpPr>
            <p:spPr>
              <a:xfrm>
                <a:off x="3154088" y="2827058"/>
                <a:ext cx="3032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8" name="TextBox 277"/>
              <p:cNvSpPr txBox="1"/>
              <p:nvPr/>
            </p:nvSpPr>
            <p:spPr>
              <a:xfrm>
                <a:off x="3413242" y="2806806"/>
                <a:ext cx="3032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38" name="그룹 337"/>
            <p:cNvGrpSpPr/>
            <p:nvPr/>
          </p:nvGrpSpPr>
          <p:grpSpPr>
            <a:xfrm>
              <a:off x="4736058" y="1115284"/>
              <a:ext cx="3643740" cy="1920295"/>
              <a:chOff x="1599808" y="2522116"/>
              <a:chExt cx="3643740" cy="1920295"/>
            </a:xfrm>
          </p:grpSpPr>
          <p:grpSp>
            <p:nvGrpSpPr>
              <p:cNvPr id="339" name="그룹 338"/>
              <p:cNvGrpSpPr/>
              <p:nvPr/>
            </p:nvGrpSpPr>
            <p:grpSpPr>
              <a:xfrm>
                <a:off x="1599808" y="2522116"/>
                <a:ext cx="3643740" cy="1920295"/>
                <a:chOff x="1529218" y="2057400"/>
                <a:chExt cx="6053958" cy="2690813"/>
              </a:xfrm>
            </p:grpSpPr>
            <p:sp>
              <p:nvSpPr>
                <p:cNvPr id="356" name="Rectangle 73"/>
                <p:cNvSpPr>
                  <a:spLocks noChangeArrowheads="1"/>
                </p:cNvSpPr>
                <p:nvPr/>
              </p:nvSpPr>
              <p:spPr bwMode="auto">
                <a:xfrm>
                  <a:off x="2571750" y="2520950"/>
                  <a:ext cx="176213" cy="18748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7" name="Freeform 74"/>
                <p:cNvSpPr>
                  <a:spLocks noEditPoints="1"/>
                </p:cNvSpPr>
                <p:nvPr/>
              </p:nvSpPr>
              <p:spPr bwMode="auto">
                <a:xfrm>
                  <a:off x="2566988" y="2516188"/>
                  <a:ext cx="184150" cy="1882775"/>
                </a:xfrm>
                <a:custGeom>
                  <a:avLst/>
                  <a:gdLst>
                    <a:gd name="T0" fmla="*/ 0 w 1936"/>
                    <a:gd name="T1" fmla="*/ 48 h 19776"/>
                    <a:gd name="T2" fmla="*/ 48 w 1936"/>
                    <a:gd name="T3" fmla="*/ 0 h 19776"/>
                    <a:gd name="T4" fmla="*/ 1888 w 1936"/>
                    <a:gd name="T5" fmla="*/ 0 h 19776"/>
                    <a:gd name="T6" fmla="*/ 1936 w 1936"/>
                    <a:gd name="T7" fmla="*/ 48 h 19776"/>
                    <a:gd name="T8" fmla="*/ 1936 w 1936"/>
                    <a:gd name="T9" fmla="*/ 19728 h 19776"/>
                    <a:gd name="T10" fmla="*/ 1888 w 1936"/>
                    <a:gd name="T11" fmla="*/ 19776 h 19776"/>
                    <a:gd name="T12" fmla="*/ 48 w 1936"/>
                    <a:gd name="T13" fmla="*/ 19776 h 19776"/>
                    <a:gd name="T14" fmla="*/ 0 w 1936"/>
                    <a:gd name="T15" fmla="*/ 19728 h 19776"/>
                    <a:gd name="T16" fmla="*/ 0 w 1936"/>
                    <a:gd name="T17" fmla="*/ 48 h 19776"/>
                    <a:gd name="T18" fmla="*/ 96 w 1936"/>
                    <a:gd name="T19" fmla="*/ 19728 h 19776"/>
                    <a:gd name="T20" fmla="*/ 48 w 1936"/>
                    <a:gd name="T21" fmla="*/ 19680 h 19776"/>
                    <a:gd name="T22" fmla="*/ 1888 w 1936"/>
                    <a:gd name="T23" fmla="*/ 19680 h 19776"/>
                    <a:gd name="T24" fmla="*/ 1840 w 1936"/>
                    <a:gd name="T25" fmla="*/ 19728 h 19776"/>
                    <a:gd name="T26" fmla="*/ 1840 w 1936"/>
                    <a:gd name="T27" fmla="*/ 48 h 19776"/>
                    <a:gd name="T28" fmla="*/ 1888 w 1936"/>
                    <a:gd name="T29" fmla="*/ 96 h 19776"/>
                    <a:gd name="T30" fmla="*/ 48 w 1936"/>
                    <a:gd name="T31" fmla="*/ 96 h 19776"/>
                    <a:gd name="T32" fmla="*/ 96 w 1936"/>
                    <a:gd name="T33" fmla="*/ 48 h 19776"/>
                    <a:gd name="T34" fmla="*/ 96 w 1936"/>
                    <a:gd name="T35" fmla="*/ 19728 h 1977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936" h="19776">
                      <a:moveTo>
                        <a:pt x="0" y="48"/>
                      </a:moveTo>
                      <a:cubicBezTo>
                        <a:pt x="0" y="22"/>
                        <a:pt x="22" y="0"/>
                        <a:pt x="48" y="0"/>
                      </a:cubicBezTo>
                      <a:lnTo>
                        <a:pt x="1888" y="0"/>
                      </a:lnTo>
                      <a:cubicBezTo>
                        <a:pt x="1915" y="0"/>
                        <a:pt x="1936" y="22"/>
                        <a:pt x="1936" y="48"/>
                      </a:cubicBezTo>
                      <a:lnTo>
                        <a:pt x="1936" y="19728"/>
                      </a:lnTo>
                      <a:cubicBezTo>
                        <a:pt x="1936" y="19755"/>
                        <a:pt x="1915" y="19776"/>
                        <a:pt x="1888" y="19776"/>
                      </a:cubicBezTo>
                      <a:lnTo>
                        <a:pt x="48" y="19776"/>
                      </a:lnTo>
                      <a:cubicBezTo>
                        <a:pt x="22" y="19776"/>
                        <a:pt x="0" y="19755"/>
                        <a:pt x="0" y="19728"/>
                      </a:cubicBezTo>
                      <a:lnTo>
                        <a:pt x="0" y="48"/>
                      </a:lnTo>
                      <a:close/>
                      <a:moveTo>
                        <a:pt x="96" y="19728"/>
                      </a:moveTo>
                      <a:lnTo>
                        <a:pt x="48" y="19680"/>
                      </a:lnTo>
                      <a:lnTo>
                        <a:pt x="1888" y="19680"/>
                      </a:lnTo>
                      <a:lnTo>
                        <a:pt x="1840" y="19728"/>
                      </a:lnTo>
                      <a:lnTo>
                        <a:pt x="1840" y="48"/>
                      </a:lnTo>
                      <a:lnTo>
                        <a:pt x="1888" y="96"/>
                      </a:lnTo>
                      <a:lnTo>
                        <a:pt x="48" y="96"/>
                      </a:lnTo>
                      <a:lnTo>
                        <a:pt x="96" y="48"/>
                      </a:lnTo>
                      <a:lnTo>
                        <a:pt x="96" y="19728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8" name="Rectangle 75"/>
                <p:cNvSpPr>
                  <a:spLocks noChangeArrowheads="1"/>
                </p:cNvSpPr>
                <p:nvPr/>
              </p:nvSpPr>
              <p:spPr bwMode="auto">
                <a:xfrm>
                  <a:off x="3013075" y="4271963"/>
                  <a:ext cx="174625" cy="123825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9" name="Freeform 76"/>
                <p:cNvSpPr>
                  <a:spLocks noEditPoints="1"/>
                </p:cNvSpPr>
                <p:nvPr/>
              </p:nvSpPr>
              <p:spPr bwMode="auto">
                <a:xfrm>
                  <a:off x="3008313" y="4267200"/>
                  <a:ext cx="184150" cy="131762"/>
                </a:xfrm>
                <a:custGeom>
                  <a:avLst/>
                  <a:gdLst>
                    <a:gd name="T0" fmla="*/ 0 w 1936"/>
                    <a:gd name="T1" fmla="*/ 48 h 1392"/>
                    <a:gd name="T2" fmla="*/ 48 w 1936"/>
                    <a:gd name="T3" fmla="*/ 0 h 1392"/>
                    <a:gd name="T4" fmla="*/ 1888 w 1936"/>
                    <a:gd name="T5" fmla="*/ 0 h 1392"/>
                    <a:gd name="T6" fmla="*/ 1936 w 1936"/>
                    <a:gd name="T7" fmla="*/ 48 h 1392"/>
                    <a:gd name="T8" fmla="*/ 1936 w 1936"/>
                    <a:gd name="T9" fmla="*/ 1344 h 1392"/>
                    <a:gd name="T10" fmla="*/ 1888 w 1936"/>
                    <a:gd name="T11" fmla="*/ 1392 h 1392"/>
                    <a:gd name="T12" fmla="*/ 48 w 1936"/>
                    <a:gd name="T13" fmla="*/ 1392 h 1392"/>
                    <a:gd name="T14" fmla="*/ 0 w 1936"/>
                    <a:gd name="T15" fmla="*/ 1344 h 1392"/>
                    <a:gd name="T16" fmla="*/ 0 w 1936"/>
                    <a:gd name="T17" fmla="*/ 48 h 1392"/>
                    <a:gd name="T18" fmla="*/ 96 w 1936"/>
                    <a:gd name="T19" fmla="*/ 1344 h 1392"/>
                    <a:gd name="T20" fmla="*/ 48 w 1936"/>
                    <a:gd name="T21" fmla="*/ 1296 h 1392"/>
                    <a:gd name="T22" fmla="*/ 1888 w 1936"/>
                    <a:gd name="T23" fmla="*/ 1296 h 1392"/>
                    <a:gd name="T24" fmla="*/ 1840 w 1936"/>
                    <a:gd name="T25" fmla="*/ 1344 h 1392"/>
                    <a:gd name="T26" fmla="*/ 1840 w 1936"/>
                    <a:gd name="T27" fmla="*/ 48 h 1392"/>
                    <a:gd name="T28" fmla="*/ 1888 w 1936"/>
                    <a:gd name="T29" fmla="*/ 96 h 1392"/>
                    <a:gd name="T30" fmla="*/ 48 w 1936"/>
                    <a:gd name="T31" fmla="*/ 96 h 1392"/>
                    <a:gd name="T32" fmla="*/ 96 w 1936"/>
                    <a:gd name="T33" fmla="*/ 48 h 1392"/>
                    <a:gd name="T34" fmla="*/ 96 w 1936"/>
                    <a:gd name="T35" fmla="*/ 1344 h 139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936" h="1392">
                      <a:moveTo>
                        <a:pt x="0" y="48"/>
                      </a:moveTo>
                      <a:cubicBezTo>
                        <a:pt x="0" y="22"/>
                        <a:pt x="22" y="0"/>
                        <a:pt x="48" y="0"/>
                      </a:cubicBezTo>
                      <a:lnTo>
                        <a:pt x="1888" y="0"/>
                      </a:lnTo>
                      <a:cubicBezTo>
                        <a:pt x="1915" y="0"/>
                        <a:pt x="1936" y="22"/>
                        <a:pt x="1936" y="48"/>
                      </a:cubicBezTo>
                      <a:lnTo>
                        <a:pt x="1936" y="1344"/>
                      </a:lnTo>
                      <a:cubicBezTo>
                        <a:pt x="1936" y="1371"/>
                        <a:pt x="1915" y="1392"/>
                        <a:pt x="1888" y="1392"/>
                      </a:cubicBezTo>
                      <a:lnTo>
                        <a:pt x="48" y="1392"/>
                      </a:lnTo>
                      <a:cubicBezTo>
                        <a:pt x="22" y="1392"/>
                        <a:pt x="0" y="1371"/>
                        <a:pt x="0" y="1344"/>
                      </a:cubicBezTo>
                      <a:lnTo>
                        <a:pt x="0" y="48"/>
                      </a:lnTo>
                      <a:close/>
                      <a:moveTo>
                        <a:pt x="96" y="1344"/>
                      </a:moveTo>
                      <a:lnTo>
                        <a:pt x="48" y="1296"/>
                      </a:lnTo>
                      <a:lnTo>
                        <a:pt x="1888" y="1296"/>
                      </a:lnTo>
                      <a:lnTo>
                        <a:pt x="1840" y="1344"/>
                      </a:lnTo>
                      <a:lnTo>
                        <a:pt x="1840" y="48"/>
                      </a:lnTo>
                      <a:lnTo>
                        <a:pt x="1888" y="96"/>
                      </a:lnTo>
                      <a:lnTo>
                        <a:pt x="48" y="96"/>
                      </a:lnTo>
                      <a:lnTo>
                        <a:pt x="96" y="48"/>
                      </a:lnTo>
                      <a:lnTo>
                        <a:pt x="96" y="1344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60" name="Rectangle 77"/>
                <p:cNvSpPr>
                  <a:spLocks noChangeArrowheads="1"/>
                </p:cNvSpPr>
                <p:nvPr/>
              </p:nvSpPr>
              <p:spPr bwMode="auto">
                <a:xfrm>
                  <a:off x="3451225" y="3214688"/>
                  <a:ext cx="176213" cy="11811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61" name="Freeform 78"/>
                <p:cNvSpPr>
                  <a:spLocks noEditPoints="1"/>
                </p:cNvSpPr>
                <p:nvPr/>
              </p:nvSpPr>
              <p:spPr bwMode="auto">
                <a:xfrm>
                  <a:off x="3446463" y="3209925"/>
                  <a:ext cx="185738" cy="1189037"/>
                </a:xfrm>
                <a:custGeom>
                  <a:avLst/>
                  <a:gdLst>
                    <a:gd name="T0" fmla="*/ 0 w 1952"/>
                    <a:gd name="T1" fmla="*/ 48 h 12496"/>
                    <a:gd name="T2" fmla="*/ 48 w 1952"/>
                    <a:gd name="T3" fmla="*/ 0 h 12496"/>
                    <a:gd name="T4" fmla="*/ 1904 w 1952"/>
                    <a:gd name="T5" fmla="*/ 0 h 12496"/>
                    <a:gd name="T6" fmla="*/ 1952 w 1952"/>
                    <a:gd name="T7" fmla="*/ 48 h 12496"/>
                    <a:gd name="T8" fmla="*/ 1952 w 1952"/>
                    <a:gd name="T9" fmla="*/ 12448 h 12496"/>
                    <a:gd name="T10" fmla="*/ 1904 w 1952"/>
                    <a:gd name="T11" fmla="*/ 12496 h 12496"/>
                    <a:gd name="T12" fmla="*/ 48 w 1952"/>
                    <a:gd name="T13" fmla="*/ 12496 h 12496"/>
                    <a:gd name="T14" fmla="*/ 0 w 1952"/>
                    <a:gd name="T15" fmla="*/ 12448 h 12496"/>
                    <a:gd name="T16" fmla="*/ 0 w 1952"/>
                    <a:gd name="T17" fmla="*/ 48 h 12496"/>
                    <a:gd name="T18" fmla="*/ 96 w 1952"/>
                    <a:gd name="T19" fmla="*/ 12448 h 12496"/>
                    <a:gd name="T20" fmla="*/ 48 w 1952"/>
                    <a:gd name="T21" fmla="*/ 12400 h 12496"/>
                    <a:gd name="T22" fmla="*/ 1904 w 1952"/>
                    <a:gd name="T23" fmla="*/ 12400 h 12496"/>
                    <a:gd name="T24" fmla="*/ 1856 w 1952"/>
                    <a:gd name="T25" fmla="*/ 12448 h 12496"/>
                    <a:gd name="T26" fmla="*/ 1856 w 1952"/>
                    <a:gd name="T27" fmla="*/ 48 h 12496"/>
                    <a:gd name="T28" fmla="*/ 1904 w 1952"/>
                    <a:gd name="T29" fmla="*/ 96 h 12496"/>
                    <a:gd name="T30" fmla="*/ 48 w 1952"/>
                    <a:gd name="T31" fmla="*/ 96 h 12496"/>
                    <a:gd name="T32" fmla="*/ 96 w 1952"/>
                    <a:gd name="T33" fmla="*/ 48 h 12496"/>
                    <a:gd name="T34" fmla="*/ 96 w 1952"/>
                    <a:gd name="T35" fmla="*/ 12448 h 1249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952" h="12496">
                      <a:moveTo>
                        <a:pt x="0" y="48"/>
                      </a:moveTo>
                      <a:cubicBezTo>
                        <a:pt x="0" y="22"/>
                        <a:pt x="22" y="0"/>
                        <a:pt x="48" y="0"/>
                      </a:cubicBezTo>
                      <a:lnTo>
                        <a:pt x="1904" y="0"/>
                      </a:lnTo>
                      <a:cubicBezTo>
                        <a:pt x="1931" y="0"/>
                        <a:pt x="1952" y="22"/>
                        <a:pt x="1952" y="48"/>
                      </a:cubicBezTo>
                      <a:lnTo>
                        <a:pt x="1952" y="12448"/>
                      </a:lnTo>
                      <a:cubicBezTo>
                        <a:pt x="1952" y="12475"/>
                        <a:pt x="1931" y="12496"/>
                        <a:pt x="1904" y="12496"/>
                      </a:cubicBezTo>
                      <a:lnTo>
                        <a:pt x="48" y="12496"/>
                      </a:lnTo>
                      <a:cubicBezTo>
                        <a:pt x="22" y="12496"/>
                        <a:pt x="0" y="12475"/>
                        <a:pt x="0" y="12448"/>
                      </a:cubicBezTo>
                      <a:lnTo>
                        <a:pt x="0" y="48"/>
                      </a:lnTo>
                      <a:close/>
                      <a:moveTo>
                        <a:pt x="96" y="12448"/>
                      </a:moveTo>
                      <a:lnTo>
                        <a:pt x="48" y="12400"/>
                      </a:lnTo>
                      <a:lnTo>
                        <a:pt x="1904" y="12400"/>
                      </a:lnTo>
                      <a:lnTo>
                        <a:pt x="1856" y="12448"/>
                      </a:lnTo>
                      <a:lnTo>
                        <a:pt x="1856" y="48"/>
                      </a:lnTo>
                      <a:lnTo>
                        <a:pt x="1904" y="96"/>
                      </a:lnTo>
                      <a:lnTo>
                        <a:pt x="48" y="96"/>
                      </a:lnTo>
                      <a:lnTo>
                        <a:pt x="96" y="48"/>
                      </a:lnTo>
                      <a:lnTo>
                        <a:pt x="96" y="12448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62" name="Rectangle 79"/>
                <p:cNvSpPr>
                  <a:spLocks noChangeArrowheads="1"/>
                </p:cNvSpPr>
                <p:nvPr/>
              </p:nvSpPr>
              <p:spPr bwMode="auto">
                <a:xfrm>
                  <a:off x="3890963" y="3970338"/>
                  <a:ext cx="177800" cy="42545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63" name="Freeform 80"/>
                <p:cNvSpPr>
                  <a:spLocks noEditPoints="1"/>
                </p:cNvSpPr>
                <p:nvPr/>
              </p:nvSpPr>
              <p:spPr bwMode="auto">
                <a:xfrm>
                  <a:off x="3887788" y="3965575"/>
                  <a:ext cx="185738" cy="433387"/>
                </a:xfrm>
                <a:custGeom>
                  <a:avLst/>
                  <a:gdLst>
                    <a:gd name="T0" fmla="*/ 0 w 1952"/>
                    <a:gd name="T1" fmla="*/ 48 h 4560"/>
                    <a:gd name="T2" fmla="*/ 48 w 1952"/>
                    <a:gd name="T3" fmla="*/ 0 h 4560"/>
                    <a:gd name="T4" fmla="*/ 1904 w 1952"/>
                    <a:gd name="T5" fmla="*/ 0 h 4560"/>
                    <a:gd name="T6" fmla="*/ 1952 w 1952"/>
                    <a:gd name="T7" fmla="*/ 48 h 4560"/>
                    <a:gd name="T8" fmla="*/ 1952 w 1952"/>
                    <a:gd name="T9" fmla="*/ 4512 h 4560"/>
                    <a:gd name="T10" fmla="*/ 1904 w 1952"/>
                    <a:gd name="T11" fmla="*/ 4560 h 4560"/>
                    <a:gd name="T12" fmla="*/ 48 w 1952"/>
                    <a:gd name="T13" fmla="*/ 4560 h 4560"/>
                    <a:gd name="T14" fmla="*/ 0 w 1952"/>
                    <a:gd name="T15" fmla="*/ 4512 h 4560"/>
                    <a:gd name="T16" fmla="*/ 0 w 1952"/>
                    <a:gd name="T17" fmla="*/ 48 h 4560"/>
                    <a:gd name="T18" fmla="*/ 96 w 1952"/>
                    <a:gd name="T19" fmla="*/ 4512 h 4560"/>
                    <a:gd name="T20" fmla="*/ 48 w 1952"/>
                    <a:gd name="T21" fmla="*/ 4464 h 4560"/>
                    <a:gd name="T22" fmla="*/ 1904 w 1952"/>
                    <a:gd name="T23" fmla="*/ 4464 h 4560"/>
                    <a:gd name="T24" fmla="*/ 1856 w 1952"/>
                    <a:gd name="T25" fmla="*/ 4512 h 4560"/>
                    <a:gd name="T26" fmla="*/ 1856 w 1952"/>
                    <a:gd name="T27" fmla="*/ 48 h 4560"/>
                    <a:gd name="T28" fmla="*/ 1904 w 1952"/>
                    <a:gd name="T29" fmla="*/ 96 h 4560"/>
                    <a:gd name="T30" fmla="*/ 48 w 1952"/>
                    <a:gd name="T31" fmla="*/ 96 h 4560"/>
                    <a:gd name="T32" fmla="*/ 96 w 1952"/>
                    <a:gd name="T33" fmla="*/ 48 h 4560"/>
                    <a:gd name="T34" fmla="*/ 96 w 1952"/>
                    <a:gd name="T35" fmla="*/ 4512 h 456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952" h="4560">
                      <a:moveTo>
                        <a:pt x="0" y="48"/>
                      </a:moveTo>
                      <a:cubicBezTo>
                        <a:pt x="0" y="22"/>
                        <a:pt x="22" y="0"/>
                        <a:pt x="48" y="0"/>
                      </a:cubicBezTo>
                      <a:lnTo>
                        <a:pt x="1904" y="0"/>
                      </a:lnTo>
                      <a:cubicBezTo>
                        <a:pt x="1931" y="0"/>
                        <a:pt x="1952" y="22"/>
                        <a:pt x="1952" y="48"/>
                      </a:cubicBezTo>
                      <a:lnTo>
                        <a:pt x="1952" y="4512"/>
                      </a:lnTo>
                      <a:cubicBezTo>
                        <a:pt x="1952" y="4539"/>
                        <a:pt x="1931" y="4560"/>
                        <a:pt x="1904" y="4560"/>
                      </a:cubicBezTo>
                      <a:lnTo>
                        <a:pt x="48" y="4560"/>
                      </a:lnTo>
                      <a:cubicBezTo>
                        <a:pt x="22" y="4560"/>
                        <a:pt x="0" y="4539"/>
                        <a:pt x="0" y="4512"/>
                      </a:cubicBezTo>
                      <a:lnTo>
                        <a:pt x="0" y="48"/>
                      </a:lnTo>
                      <a:close/>
                      <a:moveTo>
                        <a:pt x="96" y="4512"/>
                      </a:moveTo>
                      <a:lnTo>
                        <a:pt x="48" y="4464"/>
                      </a:lnTo>
                      <a:lnTo>
                        <a:pt x="1904" y="4464"/>
                      </a:lnTo>
                      <a:lnTo>
                        <a:pt x="1856" y="4512"/>
                      </a:lnTo>
                      <a:lnTo>
                        <a:pt x="1856" y="48"/>
                      </a:lnTo>
                      <a:lnTo>
                        <a:pt x="1904" y="96"/>
                      </a:lnTo>
                      <a:lnTo>
                        <a:pt x="48" y="96"/>
                      </a:lnTo>
                      <a:lnTo>
                        <a:pt x="96" y="48"/>
                      </a:lnTo>
                      <a:lnTo>
                        <a:pt x="96" y="451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64" name="Rectangle 81"/>
                <p:cNvSpPr>
                  <a:spLocks noChangeArrowheads="1"/>
                </p:cNvSpPr>
                <p:nvPr/>
              </p:nvSpPr>
              <p:spPr bwMode="auto">
                <a:xfrm>
                  <a:off x="4332288" y="4110038"/>
                  <a:ext cx="176213" cy="28575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65" name="Freeform 82"/>
                <p:cNvSpPr>
                  <a:spLocks noEditPoints="1"/>
                </p:cNvSpPr>
                <p:nvPr/>
              </p:nvSpPr>
              <p:spPr bwMode="auto">
                <a:xfrm>
                  <a:off x="4327525" y="4105275"/>
                  <a:ext cx="185738" cy="293687"/>
                </a:xfrm>
                <a:custGeom>
                  <a:avLst/>
                  <a:gdLst>
                    <a:gd name="T0" fmla="*/ 0 w 1952"/>
                    <a:gd name="T1" fmla="*/ 48 h 3088"/>
                    <a:gd name="T2" fmla="*/ 48 w 1952"/>
                    <a:gd name="T3" fmla="*/ 0 h 3088"/>
                    <a:gd name="T4" fmla="*/ 1904 w 1952"/>
                    <a:gd name="T5" fmla="*/ 0 h 3088"/>
                    <a:gd name="T6" fmla="*/ 1952 w 1952"/>
                    <a:gd name="T7" fmla="*/ 48 h 3088"/>
                    <a:gd name="T8" fmla="*/ 1952 w 1952"/>
                    <a:gd name="T9" fmla="*/ 3040 h 3088"/>
                    <a:gd name="T10" fmla="*/ 1904 w 1952"/>
                    <a:gd name="T11" fmla="*/ 3088 h 3088"/>
                    <a:gd name="T12" fmla="*/ 48 w 1952"/>
                    <a:gd name="T13" fmla="*/ 3088 h 3088"/>
                    <a:gd name="T14" fmla="*/ 0 w 1952"/>
                    <a:gd name="T15" fmla="*/ 3040 h 3088"/>
                    <a:gd name="T16" fmla="*/ 0 w 1952"/>
                    <a:gd name="T17" fmla="*/ 48 h 3088"/>
                    <a:gd name="T18" fmla="*/ 96 w 1952"/>
                    <a:gd name="T19" fmla="*/ 3040 h 3088"/>
                    <a:gd name="T20" fmla="*/ 48 w 1952"/>
                    <a:gd name="T21" fmla="*/ 2992 h 3088"/>
                    <a:gd name="T22" fmla="*/ 1904 w 1952"/>
                    <a:gd name="T23" fmla="*/ 2992 h 3088"/>
                    <a:gd name="T24" fmla="*/ 1856 w 1952"/>
                    <a:gd name="T25" fmla="*/ 3040 h 3088"/>
                    <a:gd name="T26" fmla="*/ 1856 w 1952"/>
                    <a:gd name="T27" fmla="*/ 48 h 3088"/>
                    <a:gd name="T28" fmla="*/ 1904 w 1952"/>
                    <a:gd name="T29" fmla="*/ 96 h 3088"/>
                    <a:gd name="T30" fmla="*/ 48 w 1952"/>
                    <a:gd name="T31" fmla="*/ 96 h 3088"/>
                    <a:gd name="T32" fmla="*/ 96 w 1952"/>
                    <a:gd name="T33" fmla="*/ 48 h 3088"/>
                    <a:gd name="T34" fmla="*/ 96 w 1952"/>
                    <a:gd name="T35" fmla="*/ 3040 h 308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952" h="3088">
                      <a:moveTo>
                        <a:pt x="0" y="48"/>
                      </a:moveTo>
                      <a:cubicBezTo>
                        <a:pt x="0" y="22"/>
                        <a:pt x="22" y="0"/>
                        <a:pt x="48" y="0"/>
                      </a:cubicBezTo>
                      <a:lnTo>
                        <a:pt x="1904" y="0"/>
                      </a:lnTo>
                      <a:cubicBezTo>
                        <a:pt x="1931" y="0"/>
                        <a:pt x="1952" y="22"/>
                        <a:pt x="1952" y="48"/>
                      </a:cubicBezTo>
                      <a:lnTo>
                        <a:pt x="1952" y="3040"/>
                      </a:lnTo>
                      <a:cubicBezTo>
                        <a:pt x="1952" y="3067"/>
                        <a:pt x="1931" y="3088"/>
                        <a:pt x="1904" y="3088"/>
                      </a:cubicBezTo>
                      <a:lnTo>
                        <a:pt x="48" y="3088"/>
                      </a:lnTo>
                      <a:cubicBezTo>
                        <a:pt x="22" y="3088"/>
                        <a:pt x="0" y="3067"/>
                        <a:pt x="0" y="3040"/>
                      </a:cubicBezTo>
                      <a:lnTo>
                        <a:pt x="0" y="48"/>
                      </a:lnTo>
                      <a:close/>
                      <a:moveTo>
                        <a:pt x="96" y="3040"/>
                      </a:moveTo>
                      <a:lnTo>
                        <a:pt x="48" y="2992"/>
                      </a:lnTo>
                      <a:lnTo>
                        <a:pt x="1904" y="2992"/>
                      </a:lnTo>
                      <a:lnTo>
                        <a:pt x="1856" y="3040"/>
                      </a:lnTo>
                      <a:lnTo>
                        <a:pt x="1856" y="48"/>
                      </a:lnTo>
                      <a:lnTo>
                        <a:pt x="1904" y="96"/>
                      </a:lnTo>
                      <a:lnTo>
                        <a:pt x="48" y="96"/>
                      </a:lnTo>
                      <a:lnTo>
                        <a:pt x="96" y="48"/>
                      </a:lnTo>
                      <a:lnTo>
                        <a:pt x="96" y="304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66" name="Rectangle 83"/>
                <p:cNvSpPr>
                  <a:spLocks noChangeArrowheads="1"/>
                </p:cNvSpPr>
                <p:nvPr/>
              </p:nvSpPr>
              <p:spPr bwMode="auto">
                <a:xfrm>
                  <a:off x="4772025" y="4222750"/>
                  <a:ext cx="176213" cy="17303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67" name="Freeform 84"/>
                <p:cNvSpPr>
                  <a:spLocks noEditPoints="1"/>
                </p:cNvSpPr>
                <p:nvPr/>
              </p:nvSpPr>
              <p:spPr bwMode="auto">
                <a:xfrm>
                  <a:off x="4767263" y="4217988"/>
                  <a:ext cx="184150" cy="180975"/>
                </a:xfrm>
                <a:custGeom>
                  <a:avLst/>
                  <a:gdLst>
                    <a:gd name="T0" fmla="*/ 0 w 968"/>
                    <a:gd name="T1" fmla="*/ 24 h 952"/>
                    <a:gd name="T2" fmla="*/ 24 w 968"/>
                    <a:gd name="T3" fmla="*/ 0 h 952"/>
                    <a:gd name="T4" fmla="*/ 944 w 968"/>
                    <a:gd name="T5" fmla="*/ 0 h 952"/>
                    <a:gd name="T6" fmla="*/ 968 w 968"/>
                    <a:gd name="T7" fmla="*/ 24 h 952"/>
                    <a:gd name="T8" fmla="*/ 968 w 968"/>
                    <a:gd name="T9" fmla="*/ 928 h 952"/>
                    <a:gd name="T10" fmla="*/ 944 w 968"/>
                    <a:gd name="T11" fmla="*/ 952 h 952"/>
                    <a:gd name="T12" fmla="*/ 24 w 968"/>
                    <a:gd name="T13" fmla="*/ 952 h 952"/>
                    <a:gd name="T14" fmla="*/ 0 w 968"/>
                    <a:gd name="T15" fmla="*/ 928 h 952"/>
                    <a:gd name="T16" fmla="*/ 0 w 968"/>
                    <a:gd name="T17" fmla="*/ 24 h 952"/>
                    <a:gd name="T18" fmla="*/ 48 w 968"/>
                    <a:gd name="T19" fmla="*/ 928 h 952"/>
                    <a:gd name="T20" fmla="*/ 24 w 968"/>
                    <a:gd name="T21" fmla="*/ 904 h 952"/>
                    <a:gd name="T22" fmla="*/ 944 w 968"/>
                    <a:gd name="T23" fmla="*/ 904 h 952"/>
                    <a:gd name="T24" fmla="*/ 920 w 968"/>
                    <a:gd name="T25" fmla="*/ 928 h 952"/>
                    <a:gd name="T26" fmla="*/ 920 w 968"/>
                    <a:gd name="T27" fmla="*/ 24 h 952"/>
                    <a:gd name="T28" fmla="*/ 944 w 968"/>
                    <a:gd name="T29" fmla="*/ 48 h 952"/>
                    <a:gd name="T30" fmla="*/ 24 w 968"/>
                    <a:gd name="T31" fmla="*/ 48 h 952"/>
                    <a:gd name="T32" fmla="*/ 48 w 968"/>
                    <a:gd name="T33" fmla="*/ 24 h 952"/>
                    <a:gd name="T34" fmla="*/ 48 w 968"/>
                    <a:gd name="T35" fmla="*/ 928 h 95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968" h="952">
                      <a:moveTo>
                        <a:pt x="0" y="24"/>
                      </a:moveTo>
                      <a:cubicBezTo>
                        <a:pt x="0" y="11"/>
                        <a:pt x="11" y="0"/>
                        <a:pt x="24" y="0"/>
                      </a:cubicBezTo>
                      <a:lnTo>
                        <a:pt x="944" y="0"/>
                      </a:lnTo>
                      <a:cubicBezTo>
                        <a:pt x="958" y="0"/>
                        <a:pt x="968" y="11"/>
                        <a:pt x="968" y="24"/>
                      </a:cubicBezTo>
                      <a:lnTo>
                        <a:pt x="968" y="928"/>
                      </a:lnTo>
                      <a:cubicBezTo>
                        <a:pt x="968" y="942"/>
                        <a:pt x="958" y="952"/>
                        <a:pt x="944" y="952"/>
                      </a:cubicBezTo>
                      <a:lnTo>
                        <a:pt x="24" y="952"/>
                      </a:lnTo>
                      <a:cubicBezTo>
                        <a:pt x="11" y="952"/>
                        <a:pt x="0" y="942"/>
                        <a:pt x="0" y="928"/>
                      </a:cubicBezTo>
                      <a:lnTo>
                        <a:pt x="0" y="24"/>
                      </a:lnTo>
                      <a:close/>
                      <a:moveTo>
                        <a:pt x="48" y="928"/>
                      </a:moveTo>
                      <a:lnTo>
                        <a:pt x="24" y="904"/>
                      </a:lnTo>
                      <a:lnTo>
                        <a:pt x="944" y="904"/>
                      </a:lnTo>
                      <a:lnTo>
                        <a:pt x="920" y="928"/>
                      </a:lnTo>
                      <a:lnTo>
                        <a:pt x="920" y="24"/>
                      </a:lnTo>
                      <a:lnTo>
                        <a:pt x="944" y="48"/>
                      </a:lnTo>
                      <a:lnTo>
                        <a:pt x="24" y="48"/>
                      </a:lnTo>
                      <a:lnTo>
                        <a:pt x="48" y="24"/>
                      </a:lnTo>
                      <a:lnTo>
                        <a:pt x="48" y="928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68" name="Rectangle 85"/>
                <p:cNvSpPr>
                  <a:spLocks noChangeArrowheads="1"/>
                </p:cNvSpPr>
                <p:nvPr/>
              </p:nvSpPr>
              <p:spPr bwMode="auto">
                <a:xfrm>
                  <a:off x="5213350" y="3783013"/>
                  <a:ext cx="174625" cy="612775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69" name="Freeform 86"/>
                <p:cNvSpPr>
                  <a:spLocks noEditPoints="1"/>
                </p:cNvSpPr>
                <p:nvPr/>
              </p:nvSpPr>
              <p:spPr bwMode="auto">
                <a:xfrm>
                  <a:off x="5208588" y="3778250"/>
                  <a:ext cx="184150" cy="620712"/>
                </a:xfrm>
                <a:custGeom>
                  <a:avLst/>
                  <a:gdLst>
                    <a:gd name="T0" fmla="*/ 0 w 968"/>
                    <a:gd name="T1" fmla="*/ 24 h 3264"/>
                    <a:gd name="T2" fmla="*/ 24 w 968"/>
                    <a:gd name="T3" fmla="*/ 0 h 3264"/>
                    <a:gd name="T4" fmla="*/ 944 w 968"/>
                    <a:gd name="T5" fmla="*/ 0 h 3264"/>
                    <a:gd name="T6" fmla="*/ 968 w 968"/>
                    <a:gd name="T7" fmla="*/ 24 h 3264"/>
                    <a:gd name="T8" fmla="*/ 968 w 968"/>
                    <a:gd name="T9" fmla="*/ 3240 h 3264"/>
                    <a:gd name="T10" fmla="*/ 944 w 968"/>
                    <a:gd name="T11" fmla="*/ 3264 h 3264"/>
                    <a:gd name="T12" fmla="*/ 24 w 968"/>
                    <a:gd name="T13" fmla="*/ 3264 h 3264"/>
                    <a:gd name="T14" fmla="*/ 0 w 968"/>
                    <a:gd name="T15" fmla="*/ 3240 h 3264"/>
                    <a:gd name="T16" fmla="*/ 0 w 968"/>
                    <a:gd name="T17" fmla="*/ 24 h 3264"/>
                    <a:gd name="T18" fmla="*/ 48 w 968"/>
                    <a:gd name="T19" fmla="*/ 3240 h 3264"/>
                    <a:gd name="T20" fmla="*/ 24 w 968"/>
                    <a:gd name="T21" fmla="*/ 3216 h 3264"/>
                    <a:gd name="T22" fmla="*/ 944 w 968"/>
                    <a:gd name="T23" fmla="*/ 3216 h 3264"/>
                    <a:gd name="T24" fmla="*/ 920 w 968"/>
                    <a:gd name="T25" fmla="*/ 3240 h 3264"/>
                    <a:gd name="T26" fmla="*/ 920 w 968"/>
                    <a:gd name="T27" fmla="*/ 24 h 3264"/>
                    <a:gd name="T28" fmla="*/ 944 w 968"/>
                    <a:gd name="T29" fmla="*/ 48 h 3264"/>
                    <a:gd name="T30" fmla="*/ 24 w 968"/>
                    <a:gd name="T31" fmla="*/ 48 h 3264"/>
                    <a:gd name="T32" fmla="*/ 48 w 968"/>
                    <a:gd name="T33" fmla="*/ 24 h 3264"/>
                    <a:gd name="T34" fmla="*/ 48 w 968"/>
                    <a:gd name="T35" fmla="*/ 3240 h 326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968" h="3264">
                      <a:moveTo>
                        <a:pt x="0" y="24"/>
                      </a:moveTo>
                      <a:cubicBezTo>
                        <a:pt x="0" y="11"/>
                        <a:pt x="11" y="0"/>
                        <a:pt x="24" y="0"/>
                      </a:cubicBezTo>
                      <a:lnTo>
                        <a:pt x="944" y="0"/>
                      </a:lnTo>
                      <a:cubicBezTo>
                        <a:pt x="958" y="0"/>
                        <a:pt x="968" y="11"/>
                        <a:pt x="968" y="24"/>
                      </a:cubicBezTo>
                      <a:lnTo>
                        <a:pt x="968" y="3240"/>
                      </a:lnTo>
                      <a:cubicBezTo>
                        <a:pt x="968" y="3254"/>
                        <a:pt x="958" y="3264"/>
                        <a:pt x="944" y="3264"/>
                      </a:cubicBezTo>
                      <a:lnTo>
                        <a:pt x="24" y="3264"/>
                      </a:lnTo>
                      <a:cubicBezTo>
                        <a:pt x="11" y="3264"/>
                        <a:pt x="0" y="3254"/>
                        <a:pt x="0" y="3240"/>
                      </a:cubicBezTo>
                      <a:lnTo>
                        <a:pt x="0" y="24"/>
                      </a:lnTo>
                      <a:close/>
                      <a:moveTo>
                        <a:pt x="48" y="3240"/>
                      </a:moveTo>
                      <a:lnTo>
                        <a:pt x="24" y="3216"/>
                      </a:lnTo>
                      <a:lnTo>
                        <a:pt x="944" y="3216"/>
                      </a:lnTo>
                      <a:lnTo>
                        <a:pt x="920" y="3240"/>
                      </a:lnTo>
                      <a:lnTo>
                        <a:pt x="920" y="24"/>
                      </a:lnTo>
                      <a:lnTo>
                        <a:pt x="944" y="48"/>
                      </a:lnTo>
                      <a:lnTo>
                        <a:pt x="24" y="48"/>
                      </a:lnTo>
                      <a:lnTo>
                        <a:pt x="48" y="24"/>
                      </a:lnTo>
                      <a:lnTo>
                        <a:pt x="48" y="324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0" name="Rectangle 87"/>
                <p:cNvSpPr>
                  <a:spLocks noChangeArrowheads="1"/>
                </p:cNvSpPr>
                <p:nvPr/>
              </p:nvSpPr>
              <p:spPr bwMode="auto">
                <a:xfrm>
                  <a:off x="5651500" y="2576513"/>
                  <a:ext cx="176213" cy="1819275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1" name="Freeform 88"/>
                <p:cNvSpPr>
                  <a:spLocks noEditPoints="1"/>
                </p:cNvSpPr>
                <p:nvPr/>
              </p:nvSpPr>
              <p:spPr bwMode="auto">
                <a:xfrm>
                  <a:off x="5646738" y="2571750"/>
                  <a:ext cx="185738" cy="1827212"/>
                </a:xfrm>
                <a:custGeom>
                  <a:avLst/>
                  <a:gdLst>
                    <a:gd name="T0" fmla="*/ 0 w 976"/>
                    <a:gd name="T1" fmla="*/ 24 h 9592"/>
                    <a:gd name="T2" fmla="*/ 24 w 976"/>
                    <a:gd name="T3" fmla="*/ 0 h 9592"/>
                    <a:gd name="T4" fmla="*/ 952 w 976"/>
                    <a:gd name="T5" fmla="*/ 0 h 9592"/>
                    <a:gd name="T6" fmla="*/ 976 w 976"/>
                    <a:gd name="T7" fmla="*/ 24 h 9592"/>
                    <a:gd name="T8" fmla="*/ 976 w 976"/>
                    <a:gd name="T9" fmla="*/ 9568 h 9592"/>
                    <a:gd name="T10" fmla="*/ 952 w 976"/>
                    <a:gd name="T11" fmla="*/ 9592 h 9592"/>
                    <a:gd name="T12" fmla="*/ 24 w 976"/>
                    <a:gd name="T13" fmla="*/ 9592 h 9592"/>
                    <a:gd name="T14" fmla="*/ 0 w 976"/>
                    <a:gd name="T15" fmla="*/ 9568 h 9592"/>
                    <a:gd name="T16" fmla="*/ 0 w 976"/>
                    <a:gd name="T17" fmla="*/ 24 h 9592"/>
                    <a:gd name="T18" fmla="*/ 48 w 976"/>
                    <a:gd name="T19" fmla="*/ 9568 h 9592"/>
                    <a:gd name="T20" fmla="*/ 24 w 976"/>
                    <a:gd name="T21" fmla="*/ 9544 h 9592"/>
                    <a:gd name="T22" fmla="*/ 952 w 976"/>
                    <a:gd name="T23" fmla="*/ 9544 h 9592"/>
                    <a:gd name="T24" fmla="*/ 928 w 976"/>
                    <a:gd name="T25" fmla="*/ 9568 h 9592"/>
                    <a:gd name="T26" fmla="*/ 928 w 976"/>
                    <a:gd name="T27" fmla="*/ 24 h 9592"/>
                    <a:gd name="T28" fmla="*/ 952 w 976"/>
                    <a:gd name="T29" fmla="*/ 48 h 9592"/>
                    <a:gd name="T30" fmla="*/ 24 w 976"/>
                    <a:gd name="T31" fmla="*/ 48 h 9592"/>
                    <a:gd name="T32" fmla="*/ 48 w 976"/>
                    <a:gd name="T33" fmla="*/ 24 h 9592"/>
                    <a:gd name="T34" fmla="*/ 48 w 976"/>
                    <a:gd name="T35" fmla="*/ 9568 h 959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976" h="9592">
                      <a:moveTo>
                        <a:pt x="0" y="24"/>
                      </a:moveTo>
                      <a:cubicBezTo>
                        <a:pt x="0" y="11"/>
                        <a:pt x="11" y="0"/>
                        <a:pt x="24" y="0"/>
                      </a:cubicBezTo>
                      <a:lnTo>
                        <a:pt x="952" y="0"/>
                      </a:lnTo>
                      <a:cubicBezTo>
                        <a:pt x="966" y="0"/>
                        <a:pt x="976" y="11"/>
                        <a:pt x="976" y="24"/>
                      </a:cubicBezTo>
                      <a:lnTo>
                        <a:pt x="976" y="9568"/>
                      </a:lnTo>
                      <a:cubicBezTo>
                        <a:pt x="976" y="9582"/>
                        <a:pt x="966" y="9592"/>
                        <a:pt x="952" y="9592"/>
                      </a:cubicBezTo>
                      <a:lnTo>
                        <a:pt x="24" y="9592"/>
                      </a:lnTo>
                      <a:cubicBezTo>
                        <a:pt x="11" y="9592"/>
                        <a:pt x="0" y="9582"/>
                        <a:pt x="0" y="9568"/>
                      </a:cubicBezTo>
                      <a:lnTo>
                        <a:pt x="0" y="24"/>
                      </a:lnTo>
                      <a:close/>
                      <a:moveTo>
                        <a:pt x="48" y="9568"/>
                      </a:moveTo>
                      <a:lnTo>
                        <a:pt x="24" y="9544"/>
                      </a:lnTo>
                      <a:lnTo>
                        <a:pt x="952" y="9544"/>
                      </a:lnTo>
                      <a:lnTo>
                        <a:pt x="928" y="9568"/>
                      </a:lnTo>
                      <a:lnTo>
                        <a:pt x="928" y="24"/>
                      </a:lnTo>
                      <a:lnTo>
                        <a:pt x="952" y="48"/>
                      </a:lnTo>
                      <a:lnTo>
                        <a:pt x="24" y="48"/>
                      </a:lnTo>
                      <a:lnTo>
                        <a:pt x="48" y="24"/>
                      </a:lnTo>
                      <a:lnTo>
                        <a:pt x="48" y="9568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2" name="Rectangle 89"/>
                <p:cNvSpPr>
                  <a:spLocks noChangeArrowheads="1"/>
                </p:cNvSpPr>
                <p:nvPr/>
              </p:nvSpPr>
              <p:spPr bwMode="auto">
                <a:xfrm>
                  <a:off x="6092825" y="2406650"/>
                  <a:ext cx="176213" cy="198913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3" name="Freeform 90"/>
                <p:cNvSpPr>
                  <a:spLocks noEditPoints="1"/>
                </p:cNvSpPr>
                <p:nvPr/>
              </p:nvSpPr>
              <p:spPr bwMode="auto">
                <a:xfrm>
                  <a:off x="6088063" y="2401888"/>
                  <a:ext cx="185738" cy="1997075"/>
                </a:xfrm>
                <a:custGeom>
                  <a:avLst/>
                  <a:gdLst>
                    <a:gd name="T0" fmla="*/ 0 w 976"/>
                    <a:gd name="T1" fmla="*/ 24 h 10488"/>
                    <a:gd name="T2" fmla="*/ 24 w 976"/>
                    <a:gd name="T3" fmla="*/ 0 h 10488"/>
                    <a:gd name="T4" fmla="*/ 952 w 976"/>
                    <a:gd name="T5" fmla="*/ 0 h 10488"/>
                    <a:gd name="T6" fmla="*/ 976 w 976"/>
                    <a:gd name="T7" fmla="*/ 24 h 10488"/>
                    <a:gd name="T8" fmla="*/ 976 w 976"/>
                    <a:gd name="T9" fmla="*/ 10464 h 10488"/>
                    <a:gd name="T10" fmla="*/ 952 w 976"/>
                    <a:gd name="T11" fmla="*/ 10488 h 10488"/>
                    <a:gd name="T12" fmla="*/ 24 w 976"/>
                    <a:gd name="T13" fmla="*/ 10488 h 10488"/>
                    <a:gd name="T14" fmla="*/ 0 w 976"/>
                    <a:gd name="T15" fmla="*/ 10464 h 10488"/>
                    <a:gd name="T16" fmla="*/ 0 w 976"/>
                    <a:gd name="T17" fmla="*/ 24 h 10488"/>
                    <a:gd name="T18" fmla="*/ 48 w 976"/>
                    <a:gd name="T19" fmla="*/ 10464 h 10488"/>
                    <a:gd name="T20" fmla="*/ 24 w 976"/>
                    <a:gd name="T21" fmla="*/ 10440 h 10488"/>
                    <a:gd name="T22" fmla="*/ 952 w 976"/>
                    <a:gd name="T23" fmla="*/ 10440 h 10488"/>
                    <a:gd name="T24" fmla="*/ 928 w 976"/>
                    <a:gd name="T25" fmla="*/ 10464 h 10488"/>
                    <a:gd name="T26" fmla="*/ 928 w 976"/>
                    <a:gd name="T27" fmla="*/ 24 h 10488"/>
                    <a:gd name="T28" fmla="*/ 952 w 976"/>
                    <a:gd name="T29" fmla="*/ 48 h 10488"/>
                    <a:gd name="T30" fmla="*/ 24 w 976"/>
                    <a:gd name="T31" fmla="*/ 48 h 10488"/>
                    <a:gd name="T32" fmla="*/ 48 w 976"/>
                    <a:gd name="T33" fmla="*/ 24 h 10488"/>
                    <a:gd name="T34" fmla="*/ 48 w 976"/>
                    <a:gd name="T35" fmla="*/ 10464 h 1048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976" h="10488">
                      <a:moveTo>
                        <a:pt x="0" y="24"/>
                      </a:moveTo>
                      <a:cubicBezTo>
                        <a:pt x="0" y="11"/>
                        <a:pt x="11" y="0"/>
                        <a:pt x="24" y="0"/>
                      </a:cubicBezTo>
                      <a:lnTo>
                        <a:pt x="952" y="0"/>
                      </a:lnTo>
                      <a:cubicBezTo>
                        <a:pt x="966" y="0"/>
                        <a:pt x="976" y="11"/>
                        <a:pt x="976" y="24"/>
                      </a:cubicBezTo>
                      <a:lnTo>
                        <a:pt x="976" y="10464"/>
                      </a:lnTo>
                      <a:cubicBezTo>
                        <a:pt x="976" y="10478"/>
                        <a:pt x="966" y="10488"/>
                        <a:pt x="952" y="10488"/>
                      </a:cubicBezTo>
                      <a:lnTo>
                        <a:pt x="24" y="10488"/>
                      </a:lnTo>
                      <a:cubicBezTo>
                        <a:pt x="11" y="10488"/>
                        <a:pt x="0" y="10478"/>
                        <a:pt x="0" y="10464"/>
                      </a:cubicBezTo>
                      <a:lnTo>
                        <a:pt x="0" y="24"/>
                      </a:lnTo>
                      <a:close/>
                      <a:moveTo>
                        <a:pt x="48" y="10464"/>
                      </a:moveTo>
                      <a:lnTo>
                        <a:pt x="24" y="10440"/>
                      </a:lnTo>
                      <a:lnTo>
                        <a:pt x="952" y="10440"/>
                      </a:lnTo>
                      <a:lnTo>
                        <a:pt x="928" y="10464"/>
                      </a:lnTo>
                      <a:lnTo>
                        <a:pt x="928" y="24"/>
                      </a:lnTo>
                      <a:lnTo>
                        <a:pt x="952" y="48"/>
                      </a:lnTo>
                      <a:lnTo>
                        <a:pt x="24" y="48"/>
                      </a:lnTo>
                      <a:lnTo>
                        <a:pt x="48" y="24"/>
                      </a:lnTo>
                      <a:lnTo>
                        <a:pt x="48" y="10464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4" name="Rectangle 91"/>
                <p:cNvSpPr>
                  <a:spLocks noChangeArrowheads="1"/>
                </p:cNvSpPr>
                <p:nvPr/>
              </p:nvSpPr>
              <p:spPr bwMode="auto">
                <a:xfrm>
                  <a:off x="6532563" y="3798888"/>
                  <a:ext cx="174625" cy="5969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5" name="Freeform 92"/>
                <p:cNvSpPr>
                  <a:spLocks noEditPoints="1"/>
                </p:cNvSpPr>
                <p:nvPr/>
              </p:nvSpPr>
              <p:spPr bwMode="auto">
                <a:xfrm>
                  <a:off x="6527800" y="3794125"/>
                  <a:ext cx="184150" cy="604837"/>
                </a:xfrm>
                <a:custGeom>
                  <a:avLst/>
                  <a:gdLst>
                    <a:gd name="T0" fmla="*/ 0 w 968"/>
                    <a:gd name="T1" fmla="*/ 24 h 3176"/>
                    <a:gd name="T2" fmla="*/ 24 w 968"/>
                    <a:gd name="T3" fmla="*/ 0 h 3176"/>
                    <a:gd name="T4" fmla="*/ 944 w 968"/>
                    <a:gd name="T5" fmla="*/ 0 h 3176"/>
                    <a:gd name="T6" fmla="*/ 968 w 968"/>
                    <a:gd name="T7" fmla="*/ 24 h 3176"/>
                    <a:gd name="T8" fmla="*/ 968 w 968"/>
                    <a:gd name="T9" fmla="*/ 3152 h 3176"/>
                    <a:gd name="T10" fmla="*/ 944 w 968"/>
                    <a:gd name="T11" fmla="*/ 3176 h 3176"/>
                    <a:gd name="T12" fmla="*/ 24 w 968"/>
                    <a:gd name="T13" fmla="*/ 3176 h 3176"/>
                    <a:gd name="T14" fmla="*/ 0 w 968"/>
                    <a:gd name="T15" fmla="*/ 3152 h 3176"/>
                    <a:gd name="T16" fmla="*/ 0 w 968"/>
                    <a:gd name="T17" fmla="*/ 24 h 3176"/>
                    <a:gd name="T18" fmla="*/ 48 w 968"/>
                    <a:gd name="T19" fmla="*/ 3152 h 3176"/>
                    <a:gd name="T20" fmla="*/ 24 w 968"/>
                    <a:gd name="T21" fmla="*/ 3128 h 3176"/>
                    <a:gd name="T22" fmla="*/ 944 w 968"/>
                    <a:gd name="T23" fmla="*/ 3128 h 3176"/>
                    <a:gd name="T24" fmla="*/ 920 w 968"/>
                    <a:gd name="T25" fmla="*/ 3152 h 3176"/>
                    <a:gd name="T26" fmla="*/ 920 w 968"/>
                    <a:gd name="T27" fmla="*/ 24 h 3176"/>
                    <a:gd name="T28" fmla="*/ 944 w 968"/>
                    <a:gd name="T29" fmla="*/ 48 h 3176"/>
                    <a:gd name="T30" fmla="*/ 24 w 968"/>
                    <a:gd name="T31" fmla="*/ 48 h 3176"/>
                    <a:gd name="T32" fmla="*/ 48 w 968"/>
                    <a:gd name="T33" fmla="*/ 24 h 3176"/>
                    <a:gd name="T34" fmla="*/ 48 w 968"/>
                    <a:gd name="T35" fmla="*/ 3152 h 317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968" h="3176">
                      <a:moveTo>
                        <a:pt x="0" y="24"/>
                      </a:moveTo>
                      <a:cubicBezTo>
                        <a:pt x="0" y="11"/>
                        <a:pt x="11" y="0"/>
                        <a:pt x="24" y="0"/>
                      </a:cubicBezTo>
                      <a:lnTo>
                        <a:pt x="944" y="0"/>
                      </a:lnTo>
                      <a:cubicBezTo>
                        <a:pt x="958" y="0"/>
                        <a:pt x="968" y="11"/>
                        <a:pt x="968" y="24"/>
                      </a:cubicBezTo>
                      <a:lnTo>
                        <a:pt x="968" y="3152"/>
                      </a:lnTo>
                      <a:cubicBezTo>
                        <a:pt x="968" y="3166"/>
                        <a:pt x="958" y="3176"/>
                        <a:pt x="944" y="3176"/>
                      </a:cubicBezTo>
                      <a:lnTo>
                        <a:pt x="24" y="3176"/>
                      </a:lnTo>
                      <a:cubicBezTo>
                        <a:pt x="11" y="3176"/>
                        <a:pt x="0" y="3166"/>
                        <a:pt x="0" y="3152"/>
                      </a:cubicBezTo>
                      <a:lnTo>
                        <a:pt x="0" y="24"/>
                      </a:lnTo>
                      <a:close/>
                      <a:moveTo>
                        <a:pt x="48" y="3152"/>
                      </a:moveTo>
                      <a:lnTo>
                        <a:pt x="24" y="3128"/>
                      </a:lnTo>
                      <a:lnTo>
                        <a:pt x="944" y="3128"/>
                      </a:lnTo>
                      <a:lnTo>
                        <a:pt x="920" y="3152"/>
                      </a:lnTo>
                      <a:lnTo>
                        <a:pt x="920" y="24"/>
                      </a:lnTo>
                      <a:lnTo>
                        <a:pt x="944" y="48"/>
                      </a:lnTo>
                      <a:lnTo>
                        <a:pt x="24" y="48"/>
                      </a:lnTo>
                      <a:lnTo>
                        <a:pt x="48" y="24"/>
                      </a:lnTo>
                      <a:lnTo>
                        <a:pt x="48" y="315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6" name="Rectangle 93"/>
                <p:cNvSpPr>
                  <a:spLocks noChangeArrowheads="1"/>
                </p:cNvSpPr>
                <p:nvPr/>
              </p:nvSpPr>
              <p:spPr bwMode="auto">
                <a:xfrm>
                  <a:off x="6972300" y="4248150"/>
                  <a:ext cx="176213" cy="147637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7" name="Freeform 94"/>
                <p:cNvSpPr>
                  <a:spLocks noEditPoints="1"/>
                </p:cNvSpPr>
                <p:nvPr/>
              </p:nvSpPr>
              <p:spPr bwMode="auto">
                <a:xfrm>
                  <a:off x="6967538" y="4244975"/>
                  <a:ext cx="185738" cy="153987"/>
                </a:xfrm>
                <a:custGeom>
                  <a:avLst/>
                  <a:gdLst>
                    <a:gd name="T0" fmla="*/ 0 w 968"/>
                    <a:gd name="T1" fmla="*/ 24 h 816"/>
                    <a:gd name="T2" fmla="*/ 24 w 968"/>
                    <a:gd name="T3" fmla="*/ 0 h 816"/>
                    <a:gd name="T4" fmla="*/ 944 w 968"/>
                    <a:gd name="T5" fmla="*/ 0 h 816"/>
                    <a:gd name="T6" fmla="*/ 968 w 968"/>
                    <a:gd name="T7" fmla="*/ 24 h 816"/>
                    <a:gd name="T8" fmla="*/ 968 w 968"/>
                    <a:gd name="T9" fmla="*/ 792 h 816"/>
                    <a:gd name="T10" fmla="*/ 944 w 968"/>
                    <a:gd name="T11" fmla="*/ 816 h 816"/>
                    <a:gd name="T12" fmla="*/ 24 w 968"/>
                    <a:gd name="T13" fmla="*/ 816 h 816"/>
                    <a:gd name="T14" fmla="*/ 0 w 968"/>
                    <a:gd name="T15" fmla="*/ 792 h 816"/>
                    <a:gd name="T16" fmla="*/ 0 w 968"/>
                    <a:gd name="T17" fmla="*/ 24 h 816"/>
                    <a:gd name="T18" fmla="*/ 48 w 968"/>
                    <a:gd name="T19" fmla="*/ 792 h 816"/>
                    <a:gd name="T20" fmla="*/ 24 w 968"/>
                    <a:gd name="T21" fmla="*/ 768 h 816"/>
                    <a:gd name="T22" fmla="*/ 944 w 968"/>
                    <a:gd name="T23" fmla="*/ 768 h 816"/>
                    <a:gd name="T24" fmla="*/ 920 w 968"/>
                    <a:gd name="T25" fmla="*/ 792 h 816"/>
                    <a:gd name="T26" fmla="*/ 920 w 968"/>
                    <a:gd name="T27" fmla="*/ 24 h 816"/>
                    <a:gd name="T28" fmla="*/ 944 w 968"/>
                    <a:gd name="T29" fmla="*/ 48 h 816"/>
                    <a:gd name="T30" fmla="*/ 24 w 968"/>
                    <a:gd name="T31" fmla="*/ 48 h 816"/>
                    <a:gd name="T32" fmla="*/ 48 w 968"/>
                    <a:gd name="T33" fmla="*/ 24 h 816"/>
                    <a:gd name="T34" fmla="*/ 48 w 968"/>
                    <a:gd name="T35" fmla="*/ 792 h 81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968" h="816">
                      <a:moveTo>
                        <a:pt x="0" y="24"/>
                      </a:moveTo>
                      <a:cubicBezTo>
                        <a:pt x="0" y="11"/>
                        <a:pt x="11" y="0"/>
                        <a:pt x="24" y="0"/>
                      </a:cubicBezTo>
                      <a:lnTo>
                        <a:pt x="944" y="0"/>
                      </a:lnTo>
                      <a:cubicBezTo>
                        <a:pt x="958" y="0"/>
                        <a:pt x="968" y="11"/>
                        <a:pt x="968" y="24"/>
                      </a:cubicBezTo>
                      <a:lnTo>
                        <a:pt x="968" y="792"/>
                      </a:lnTo>
                      <a:cubicBezTo>
                        <a:pt x="968" y="806"/>
                        <a:pt x="958" y="816"/>
                        <a:pt x="944" y="816"/>
                      </a:cubicBezTo>
                      <a:lnTo>
                        <a:pt x="24" y="816"/>
                      </a:lnTo>
                      <a:cubicBezTo>
                        <a:pt x="11" y="816"/>
                        <a:pt x="0" y="806"/>
                        <a:pt x="0" y="792"/>
                      </a:cubicBezTo>
                      <a:lnTo>
                        <a:pt x="0" y="24"/>
                      </a:lnTo>
                      <a:close/>
                      <a:moveTo>
                        <a:pt x="48" y="792"/>
                      </a:moveTo>
                      <a:lnTo>
                        <a:pt x="24" y="768"/>
                      </a:lnTo>
                      <a:lnTo>
                        <a:pt x="944" y="768"/>
                      </a:lnTo>
                      <a:lnTo>
                        <a:pt x="920" y="792"/>
                      </a:lnTo>
                      <a:lnTo>
                        <a:pt x="920" y="24"/>
                      </a:lnTo>
                      <a:lnTo>
                        <a:pt x="944" y="48"/>
                      </a:lnTo>
                      <a:lnTo>
                        <a:pt x="24" y="48"/>
                      </a:lnTo>
                      <a:lnTo>
                        <a:pt x="48" y="24"/>
                      </a:lnTo>
                      <a:lnTo>
                        <a:pt x="48" y="79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8" name="Rectangle 95"/>
                <p:cNvSpPr>
                  <a:spLocks noChangeArrowheads="1"/>
                </p:cNvSpPr>
                <p:nvPr/>
              </p:nvSpPr>
              <p:spPr bwMode="auto">
                <a:xfrm>
                  <a:off x="2435225" y="2144713"/>
                  <a:ext cx="7938" cy="2251075"/>
                </a:xfrm>
                <a:prstGeom prst="rect">
                  <a:avLst/>
                </a:prstGeom>
                <a:solidFill>
                  <a:srgbClr val="868686"/>
                </a:solidFill>
                <a:ln w="1" cap="flat">
                  <a:solidFill>
                    <a:schemeClr val="tx1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79" name="Freeform 96"/>
                <p:cNvSpPr>
                  <a:spLocks noEditPoints="1"/>
                </p:cNvSpPr>
                <p:nvPr/>
              </p:nvSpPr>
              <p:spPr bwMode="auto">
                <a:xfrm>
                  <a:off x="2393950" y="2141538"/>
                  <a:ext cx="46038" cy="2257425"/>
                </a:xfrm>
                <a:custGeom>
                  <a:avLst/>
                  <a:gdLst>
                    <a:gd name="T0" fmla="*/ 0 w 29"/>
                    <a:gd name="T1" fmla="*/ 1417 h 1422"/>
                    <a:gd name="T2" fmla="*/ 29 w 29"/>
                    <a:gd name="T3" fmla="*/ 1417 h 1422"/>
                    <a:gd name="T4" fmla="*/ 29 w 29"/>
                    <a:gd name="T5" fmla="*/ 1422 h 1422"/>
                    <a:gd name="T6" fmla="*/ 0 w 29"/>
                    <a:gd name="T7" fmla="*/ 1422 h 1422"/>
                    <a:gd name="T8" fmla="*/ 0 w 29"/>
                    <a:gd name="T9" fmla="*/ 1417 h 1422"/>
                    <a:gd name="T10" fmla="*/ 0 w 29"/>
                    <a:gd name="T11" fmla="*/ 1181 h 1422"/>
                    <a:gd name="T12" fmla="*/ 29 w 29"/>
                    <a:gd name="T13" fmla="*/ 1181 h 1422"/>
                    <a:gd name="T14" fmla="*/ 29 w 29"/>
                    <a:gd name="T15" fmla="*/ 1186 h 1422"/>
                    <a:gd name="T16" fmla="*/ 0 w 29"/>
                    <a:gd name="T17" fmla="*/ 1186 h 1422"/>
                    <a:gd name="T18" fmla="*/ 0 w 29"/>
                    <a:gd name="T19" fmla="*/ 1181 h 1422"/>
                    <a:gd name="T20" fmla="*/ 0 w 29"/>
                    <a:gd name="T21" fmla="*/ 944 h 1422"/>
                    <a:gd name="T22" fmla="*/ 29 w 29"/>
                    <a:gd name="T23" fmla="*/ 944 h 1422"/>
                    <a:gd name="T24" fmla="*/ 29 w 29"/>
                    <a:gd name="T25" fmla="*/ 950 h 1422"/>
                    <a:gd name="T26" fmla="*/ 0 w 29"/>
                    <a:gd name="T27" fmla="*/ 950 h 1422"/>
                    <a:gd name="T28" fmla="*/ 0 w 29"/>
                    <a:gd name="T29" fmla="*/ 944 h 1422"/>
                    <a:gd name="T30" fmla="*/ 0 w 29"/>
                    <a:gd name="T31" fmla="*/ 708 h 1422"/>
                    <a:gd name="T32" fmla="*/ 29 w 29"/>
                    <a:gd name="T33" fmla="*/ 708 h 1422"/>
                    <a:gd name="T34" fmla="*/ 29 w 29"/>
                    <a:gd name="T35" fmla="*/ 714 h 1422"/>
                    <a:gd name="T36" fmla="*/ 0 w 29"/>
                    <a:gd name="T37" fmla="*/ 714 h 1422"/>
                    <a:gd name="T38" fmla="*/ 0 w 29"/>
                    <a:gd name="T39" fmla="*/ 708 h 1422"/>
                    <a:gd name="T40" fmla="*/ 0 w 29"/>
                    <a:gd name="T41" fmla="*/ 472 h 1422"/>
                    <a:gd name="T42" fmla="*/ 29 w 29"/>
                    <a:gd name="T43" fmla="*/ 472 h 1422"/>
                    <a:gd name="T44" fmla="*/ 29 w 29"/>
                    <a:gd name="T45" fmla="*/ 478 h 1422"/>
                    <a:gd name="T46" fmla="*/ 0 w 29"/>
                    <a:gd name="T47" fmla="*/ 478 h 1422"/>
                    <a:gd name="T48" fmla="*/ 0 w 29"/>
                    <a:gd name="T49" fmla="*/ 472 h 1422"/>
                    <a:gd name="T50" fmla="*/ 0 w 29"/>
                    <a:gd name="T51" fmla="*/ 236 h 1422"/>
                    <a:gd name="T52" fmla="*/ 29 w 29"/>
                    <a:gd name="T53" fmla="*/ 236 h 1422"/>
                    <a:gd name="T54" fmla="*/ 29 w 29"/>
                    <a:gd name="T55" fmla="*/ 242 h 1422"/>
                    <a:gd name="T56" fmla="*/ 0 w 29"/>
                    <a:gd name="T57" fmla="*/ 242 h 1422"/>
                    <a:gd name="T58" fmla="*/ 0 w 29"/>
                    <a:gd name="T59" fmla="*/ 236 h 1422"/>
                    <a:gd name="T60" fmla="*/ 0 w 29"/>
                    <a:gd name="T61" fmla="*/ 0 h 1422"/>
                    <a:gd name="T62" fmla="*/ 29 w 29"/>
                    <a:gd name="T63" fmla="*/ 0 h 1422"/>
                    <a:gd name="T64" fmla="*/ 29 w 29"/>
                    <a:gd name="T65" fmla="*/ 5 h 1422"/>
                    <a:gd name="T66" fmla="*/ 0 w 29"/>
                    <a:gd name="T67" fmla="*/ 5 h 1422"/>
                    <a:gd name="T68" fmla="*/ 0 w 29"/>
                    <a:gd name="T69" fmla="*/ 0 h 142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</a:cxnLst>
                  <a:rect l="0" t="0" r="r" b="b"/>
                  <a:pathLst>
                    <a:path w="29" h="1422">
                      <a:moveTo>
                        <a:pt x="0" y="1417"/>
                      </a:moveTo>
                      <a:lnTo>
                        <a:pt x="29" y="1417"/>
                      </a:lnTo>
                      <a:lnTo>
                        <a:pt x="29" y="1422"/>
                      </a:lnTo>
                      <a:lnTo>
                        <a:pt x="0" y="1422"/>
                      </a:lnTo>
                      <a:lnTo>
                        <a:pt x="0" y="1417"/>
                      </a:lnTo>
                      <a:close/>
                      <a:moveTo>
                        <a:pt x="0" y="1181"/>
                      </a:moveTo>
                      <a:lnTo>
                        <a:pt x="29" y="1181"/>
                      </a:lnTo>
                      <a:lnTo>
                        <a:pt x="29" y="1186"/>
                      </a:lnTo>
                      <a:lnTo>
                        <a:pt x="0" y="1186"/>
                      </a:lnTo>
                      <a:lnTo>
                        <a:pt x="0" y="1181"/>
                      </a:lnTo>
                      <a:close/>
                      <a:moveTo>
                        <a:pt x="0" y="944"/>
                      </a:moveTo>
                      <a:lnTo>
                        <a:pt x="29" y="944"/>
                      </a:lnTo>
                      <a:lnTo>
                        <a:pt x="29" y="950"/>
                      </a:lnTo>
                      <a:lnTo>
                        <a:pt x="0" y="950"/>
                      </a:lnTo>
                      <a:lnTo>
                        <a:pt x="0" y="944"/>
                      </a:lnTo>
                      <a:close/>
                      <a:moveTo>
                        <a:pt x="0" y="708"/>
                      </a:moveTo>
                      <a:lnTo>
                        <a:pt x="29" y="708"/>
                      </a:lnTo>
                      <a:lnTo>
                        <a:pt x="29" y="714"/>
                      </a:lnTo>
                      <a:lnTo>
                        <a:pt x="0" y="714"/>
                      </a:lnTo>
                      <a:lnTo>
                        <a:pt x="0" y="708"/>
                      </a:lnTo>
                      <a:close/>
                      <a:moveTo>
                        <a:pt x="0" y="472"/>
                      </a:moveTo>
                      <a:lnTo>
                        <a:pt x="29" y="472"/>
                      </a:lnTo>
                      <a:lnTo>
                        <a:pt x="29" y="478"/>
                      </a:lnTo>
                      <a:lnTo>
                        <a:pt x="0" y="478"/>
                      </a:lnTo>
                      <a:lnTo>
                        <a:pt x="0" y="472"/>
                      </a:lnTo>
                      <a:close/>
                      <a:moveTo>
                        <a:pt x="0" y="236"/>
                      </a:moveTo>
                      <a:lnTo>
                        <a:pt x="29" y="236"/>
                      </a:lnTo>
                      <a:lnTo>
                        <a:pt x="29" y="242"/>
                      </a:lnTo>
                      <a:lnTo>
                        <a:pt x="0" y="242"/>
                      </a:lnTo>
                      <a:lnTo>
                        <a:pt x="0" y="236"/>
                      </a:lnTo>
                      <a:close/>
                      <a:moveTo>
                        <a:pt x="0" y="0"/>
                      </a:moveTo>
                      <a:lnTo>
                        <a:pt x="29" y="0"/>
                      </a:lnTo>
                      <a:lnTo>
                        <a:pt x="29" y="5"/>
                      </a:lnTo>
                      <a:lnTo>
                        <a:pt x="0" y="5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1" cap="flat">
                  <a:solidFill>
                    <a:schemeClr val="tx1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80" name="Rectangle 97"/>
                <p:cNvSpPr>
                  <a:spLocks noChangeArrowheads="1"/>
                </p:cNvSpPr>
                <p:nvPr/>
              </p:nvSpPr>
              <p:spPr bwMode="auto">
                <a:xfrm>
                  <a:off x="2439988" y="4391025"/>
                  <a:ext cx="4840288" cy="7937"/>
                </a:xfrm>
                <a:prstGeom prst="rect">
                  <a:avLst/>
                </a:prstGeom>
                <a:solidFill>
                  <a:srgbClr val="868686"/>
                </a:solidFill>
                <a:ln w="1" cap="flat">
                  <a:solidFill>
                    <a:schemeClr val="tx1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81" name="Rectangle 98"/>
                <p:cNvSpPr>
                  <a:spLocks noChangeArrowheads="1"/>
                </p:cNvSpPr>
                <p:nvPr/>
              </p:nvSpPr>
              <p:spPr bwMode="auto">
                <a:xfrm>
                  <a:off x="2109997" y="4305300"/>
                  <a:ext cx="141158" cy="2587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0</a:t>
                  </a:r>
                  <a:endParaRPr kumimoji="1" lang="ko-KR" altLang="ko-KR" sz="12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82" name="Rectangle 99"/>
                <p:cNvSpPr>
                  <a:spLocks noChangeArrowheads="1"/>
                </p:cNvSpPr>
                <p:nvPr/>
              </p:nvSpPr>
              <p:spPr bwMode="auto">
                <a:xfrm>
                  <a:off x="1940584" y="3932238"/>
                  <a:ext cx="354225" cy="2587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0.2</a:t>
                  </a:r>
                  <a:endParaRPr kumimoji="1" lang="ko-KR" altLang="ko-KR" sz="12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83" name="Rectangle 100"/>
                <p:cNvSpPr>
                  <a:spLocks noChangeArrowheads="1"/>
                </p:cNvSpPr>
                <p:nvPr/>
              </p:nvSpPr>
              <p:spPr bwMode="auto">
                <a:xfrm>
                  <a:off x="1940584" y="3557588"/>
                  <a:ext cx="354225" cy="2587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0.4</a:t>
                  </a:r>
                  <a:endParaRPr kumimoji="1" lang="ko-KR" altLang="ko-KR" sz="12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84" name="Rectangle 101"/>
                <p:cNvSpPr>
                  <a:spLocks noChangeArrowheads="1"/>
                </p:cNvSpPr>
                <p:nvPr/>
              </p:nvSpPr>
              <p:spPr bwMode="auto">
                <a:xfrm>
                  <a:off x="1940584" y="3182938"/>
                  <a:ext cx="354225" cy="2587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0.6</a:t>
                  </a:r>
                  <a:endParaRPr kumimoji="1" lang="ko-KR" altLang="ko-KR" sz="12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85" name="Rectangle 102"/>
                <p:cNvSpPr>
                  <a:spLocks noChangeArrowheads="1"/>
                </p:cNvSpPr>
                <p:nvPr/>
              </p:nvSpPr>
              <p:spPr bwMode="auto">
                <a:xfrm>
                  <a:off x="1940584" y="2806700"/>
                  <a:ext cx="354225" cy="2587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0.8</a:t>
                  </a:r>
                  <a:endParaRPr kumimoji="1" lang="ko-KR" altLang="ko-KR" sz="12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86" name="Rectangle 103"/>
                <p:cNvSpPr>
                  <a:spLocks noChangeArrowheads="1"/>
                </p:cNvSpPr>
                <p:nvPr/>
              </p:nvSpPr>
              <p:spPr bwMode="auto">
                <a:xfrm>
                  <a:off x="2109997" y="2432049"/>
                  <a:ext cx="141158" cy="2587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1</a:t>
                  </a:r>
                  <a:endParaRPr kumimoji="1" lang="ko-KR" altLang="ko-KR" sz="12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87" name="Rectangle 104"/>
                <p:cNvSpPr>
                  <a:spLocks noChangeArrowheads="1"/>
                </p:cNvSpPr>
                <p:nvPr/>
              </p:nvSpPr>
              <p:spPr bwMode="auto">
                <a:xfrm>
                  <a:off x="1940584" y="2057400"/>
                  <a:ext cx="354225" cy="2587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1.2</a:t>
                  </a:r>
                  <a:endParaRPr kumimoji="1" lang="ko-KR" altLang="ko-KR" sz="12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88" name="Rectangle 105"/>
                <p:cNvSpPr>
                  <a:spLocks noChangeArrowheads="1"/>
                </p:cNvSpPr>
                <p:nvPr/>
              </p:nvSpPr>
              <p:spPr bwMode="auto">
                <a:xfrm>
                  <a:off x="2393219" y="4489450"/>
                  <a:ext cx="537995" cy="2587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ont</a:t>
                  </a:r>
                  <a:endParaRPr kumimoji="1" lang="ko-KR" altLang="ko-KR" sz="12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89" name="Rectangle 106"/>
                <p:cNvSpPr>
                  <a:spLocks noChangeArrowheads="1"/>
                </p:cNvSpPr>
                <p:nvPr/>
              </p:nvSpPr>
              <p:spPr bwMode="auto">
                <a:xfrm>
                  <a:off x="2938872" y="4489450"/>
                  <a:ext cx="324926" cy="2587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1</a:t>
                  </a:r>
                  <a:endParaRPr kumimoji="1" lang="ko-KR" altLang="ko-KR" sz="12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90" name="Rectangle 107"/>
                <p:cNvSpPr>
                  <a:spLocks noChangeArrowheads="1"/>
                </p:cNvSpPr>
                <p:nvPr/>
              </p:nvSpPr>
              <p:spPr bwMode="auto">
                <a:xfrm>
                  <a:off x="3378609" y="4489450"/>
                  <a:ext cx="324926" cy="2587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2</a:t>
                  </a:r>
                  <a:endParaRPr kumimoji="1" lang="ko-KR" altLang="ko-KR" sz="12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91" name="Rectangle 108"/>
                <p:cNvSpPr>
                  <a:spLocks noChangeArrowheads="1"/>
                </p:cNvSpPr>
                <p:nvPr/>
              </p:nvSpPr>
              <p:spPr bwMode="auto">
                <a:xfrm>
                  <a:off x="3818346" y="4489450"/>
                  <a:ext cx="324926" cy="2587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3</a:t>
                  </a:r>
                  <a:endParaRPr kumimoji="1" lang="ko-KR" altLang="ko-KR" sz="12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92" name="Rectangle 109"/>
                <p:cNvSpPr>
                  <a:spLocks noChangeArrowheads="1"/>
                </p:cNvSpPr>
                <p:nvPr/>
              </p:nvSpPr>
              <p:spPr bwMode="auto">
                <a:xfrm>
                  <a:off x="4258083" y="4489450"/>
                  <a:ext cx="324926" cy="2587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4</a:t>
                  </a:r>
                  <a:endParaRPr kumimoji="1" lang="ko-KR" altLang="ko-KR" sz="12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93" name="Rectangle 110"/>
                <p:cNvSpPr>
                  <a:spLocks noChangeArrowheads="1"/>
                </p:cNvSpPr>
                <p:nvPr/>
              </p:nvSpPr>
              <p:spPr bwMode="auto">
                <a:xfrm>
                  <a:off x="4699409" y="4489450"/>
                  <a:ext cx="324926" cy="2587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5</a:t>
                  </a:r>
                  <a:endParaRPr kumimoji="1" lang="ko-KR" altLang="ko-KR" sz="12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94" name="Rectangle 111"/>
                <p:cNvSpPr>
                  <a:spLocks noChangeArrowheads="1"/>
                </p:cNvSpPr>
                <p:nvPr/>
              </p:nvSpPr>
              <p:spPr bwMode="auto">
                <a:xfrm>
                  <a:off x="5139146" y="4489450"/>
                  <a:ext cx="324926" cy="2587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6</a:t>
                  </a:r>
                  <a:endParaRPr kumimoji="1" lang="ko-KR" altLang="ko-KR" sz="12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95" name="Rectangle 112"/>
                <p:cNvSpPr>
                  <a:spLocks noChangeArrowheads="1"/>
                </p:cNvSpPr>
                <p:nvPr/>
              </p:nvSpPr>
              <p:spPr bwMode="auto">
                <a:xfrm>
                  <a:off x="5578883" y="4489450"/>
                  <a:ext cx="324926" cy="2587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7</a:t>
                  </a:r>
                  <a:endParaRPr kumimoji="1" lang="ko-KR" altLang="ko-KR" sz="12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96" name="Rectangle 113"/>
                <p:cNvSpPr>
                  <a:spLocks noChangeArrowheads="1"/>
                </p:cNvSpPr>
                <p:nvPr/>
              </p:nvSpPr>
              <p:spPr bwMode="auto">
                <a:xfrm>
                  <a:off x="6018620" y="4489450"/>
                  <a:ext cx="324926" cy="2587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8</a:t>
                  </a:r>
                  <a:endParaRPr kumimoji="1" lang="ko-KR" altLang="ko-KR" sz="12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97" name="Rectangle 114"/>
                <p:cNvSpPr>
                  <a:spLocks noChangeArrowheads="1"/>
                </p:cNvSpPr>
                <p:nvPr/>
              </p:nvSpPr>
              <p:spPr bwMode="auto">
                <a:xfrm>
                  <a:off x="6458359" y="4489450"/>
                  <a:ext cx="324926" cy="2587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9</a:t>
                  </a:r>
                  <a:endParaRPr kumimoji="1" lang="ko-KR" altLang="ko-KR" sz="12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98" name="Rectangle 115"/>
                <p:cNvSpPr>
                  <a:spLocks noChangeArrowheads="1"/>
                </p:cNvSpPr>
                <p:nvPr/>
              </p:nvSpPr>
              <p:spPr bwMode="auto">
                <a:xfrm>
                  <a:off x="6858746" y="4489450"/>
                  <a:ext cx="724430" cy="2587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GCSE</a:t>
                  </a:r>
                  <a:endParaRPr kumimoji="1" lang="ko-KR" altLang="ko-KR" sz="12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399" name="Rectangle 116"/>
                <p:cNvSpPr>
                  <a:spLocks noChangeArrowheads="1"/>
                </p:cNvSpPr>
                <p:nvPr/>
              </p:nvSpPr>
              <p:spPr bwMode="auto">
                <a:xfrm rot="16200000">
                  <a:off x="530322" y="3107025"/>
                  <a:ext cx="2304609" cy="30681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Relative IL</a:t>
                  </a:r>
                  <a:r>
                    <a:rPr kumimoji="1" lang="en-US" altLang="ko-KR" sz="12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-</a:t>
                  </a:r>
                  <a:r>
                    <a:rPr kumimoji="1" lang="ko-KR" altLang="ko-KR" sz="12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5 </a:t>
                  </a:r>
                  <a:r>
                    <a:rPr kumimoji="1" lang="en-US" altLang="ko-KR" sz="12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expression</a:t>
                  </a:r>
                  <a:endParaRPr kumimoji="1" lang="ko-KR" altLang="ko-KR" sz="12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</p:grpSp>
          <p:cxnSp>
            <p:nvCxnSpPr>
              <p:cNvPr id="340" name="꺾인 연결선 339"/>
              <p:cNvCxnSpPr/>
              <p:nvPr/>
            </p:nvCxnSpPr>
            <p:spPr>
              <a:xfrm rot="5400000" flipH="1">
                <a:off x="3054414" y="2050917"/>
                <a:ext cx="1116000" cy="2628000"/>
              </a:xfrm>
              <a:prstGeom prst="bentConnector3">
                <a:avLst>
                  <a:gd name="adj1" fmla="val 116897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1" name="꺾인 연결선 340"/>
              <p:cNvCxnSpPr/>
              <p:nvPr/>
            </p:nvCxnSpPr>
            <p:spPr>
              <a:xfrm rot="5400000" flipH="1">
                <a:off x="3052622" y="2007771"/>
                <a:ext cx="864000" cy="2376000"/>
              </a:xfrm>
              <a:prstGeom prst="bentConnector3">
                <a:avLst>
                  <a:gd name="adj1" fmla="val 116897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2" name="꺾인 연결선 341"/>
              <p:cNvCxnSpPr/>
              <p:nvPr/>
            </p:nvCxnSpPr>
            <p:spPr>
              <a:xfrm rot="5400000" flipH="1">
                <a:off x="1843622" y="3265432"/>
                <a:ext cx="1152000" cy="252000"/>
              </a:xfrm>
              <a:prstGeom prst="bentConnector3">
                <a:avLst>
                  <a:gd name="adj1" fmla="val 10891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3" name="꺾인 연결선 342"/>
              <p:cNvCxnSpPr/>
              <p:nvPr/>
            </p:nvCxnSpPr>
            <p:spPr>
              <a:xfrm rot="5400000" flipH="1">
                <a:off x="2322930" y="2728050"/>
                <a:ext cx="468000" cy="522000"/>
              </a:xfrm>
              <a:prstGeom prst="bentConnector3">
                <a:avLst>
                  <a:gd name="adj1" fmla="val 10891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4" name="꺾인 연결선 343"/>
              <p:cNvCxnSpPr/>
              <p:nvPr/>
            </p:nvCxnSpPr>
            <p:spPr>
              <a:xfrm rot="5400000" flipH="1">
                <a:off x="2224622" y="2861554"/>
                <a:ext cx="936000" cy="792000"/>
              </a:xfrm>
              <a:prstGeom prst="bentConnector3">
                <a:avLst>
                  <a:gd name="adj1" fmla="val 10891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5" name="꺾인 연결선 344"/>
              <p:cNvCxnSpPr/>
              <p:nvPr/>
            </p:nvCxnSpPr>
            <p:spPr>
              <a:xfrm rot="5400000" flipH="1">
                <a:off x="2295118" y="2798180"/>
                <a:ext cx="1044000" cy="1044000"/>
              </a:xfrm>
              <a:prstGeom prst="bentConnector3">
                <a:avLst>
                  <a:gd name="adj1" fmla="val 10891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6" name="꺾인 연결선 345"/>
              <p:cNvCxnSpPr/>
              <p:nvPr/>
            </p:nvCxnSpPr>
            <p:spPr>
              <a:xfrm rot="5400000" flipH="1">
                <a:off x="2422766" y="2672180"/>
                <a:ext cx="1044000" cy="1296000"/>
              </a:xfrm>
              <a:prstGeom prst="bentConnector3">
                <a:avLst>
                  <a:gd name="adj1" fmla="val 10891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7" name="꺾인 연결선 346"/>
              <p:cNvCxnSpPr/>
              <p:nvPr/>
            </p:nvCxnSpPr>
            <p:spPr>
              <a:xfrm rot="5400000" flipH="1">
                <a:off x="2674798" y="2402928"/>
                <a:ext cx="828000" cy="1584000"/>
              </a:xfrm>
              <a:prstGeom prst="bentConnector3">
                <a:avLst>
                  <a:gd name="adj1" fmla="val 10891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8" name="TextBox 347"/>
              <p:cNvSpPr txBox="1"/>
              <p:nvPr/>
            </p:nvSpPr>
            <p:spPr>
              <a:xfrm>
                <a:off x="2382528" y="3941089"/>
                <a:ext cx="3626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9" name="TextBox 348"/>
              <p:cNvSpPr txBox="1"/>
              <p:nvPr/>
            </p:nvSpPr>
            <p:spPr>
              <a:xfrm>
                <a:off x="2701787" y="3192724"/>
                <a:ext cx="2439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0" name="TextBox 349"/>
              <p:cNvSpPr txBox="1"/>
              <p:nvPr/>
            </p:nvSpPr>
            <p:spPr>
              <a:xfrm>
                <a:off x="2913256" y="3734284"/>
                <a:ext cx="3626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1" name="TextBox 350"/>
              <p:cNvSpPr txBox="1"/>
              <p:nvPr/>
            </p:nvSpPr>
            <p:spPr>
              <a:xfrm>
                <a:off x="3169344" y="3835170"/>
                <a:ext cx="3626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2" name="TextBox 351"/>
              <p:cNvSpPr txBox="1"/>
              <p:nvPr/>
            </p:nvSpPr>
            <p:spPr>
              <a:xfrm>
                <a:off x="3425938" y="3912804"/>
                <a:ext cx="3626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3" name="TextBox 352"/>
              <p:cNvSpPr txBox="1"/>
              <p:nvPr/>
            </p:nvSpPr>
            <p:spPr>
              <a:xfrm>
                <a:off x="3699278" y="3601894"/>
                <a:ext cx="3626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4" name="TextBox 353"/>
              <p:cNvSpPr txBox="1"/>
              <p:nvPr/>
            </p:nvSpPr>
            <p:spPr>
              <a:xfrm>
                <a:off x="4497432" y="3610520"/>
                <a:ext cx="3626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5" name="TextBox 354"/>
              <p:cNvSpPr txBox="1"/>
              <p:nvPr/>
            </p:nvSpPr>
            <p:spPr>
              <a:xfrm>
                <a:off x="4759586" y="3930056"/>
                <a:ext cx="3626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01" name="그룹 400"/>
            <p:cNvGrpSpPr/>
            <p:nvPr/>
          </p:nvGrpSpPr>
          <p:grpSpPr>
            <a:xfrm>
              <a:off x="683569" y="3602867"/>
              <a:ext cx="3615260" cy="1919253"/>
              <a:chOff x="1759346" y="2500495"/>
              <a:chExt cx="3615260" cy="1919253"/>
            </a:xfrm>
          </p:grpSpPr>
          <p:grpSp>
            <p:nvGrpSpPr>
              <p:cNvPr id="402" name="그룹 401"/>
              <p:cNvGrpSpPr/>
              <p:nvPr/>
            </p:nvGrpSpPr>
            <p:grpSpPr>
              <a:xfrm>
                <a:off x="1759346" y="2500495"/>
                <a:ext cx="3615260" cy="1919253"/>
                <a:chOff x="1619973" y="2025883"/>
                <a:chExt cx="5948758" cy="2725842"/>
              </a:xfrm>
            </p:grpSpPr>
            <p:sp>
              <p:nvSpPr>
                <p:cNvPr id="421" name="Rectangle 124"/>
                <p:cNvSpPr>
                  <a:spLocks noChangeArrowheads="1"/>
                </p:cNvSpPr>
                <p:nvPr/>
              </p:nvSpPr>
              <p:spPr bwMode="auto">
                <a:xfrm>
                  <a:off x="2566988" y="3495675"/>
                  <a:ext cx="177800" cy="90170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22" name="Freeform 125"/>
                <p:cNvSpPr>
                  <a:spLocks noEditPoints="1"/>
                </p:cNvSpPr>
                <p:nvPr/>
              </p:nvSpPr>
              <p:spPr bwMode="auto">
                <a:xfrm>
                  <a:off x="2562226" y="3490913"/>
                  <a:ext cx="185738" cy="909638"/>
                </a:xfrm>
                <a:custGeom>
                  <a:avLst/>
                  <a:gdLst>
                    <a:gd name="T0" fmla="*/ 0 w 1952"/>
                    <a:gd name="T1" fmla="*/ 48 h 9552"/>
                    <a:gd name="T2" fmla="*/ 48 w 1952"/>
                    <a:gd name="T3" fmla="*/ 0 h 9552"/>
                    <a:gd name="T4" fmla="*/ 1904 w 1952"/>
                    <a:gd name="T5" fmla="*/ 0 h 9552"/>
                    <a:gd name="T6" fmla="*/ 1952 w 1952"/>
                    <a:gd name="T7" fmla="*/ 48 h 9552"/>
                    <a:gd name="T8" fmla="*/ 1952 w 1952"/>
                    <a:gd name="T9" fmla="*/ 9504 h 9552"/>
                    <a:gd name="T10" fmla="*/ 1904 w 1952"/>
                    <a:gd name="T11" fmla="*/ 9552 h 9552"/>
                    <a:gd name="T12" fmla="*/ 48 w 1952"/>
                    <a:gd name="T13" fmla="*/ 9552 h 9552"/>
                    <a:gd name="T14" fmla="*/ 0 w 1952"/>
                    <a:gd name="T15" fmla="*/ 9504 h 9552"/>
                    <a:gd name="T16" fmla="*/ 0 w 1952"/>
                    <a:gd name="T17" fmla="*/ 48 h 9552"/>
                    <a:gd name="T18" fmla="*/ 96 w 1952"/>
                    <a:gd name="T19" fmla="*/ 9504 h 9552"/>
                    <a:gd name="T20" fmla="*/ 48 w 1952"/>
                    <a:gd name="T21" fmla="*/ 9456 h 9552"/>
                    <a:gd name="T22" fmla="*/ 1904 w 1952"/>
                    <a:gd name="T23" fmla="*/ 9456 h 9552"/>
                    <a:gd name="T24" fmla="*/ 1856 w 1952"/>
                    <a:gd name="T25" fmla="*/ 9504 h 9552"/>
                    <a:gd name="T26" fmla="*/ 1856 w 1952"/>
                    <a:gd name="T27" fmla="*/ 48 h 9552"/>
                    <a:gd name="T28" fmla="*/ 1904 w 1952"/>
                    <a:gd name="T29" fmla="*/ 96 h 9552"/>
                    <a:gd name="T30" fmla="*/ 48 w 1952"/>
                    <a:gd name="T31" fmla="*/ 96 h 9552"/>
                    <a:gd name="T32" fmla="*/ 96 w 1952"/>
                    <a:gd name="T33" fmla="*/ 48 h 9552"/>
                    <a:gd name="T34" fmla="*/ 96 w 1952"/>
                    <a:gd name="T35" fmla="*/ 9504 h 955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952" h="9552">
                      <a:moveTo>
                        <a:pt x="0" y="48"/>
                      </a:moveTo>
                      <a:cubicBezTo>
                        <a:pt x="0" y="22"/>
                        <a:pt x="22" y="0"/>
                        <a:pt x="48" y="0"/>
                      </a:cubicBezTo>
                      <a:lnTo>
                        <a:pt x="1904" y="0"/>
                      </a:lnTo>
                      <a:cubicBezTo>
                        <a:pt x="1931" y="0"/>
                        <a:pt x="1952" y="22"/>
                        <a:pt x="1952" y="48"/>
                      </a:cubicBezTo>
                      <a:lnTo>
                        <a:pt x="1952" y="9504"/>
                      </a:lnTo>
                      <a:cubicBezTo>
                        <a:pt x="1952" y="9531"/>
                        <a:pt x="1931" y="9552"/>
                        <a:pt x="1904" y="9552"/>
                      </a:cubicBezTo>
                      <a:lnTo>
                        <a:pt x="48" y="9552"/>
                      </a:lnTo>
                      <a:cubicBezTo>
                        <a:pt x="22" y="9552"/>
                        <a:pt x="0" y="9531"/>
                        <a:pt x="0" y="9504"/>
                      </a:cubicBezTo>
                      <a:lnTo>
                        <a:pt x="0" y="48"/>
                      </a:lnTo>
                      <a:close/>
                      <a:moveTo>
                        <a:pt x="96" y="9504"/>
                      </a:moveTo>
                      <a:lnTo>
                        <a:pt x="48" y="9456"/>
                      </a:lnTo>
                      <a:lnTo>
                        <a:pt x="1904" y="9456"/>
                      </a:lnTo>
                      <a:lnTo>
                        <a:pt x="1856" y="9504"/>
                      </a:lnTo>
                      <a:lnTo>
                        <a:pt x="1856" y="48"/>
                      </a:lnTo>
                      <a:lnTo>
                        <a:pt x="1904" y="96"/>
                      </a:lnTo>
                      <a:lnTo>
                        <a:pt x="48" y="96"/>
                      </a:lnTo>
                      <a:lnTo>
                        <a:pt x="96" y="48"/>
                      </a:lnTo>
                      <a:lnTo>
                        <a:pt x="96" y="9504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23" name="Rectangle 126"/>
                <p:cNvSpPr>
                  <a:spLocks noChangeArrowheads="1"/>
                </p:cNvSpPr>
                <p:nvPr/>
              </p:nvSpPr>
              <p:spPr bwMode="auto">
                <a:xfrm>
                  <a:off x="3008313" y="4318000"/>
                  <a:ext cx="176213" cy="79375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24" name="Freeform 127"/>
                <p:cNvSpPr>
                  <a:spLocks noEditPoints="1"/>
                </p:cNvSpPr>
                <p:nvPr/>
              </p:nvSpPr>
              <p:spPr bwMode="auto">
                <a:xfrm>
                  <a:off x="3003551" y="4313238"/>
                  <a:ext cx="185738" cy="87313"/>
                </a:xfrm>
                <a:custGeom>
                  <a:avLst/>
                  <a:gdLst>
                    <a:gd name="T0" fmla="*/ 0 w 1952"/>
                    <a:gd name="T1" fmla="*/ 48 h 928"/>
                    <a:gd name="T2" fmla="*/ 48 w 1952"/>
                    <a:gd name="T3" fmla="*/ 0 h 928"/>
                    <a:gd name="T4" fmla="*/ 1904 w 1952"/>
                    <a:gd name="T5" fmla="*/ 0 h 928"/>
                    <a:gd name="T6" fmla="*/ 1952 w 1952"/>
                    <a:gd name="T7" fmla="*/ 48 h 928"/>
                    <a:gd name="T8" fmla="*/ 1952 w 1952"/>
                    <a:gd name="T9" fmla="*/ 880 h 928"/>
                    <a:gd name="T10" fmla="*/ 1904 w 1952"/>
                    <a:gd name="T11" fmla="*/ 928 h 928"/>
                    <a:gd name="T12" fmla="*/ 48 w 1952"/>
                    <a:gd name="T13" fmla="*/ 928 h 928"/>
                    <a:gd name="T14" fmla="*/ 0 w 1952"/>
                    <a:gd name="T15" fmla="*/ 880 h 928"/>
                    <a:gd name="T16" fmla="*/ 0 w 1952"/>
                    <a:gd name="T17" fmla="*/ 48 h 928"/>
                    <a:gd name="T18" fmla="*/ 96 w 1952"/>
                    <a:gd name="T19" fmla="*/ 880 h 928"/>
                    <a:gd name="T20" fmla="*/ 48 w 1952"/>
                    <a:gd name="T21" fmla="*/ 832 h 928"/>
                    <a:gd name="T22" fmla="*/ 1904 w 1952"/>
                    <a:gd name="T23" fmla="*/ 832 h 928"/>
                    <a:gd name="T24" fmla="*/ 1856 w 1952"/>
                    <a:gd name="T25" fmla="*/ 880 h 928"/>
                    <a:gd name="T26" fmla="*/ 1856 w 1952"/>
                    <a:gd name="T27" fmla="*/ 48 h 928"/>
                    <a:gd name="T28" fmla="*/ 1904 w 1952"/>
                    <a:gd name="T29" fmla="*/ 96 h 928"/>
                    <a:gd name="T30" fmla="*/ 48 w 1952"/>
                    <a:gd name="T31" fmla="*/ 96 h 928"/>
                    <a:gd name="T32" fmla="*/ 96 w 1952"/>
                    <a:gd name="T33" fmla="*/ 48 h 928"/>
                    <a:gd name="T34" fmla="*/ 96 w 1952"/>
                    <a:gd name="T35" fmla="*/ 880 h 9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952" h="928">
                      <a:moveTo>
                        <a:pt x="0" y="48"/>
                      </a:moveTo>
                      <a:cubicBezTo>
                        <a:pt x="0" y="22"/>
                        <a:pt x="22" y="0"/>
                        <a:pt x="48" y="0"/>
                      </a:cubicBezTo>
                      <a:lnTo>
                        <a:pt x="1904" y="0"/>
                      </a:lnTo>
                      <a:cubicBezTo>
                        <a:pt x="1931" y="0"/>
                        <a:pt x="1952" y="22"/>
                        <a:pt x="1952" y="48"/>
                      </a:cubicBezTo>
                      <a:lnTo>
                        <a:pt x="1952" y="880"/>
                      </a:lnTo>
                      <a:cubicBezTo>
                        <a:pt x="1952" y="907"/>
                        <a:pt x="1931" y="928"/>
                        <a:pt x="1904" y="928"/>
                      </a:cubicBezTo>
                      <a:lnTo>
                        <a:pt x="48" y="928"/>
                      </a:lnTo>
                      <a:cubicBezTo>
                        <a:pt x="22" y="928"/>
                        <a:pt x="0" y="907"/>
                        <a:pt x="0" y="880"/>
                      </a:cubicBezTo>
                      <a:lnTo>
                        <a:pt x="0" y="48"/>
                      </a:lnTo>
                      <a:close/>
                      <a:moveTo>
                        <a:pt x="96" y="880"/>
                      </a:moveTo>
                      <a:lnTo>
                        <a:pt x="48" y="832"/>
                      </a:lnTo>
                      <a:lnTo>
                        <a:pt x="1904" y="832"/>
                      </a:lnTo>
                      <a:lnTo>
                        <a:pt x="1856" y="880"/>
                      </a:lnTo>
                      <a:lnTo>
                        <a:pt x="1856" y="48"/>
                      </a:lnTo>
                      <a:lnTo>
                        <a:pt x="1904" y="96"/>
                      </a:lnTo>
                      <a:lnTo>
                        <a:pt x="48" y="96"/>
                      </a:lnTo>
                      <a:lnTo>
                        <a:pt x="96" y="48"/>
                      </a:lnTo>
                      <a:lnTo>
                        <a:pt x="96" y="88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25" name="Rectangle 128"/>
                <p:cNvSpPr>
                  <a:spLocks noChangeArrowheads="1"/>
                </p:cNvSpPr>
                <p:nvPr/>
              </p:nvSpPr>
              <p:spPr bwMode="auto">
                <a:xfrm>
                  <a:off x="3449638" y="3590925"/>
                  <a:ext cx="176213" cy="80645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26" name="Freeform 129"/>
                <p:cNvSpPr>
                  <a:spLocks noEditPoints="1"/>
                </p:cNvSpPr>
                <p:nvPr/>
              </p:nvSpPr>
              <p:spPr bwMode="auto">
                <a:xfrm>
                  <a:off x="3444876" y="3586163"/>
                  <a:ext cx="185738" cy="814388"/>
                </a:xfrm>
                <a:custGeom>
                  <a:avLst/>
                  <a:gdLst>
                    <a:gd name="T0" fmla="*/ 0 w 1952"/>
                    <a:gd name="T1" fmla="*/ 48 h 8560"/>
                    <a:gd name="T2" fmla="*/ 48 w 1952"/>
                    <a:gd name="T3" fmla="*/ 0 h 8560"/>
                    <a:gd name="T4" fmla="*/ 1904 w 1952"/>
                    <a:gd name="T5" fmla="*/ 0 h 8560"/>
                    <a:gd name="T6" fmla="*/ 1952 w 1952"/>
                    <a:gd name="T7" fmla="*/ 48 h 8560"/>
                    <a:gd name="T8" fmla="*/ 1952 w 1952"/>
                    <a:gd name="T9" fmla="*/ 8512 h 8560"/>
                    <a:gd name="T10" fmla="*/ 1904 w 1952"/>
                    <a:gd name="T11" fmla="*/ 8560 h 8560"/>
                    <a:gd name="T12" fmla="*/ 48 w 1952"/>
                    <a:gd name="T13" fmla="*/ 8560 h 8560"/>
                    <a:gd name="T14" fmla="*/ 0 w 1952"/>
                    <a:gd name="T15" fmla="*/ 8512 h 8560"/>
                    <a:gd name="T16" fmla="*/ 0 w 1952"/>
                    <a:gd name="T17" fmla="*/ 48 h 8560"/>
                    <a:gd name="T18" fmla="*/ 96 w 1952"/>
                    <a:gd name="T19" fmla="*/ 8512 h 8560"/>
                    <a:gd name="T20" fmla="*/ 48 w 1952"/>
                    <a:gd name="T21" fmla="*/ 8464 h 8560"/>
                    <a:gd name="T22" fmla="*/ 1904 w 1952"/>
                    <a:gd name="T23" fmla="*/ 8464 h 8560"/>
                    <a:gd name="T24" fmla="*/ 1856 w 1952"/>
                    <a:gd name="T25" fmla="*/ 8512 h 8560"/>
                    <a:gd name="T26" fmla="*/ 1856 w 1952"/>
                    <a:gd name="T27" fmla="*/ 48 h 8560"/>
                    <a:gd name="T28" fmla="*/ 1904 w 1952"/>
                    <a:gd name="T29" fmla="*/ 96 h 8560"/>
                    <a:gd name="T30" fmla="*/ 48 w 1952"/>
                    <a:gd name="T31" fmla="*/ 96 h 8560"/>
                    <a:gd name="T32" fmla="*/ 96 w 1952"/>
                    <a:gd name="T33" fmla="*/ 48 h 8560"/>
                    <a:gd name="T34" fmla="*/ 96 w 1952"/>
                    <a:gd name="T35" fmla="*/ 8512 h 856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952" h="8560">
                      <a:moveTo>
                        <a:pt x="0" y="48"/>
                      </a:moveTo>
                      <a:cubicBezTo>
                        <a:pt x="0" y="22"/>
                        <a:pt x="22" y="0"/>
                        <a:pt x="48" y="0"/>
                      </a:cubicBezTo>
                      <a:lnTo>
                        <a:pt x="1904" y="0"/>
                      </a:lnTo>
                      <a:cubicBezTo>
                        <a:pt x="1931" y="0"/>
                        <a:pt x="1952" y="22"/>
                        <a:pt x="1952" y="48"/>
                      </a:cubicBezTo>
                      <a:lnTo>
                        <a:pt x="1952" y="8512"/>
                      </a:lnTo>
                      <a:cubicBezTo>
                        <a:pt x="1952" y="8539"/>
                        <a:pt x="1931" y="8560"/>
                        <a:pt x="1904" y="8560"/>
                      </a:cubicBezTo>
                      <a:lnTo>
                        <a:pt x="48" y="8560"/>
                      </a:lnTo>
                      <a:cubicBezTo>
                        <a:pt x="22" y="8560"/>
                        <a:pt x="0" y="8539"/>
                        <a:pt x="0" y="8512"/>
                      </a:cubicBezTo>
                      <a:lnTo>
                        <a:pt x="0" y="48"/>
                      </a:lnTo>
                      <a:close/>
                      <a:moveTo>
                        <a:pt x="96" y="8512"/>
                      </a:moveTo>
                      <a:lnTo>
                        <a:pt x="48" y="8464"/>
                      </a:lnTo>
                      <a:lnTo>
                        <a:pt x="1904" y="8464"/>
                      </a:lnTo>
                      <a:lnTo>
                        <a:pt x="1856" y="8512"/>
                      </a:lnTo>
                      <a:lnTo>
                        <a:pt x="1856" y="48"/>
                      </a:lnTo>
                      <a:lnTo>
                        <a:pt x="1904" y="96"/>
                      </a:lnTo>
                      <a:lnTo>
                        <a:pt x="48" y="96"/>
                      </a:lnTo>
                      <a:lnTo>
                        <a:pt x="96" y="48"/>
                      </a:lnTo>
                      <a:lnTo>
                        <a:pt x="96" y="851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27" name="Rectangle 130"/>
                <p:cNvSpPr>
                  <a:spLocks noChangeArrowheads="1"/>
                </p:cNvSpPr>
                <p:nvPr/>
              </p:nvSpPr>
              <p:spPr bwMode="auto">
                <a:xfrm>
                  <a:off x="3889376" y="4030663"/>
                  <a:ext cx="177800" cy="366713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28" name="Freeform 131"/>
                <p:cNvSpPr>
                  <a:spLocks noEditPoints="1"/>
                </p:cNvSpPr>
                <p:nvPr/>
              </p:nvSpPr>
              <p:spPr bwMode="auto">
                <a:xfrm>
                  <a:off x="3886201" y="4025900"/>
                  <a:ext cx="185738" cy="374650"/>
                </a:xfrm>
                <a:custGeom>
                  <a:avLst/>
                  <a:gdLst>
                    <a:gd name="T0" fmla="*/ 0 w 1952"/>
                    <a:gd name="T1" fmla="*/ 48 h 3936"/>
                    <a:gd name="T2" fmla="*/ 48 w 1952"/>
                    <a:gd name="T3" fmla="*/ 0 h 3936"/>
                    <a:gd name="T4" fmla="*/ 1904 w 1952"/>
                    <a:gd name="T5" fmla="*/ 0 h 3936"/>
                    <a:gd name="T6" fmla="*/ 1952 w 1952"/>
                    <a:gd name="T7" fmla="*/ 48 h 3936"/>
                    <a:gd name="T8" fmla="*/ 1952 w 1952"/>
                    <a:gd name="T9" fmla="*/ 3888 h 3936"/>
                    <a:gd name="T10" fmla="*/ 1904 w 1952"/>
                    <a:gd name="T11" fmla="*/ 3936 h 3936"/>
                    <a:gd name="T12" fmla="*/ 48 w 1952"/>
                    <a:gd name="T13" fmla="*/ 3936 h 3936"/>
                    <a:gd name="T14" fmla="*/ 0 w 1952"/>
                    <a:gd name="T15" fmla="*/ 3888 h 3936"/>
                    <a:gd name="T16" fmla="*/ 0 w 1952"/>
                    <a:gd name="T17" fmla="*/ 48 h 3936"/>
                    <a:gd name="T18" fmla="*/ 96 w 1952"/>
                    <a:gd name="T19" fmla="*/ 3888 h 3936"/>
                    <a:gd name="T20" fmla="*/ 48 w 1952"/>
                    <a:gd name="T21" fmla="*/ 3840 h 3936"/>
                    <a:gd name="T22" fmla="*/ 1904 w 1952"/>
                    <a:gd name="T23" fmla="*/ 3840 h 3936"/>
                    <a:gd name="T24" fmla="*/ 1856 w 1952"/>
                    <a:gd name="T25" fmla="*/ 3888 h 3936"/>
                    <a:gd name="T26" fmla="*/ 1856 w 1952"/>
                    <a:gd name="T27" fmla="*/ 48 h 3936"/>
                    <a:gd name="T28" fmla="*/ 1904 w 1952"/>
                    <a:gd name="T29" fmla="*/ 96 h 3936"/>
                    <a:gd name="T30" fmla="*/ 48 w 1952"/>
                    <a:gd name="T31" fmla="*/ 96 h 3936"/>
                    <a:gd name="T32" fmla="*/ 96 w 1952"/>
                    <a:gd name="T33" fmla="*/ 48 h 3936"/>
                    <a:gd name="T34" fmla="*/ 96 w 1952"/>
                    <a:gd name="T35" fmla="*/ 3888 h 39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952" h="3936">
                      <a:moveTo>
                        <a:pt x="0" y="48"/>
                      </a:moveTo>
                      <a:cubicBezTo>
                        <a:pt x="0" y="22"/>
                        <a:pt x="22" y="0"/>
                        <a:pt x="48" y="0"/>
                      </a:cubicBezTo>
                      <a:lnTo>
                        <a:pt x="1904" y="0"/>
                      </a:lnTo>
                      <a:cubicBezTo>
                        <a:pt x="1931" y="0"/>
                        <a:pt x="1952" y="22"/>
                        <a:pt x="1952" y="48"/>
                      </a:cubicBezTo>
                      <a:lnTo>
                        <a:pt x="1952" y="3888"/>
                      </a:lnTo>
                      <a:cubicBezTo>
                        <a:pt x="1952" y="3915"/>
                        <a:pt x="1931" y="3936"/>
                        <a:pt x="1904" y="3936"/>
                      </a:cubicBezTo>
                      <a:lnTo>
                        <a:pt x="48" y="3936"/>
                      </a:lnTo>
                      <a:cubicBezTo>
                        <a:pt x="22" y="3936"/>
                        <a:pt x="0" y="3915"/>
                        <a:pt x="0" y="3888"/>
                      </a:cubicBezTo>
                      <a:lnTo>
                        <a:pt x="0" y="48"/>
                      </a:lnTo>
                      <a:close/>
                      <a:moveTo>
                        <a:pt x="96" y="3888"/>
                      </a:moveTo>
                      <a:lnTo>
                        <a:pt x="48" y="3840"/>
                      </a:lnTo>
                      <a:lnTo>
                        <a:pt x="1904" y="3840"/>
                      </a:lnTo>
                      <a:lnTo>
                        <a:pt x="1856" y="3888"/>
                      </a:lnTo>
                      <a:lnTo>
                        <a:pt x="1856" y="48"/>
                      </a:lnTo>
                      <a:lnTo>
                        <a:pt x="1904" y="96"/>
                      </a:lnTo>
                      <a:lnTo>
                        <a:pt x="48" y="96"/>
                      </a:lnTo>
                      <a:lnTo>
                        <a:pt x="96" y="48"/>
                      </a:lnTo>
                      <a:lnTo>
                        <a:pt x="96" y="3888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29" name="Rectangle 132"/>
                <p:cNvSpPr>
                  <a:spLocks noChangeArrowheads="1"/>
                </p:cNvSpPr>
                <p:nvPr/>
              </p:nvSpPr>
              <p:spPr bwMode="auto">
                <a:xfrm>
                  <a:off x="4330701" y="4183063"/>
                  <a:ext cx="176213" cy="214313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30" name="Freeform 133"/>
                <p:cNvSpPr>
                  <a:spLocks noEditPoints="1"/>
                </p:cNvSpPr>
                <p:nvPr/>
              </p:nvSpPr>
              <p:spPr bwMode="auto">
                <a:xfrm>
                  <a:off x="4325938" y="4178300"/>
                  <a:ext cx="185738" cy="222250"/>
                </a:xfrm>
                <a:custGeom>
                  <a:avLst/>
                  <a:gdLst>
                    <a:gd name="T0" fmla="*/ 0 w 1952"/>
                    <a:gd name="T1" fmla="*/ 48 h 2336"/>
                    <a:gd name="T2" fmla="*/ 48 w 1952"/>
                    <a:gd name="T3" fmla="*/ 0 h 2336"/>
                    <a:gd name="T4" fmla="*/ 1904 w 1952"/>
                    <a:gd name="T5" fmla="*/ 0 h 2336"/>
                    <a:gd name="T6" fmla="*/ 1952 w 1952"/>
                    <a:gd name="T7" fmla="*/ 48 h 2336"/>
                    <a:gd name="T8" fmla="*/ 1952 w 1952"/>
                    <a:gd name="T9" fmla="*/ 2288 h 2336"/>
                    <a:gd name="T10" fmla="*/ 1904 w 1952"/>
                    <a:gd name="T11" fmla="*/ 2336 h 2336"/>
                    <a:gd name="T12" fmla="*/ 48 w 1952"/>
                    <a:gd name="T13" fmla="*/ 2336 h 2336"/>
                    <a:gd name="T14" fmla="*/ 0 w 1952"/>
                    <a:gd name="T15" fmla="*/ 2288 h 2336"/>
                    <a:gd name="T16" fmla="*/ 0 w 1952"/>
                    <a:gd name="T17" fmla="*/ 48 h 2336"/>
                    <a:gd name="T18" fmla="*/ 96 w 1952"/>
                    <a:gd name="T19" fmla="*/ 2288 h 2336"/>
                    <a:gd name="T20" fmla="*/ 48 w 1952"/>
                    <a:gd name="T21" fmla="*/ 2240 h 2336"/>
                    <a:gd name="T22" fmla="*/ 1904 w 1952"/>
                    <a:gd name="T23" fmla="*/ 2240 h 2336"/>
                    <a:gd name="T24" fmla="*/ 1856 w 1952"/>
                    <a:gd name="T25" fmla="*/ 2288 h 2336"/>
                    <a:gd name="T26" fmla="*/ 1856 w 1952"/>
                    <a:gd name="T27" fmla="*/ 48 h 2336"/>
                    <a:gd name="T28" fmla="*/ 1904 w 1952"/>
                    <a:gd name="T29" fmla="*/ 96 h 2336"/>
                    <a:gd name="T30" fmla="*/ 48 w 1952"/>
                    <a:gd name="T31" fmla="*/ 96 h 2336"/>
                    <a:gd name="T32" fmla="*/ 96 w 1952"/>
                    <a:gd name="T33" fmla="*/ 48 h 2336"/>
                    <a:gd name="T34" fmla="*/ 96 w 1952"/>
                    <a:gd name="T35" fmla="*/ 2288 h 23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952" h="2336">
                      <a:moveTo>
                        <a:pt x="0" y="48"/>
                      </a:moveTo>
                      <a:cubicBezTo>
                        <a:pt x="0" y="22"/>
                        <a:pt x="22" y="0"/>
                        <a:pt x="48" y="0"/>
                      </a:cubicBezTo>
                      <a:lnTo>
                        <a:pt x="1904" y="0"/>
                      </a:lnTo>
                      <a:cubicBezTo>
                        <a:pt x="1931" y="0"/>
                        <a:pt x="1952" y="22"/>
                        <a:pt x="1952" y="48"/>
                      </a:cubicBezTo>
                      <a:lnTo>
                        <a:pt x="1952" y="2288"/>
                      </a:lnTo>
                      <a:cubicBezTo>
                        <a:pt x="1952" y="2315"/>
                        <a:pt x="1931" y="2336"/>
                        <a:pt x="1904" y="2336"/>
                      </a:cubicBezTo>
                      <a:lnTo>
                        <a:pt x="48" y="2336"/>
                      </a:lnTo>
                      <a:cubicBezTo>
                        <a:pt x="22" y="2336"/>
                        <a:pt x="0" y="2315"/>
                        <a:pt x="0" y="2288"/>
                      </a:cubicBezTo>
                      <a:lnTo>
                        <a:pt x="0" y="48"/>
                      </a:lnTo>
                      <a:close/>
                      <a:moveTo>
                        <a:pt x="96" y="2288"/>
                      </a:moveTo>
                      <a:lnTo>
                        <a:pt x="48" y="2240"/>
                      </a:lnTo>
                      <a:lnTo>
                        <a:pt x="1904" y="2240"/>
                      </a:lnTo>
                      <a:lnTo>
                        <a:pt x="1856" y="2288"/>
                      </a:lnTo>
                      <a:lnTo>
                        <a:pt x="1856" y="48"/>
                      </a:lnTo>
                      <a:lnTo>
                        <a:pt x="1904" y="96"/>
                      </a:lnTo>
                      <a:lnTo>
                        <a:pt x="48" y="96"/>
                      </a:lnTo>
                      <a:lnTo>
                        <a:pt x="96" y="48"/>
                      </a:lnTo>
                      <a:lnTo>
                        <a:pt x="96" y="2288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31" name="Rectangle 134"/>
                <p:cNvSpPr>
                  <a:spLocks noChangeArrowheads="1"/>
                </p:cNvSpPr>
                <p:nvPr/>
              </p:nvSpPr>
              <p:spPr bwMode="auto">
                <a:xfrm>
                  <a:off x="4772026" y="4206875"/>
                  <a:ext cx="177800" cy="1905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32" name="Freeform 135"/>
                <p:cNvSpPr>
                  <a:spLocks noEditPoints="1"/>
                </p:cNvSpPr>
                <p:nvPr/>
              </p:nvSpPr>
              <p:spPr bwMode="auto">
                <a:xfrm>
                  <a:off x="4767263" y="4202113"/>
                  <a:ext cx="187325" cy="198438"/>
                </a:xfrm>
                <a:custGeom>
                  <a:avLst/>
                  <a:gdLst>
                    <a:gd name="T0" fmla="*/ 0 w 976"/>
                    <a:gd name="T1" fmla="*/ 24 h 1048"/>
                    <a:gd name="T2" fmla="*/ 24 w 976"/>
                    <a:gd name="T3" fmla="*/ 0 h 1048"/>
                    <a:gd name="T4" fmla="*/ 952 w 976"/>
                    <a:gd name="T5" fmla="*/ 0 h 1048"/>
                    <a:gd name="T6" fmla="*/ 976 w 976"/>
                    <a:gd name="T7" fmla="*/ 24 h 1048"/>
                    <a:gd name="T8" fmla="*/ 976 w 976"/>
                    <a:gd name="T9" fmla="*/ 1024 h 1048"/>
                    <a:gd name="T10" fmla="*/ 952 w 976"/>
                    <a:gd name="T11" fmla="*/ 1048 h 1048"/>
                    <a:gd name="T12" fmla="*/ 24 w 976"/>
                    <a:gd name="T13" fmla="*/ 1048 h 1048"/>
                    <a:gd name="T14" fmla="*/ 0 w 976"/>
                    <a:gd name="T15" fmla="*/ 1024 h 1048"/>
                    <a:gd name="T16" fmla="*/ 0 w 976"/>
                    <a:gd name="T17" fmla="*/ 24 h 1048"/>
                    <a:gd name="T18" fmla="*/ 48 w 976"/>
                    <a:gd name="T19" fmla="*/ 1024 h 1048"/>
                    <a:gd name="T20" fmla="*/ 24 w 976"/>
                    <a:gd name="T21" fmla="*/ 1000 h 1048"/>
                    <a:gd name="T22" fmla="*/ 952 w 976"/>
                    <a:gd name="T23" fmla="*/ 1000 h 1048"/>
                    <a:gd name="T24" fmla="*/ 928 w 976"/>
                    <a:gd name="T25" fmla="*/ 1024 h 1048"/>
                    <a:gd name="T26" fmla="*/ 928 w 976"/>
                    <a:gd name="T27" fmla="*/ 24 h 1048"/>
                    <a:gd name="T28" fmla="*/ 952 w 976"/>
                    <a:gd name="T29" fmla="*/ 48 h 1048"/>
                    <a:gd name="T30" fmla="*/ 24 w 976"/>
                    <a:gd name="T31" fmla="*/ 48 h 1048"/>
                    <a:gd name="T32" fmla="*/ 48 w 976"/>
                    <a:gd name="T33" fmla="*/ 24 h 1048"/>
                    <a:gd name="T34" fmla="*/ 48 w 976"/>
                    <a:gd name="T35" fmla="*/ 1024 h 10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976" h="1048">
                      <a:moveTo>
                        <a:pt x="0" y="24"/>
                      </a:moveTo>
                      <a:cubicBezTo>
                        <a:pt x="0" y="11"/>
                        <a:pt x="11" y="0"/>
                        <a:pt x="24" y="0"/>
                      </a:cubicBezTo>
                      <a:lnTo>
                        <a:pt x="952" y="0"/>
                      </a:lnTo>
                      <a:cubicBezTo>
                        <a:pt x="966" y="0"/>
                        <a:pt x="976" y="11"/>
                        <a:pt x="976" y="24"/>
                      </a:cubicBezTo>
                      <a:lnTo>
                        <a:pt x="976" y="1024"/>
                      </a:lnTo>
                      <a:cubicBezTo>
                        <a:pt x="976" y="1038"/>
                        <a:pt x="966" y="1048"/>
                        <a:pt x="952" y="1048"/>
                      </a:cubicBezTo>
                      <a:lnTo>
                        <a:pt x="24" y="1048"/>
                      </a:lnTo>
                      <a:cubicBezTo>
                        <a:pt x="11" y="1048"/>
                        <a:pt x="0" y="1038"/>
                        <a:pt x="0" y="1024"/>
                      </a:cubicBezTo>
                      <a:lnTo>
                        <a:pt x="0" y="24"/>
                      </a:lnTo>
                      <a:close/>
                      <a:moveTo>
                        <a:pt x="48" y="1024"/>
                      </a:moveTo>
                      <a:lnTo>
                        <a:pt x="24" y="1000"/>
                      </a:lnTo>
                      <a:lnTo>
                        <a:pt x="952" y="1000"/>
                      </a:lnTo>
                      <a:lnTo>
                        <a:pt x="928" y="1024"/>
                      </a:lnTo>
                      <a:lnTo>
                        <a:pt x="928" y="24"/>
                      </a:lnTo>
                      <a:lnTo>
                        <a:pt x="952" y="48"/>
                      </a:lnTo>
                      <a:lnTo>
                        <a:pt x="24" y="48"/>
                      </a:lnTo>
                      <a:lnTo>
                        <a:pt x="48" y="24"/>
                      </a:lnTo>
                      <a:lnTo>
                        <a:pt x="48" y="1024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33" name="Rectangle 136"/>
                <p:cNvSpPr>
                  <a:spLocks noChangeArrowheads="1"/>
                </p:cNvSpPr>
                <p:nvPr/>
              </p:nvSpPr>
              <p:spPr bwMode="auto">
                <a:xfrm>
                  <a:off x="5213351" y="4016375"/>
                  <a:ext cx="176213" cy="3810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34" name="Freeform 137"/>
                <p:cNvSpPr>
                  <a:spLocks noEditPoints="1"/>
                </p:cNvSpPr>
                <p:nvPr/>
              </p:nvSpPr>
              <p:spPr bwMode="auto">
                <a:xfrm>
                  <a:off x="5208588" y="4013200"/>
                  <a:ext cx="185738" cy="387350"/>
                </a:xfrm>
                <a:custGeom>
                  <a:avLst/>
                  <a:gdLst>
                    <a:gd name="T0" fmla="*/ 0 w 976"/>
                    <a:gd name="T1" fmla="*/ 24 h 2040"/>
                    <a:gd name="T2" fmla="*/ 24 w 976"/>
                    <a:gd name="T3" fmla="*/ 0 h 2040"/>
                    <a:gd name="T4" fmla="*/ 952 w 976"/>
                    <a:gd name="T5" fmla="*/ 0 h 2040"/>
                    <a:gd name="T6" fmla="*/ 976 w 976"/>
                    <a:gd name="T7" fmla="*/ 24 h 2040"/>
                    <a:gd name="T8" fmla="*/ 976 w 976"/>
                    <a:gd name="T9" fmla="*/ 2016 h 2040"/>
                    <a:gd name="T10" fmla="*/ 952 w 976"/>
                    <a:gd name="T11" fmla="*/ 2040 h 2040"/>
                    <a:gd name="T12" fmla="*/ 24 w 976"/>
                    <a:gd name="T13" fmla="*/ 2040 h 2040"/>
                    <a:gd name="T14" fmla="*/ 0 w 976"/>
                    <a:gd name="T15" fmla="*/ 2016 h 2040"/>
                    <a:gd name="T16" fmla="*/ 0 w 976"/>
                    <a:gd name="T17" fmla="*/ 24 h 2040"/>
                    <a:gd name="T18" fmla="*/ 48 w 976"/>
                    <a:gd name="T19" fmla="*/ 2016 h 2040"/>
                    <a:gd name="T20" fmla="*/ 24 w 976"/>
                    <a:gd name="T21" fmla="*/ 1992 h 2040"/>
                    <a:gd name="T22" fmla="*/ 952 w 976"/>
                    <a:gd name="T23" fmla="*/ 1992 h 2040"/>
                    <a:gd name="T24" fmla="*/ 928 w 976"/>
                    <a:gd name="T25" fmla="*/ 2016 h 2040"/>
                    <a:gd name="T26" fmla="*/ 928 w 976"/>
                    <a:gd name="T27" fmla="*/ 24 h 2040"/>
                    <a:gd name="T28" fmla="*/ 952 w 976"/>
                    <a:gd name="T29" fmla="*/ 48 h 2040"/>
                    <a:gd name="T30" fmla="*/ 24 w 976"/>
                    <a:gd name="T31" fmla="*/ 48 h 2040"/>
                    <a:gd name="T32" fmla="*/ 48 w 976"/>
                    <a:gd name="T33" fmla="*/ 24 h 2040"/>
                    <a:gd name="T34" fmla="*/ 48 w 976"/>
                    <a:gd name="T35" fmla="*/ 2016 h 204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976" h="2040">
                      <a:moveTo>
                        <a:pt x="0" y="24"/>
                      </a:moveTo>
                      <a:cubicBezTo>
                        <a:pt x="0" y="11"/>
                        <a:pt x="11" y="0"/>
                        <a:pt x="24" y="0"/>
                      </a:cubicBezTo>
                      <a:lnTo>
                        <a:pt x="952" y="0"/>
                      </a:lnTo>
                      <a:cubicBezTo>
                        <a:pt x="966" y="0"/>
                        <a:pt x="976" y="11"/>
                        <a:pt x="976" y="24"/>
                      </a:cubicBezTo>
                      <a:lnTo>
                        <a:pt x="976" y="2016"/>
                      </a:lnTo>
                      <a:cubicBezTo>
                        <a:pt x="976" y="2030"/>
                        <a:pt x="966" y="2040"/>
                        <a:pt x="952" y="2040"/>
                      </a:cubicBezTo>
                      <a:lnTo>
                        <a:pt x="24" y="2040"/>
                      </a:lnTo>
                      <a:cubicBezTo>
                        <a:pt x="11" y="2040"/>
                        <a:pt x="0" y="2030"/>
                        <a:pt x="0" y="2016"/>
                      </a:cubicBezTo>
                      <a:lnTo>
                        <a:pt x="0" y="24"/>
                      </a:lnTo>
                      <a:close/>
                      <a:moveTo>
                        <a:pt x="48" y="2016"/>
                      </a:moveTo>
                      <a:lnTo>
                        <a:pt x="24" y="1992"/>
                      </a:lnTo>
                      <a:lnTo>
                        <a:pt x="952" y="1992"/>
                      </a:lnTo>
                      <a:lnTo>
                        <a:pt x="928" y="2016"/>
                      </a:lnTo>
                      <a:lnTo>
                        <a:pt x="928" y="24"/>
                      </a:lnTo>
                      <a:lnTo>
                        <a:pt x="952" y="48"/>
                      </a:lnTo>
                      <a:lnTo>
                        <a:pt x="24" y="48"/>
                      </a:lnTo>
                      <a:lnTo>
                        <a:pt x="48" y="24"/>
                      </a:lnTo>
                      <a:lnTo>
                        <a:pt x="48" y="2016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35" name="Rectangle 138"/>
                <p:cNvSpPr>
                  <a:spLocks noChangeArrowheads="1"/>
                </p:cNvSpPr>
                <p:nvPr/>
              </p:nvSpPr>
              <p:spPr bwMode="auto">
                <a:xfrm>
                  <a:off x="5654676" y="2570163"/>
                  <a:ext cx="176213" cy="1827213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36" name="Freeform 139"/>
                <p:cNvSpPr>
                  <a:spLocks noEditPoints="1"/>
                </p:cNvSpPr>
                <p:nvPr/>
              </p:nvSpPr>
              <p:spPr bwMode="auto">
                <a:xfrm>
                  <a:off x="5649913" y="2565400"/>
                  <a:ext cx="184150" cy="1835150"/>
                </a:xfrm>
                <a:custGeom>
                  <a:avLst/>
                  <a:gdLst>
                    <a:gd name="T0" fmla="*/ 0 w 968"/>
                    <a:gd name="T1" fmla="*/ 24 h 9632"/>
                    <a:gd name="T2" fmla="*/ 24 w 968"/>
                    <a:gd name="T3" fmla="*/ 0 h 9632"/>
                    <a:gd name="T4" fmla="*/ 944 w 968"/>
                    <a:gd name="T5" fmla="*/ 0 h 9632"/>
                    <a:gd name="T6" fmla="*/ 968 w 968"/>
                    <a:gd name="T7" fmla="*/ 24 h 9632"/>
                    <a:gd name="T8" fmla="*/ 968 w 968"/>
                    <a:gd name="T9" fmla="*/ 9608 h 9632"/>
                    <a:gd name="T10" fmla="*/ 944 w 968"/>
                    <a:gd name="T11" fmla="*/ 9632 h 9632"/>
                    <a:gd name="T12" fmla="*/ 24 w 968"/>
                    <a:gd name="T13" fmla="*/ 9632 h 9632"/>
                    <a:gd name="T14" fmla="*/ 0 w 968"/>
                    <a:gd name="T15" fmla="*/ 9608 h 9632"/>
                    <a:gd name="T16" fmla="*/ 0 w 968"/>
                    <a:gd name="T17" fmla="*/ 24 h 9632"/>
                    <a:gd name="T18" fmla="*/ 48 w 968"/>
                    <a:gd name="T19" fmla="*/ 9608 h 9632"/>
                    <a:gd name="T20" fmla="*/ 24 w 968"/>
                    <a:gd name="T21" fmla="*/ 9584 h 9632"/>
                    <a:gd name="T22" fmla="*/ 944 w 968"/>
                    <a:gd name="T23" fmla="*/ 9584 h 9632"/>
                    <a:gd name="T24" fmla="*/ 920 w 968"/>
                    <a:gd name="T25" fmla="*/ 9608 h 9632"/>
                    <a:gd name="T26" fmla="*/ 920 w 968"/>
                    <a:gd name="T27" fmla="*/ 24 h 9632"/>
                    <a:gd name="T28" fmla="*/ 944 w 968"/>
                    <a:gd name="T29" fmla="*/ 48 h 9632"/>
                    <a:gd name="T30" fmla="*/ 24 w 968"/>
                    <a:gd name="T31" fmla="*/ 48 h 9632"/>
                    <a:gd name="T32" fmla="*/ 48 w 968"/>
                    <a:gd name="T33" fmla="*/ 24 h 9632"/>
                    <a:gd name="T34" fmla="*/ 48 w 968"/>
                    <a:gd name="T35" fmla="*/ 9608 h 96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968" h="9632">
                      <a:moveTo>
                        <a:pt x="0" y="24"/>
                      </a:moveTo>
                      <a:cubicBezTo>
                        <a:pt x="0" y="11"/>
                        <a:pt x="11" y="0"/>
                        <a:pt x="24" y="0"/>
                      </a:cubicBezTo>
                      <a:lnTo>
                        <a:pt x="944" y="0"/>
                      </a:lnTo>
                      <a:cubicBezTo>
                        <a:pt x="958" y="0"/>
                        <a:pt x="968" y="11"/>
                        <a:pt x="968" y="24"/>
                      </a:cubicBezTo>
                      <a:lnTo>
                        <a:pt x="968" y="9608"/>
                      </a:lnTo>
                      <a:cubicBezTo>
                        <a:pt x="968" y="9622"/>
                        <a:pt x="958" y="9632"/>
                        <a:pt x="944" y="9632"/>
                      </a:cubicBezTo>
                      <a:lnTo>
                        <a:pt x="24" y="9632"/>
                      </a:lnTo>
                      <a:cubicBezTo>
                        <a:pt x="11" y="9632"/>
                        <a:pt x="0" y="9622"/>
                        <a:pt x="0" y="9608"/>
                      </a:cubicBezTo>
                      <a:lnTo>
                        <a:pt x="0" y="24"/>
                      </a:lnTo>
                      <a:close/>
                      <a:moveTo>
                        <a:pt x="48" y="9608"/>
                      </a:moveTo>
                      <a:lnTo>
                        <a:pt x="24" y="9584"/>
                      </a:lnTo>
                      <a:lnTo>
                        <a:pt x="944" y="9584"/>
                      </a:lnTo>
                      <a:lnTo>
                        <a:pt x="920" y="9608"/>
                      </a:lnTo>
                      <a:lnTo>
                        <a:pt x="920" y="24"/>
                      </a:lnTo>
                      <a:lnTo>
                        <a:pt x="944" y="48"/>
                      </a:lnTo>
                      <a:lnTo>
                        <a:pt x="24" y="48"/>
                      </a:lnTo>
                      <a:lnTo>
                        <a:pt x="48" y="24"/>
                      </a:lnTo>
                      <a:lnTo>
                        <a:pt x="48" y="9608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37" name="Rectangle 140"/>
                <p:cNvSpPr>
                  <a:spLocks noChangeArrowheads="1"/>
                </p:cNvSpPr>
                <p:nvPr/>
              </p:nvSpPr>
              <p:spPr bwMode="auto">
                <a:xfrm>
                  <a:off x="6096001" y="2347913"/>
                  <a:ext cx="176213" cy="2049463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38" name="Freeform 141"/>
                <p:cNvSpPr>
                  <a:spLocks noEditPoints="1"/>
                </p:cNvSpPr>
                <p:nvPr/>
              </p:nvSpPr>
              <p:spPr bwMode="auto">
                <a:xfrm>
                  <a:off x="6091238" y="2343150"/>
                  <a:ext cx="185738" cy="2057400"/>
                </a:xfrm>
                <a:custGeom>
                  <a:avLst/>
                  <a:gdLst>
                    <a:gd name="T0" fmla="*/ 0 w 976"/>
                    <a:gd name="T1" fmla="*/ 24 h 10800"/>
                    <a:gd name="T2" fmla="*/ 24 w 976"/>
                    <a:gd name="T3" fmla="*/ 0 h 10800"/>
                    <a:gd name="T4" fmla="*/ 952 w 976"/>
                    <a:gd name="T5" fmla="*/ 0 h 10800"/>
                    <a:gd name="T6" fmla="*/ 976 w 976"/>
                    <a:gd name="T7" fmla="*/ 24 h 10800"/>
                    <a:gd name="T8" fmla="*/ 976 w 976"/>
                    <a:gd name="T9" fmla="*/ 10776 h 10800"/>
                    <a:gd name="T10" fmla="*/ 952 w 976"/>
                    <a:gd name="T11" fmla="*/ 10800 h 10800"/>
                    <a:gd name="T12" fmla="*/ 24 w 976"/>
                    <a:gd name="T13" fmla="*/ 10800 h 10800"/>
                    <a:gd name="T14" fmla="*/ 0 w 976"/>
                    <a:gd name="T15" fmla="*/ 10776 h 10800"/>
                    <a:gd name="T16" fmla="*/ 0 w 976"/>
                    <a:gd name="T17" fmla="*/ 24 h 10800"/>
                    <a:gd name="T18" fmla="*/ 48 w 976"/>
                    <a:gd name="T19" fmla="*/ 10776 h 10800"/>
                    <a:gd name="T20" fmla="*/ 24 w 976"/>
                    <a:gd name="T21" fmla="*/ 10752 h 10800"/>
                    <a:gd name="T22" fmla="*/ 952 w 976"/>
                    <a:gd name="T23" fmla="*/ 10752 h 10800"/>
                    <a:gd name="T24" fmla="*/ 928 w 976"/>
                    <a:gd name="T25" fmla="*/ 10776 h 10800"/>
                    <a:gd name="T26" fmla="*/ 928 w 976"/>
                    <a:gd name="T27" fmla="*/ 24 h 10800"/>
                    <a:gd name="T28" fmla="*/ 952 w 976"/>
                    <a:gd name="T29" fmla="*/ 48 h 10800"/>
                    <a:gd name="T30" fmla="*/ 24 w 976"/>
                    <a:gd name="T31" fmla="*/ 48 h 10800"/>
                    <a:gd name="T32" fmla="*/ 48 w 976"/>
                    <a:gd name="T33" fmla="*/ 24 h 10800"/>
                    <a:gd name="T34" fmla="*/ 48 w 976"/>
                    <a:gd name="T35" fmla="*/ 10776 h 1080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976" h="10800">
                      <a:moveTo>
                        <a:pt x="0" y="24"/>
                      </a:moveTo>
                      <a:cubicBezTo>
                        <a:pt x="0" y="11"/>
                        <a:pt x="11" y="0"/>
                        <a:pt x="24" y="0"/>
                      </a:cubicBezTo>
                      <a:lnTo>
                        <a:pt x="952" y="0"/>
                      </a:lnTo>
                      <a:cubicBezTo>
                        <a:pt x="966" y="0"/>
                        <a:pt x="976" y="11"/>
                        <a:pt x="976" y="24"/>
                      </a:cubicBezTo>
                      <a:lnTo>
                        <a:pt x="976" y="10776"/>
                      </a:lnTo>
                      <a:cubicBezTo>
                        <a:pt x="976" y="10790"/>
                        <a:pt x="966" y="10800"/>
                        <a:pt x="952" y="10800"/>
                      </a:cubicBezTo>
                      <a:lnTo>
                        <a:pt x="24" y="10800"/>
                      </a:lnTo>
                      <a:cubicBezTo>
                        <a:pt x="11" y="10800"/>
                        <a:pt x="0" y="10790"/>
                        <a:pt x="0" y="10776"/>
                      </a:cubicBezTo>
                      <a:lnTo>
                        <a:pt x="0" y="24"/>
                      </a:lnTo>
                      <a:close/>
                      <a:moveTo>
                        <a:pt x="48" y="10776"/>
                      </a:moveTo>
                      <a:lnTo>
                        <a:pt x="24" y="10752"/>
                      </a:lnTo>
                      <a:lnTo>
                        <a:pt x="952" y="10752"/>
                      </a:lnTo>
                      <a:lnTo>
                        <a:pt x="928" y="10776"/>
                      </a:lnTo>
                      <a:lnTo>
                        <a:pt x="928" y="24"/>
                      </a:lnTo>
                      <a:lnTo>
                        <a:pt x="952" y="48"/>
                      </a:lnTo>
                      <a:lnTo>
                        <a:pt x="24" y="48"/>
                      </a:lnTo>
                      <a:lnTo>
                        <a:pt x="48" y="24"/>
                      </a:lnTo>
                      <a:lnTo>
                        <a:pt x="48" y="10776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39" name="Rectangle 142"/>
                <p:cNvSpPr>
                  <a:spLocks noChangeArrowheads="1"/>
                </p:cNvSpPr>
                <p:nvPr/>
              </p:nvSpPr>
              <p:spPr bwMode="auto">
                <a:xfrm>
                  <a:off x="6535738" y="3787775"/>
                  <a:ext cx="176213" cy="60960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40" name="Freeform 143"/>
                <p:cNvSpPr>
                  <a:spLocks noEditPoints="1"/>
                </p:cNvSpPr>
                <p:nvPr/>
              </p:nvSpPr>
              <p:spPr bwMode="auto">
                <a:xfrm>
                  <a:off x="6530976" y="3784600"/>
                  <a:ext cx="185738" cy="615950"/>
                </a:xfrm>
                <a:custGeom>
                  <a:avLst/>
                  <a:gdLst>
                    <a:gd name="T0" fmla="*/ 0 w 976"/>
                    <a:gd name="T1" fmla="*/ 24 h 3240"/>
                    <a:gd name="T2" fmla="*/ 24 w 976"/>
                    <a:gd name="T3" fmla="*/ 0 h 3240"/>
                    <a:gd name="T4" fmla="*/ 952 w 976"/>
                    <a:gd name="T5" fmla="*/ 0 h 3240"/>
                    <a:gd name="T6" fmla="*/ 976 w 976"/>
                    <a:gd name="T7" fmla="*/ 24 h 3240"/>
                    <a:gd name="T8" fmla="*/ 976 w 976"/>
                    <a:gd name="T9" fmla="*/ 3216 h 3240"/>
                    <a:gd name="T10" fmla="*/ 952 w 976"/>
                    <a:gd name="T11" fmla="*/ 3240 h 3240"/>
                    <a:gd name="T12" fmla="*/ 24 w 976"/>
                    <a:gd name="T13" fmla="*/ 3240 h 3240"/>
                    <a:gd name="T14" fmla="*/ 0 w 976"/>
                    <a:gd name="T15" fmla="*/ 3216 h 3240"/>
                    <a:gd name="T16" fmla="*/ 0 w 976"/>
                    <a:gd name="T17" fmla="*/ 24 h 3240"/>
                    <a:gd name="T18" fmla="*/ 48 w 976"/>
                    <a:gd name="T19" fmla="*/ 3216 h 3240"/>
                    <a:gd name="T20" fmla="*/ 24 w 976"/>
                    <a:gd name="T21" fmla="*/ 3192 h 3240"/>
                    <a:gd name="T22" fmla="*/ 952 w 976"/>
                    <a:gd name="T23" fmla="*/ 3192 h 3240"/>
                    <a:gd name="T24" fmla="*/ 928 w 976"/>
                    <a:gd name="T25" fmla="*/ 3216 h 3240"/>
                    <a:gd name="T26" fmla="*/ 928 w 976"/>
                    <a:gd name="T27" fmla="*/ 24 h 3240"/>
                    <a:gd name="T28" fmla="*/ 952 w 976"/>
                    <a:gd name="T29" fmla="*/ 48 h 3240"/>
                    <a:gd name="T30" fmla="*/ 24 w 976"/>
                    <a:gd name="T31" fmla="*/ 48 h 3240"/>
                    <a:gd name="T32" fmla="*/ 48 w 976"/>
                    <a:gd name="T33" fmla="*/ 24 h 3240"/>
                    <a:gd name="T34" fmla="*/ 48 w 976"/>
                    <a:gd name="T35" fmla="*/ 3216 h 324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976" h="3240">
                      <a:moveTo>
                        <a:pt x="0" y="24"/>
                      </a:moveTo>
                      <a:cubicBezTo>
                        <a:pt x="0" y="11"/>
                        <a:pt x="11" y="0"/>
                        <a:pt x="24" y="0"/>
                      </a:cubicBezTo>
                      <a:lnTo>
                        <a:pt x="952" y="0"/>
                      </a:lnTo>
                      <a:cubicBezTo>
                        <a:pt x="966" y="0"/>
                        <a:pt x="976" y="11"/>
                        <a:pt x="976" y="24"/>
                      </a:cubicBezTo>
                      <a:lnTo>
                        <a:pt x="976" y="3216"/>
                      </a:lnTo>
                      <a:cubicBezTo>
                        <a:pt x="976" y="3230"/>
                        <a:pt x="966" y="3240"/>
                        <a:pt x="952" y="3240"/>
                      </a:cubicBezTo>
                      <a:lnTo>
                        <a:pt x="24" y="3240"/>
                      </a:lnTo>
                      <a:cubicBezTo>
                        <a:pt x="11" y="3240"/>
                        <a:pt x="0" y="3230"/>
                        <a:pt x="0" y="3216"/>
                      </a:cubicBezTo>
                      <a:lnTo>
                        <a:pt x="0" y="24"/>
                      </a:lnTo>
                      <a:close/>
                      <a:moveTo>
                        <a:pt x="48" y="3216"/>
                      </a:moveTo>
                      <a:lnTo>
                        <a:pt x="24" y="3192"/>
                      </a:lnTo>
                      <a:lnTo>
                        <a:pt x="952" y="3192"/>
                      </a:lnTo>
                      <a:lnTo>
                        <a:pt x="928" y="3216"/>
                      </a:lnTo>
                      <a:lnTo>
                        <a:pt x="928" y="24"/>
                      </a:lnTo>
                      <a:lnTo>
                        <a:pt x="952" y="48"/>
                      </a:lnTo>
                      <a:lnTo>
                        <a:pt x="24" y="48"/>
                      </a:lnTo>
                      <a:lnTo>
                        <a:pt x="48" y="24"/>
                      </a:lnTo>
                      <a:lnTo>
                        <a:pt x="48" y="3216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41" name="Rectangle 144"/>
                <p:cNvSpPr>
                  <a:spLocks noChangeArrowheads="1"/>
                </p:cNvSpPr>
                <p:nvPr/>
              </p:nvSpPr>
              <p:spPr bwMode="auto">
                <a:xfrm>
                  <a:off x="6977063" y="4364038"/>
                  <a:ext cx="176213" cy="33338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42" name="Freeform 145"/>
                <p:cNvSpPr>
                  <a:spLocks noEditPoints="1"/>
                </p:cNvSpPr>
                <p:nvPr/>
              </p:nvSpPr>
              <p:spPr bwMode="auto">
                <a:xfrm>
                  <a:off x="6973888" y="4359275"/>
                  <a:ext cx="184150" cy="41275"/>
                </a:xfrm>
                <a:custGeom>
                  <a:avLst/>
                  <a:gdLst>
                    <a:gd name="T0" fmla="*/ 0 w 968"/>
                    <a:gd name="T1" fmla="*/ 24 h 216"/>
                    <a:gd name="T2" fmla="*/ 24 w 968"/>
                    <a:gd name="T3" fmla="*/ 0 h 216"/>
                    <a:gd name="T4" fmla="*/ 944 w 968"/>
                    <a:gd name="T5" fmla="*/ 0 h 216"/>
                    <a:gd name="T6" fmla="*/ 968 w 968"/>
                    <a:gd name="T7" fmla="*/ 24 h 216"/>
                    <a:gd name="T8" fmla="*/ 968 w 968"/>
                    <a:gd name="T9" fmla="*/ 192 h 216"/>
                    <a:gd name="T10" fmla="*/ 944 w 968"/>
                    <a:gd name="T11" fmla="*/ 216 h 216"/>
                    <a:gd name="T12" fmla="*/ 24 w 968"/>
                    <a:gd name="T13" fmla="*/ 216 h 216"/>
                    <a:gd name="T14" fmla="*/ 0 w 968"/>
                    <a:gd name="T15" fmla="*/ 192 h 216"/>
                    <a:gd name="T16" fmla="*/ 0 w 968"/>
                    <a:gd name="T17" fmla="*/ 24 h 216"/>
                    <a:gd name="T18" fmla="*/ 48 w 968"/>
                    <a:gd name="T19" fmla="*/ 192 h 216"/>
                    <a:gd name="T20" fmla="*/ 24 w 968"/>
                    <a:gd name="T21" fmla="*/ 168 h 216"/>
                    <a:gd name="T22" fmla="*/ 944 w 968"/>
                    <a:gd name="T23" fmla="*/ 168 h 216"/>
                    <a:gd name="T24" fmla="*/ 920 w 968"/>
                    <a:gd name="T25" fmla="*/ 192 h 216"/>
                    <a:gd name="T26" fmla="*/ 920 w 968"/>
                    <a:gd name="T27" fmla="*/ 24 h 216"/>
                    <a:gd name="T28" fmla="*/ 944 w 968"/>
                    <a:gd name="T29" fmla="*/ 48 h 216"/>
                    <a:gd name="T30" fmla="*/ 24 w 968"/>
                    <a:gd name="T31" fmla="*/ 48 h 216"/>
                    <a:gd name="T32" fmla="*/ 48 w 968"/>
                    <a:gd name="T33" fmla="*/ 24 h 216"/>
                    <a:gd name="T34" fmla="*/ 48 w 968"/>
                    <a:gd name="T35" fmla="*/ 192 h 21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968" h="216">
                      <a:moveTo>
                        <a:pt x="0" y="24"/>
                      </a:moveTo>
                      <a:cubicBezTo>
                        <a:pt x="0" y="11"/>
                        <a:pt x="11" y="0"/>
                        <a:pt x="24" y="0"/>
                      </a:cubicBezTo>
                      <a:lnTo>
                        <a:pt x="944" y="0"/>
                      </a:lnTo>
                      <a:cubicBezTo>
                        <a:pt x="958" y="0"/>
                        <a:pt x="968" y="11"/>
                        <a:pt x="968" y="24"/>
                      </a:cubicBezTo>
                      <a:lnTo>
                        <a:pt x="968" y="192"/>
                      </a:lnTo>
                      <a:cubicBezTo>
                        <a:pt x="968" y="206"/>
                        <a:pt x="958" y="216"/>
                        <a:pt x="944" y="216"/>
                      </a:cubicBezTo>
                      <a:lnTo>
                        <a:pt x="24" y="216"/>
                      </a:lnTo>
                      <a:cubicBezTo>
                        <a:pt x="11" y="216"/>
                        <a:pt x="0" y="206"/>
                        <a:pt x="0" y="192"/>
                      </a:cubicBezTo>
                      <a:lnTo>
                        <a:pt x="0" y="24"/>
                      </a:lnTo>
                      <a:close/>
                      <a:moveTo>
                        <a:pt x="48" y="192"/>
                      </a:moveTo>
                      <a:lnTo>
                        <a:pt x="24" y="168"/>
                      </a:lnTo>
                      <a:lnTo>
                        <a:pt x="944" y="168"/>
                      </a:lnTo>
                      <a:lnTo>
                        <a:pt x="920" y="192"/>
                      </a:lnTo>
                      <a:lnTo>
                        <a:pt x="920" y="24"/>
                      </a:lnTo>
                      <a:lnTo>
                        <a:pt x="944" y="48"/>
                      </a:lnTo>
                      <a:lnTo>
                        <a:pt x="24" y="48"/>
                      </a:lnTo>
                      <a:lnTo>
                        <a:pt x="48" y="24"/>
                      </a:lnTo>
                      <a:lnTo>
                        <a:pt x="48" y="19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43" name="Rectangle 146"/>
                <p:cNvSpPr>
                  <a:spLocks noChangeArrowheads="1"/>
                </p:cNvSpPr>
                <p:nvPr/>
              </p:nvSpPr>
              <p:spPr bwMode="auto">
                <a:xfrm>
                  <a:off x="2430463" y="2146300"/>
                  <a:ext cx="9525" cy="2251075"/>
                </a:xfrm>
                <a:prstGeom prst="rect">
                  <a:avLst/>
                </a:prstGeom>
                <a:solidFill>
                  <a:srgbClr val="868686"/>
                </a:solidFill>
                <a:ln w="1" cap="flat">
                  <a:solidFill>
                    <a:schemeClr val="tx1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44" name="Freeform 147"/>
                <p:cNvSpPr>
                  <a:spLocks noEditPoints="1"/>
                </p:cNvSpPr>
                <p:nvPr/>
              </p:nvSpPr>
              <p:spPr bwMode="auto">
                <a:xfrm>
                  <a:off x="2389188" y="2143125"/>
                  <a:ext cx="46038" cy="2257425"/>
                </a:xfrm>
                <a:custGeom>
                  <a:avLst/>
                  <a:gdLst>
                    <a:gd name="T0" fmla="*/ 0 w 29"/>
                    <a:gd name="T1" fmla="*/ 1417 h 1422"/>
                    <a:gd name="T2" fmla="*/ 29 w 29"/>
                    <a:gd name="T3" fmla="*/ 1417 h 1422"/>
                    <a:gd name="T4" fmla="*/ 29 w 29"/>
                    <a:gd name="T5" fmla="*/ 1422 h 1422"/>
                    <a:gd name="T6" fmla="*/ 0 w 29"/>
                    <a:gd name="T7" fmla="*/ 1422 h 1422"/>
                    <a:gd name="T8" fmla="*/ 0 w 29"/>
                    <a:gd name="T9" fmla="*/ 1417 h 1422"/>
                    <a:gd name="T10" fmla="*/ 0 w 29"/>
                    <a:gd name="T11" fmla="*/ 1132 h 1422"/>
                    <a:gd name="T12" fmla="*/ 29 w 29"/>
                    <a:gd name="T13" fmla="*/ 1132 h 1422"/>
                    <a:gd name="T14" fmla="*/ 29 w 29"/>
                    <a:gd name="T15" fmla="*/ 1138 h 1422"/>
                    <a:gd name="T16" fmla="*/ 0 w 29"/>
                    <a:gd name="T17" fmla="*/ 1138 h 1422"/>
                    <a:gd name="T18" fmla="*/ 0 w 29"/>
                    <a:gd name="T19" fmla="*/ 1132 h 1422"/>
                    <a:gd name="T20" fmla="*/ 0 w 29"/>
                    <a:gd name="T21" fmla="*/ 849 h 1422"/>
                    <a:gd name="T22" fmla="*/ 29 w 29"/>
                    <a:gd name="T23" fmla="*/ 849 h 1422"/>
                    <a:gd name="T24" fmla="*/ 29 w 29"/>
                    <a:gd name="T25" fmla="*/ 855 h 1422"/>
                    <a:gd name="T26" fmla="*/ 0 w 29"/>
                    <a:gd name="T27" fmla="*/ 855 h 1422"/>
                    <a:gd name="T28" fmla="*/ 0 w 29"/>
                    <a:gd name="T29" fmla="*/ 849 h 1422"/>
                    <a:gd name="T30" fmla="*/ 0 w 29"/>
                    <a:gd name="T31" fmla="*/ 566 h 1422"/>
                    <a:gd name="T32" fmla="*/ 29 w 29"/>
                    <a:gd name="T33" fmla="*/ 566 h 1422"/>
                    <a:gd name="T34" fmla="*/ 29 w 29"/>
                    <a:gd name="T35" fmla="*/ 572 h 1422"/>
                    <a:gd name="T36" fmla="*/ 0 w 29"/>
                    <a:gd name="T37" fmla="*/ 572 h 1422"/>
                    <a:gd name="T38" fmla="*/ 0 w 29"/>
                    <a:gd name="T39" fmla="*/ 566 h 1422"/>
                    <a:gd name="T40" fmla="*/ 0 w 29"/>
                    <a:gd name="T41" fmla="*/ 283 h 1422"/>
                    <a:gd name="T42" fmla="*/ 29 w 29"/>
                    <a:gd name="T43" fmla="*/ 283 h 1422"/>
                    <a:gd name="T44" fmla="*/ 29 w 29"/>
                    <a:gd name="T45" fmla="*/ 289 h 1422"/>
                    <a:gd name="T46" fmla="*/ 0 w 29"/>
                    <a:gd name="T47" fmla="*/ 289 h 1422"/>
                    <a:gd name="T48" fmla="*/ 0 w 29"/>
                    <a:gd name="T49" fmla="*/ 283 h 1422"/>
                    <a:gd name="T50" fmla="*/ 0 w 29"/>
                    <a:gd name="T51" fmla="*/ 0 h 1422"/>
                    <a:gd name="T52" fmla="*/ 29 w 29"/>
                    <a:gd name="T53" fmla="*/ 0 h 1422"/>
                    <a:gd name="T54" fmla="*/ 29 w 29"/>
                    <a:gd name="T55" fmla="*/ 5 h 1422"/>
                    <a:gd name="T56" fmla="*/ 0 w 29"/>
                    <a:gd name="T57" fmla="*/ 5 h 1422"/>
                    <a:gd name="T58" fmla="*/ 0 w 29"/>
                    <a:gd name="T59" fmla="*/ 0 h 142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</a:cxnLst>
                  <a:rect l="0" t="0" r="r" b="b"/>
                  <a:pathLst>
                    <a:path w="29" h="1422">
                      <a:moveTo>
                        <a:pt x="0" y="1417"/>
                      </a:moveTo>
                      <a:lnTo>
                        <a:pt x="29" y="1417"/>
                      </a:lnTo>
                      <a:lnTo>
                        <a:pt x="29" y="1422"/>
                      </a:lnTo>
                      <a:lnTo>
                        <a:pt x="0" y="1422"/>
                      </a:lnTo>
                      <a:lnTo>
                        <a:pt x="0" y="1417"/>
                      </a:lnTo>
                      <a:close/>
                      <a:moveTo>
                        <a:pt x="0" y="1132"/>
                      </a:moveTo>
                      <a:lnTo>
                        <a:pt x="29" y="1132"/>
                      </a:lnTo>
                      <a:lnTo>
                        <a:pt x="29" y="1138"/>
                      </a:lnTo>
                      <a:lnTo>
                        <a:pt x="0" y="1138"/>
                      </a:lnTo>
                      <a:lnTo>
                        <a:pt x="0" y="1132"/>
                      </a:lnTo>
                      <a:close/>
                      <a:moveTo>
                        <a:pt x="0" y="849"/>
                      </a:moveTo>
                      <a:lnTo>
                        <a:pt x="29" y="849"/>
                      </a:lnTo>
                      <a:lnTo>
                        <a:pt x="29" y="855"/>
                      </a:lnTo>
                      <a:lnTo>
                        <a:pt x="0" y="855"/>
                      </a:lnTo>
                      <a:lnTo>
                        <a:pt x="0" y="849"/>
                      </a:lnTo>
                      <a:close/>
                      <a:moveTo>
                        <a:pt x="0" y="566"/>
                      </a:moveTo>
                      <a:lnTo>
                        <a:pt x="29" y="566"/>
                      </a:lnTo>
                      <a:lnTo>
                        <a:pt x="29" y="572"/>
                      </a:lnTo>
                      <a:lnTo>
                        <a:pt x="0" y="572"/>
                      </a:lnTo>
                      <a:lnTo>
                        <a:pt x="0" y="566"/>
                      </a:lnTo>
                      <a:close/>
                      <a:moveTo>
                        <a:pt x="0" y="283"/>
                      </a:moveTo>
                      <a:lnTo>
                        <a:pt x="29" y="283"/>
                      </a:lnTo>
                      <a:lnTo>
                        <a:pt x="29" y="289"/>
                      </a:lnTo>
                      <a:lnTo>
                        <a:pt x="0" y="289"/>
                      </a:lnTo>
                      <a:lnTo>
                        <a:pt x="0" y="283"/>
                      </a:lnTo>
                      <a:close/>
                      <a:moveTo>
                        <a:pt x="0" y="0"/>
                      </a:moveTo>
                      <a:lnTo>
                        <a:pt x="29" y="0"/>
                      </a:lnTo>
                      <a:lnTo>
                        <a:pt x="29" y="5"/>
                      </a:lnTo>
                      <a:lnTo>
                        <a:pt x="0" y="5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1" cap="flat">
                  <a:solidFill>
                    <a:schemeClr val="tx1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45" name="Rectangle 148"/>
                <p:cNvSpPr>
                  <a:spLocks noChangeArrowheads="1"/>
                </p:cNvSpPr>
                <p:nvPr/>
              </p:nvSpPr>
              <p:spPr bwMode="auto">
                <a:xfrm>
                  <a:off x="2435226" y="4392613"/>
                  <a:ext cx="4849813" cy="7938"/>
                </a:xfrm>
                <a:prstGeom prst="rect">
                  <a:avLst/>
                </a:prstGeom>
                <a:solidFill>
                  <a:srgbClr val="868686"/>
                </a:solidFill>
                <a:ln w="1" cap="flat">
                  <a:solidFill>
                    <a:schemeClr val="tx1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ko-KR" alt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46" name="Rectangle 149"/>
                <p:cNvSpPr>
                  <a:spLocks noChangeArrowheads="1"/>
                </p:cNvSpPr>
                <p:nvPr/>
              </p:nvSpPr>
              <p:spPr bwMode="auto">
                <a:xfrm>
                  <a:off x="2149328" y="4308475"/>
                  <a:ext cx="139798" cy="2622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0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447" name="Rectangle 150"/>
                <p:cNvSpPr>
                  <a:spLocks noChangeArrowheads="1"/>
                </p:cNvSpPr>
                <p:nvPr/>
              </p:nvSpPr>
              <p:spPr bwMode="auto">
                <a:xfrm>
                  <a:off x="1980938" y="3857626"/>
                  <a:ext cx="350812" cy="2622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0.5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448" name="Rectangle 151"/>
                <p:cNvSpPr>
                  <a:spLocks noChangeArrowheads="1"/>
                </p:cNvSpPr>
                <p:nvPr/>
              </p:nvSpPr>
              <p:spPr bwMode="auto">
                <a:xfrm>
                  <a:off x="2149328" y="3408362"/>
                  <a:ext cx="139798" cy="2622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1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449" name="Rectangle 152"/>
                <p:cNvSpPr>
                  <a:spLocks noChangeArrowheads="1"/>
                </p:cNvSpPr>
                <p:nvPr/>
              </p:nvSpPr>
              <p:spPr bwMode="auto">
                <a:xfrm>
                  <a:off x="1980938" y="2959101"/>
                  <a:ext cx="350812" cy="2622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1.5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450" name="Rectangle 153"/>
                <p:cNvSpPr>
                  <a:spLocks noChangeArrowheads="1"/>
                </p:cNvSpPr>
                <p:nvPr/>
              </p:nvSpPr>
              <p:spPr bwMode="auto">
                <a:xfrm>
                  <a:off x="2149328" y="2508250"/>
                  <a:ext cx="139798" cy="2622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2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451" name="Rectangle 154"/>
                <p:cNvSpPr>
                  <a:spLocks noChangeArrowheads="1"/>
                </p:cNvSpPr>
                <p:nvPr/>
              </p:nvSpPr>
              <p:spPr bwMode="auto">
                <a:xfrm>
                  <a:off x="1980938" y="2058988"/>
                  <a:ext cx="350812" cy="2622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2.5</a:t>
                  </a:r>
                  <a:endPara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452" name="Rectangle 155"/>
                <p:cNvSpPr>
                  <a:spLocks noChangeArrowheads="1"/>
                </p:cNvSpPr>
                <p:nvPr/>
              </p:nvSpPr>
              <p:spPr bwMode="auto">
                <a:xfrm>
                  <a:off x="2376855" y="4489451"/>
                  <a:ext cx="532813" cy="2622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ont</a:t>
                  </a:r>
                  <a:endPara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453" name="Rectangle 156"/>
                <p:cNvSpPr>
                  <a:spLocks noChangeArrowheads="1"/>
                </p:cNvSpPr>
                <p:nvPr/>
              </p:nvSpPr>
              <p:spPr bwMode="auto">
                <a:xfrm>
                  <a:off x="2921480" y="4489449"/>
                  <a:ext cx="321796" cy="2622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1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454" name="Rectangle 157"/>
                <p:cNvSpPr>
                  <a:spLocks noChangeArrowheads="1"/>
                </p:cNvSpPr>
                <p:nvPr/>
              </p:nvSpPr>
              <p:spPr bwMode="auto">
                <a:xfrm>
                  <a:off x="3362804" y="4489449"/>
                  <a:ext cx="321796" cy="2622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2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455" name="Rectangle 158"/>
                <p:cNvSpPr>
                  <a:spLocks noChangeArrowheads="1"/>
                </p:cNvSpPr>
                <p:nvPr/>
              </p:nvSpPr>
              <p:spPr bwMode="auto">
                <a:xfrm>
                  <a:off x="3804129" y="4489449"/>
                  <a:ext cx="321796" cy="2622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3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456" name="Rectangle 159"/>
                <p:cNvSpPr>
                  <a:spLocks noChangeArrowheads="1"/>
                </p:cNvSpPr>
                <p:nvPr/>
              </p:nvSpPr>
              <p:spPr bwMode="auto">
                <a:xfrm>
                  <a:off x="4245454" y="4489449"/>
                  <a:ext cx="321796" cy="2622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4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457" name="Rectangle 160"/>
                <p:cNvSpPr>
                  <a:spLocks noChangeArrowheads="1"/>
                </p:cNvSpPr>
                <p:nvPr/>
              </p:nvSpPr>
              <p:spPr bwMode="auto">
                <a:xfrm>
                  <a:off x="4686779" y="4489449"/>
                  <a:ext cx="321796" cy="2622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5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458" name="Rectangle 161"/>
                <p:cNvSpPr>
                  <a:spLocks noChangeArrowheads="1"/>
                </p:cNvSpPr>
                <p:nvPr/>
              </p:nvSpPr>
              <p:spPr bwMode="auto">
                <a:xfrm>
                  <a:off x="5126518" y="4489449"/>
                  <a:ext cx="321796" cy="2622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6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459" name="Rectangle 162"/>
                <p:cNvSpPr>
                  <a:spLocks noChangeArrowheads="1"/>
                </p:cNvSpPr>
                <p:nvPr/>
              </p:nvSpPr>
              <p:spPr bwMode="auto">
                <a:xfrm>
                  <a:off x="5567843" y="4489449"/>
                  <a:ext cx="321796" cy="2622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7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460" name="Rectangle 163"/>
                <p:cNvSpPr>
                  <a:spLocks noChangeArrowheads="1"/>
                </p:cNvSpPr>
                <p:nvPr/>
              </p:nvSpPr>
              <p:spPr bwMode="auto">
                <a:xfrm>
                  <a:off x="6009168" y="4489449"/>
                  <a:ext cx="321796" cy="2622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8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461" name="Rectangle 164"/>
                <p:cNvSpPr>
                  <a:spLocks noChangeArrowheads="1"/>
                </p:cNvSpPr>
                <p:nvPr/>
              </p:nvSpPr>
              <p:spPr bwMode="auto">
                <a:xfrm>
                  <a:off x="6450493" y="4489449"/>
                  <a:ext cx="321796" cy="2622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C9</a:t>
                  </a:r>
                  <a:endPara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462" name="Rectangle 165"/>
                <p:cNvSpPr>
                  <a:spLocks noChangeArrowheads="1"/>
                </p:cNvSpPr>
                <p:nvPr/>
              </p:nvSpPr>
              <p:spPr bwMode="auto">
                <a:xfrm>
                  <a:off x="6851282" y="4489449"/>
                  <a:ext cx="717449" cy="2622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GCSE</a:t>
                  </a:r>
                  <a:endPara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  <p:sp>
              <p:nvSpPr>
                <p:cNvPr id="463" name="Rectangle 166"/>
                <p:cNvSpPr>
                  <a:spLocks noChangeArrowheads="1"/>
                </p:cNvSpPr>
                <p:nvPr/>
              </p:nvSpPr>
              <p:spPr bwMode="auto">
                <a:xfrm rot="16200000">
                  <a:off x="534524" y="3111332"/>
                  <a:ext cx="2474757" cy="30386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ctr" defTabSz="914400" rtl="0" eaLnBrk="1" fontAlgn="base" latinLnBrk="1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ko-KR" altLang="ko-K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Relative IFN</a:t>
                  </a:r>
                  <a:r>
                    <a:rPr kumimoji="1" lang="en-US" altLang="ko-K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-</a:t>
                  </a:r>
                  <a:r>
                    <a:rPr kumimoji="1" lang="ko-KR" altLang="ko-K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Symbol" pitchFamily="18" charset="2"/>
                      <a:ea typeface="굴림" pitchFamily="50" charset="-127"/>
                      <a:cs typeface="Arial" pitchFamily="34" charset="0"/>
                    </a:rPr>
                    <a:t>g</a:t>
                  </a:r>
                  <a:r>
                    <a:rPr kumimoji="1" lang="ko-KR" altLang="ko-K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 </a:t>
                  </a:r>
                  <a:r>
                    <a:rPr kumimoji="1" lang="en-US" altLang="ko-K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ea typeface="굴림" pitchFamily="50" charset="-127"/>
                      <a:cs typeface="Arial" pitchFamily="34" charset="0"/>
                    </a:rPr>
                    <a:t>expression</a:t>
                  </a:r>
                  <a:endPara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굴림" pitchFamily="50" charset="-127"/>
                    <a:cs typeface="Arial" pitchFamily="34" charset="0"/>
                  </a:endParaRPr>
                </a:p>
              </p:txBody>
            </p:sp>
          </p:grpSp>
          <p:cxnSp>
            <p:nvCxnSpPr>
              <p:cNvPr id="403" name="꺾인 연결선 402"/>
              <p:cNvCxnSpPr/>
              <p:nvPr/>
            </p:nvCxnSpPr>
            <p:spPr>
              <a:xfrm rot="5400000" flipH="1">
                <a:off x="3482112" y="2363881"/>
                <a:ext cx="504000" cy="2664000"/>
              </a:xfrm>
              <a:prstGeom prst="bentConnector3">
                <a:avLst>
                  <a:gd name="adj1" fmla="val 267355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4" name="꺾인 연결선 403"/>
              <p:cNvCxnSpPr/>
              <p:nvPr/>
            </p:nvCxnSpPr>
            <p:spPr>
              <a:xfrm rot="5400000" flipH="1">
                <a:off x="3420508" y="2178350"/>
                <a:ext cx="360000" cy="2412000"/>
              </a:xfrm>
              <a:prstGeom prst="bentConnector3">
                <a:avLst>
                  <a:gd name="adj1" fmla="val 267355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5" name="꺾인 연결선 404"/>
              <p:cNvCxnSpPr/>
              <p:nvPr/>
            </p:nvCxnSpPr>
            <p:spPr>
              <a:xfrm rot="5400000" flipH="1">
                <a:off x="3438508" y="1613164"/>
                <a:ext cx="36000" cy="2124000"/>
              </a:xfrm>
              <a:prstGeom prst="bentConnector3">
                <a:avLst>
                  <a:gd name="adj1" fmla="val 267355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6" name="꺾인 연결선 405"/>
              <p:cNvCxnSpPr/>
              <p:nvPr/>
            </p:nvCxnSpPr>
            <p:spPr>
              <a:xfrm rot="5400000" flipH="1">
                <a:off x="3294716" y="1817546"/>
                <a:ext cx="72000" cy="1872000"/>
              </a:xfrm>
              <a:prstGeom prst="bentConnector3">
                <a:avLst>
                  <a:gd name="adj1" fmla="val 267355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7" name="꺾인 연결선 406"/>
              <p:cNvCxnSpPr/>
              <p:nvPr/>
            </p:nvCxnSpPr>
            <p:spPr>
              <a:xfrm rot="5400000" flipH="1">
                <a:off x="3023386" y="2733031"/>
                <a:ext cx="360000" cy="1602000"/>
              </a:xfrm>
              <a:prstGeom prst="bentConnector3">
                <a:avLst>
                  <a:gd name="adj1" fmla="val 267355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8" name="꺾인 연결선 407"/>
              <p:cNvCxnSpPr/>
              <p:nvPr/>
            </p:nvCxnSpPr>
            <p:spPr>
              <a:xfrm rot="5400000" flipH="1">
                <a:off x="2862508" y="2946795"/>
                <a:ext cx="396000" cy="1332000"/>
              </a:xfrm>
              <a:prstGeom prst="bentConnector3">
                <a:avLst>
                  <a:gd name="adj1" fmla="val 267355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9" name="꺾인 연결선 408"/>
              <p:cNvCxnSpPr/>
              <p:nvPr/>
            </p:nvCxnSpPr>
            <p:spPr>
              <a:xfrm rot="5400000" flipH="1">
                <a:off x="2736508" y="3131673"/>
                <a:ext cx="396000" cy="1080000"/>
              </a:xfrm>
              <a:prstGeom prst="bentConnector3">
                <a:avLst>
                  <a:gd name="adj1" fmla="val 267355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0" name="꺾인 연결선 409"/>
              <p:cNvCxnSpPr/>
              <p:nvPr/>
            </p:nvCxnSpPr>
            <p:spPr>
              <a:xfrm rot="5400000" flipH="1">
                <a:off x="2616134" y="3195787"/>
                <a:ext cx="360000" cy="792000"/>
              </a:xfrm>
              <a:prstGeom prst="bentConnector3">
                <a:avLst>
                  <a:gd name="adj1" fmla="val 267355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1" name="꺾인 연결선 410"/>
              <p:cNvCxnSpPr/>
              <p:nvPr/>
            </p:nvCxnSpPr>
            <p:spPr>
              <a:xfrm rot="5400000" flipH="1">
                <a:off x="2323256" y="3583177"/>
                <a:ext cx="414000" cy="270000"/>
              </a:xfrm>
              <a:prstGeom prst="bentConnector3">
                <a:avLst>
                  <a:gd name="adj1" fmla="val 267355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2" name="TextBox 411"/>
              <p:cNvSpPr txBox="1"/>
              <p:nvPr/>
            </p:nvSpPr>
            <p:spPr>
              <a:xfrm>
                <a:off x="2483768" y="3932463"/>
                <a:ext cx="3626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3" name="TextBox 412"/>
              <p:cNvSpPr txBox="1"/>
              <p:nvPr/>
            </p:nvSpPr>
            <p:spPr>
              <a:xfrm>
                <a:off x="3049424" y="3760162"/>
                <a:ext cx="3032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4" name="TextBox 413"/>
              <p:cNvSpPr txBox="1"/>
              <p:nvPr/>
            </p:nvSpPr>
            <p:spPr>
              <a:xfrm>
                <a:off x="3320982" y="3861048"/>
                <a:ext cx="3032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5" name="TextBox 414"/>
              <p:cNvSpPr txBox="1"/>
              <p:nvPr/>
            </p:nvSpPr>
            <p:spPr>
              <a:xfrm>
                <a:off x="3583136" y="3878300"/>
                <a:ext cx="3032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6" name="TextBox 415"/>
              <p:cNvSpPr txBox="1"/>
              <p:nvPr/>
            </p:nvSpPr>
            <p:spPr>
              <a:xfrm>
                <a:off x="3851920" y="3751536"/>
                <a:ext cx="3032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7" name="TextBox 416"/>
              <p:cNvSpPr txBox="1"/>
              <p:nvPr/>
            </p:nvSpPr>
            <p:spPr>
              <a:xfrm>
                <a:off x="4149355" y="2734798"/>
                <a:ext cx="2439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8" name="TextBox 417"/>
              <p:cNvSpPr txBox="1"/>
              <p:nvPr/>
            </p:nvSpPr>
            <p:spPr>
              <a:xfrm>
                <a:off x="4436610" y="2585156"/>
                <a:ext cx="2439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9" name="TextBox 418"/>
              <p:cNvSpPr txBox="1"/>
              <p:nvPr/>
            </p:nvSpPr>
            <p:spPr>
              <a:xfrm>
                <a:off x="4688063" y="3584049"/>
                <a:ext cx="2439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0" name="TextBox 419"/>
              <p:cNvSpPr txBox="1"/>
              <p:nvPr/>
            </p:nvSpPr>
            <p:spPr>
              <a:xfrm>
                <a:off x="4894976" y="3984812"/>
                <a:ext cx="3626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214" name="TextBox 213"/>
          <p:cNvSpPr txBox="1"/>
          <p:nvPr/>
        </p:nvSpPr>
        <p:spPr>
          <a:xfrm>
            <a:off x="748946" y="334145"/>
            <a:ext cx="3032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A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5" name="TextBox 214"/>
          <p:cNvSpPr txBox="1"/>
          <p:nvPr/>
        </p:nvSpPr>
        <p:spPr>
          <a:xfrm>
            <a:off x="4765231" y="332656"/>
            <a:ext cx="3032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B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6" name="TextBox 215"/>
          <p:cNvSpPr txBox="1"/>
          <p:nvPr/>
        </p:nvSpPr>
        <p:spPr>
          <a:xfrm>
            <a:off x="692194" y="272411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C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572000" y="2991544"/>
            <a:ext cx="4330255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upplement </a:t>
            </a:r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Figure 2. Inhibitory effect of GCSE on cytokine production.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 Draining lymph node CD4+ T cells from AD-induced mice were stimulated with PMA (50 </a:t>
            </a:r>
            <a:r>
              <a:rPr lang="en-US" altLang="ko-KR" sz="1200" dirty="0" err="1">
                <a:latin typeface="Arial" pitchFamily="34" charset="0"/>
                <a:cs typeface="Arial" pitchFamily="34" charset="0"/>
              </a:rPr>
              <a:t>ng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/ml)/ionomycin (1 </a:t>
            </a:r>
            <a:r>
              <a:rPr lang="en-US" altLang="ko-KR" sz="1200" dirty="0" err="1">
                <a:latin typeface="Symbol"/>
                <a:ea typeface="바탕"/>
                <a:cs typeface="Arial"/>
              </a:rPr>
              <a:t>m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M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) in the presence of each individual component of GCSE or a mixture of them (GCSE; 0.25 mg/ml) for 4 hrs. Relative expression levels of IL-4 (A), IL-5 (B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),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and IFN-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g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 (C) of single extract treated samples were compared with control samples by </a:t>
            </a:r>
            <a:r>
              <a:rPr lang="en-US" altLang="ko-KR" sz="1200" dirty="0" err="1">
                <a:latin typeface="Arial" pitchFamily="34" charset="0"/>
                <a:cs typeface="Arial" pitchFamily="34" charset="0"/>
              </a:rPr>
              <a:t>qRT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-PCR. Expression level of HPRT was used as an internal control. Error bars indicate SD. One (*), two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(**),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and three (***) indicate p&lt;0.05,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p&lt;0.01,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and p&lt;0.001 respectively. Data are representative of three independent experiments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20393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0" name="그룹 69"/>
          <p:cNvGrpSpPr/>
          <p:nvPr/>
        </p:nvGrpSpPr>
        <p:grpSpPr>
          <a:xfrm>
            <a:off x="1962852" y="886068"/>
            <a:ext cx="2619360" cy="2252181"/>
            <a:chOff x="1746828" y="1988840"/>
            <a:chExt cx="2619360" cy="2467956"/>
          </a:xfrm>
        </p:grpSpPr>
        <p:grpSp>
          <p:nvGrpSpPr>
            <p:cNvPr id="1042" name="그룹 1041"/>
            <p:cNvGrpSpPr/>
            <p:nvPr/>
          </p:nvGrpSpPr>
          <p:grpSpPr>
            <a:xfrm>
              <a:off x="1821192" y="2327817"/>
              <a:ext cx="2544996" cy="2128979"/>
              <a:chOff x="2869724" y="2102398"/>
              <a:chExt cx="3582894" cy="2543829"/>
            </a:xfrm>
          </p:grpSpPr>
          <p:sp>
            <p:nvSpPr>
              <p:cNvPr id="7" name="Rectangle 8"/>
              <p:cNvSpPr>
                <a:spLocks noChangeArrowheads="1"/>
              </p:cNvSpPr>
              <p:nvPr/>
            </p:nvSpPr>
            <p:spPr bwMode="auto">
              <a:xfrm>
                <a:off x="3700463" y="4283075"/>
                <a:ext cx="184150" cy="682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Freeform 9"/>
              <p:cNvSpPr>
                <a:spLocks noEditPoints="1"/>
              </p:cNvSpPr>
              <p:nvPr/>
            </p:nvSpPr>
            <p:spPr bwMode="auto">
              <a:xfrm>
                <a:off x="3695700" y="4278313"/>
                <a:ext cx="193675" cy="77788"/>
              </a:xfrm>
              <a:custGeom>
                <a:avLst/>
                <a:gdLst>
                  <a:gd name="T0" fmla="*/ 0 w 2032"/>
                  <a:gd name="T1" fmla="*/ 48 h 816"/>
                  <a:gd name="T2" fmla="*/ 48 w 2032"/>
                  <a:gd name="T3" fmla="*/ 0 h 816"/>
                  <a:gd name="T4" fmla="*/ 1984 w 2032"/>
                  <a:gd name="T5" fmla="*/ 0 h 816"/>
                  <a:gd name="T6" fmla="*/ 2032 w 2032"/>
                  <a:gd name="T7" fmla="*/ 48 h 816"/>
                  <a:gd name="T8" fmla="*/ 2032 w 2032"/>
                  <a:gd name="T9" fmla="*/ 768 h 816"/>
                  <a:gd name="T10" fmla="*/ 1984 w 2032"/>
                  <a:gd name="T11" fmla="*/ 816 h 816"/>
                  <a:gd name="T12" fmla="*/ 48 w 2032"/>
                  <a:gd name="T13" fmla="*/ 816 h 816"/>
                  <a:gd name="T14" fmla="*/ 0 w 2032"/>
                  <a:gd name="T15" fmla="*/ 768 h 816"/>
                  <a:gd name="T16" fmla="*/ 0 w 2032"/>
                  <a:gd name="T17" fmla="*/ 48 h 816"/>
                  <a:gd name="T18" fmla="*/ 96 w 2032"/>
                  <a:gd name="T19" fmla="*/ 768 h 816"/>
                  <a:gd name="T20" fmla="*/ 48 w 2032"/>
                  <a:gd name="T21" fmla="*/ 720 h 816"/>
                  <a:gd name="T22" fmla="*/ 1984 w 2032"/>
                  <a:gd name="T23" fmla="*/ 720 h 816"/>
                  <a:gd name="T24" fmla="*/ 1936 w 2032"/>
                  <a:gd name="T25" fmla="*/ 768 h 816"/>
                  <a:gd name="T26" fmla="*/ 1936 w 2032"/>
                  <a:gd name="T27" fmla="*/ 48 h 816"/>
                  <a:gd name="T28" fmla="*/ 1984 w 2032"/>
                  <a:gd name="T29" fmla="*/ 96 h 816"/>
                  <a:gd name="T30" fmla="*/ 48 w 2032"/>
                  <a:gd name="T31" fmla="*/ 96 h 816"/>
                  <a:gd name="T32" fmla="*/ 96 w 2032"/>
                  <a:gd name="T33" fmla="*/ 48 h 816"/>
                  <a:gd name="T34" fmla="*/ 96 w 2032"/>
                  <a:gd name="T35" fmla="*/ 768 h 8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2032" h="816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1984" y="0"/>
                    </a:lnTo>
                    <a:cubicBezTo>
                      <a:pt x="2011" y="0"/>
                      <a:pt x="2032" y="22"/>
                      <a:pt x="2032" y="48"/>
                    </a:cubicBezTo>
                    <a:lnTo>
                      <a:pt x="2032" y="768"/>
                    </a:lnTo>
                    <a:cubicBezTo>
                      <a:pt x="2032" y="795"/>
                      <a:pt x="2011" y="816"/>
                      <a:pt x="1984" y="816"/>
                    </a:cubicBezTo>
                    <a:lnTo>
                      <a:pt x="48" y="816"/>
                    </a:lnTo>
                    <a:cubicBezTo>
                      <a:pt x="22" y="816"/>
                      <a:pt x="0" y="795"/>
                      <a:pt x="0" y="768"/>
                    </a:cubicBezTo>
                    <a:lnTo>
                      <a:pt x="0" y="48"/>
                    </a:lnTo>
                    <a:close/>
                    <a:moveTo>
                      <a:pt x="96" y="768"/>
                    </a:moveTo>
                    <a:lnTo>
                      <a:pt x="48" y="720"/>
                    </a:lnTo>
                    <a:lnTo>
                      <a:pt x="1984" y="720"/>
                    </a:lnTo>
                    <a:lnTo>
                      <a:pt x="1936" y="768"/>
                    </a:lnTo>
                    <a:lnTo>
                      <a:pt x="1936" y="48"/>
                    </a:lnTo>
                    <a:lnTo>
                      <a:pt x="1984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76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Rectangle 10"/>
              <p:cNvSpPr>
                <a:spLocks noChangeArrowheads="1"/>
              </p:cNvSpPr>
              <p:nvPr/>
            </p:nvSpPr>
            <p:spPr bwMode="auto">
              <a:xfrm>
                <a:off x="4344988" y="4283075"/>
                <a:ext cx="184150" cy="682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Freeform 11"/>
              <p:cNvSpPr>
                <a:spLocks noEditPoints="1"/>
              </p:cNvSpPr>
              <p:nvPr/>
            </p:nvSpPr>
            <p:spPr bwMode="auto">
              <a:xfrm>
                <a:off x="4340225" y="4278313"/>
                <a:ext cx="193675" cy="77788"/>
              </a:xfrm>
              <a:custGeom>
                <a:avLst/>
                <a:gdLst>
                  <a:gd name="T0" fmla="*/ 0 w 2032"/>
                  <a:gd name="T1" fmla="*/ 48 h 816"/>
                  <a:gd name="T2" fmla="*/ 48 w 2032"/>
                  <a:gd name="T3" fmla="*/ 0 h 816"/>
                  <a:gd name="T4" fmla="*/ 1984 w 2032"/>
                  <a:gd name="T5" fmla="*/ 0 h 816"/>
                  <a:gd name="T6" fmla="*/ 2032 w 2032"/>
                  <a:gd name="T7" fmla="*/ 48 h 816"/>
                  <a:gd name="T8" fmla="*/ 2032 w 2032"/>
                  <a:gd name="T9" fmla="*/ 768 h 816"/>
                  <a:gd name="T10" fmla="*/ 1984 w 2032"/>
                  <a:gd name="T11" fmla="*/ 816 h 816"/>
                  <a:gd name="T12" fmla="*/ 48 w 2032"/>
                  <a:gd name="T13" fmla="*/ 816 h 816"/>
                  <a:gd name="T14" fmla="*/ 0 w 2032"/>
                  <a:gd name="T15" fmla="*/ 768 h 816"/>
                  <a:gd name="T16" fmla="*/ 0 w 2032"/>
                  <a:gd name="T17" fmla="*/ 48 h 816"/>
                  <a:gd name="T18" fmla="*/ 96 w 2032"/>
                  <a:gd name="T19" fmla="*/ 768 h 816"/>
                  <a:gd name="T20" fmla="*/ 48 w 2032"/>
                  <a:gd name="T21" fmla="*/ 720 h 816"/>
                  <a:gd name="T22" fmla="*/ 1984 w 2032"/>
                  <a:gd name="T23" fmla="*/ 720 h 816"/>
                  <a:gd name="T24" fmla="*/ 1936 w 2032"/>
                  <a:gd name="T25" fmla="*/ 768 h 816"/>
                  <a:gd name="T26" fmla="*/ 1936 w 2032"/>
                  <a:gd name="T27" fmla="*/ 48 h 816"/>
                  <a:gd name="T28" fmla="*/ 1984 w 2032"/>
                  <a:gd name="T29" fmla="*/ 96 h 816"/>
                  <a:gd name="T30" fmla="*/ 48 w 2032"/>
                  <a:gd name="T31" fmla="*/ 96 h 816"/>
                  <a:gd name="T32" fmla="*/ 96 w 2032"/>
                  <a:gd name="T33" fmla="*/ 48 h 816"/>
                  <a:gd name="T34" fmla="*/ 96 w 2032"/>
                  <a:gd name="T35" fmla="*/ 768 h 8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2032" h="816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1984" y="0"/>
                    </a:lnTo>
                    <a:cubicBezTo>
                      <a:pt x="2011" y="0"/>
                      <a:pt x="2032" y="22"/>
                      <a:pt x="2032" y="48"/>
                    </a:cubicBezTo>
                    <a:lnTo>
                      <a:pt x="2032" y="768"/>
                    </a:lnTo>
                    <a:cubicBezTo>
                      <a:pt x="2032" y="795"/>
                      <a:pt x="2011" y="816"/>
                      <a:pt x="1984" y="816"/>
                    </a:cubicBezTo>
                    <a:lnTo>
                      <a:pt x="48" y="816"/>
                    </a:lnTo>
                    <a:cubicBezTo>
                      <a:pt x="22" y="816"/>
                      <a:pt x="0" y="795"/>
                      <a:pt x="0" y="768"/>
                    </a:cubicBezTo>
                    <a:lnTo>
                      <a:pt x="0" y="48"/>
                    </a:lnTo>
                    <a:close/>
                    <a:moveTo>
                      <a:pt x="96" y="768"/>
                    </a:moveTo>
                    <a:lnTo>
                      <a:pt x="48" y="720"/>
                    </a:lnTo>
                    <a:lnTo>
                      <a:pt x="1984" y="720"/>
                    </a:lnTo>
                    <a:lnTo>
                      <a:pt x="1936" y="768"/>
                    </a:lnTo>
                    <a:lnTo>
                      <a:pt x="1936" y="48"/>
                    </a:lnTo>
                    <a:lnTo>
                      <a:pt x="1984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76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Rectangle 12"/>
              <p:cNvSpPr>
                <a:spLocks noChangeArrowheads="1"/>
              </p:cNvSpPr>
              <p:nvPr/>
            </p:nvSpPr>
            <p:spPr bwMode="auto">
              <a:xfrm>
                <a:off x="4989513" y="4283075"/>
                <a:ext cx="184150" cy="682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Freeform 13"/>
              <p:cNvSpPr>
                <a:spLocks noEditPoints="1"/>
              </p:cNvSpPr>
              <p:nvPr/>
            </p:nvSpPr>
            <p:spPr bwMode="auto">
              <a:xfrm>
                <a:off x="4984750" y="4278313"/>
                <a:ext cx="193675" cy="77788"/>
              </a:xfrm>
              <a:custGeom>
                <a:avLst/>
                <a:gdLst>
                  <a:gd name="T0" fmla="*/ 0 w 2032"/>
                  <a:gd name="T1" fmla="*/ 48 h 816"/>
                  <a:gd name="T2" fmla="*/ 48 w 2032"/>
                  <a:gd name="T3" fmla="*/ 0 h 816"/>
                  <a:gd name="T4" fmla="*/ 1984 w 2032"/>
                  <a:gd name="T5" fmla="*/ 0 h 816"/>
                  <a:gd name="T6" fmla="*/ 2032 w 2032"/>
                  <a:gd name="T7" fmla="*/ 48 h 816"/>
                  <a:gd name="T8" fmla="*/ 2032 w 2032"/>
                  <a:gd name="T9" fmla="*/ 768 h 816"/>
                  <a:gd name="T10" fmla="*/ 1984 w 2032"/>
                  <a:gd name="T11" fmla="*/ 816 h 816"/>
                  <a:gd name="T12" fmla="*/ 48 w 2032"/>
                  <a:gd name="T13" fmla="*/ 816 h 816"/>
                  <a:gd name="T14" fmla="*/ 0 w 2032"/>
                  <a:gd name="T15" fmla="*/ 768 h 816"/>
                  <a:gd name="T16" fmla="*/ 0 w 2032"/>
                  <a:gd name="T17" fmla="*/ 48 h 816"/>
                  <a:gd name="T18" fmla="*/ 96 w 2032"/>
                  <a:gd name="T19" fmla="*/ 768 h 816"/>
                  <a:gd name="T20" fmla="*/ 48 w 2032"/>
                  <a:gd name="T21" fmla="*/ 720 h 816"/>
                  <a:gd name="T22" fmla="*/ 1984 w 2032"/>
                  <a:gd name="T23" fmla="*/ 720 h 816"/>
                  <a:gd name="T24" fmla="*/ 1936 w 2032"/>
                  <a:gd name="T25" fmla="*/ 768 h 816"/>
                  <a:gd name="T26" fmla="*/ 1936 w 2032"/>
                  <a:gd name="T27" fmla="*/ 48 h 816"/>
                  <a:gd name="T28" fmla="*/ 1984 w 2032"/>
                  <a:gd name="T29" fmla="*/ 96 h 816"/>
                  <a:gd name="T30" fmla="*/ 48 w 2032"/>
                  <a:gd name="T31" fmla="*/ 96 h 816"/>
                  <a:gd name="T32" fmla="*/ 96 w 2032"/>
                  <a:gd name="T33" fmla="*/ 48 h 816"/>
                  <a:gd name="T34" fmla="*/ 96 w 2032"/>
                  <a:gd name="T35" fmla="*/ 768 h 8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2032" h="816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1984" y="0"/>
                    </a:lnTo>
                    <a:cubicBezTo>
                      <a:pt x="2011" y="0"/>
                      <a:pt x="2032" y="22"/>
                      <a:pt x="2032" y="48"/>
                    </a:cubicBezTo>
                    <a:lnTo>
                      <a:pt x="2032" y="768"/>
                    </a:lnTo>
                    <a:cubicBezTo>
                      <a:pt x="2032" y="795"/>
                      <a:pt x="2011" y="816"/>
                      <a:pt x="1984" y="816"/>
                    </a:cubicBezTo>
                    <a:lnTo>
                      <a:pt x="48" y="816"/>
                    </a:lnTo>
                    <a:cubicBezTo>
                      <a:pt x="22" y="816"/>
                      <a:pt x="0" y="795"/>
                      <a:pt x="0" y="768"/>
                    </a:cubicBezTo>
                    <a:lnTo>
                      <a:pt x="0" y="48"/>
                    </a:lnTo>
                    <a:close/>
                    <a:moveTo>
                      <a:pt x="96" y="768"/>
                    </a:moveTo>
                    <a:lnTo>
                      <a:pt x="48" y="720"/>
                    </a:lnTo>
                    <a:lnTo>
                      <a:pt x="1984" y="720"/>
                    </a:lnTo>
                    <a:lnTo>
                      <a:pt x="1936" y="768"/>
                    </a:lnTo>
                    <a:lnTo>
                      <a:pt x="1936" y="48"/>
                    </a:lnTo>
                    <a:lnTo>
                      <a:pt x="1984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76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Rectangle 14"/>
              <p:cNvSpPr>
                <a:spLocks noChangeArrowheads="1"/>
              </p:cNvSpPr>
              <p:nvPr/>
            </p:nvSpPr>
            <p:spPr bwMode="auto">
              <a:xfrm>
                <a:off x="5635625" y="4283075"/>
                <a:ext cx="184150" cy="682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Freeform 15"/>
              <p:cNvSpPr>
                <a:spLocks noEditPoints="1"/>
              </p:cNvSpPr>
              <p:nvPr/>
            </p:nvSpPr>
            <p:spPr bwMode="auto">
              <a:xfrm>
                <a:off x="5630863" y="4278313"/>
                <a:ext cx="193675" cy="77788"/>
              </a:xfrm>
              <a:custGeom>
                <a:avLst/>
                <a:gdLst>
                  <a:gd name="T0" fmla="*/ 0 w 2032"/>
                  <a:gd name="T1" fmla="*/ 48 h 816"/>
                  <a:gd name="T2" fmla="*/ 48 w 2032"/>
                  <a:gd name="T3" fmla="*/ 0 h 816"/>
                  <a:gd name="T4" fmla="*/ 1984 w 2032"/>
                  <a:gd name="T5" fmla="*/ 0 h 816"/>
                  <a:gd name="T6" fmla="*/ 2032 w 2032"/>
                  <a:gd name="T7" fmla="*/ 48 h 816"/>
                  <a:gd name="T8" fmla="*/ 2032 w 2032"/>
                  <a:gd name="T9" fmla="*/ 768 h 816"/>
                  <a:gd name="T10" fmla="*/ 1984 w 2032"/>
                  <a:gd name="T11" fmla="*/ 816 h 816"/>
                  <a:gd name="T12" fmla="*/ 48 w 2032"/>
                  <a:gd name="T13" fmla="*/ 816 h 816"/>
                  <a:gd name="T14" fmla="*/ 0 w 2032"/>
                  <a:gd name="T15" fmla="*/ 768 h 816"/>
                  <a:gd name="T16" fmla="*/ 0 w 2032"/>
                  <a:gd name="T17" fmla="*/ 48 h 816"/>
                  <a:gd name="T18" fmla="*/ 96 w 2032"/>
                  <a:gd name="T19" fmla="*/ 768 h 816"/>
                  <a:gd name="T20" fmla="*/ 48 w 2032"/>
                  <a:gd name="T21" fmla="*/ 720 h 816"/>
                  <a:gd name="T22" fmla="*/ 1984 w 2032"/>
                  <a:gd name="T23" fmla="*/ 720 h 816"/>
                  <a:gd name="T24" fmla="*/ 1936 w 2032"/>
                  <a:gd name="T25" fmla="*/ 768 h 816"/>
                  <a:gd name="T26" fmla="*/ 1936 w 2032"/>
                  <a:gd name="T27" fmla="*/ 48 h 816"/>
                  <a:gd name="T28" fmla="*/ 1984 w 2032"/>
                  <a:gd name="T29" fmla="*/ 96 h 816"/>
                  <a:gd name="T30" fmla="*/ 48 w 2032"/>
                  <a:gd name="T31" fmla="*/ 96 h 816"/>
                  <a:gd name="T32" fmla="*/ 96 w 2032"/>
                  <a:gd name="T33" fmla="*/ 48 h 816"/>
                  <a:gd name="T34" fmla="*/ 96 w 2032"/>
                  <a:gd name="T35" fmla="*/ 768 h 8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2032" h="816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1984" y="0"/>
                    </a:lnTo>
                    <a:cubicBezTo>
                      <a:pt x="2011" y="0"/>
                      <a:pt x="2032" y="22"/>
                      <a:pt x="2032" y="48"/>
                    </a:cubicBezTo>
                    <a:lnTo>
                      <a:pt x="2032" y="768"/>
                    </a:lnTo>
                    <a:cubicBezTo>
                      <a:pt x="2032" y="795"/>
                      <a:pt x="2011" y="816"/>
                      <a:pt x="1984" y="816"/>
                    </a:cubicBezTo>
                    <a:lnTo>
                      <a:pt x="48" y="816"/>
                    </a:lnTo>
                    <a:cubicBezTo>
                      <a:pt x="22" y="816"/>
                      <a:pt x="0" y="795"/>
                      <a:pt x="0" y="768"/>
                    </a:cubicBezTo>
                    <a:lnTo>
                      <a:pt x="0" y="48"/>
                    </a:lnTo>
                    <a:close/>
                    <a:moveTo>
                      <a:pt x="96" y="768"/>
                    </a:moveTo>
                    <a:lnTo>
                      <a:pt x="48" y="720"/>
                    </a:lnTo>
                    <a:lnTo>
                      <a:pt x="1984" y="720"/>
                    </a:lnTo>
                    <a:lnTo>
                      <a:pt x="1936" y="768"/>
                    </a:lnTo>
                    <a:lnTo>
                      <a:pt x="1936" y="48"/>
                    </a:lnTo>
                    <a:lnTo>
                      <a:pt x="1984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76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Rectangle 16"/>
              <p:cNvSpPr>
                <a:spLocks noChangeArrowheads="1"/>
              </p:cNvSpPr>
              <p:nvPr/>
            </p:nvSpPr>
            <p:spPr bwMode="auto">
              <a:xfrm>
                <a:off x="3884613" y="2719388"/>
                <a:ext cx="184150" cy="16319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Freeform 17"/>
              <p:cNvSpPr>
                <a:spLocks noEditPoints="1"/>
              </p:cNvSpPr>
              <p:nvPr/>
            </p:nvSpPr>
            <p:spPr bwMode="auto">
              <a:xfrm>
                <a:off x="3879850" y="2714625"/>
                <a:ext cx="193675" cy="1641475"/>
              </a:xfrm>
              <a:custGeom>
                <a:avLst/>
                <a:gdLst>
                  <a:gd name="T0" fmla="*/ 0 w 2032"/>
                  <a:gd name="T1" fmla="*/ 48 h 17232"/>
                  <a:gd name="T2" fmla="*/ 48 w 2032"/>
                  <a:gd name="T3" fmla="*/ 0 h 17232"/>
                  <a:gd name="T4" fmla="*/ 1984 w 2032"/>
                  <a:gd name="T5" fmla="*/ 0 h 17232"/>
                  <a:gd name="T6" fmla="*/ 2032 w 2032"/>
                  <a:gd name="T7" fmla="*/ 48 h 17232"/>
                  <a:gd name="T8" fmla="*/ 2032 w 2032"/>
                  <a:gd name="T9" fmla="*/ 17184 h 17232"/>
                  <a:gd name="T10" fmla="*/ 1984 w 2032"/>
                  <a:gd name="T11" fmla="*/ 17232 h 17232"/>
                  <a:gd name="T12" fmla="*/ 48 w 2032"/>
                  <a:gd name="T13" fmla="*/ 17232 h 17232"/>
                  <a:gd name="T14" fmla="*/ 0 w 2032"/>
                  <a:gd name="T15" fmla="*/ 17184 h 17232"/>
                  <a:gd name="T16" fmla="*/ 0 w 2032"/>
                  <a:gd name="T17" fmla="*/ 48 h 17232"/>
                  <a:gd name="T18" fmla="*/ 96 w 2032"/>
                  <a:gd name="T19" fmla="*/ 17184 h 17232"/>
                  <a:gd name="T20" fmla="*/ 48 w 2032"/>
                  <a:gd name="T21" fmla="*/ 17136 h 17232"/>
                  <a:gd name="T22" fmla="*/ 1984 w 2032"/>
                  <a:gd name="T23" fmla="*/ 17136 h 17232"/>
                  <a:gd name="T24" fmla="*/ 1936 w 2032"/>
                  <a:gd name="T25" fmla="*/ 17184 h 17232"/>
                  <a:gd name="T26" fmla="*/ 1936 w 2032"/>
                  <a:gd name="T27" fmla="*/ 48 h 17232"/>
                  <a:gd name="T28" fmla="*/ 1984 w 2032"/>
                  <a:gd name="T29" fmla="*/ 96 h 17232"/>
                  <a:gd name="T30" fmla="*/ 48 w 2032"/>
                  <a:gd name="T31" fmla="*/ 96 h 17232"/>
                  <a:gd name="T32" fmla="*/ 96 w 2032"/>
                  <a:gd name="T33" fmla="*/ 48 h 17232"/>
                  <a:gd name="T34" fmla="*/ 96 w 2032"/>
                  <a:gd name="T35" fmla="*/ 17184 h 172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2032" h="17232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1984" y="0"/>
                    </a:lnTo>
                    <a:cubicBezTo>
                      <a:pt x="2011" y="0"/>
                      <a:pt x="2032" y="22"/>
                      <a:pt x="2032" y="48"/>
                    </a:cubicBezTo>
                    <a:lnTo>
                      <a:pt x="2032" y="17184"/>
                    </a:lnTo>
                    <a:cubicBezTo>
                      <a:pt x="2032" y="17211"/>
                      <a:pt x="2011" y="17232"/>
                      <a:pt x="1984" y="17232"/>
                    </a:cubicBezTo>
                    <a:lnTo>
                      <a:pt x="48" y="17232"/>
                    </a:lnTo>
                    <a:cubicBezTo>
                      <a:pt x="22" y="17232"/>
                      <a:pt x="0" y="17211"/>
                      <a:pt x="0" y="17184"/>
                    </a:cubicBezTo>
                    <a:lnTo>
                      <a:pt x="0" y="48"/>
                    </a:lnTo>
                    <a:close/>
                    <a:moveTo>
                      <a:pt x="96" y="17184"/>
                    </a:moveTo>
                    <a:lnTo>
                      <a:pt x="48" y="17136"/>
                    </a:lnTo>
                    <a:lnTo>
                      <a:pt x="1984" y="17136"/>
                    </a:lnTo>
                    <a:lnTo>
                      <a:pt x="1936" y="17184"/>
                    </a:lnTo>
                    <a:lnTo>
                      <a:pt x="1936" y="48"/>
                    </a:lnTo>
                    <a:lnTo>
                      <a:pt x="1984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17184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Rectangle 18"/>
              <p:cNvSpPr>
                <a:spLocks noChangeArrowheads="1"/>
              </p:cNvSpPr>
              <p:nvPr/>
            </p:nvSpPr>
            <p:spPr bwMode="auto">
              <a:xfrm>
                <a:off x="4529138" y="3959225"/>
                <a:ext cx="184150" cy="39211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Freeform 19"/>
              <p:cNvSpPr>
                <a:spLocks noEditPoints="1"/>
              </p:cNvSpPr>
              <p:nvPr/>
            </p:nvSpPr>
            <p:spPr bwMode="auto">
              <a:xfrm>
                <a:off x="4524375" y="3954463"/>
                <a:ext cx="193675" cy="401638"/>
              </a:xfrm>
              <a:custGeom>
                <a:avLst/>
                <a:gdLst>
                  <a:gd name="T0" fmla="*/ 0 w 2032"/>
                  <a:gd name="T1" fmla="*/ 48 h 4208"/>
                  <a:gd name="T2" fmla="*/ 48 w 2032"/>
                  <a:gd name="T3" fmla="*/ 0 h 4208"/>
                  <a:gd name="T4" fmla="*/ 1984 w 2032"/>
                  <a:gd name="T5" fmla="*/ 0 h 4208"/>
                  <a:gd name="T6" fmla="*/ 2032 w 2032"/>
                  <a:gd name="T7" fmla="*/ 48 h 4208"/>
                  <a:gd name="T8" fmla="*/ 2032 w 2032"/>
                  <a:gd name="T9" fmla="*/ 4160 h 4208"/>
                  <a:gd name="T10" fmla="*/ 1984 w 2032"/>
                  <a:gd name="T11" fmla="*/ 4208 h 4208"/>
                  <a:gd name="T12" fmla="*/ 48 w 2032"/>
                  <a:gd name="T13" fmla="*/ 4208 h 4208"/>
                  <a:gd name="T14" fmla="*/ 0 w 2032"/>
                  <a:gd name="T15" fmla="*/ 4160 h 4208"/>
                  <a:gd name="T16" fmla="*/ 0 w 2032"/>
                  <a:gd name="T17" fmla="*/ 48 h 4208"/>
                  <a:gd name="T18" fmla="*/ 96 w 2032"/>
                  <a:gd name="T19" fmla="*/ 4160 h 4208"/>
                  <a:gd name="T20" fmla="*/ 48 w 2032"/>
                  <a:gd name="T21" fmla="*/ 4112 h 4208"/>
                  <a:gd name="T22" fmla="*/ 1984 w 2032"/>
                  <a:gd name="T23" fmla="*/ 4112 h 4208"/>
                  <a:gd name="T24" fmla="*/ 1936 w 2032"/>
                  <a:gd name="T25" fmla="*/ 4160 h 4208"/>
                  <a:gd name="T26" fmla="*/ 1936 w 2032"/>
                  <a:gd name="T27" fmla="*/ 48 h 4208"/>
                  <a:gd name="T28" fmla="*/ 1984 w 2032"/>
                  <a:gd name="T29" fmla="*/ 96 h 4208"/>
                  <a:gd name="T30" fmla="*/ 48 w 2032"/>
                  <a:gd name="T31" fmla="*/ 96 h 4208"/>
                  <a:gd name="T32" fmla="*/ 96 w 2032"/>
                  <a:gd name="T33" fmla="*/ 48 h 4208"/>
                  <a:gd name="T34" fmla="*/ 96 w 2032"/>
                  <a:gd name="T35" fmla="*/ 4160 h 420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2032" h="4208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1984" y="0"/>
                    </a:lnTo>
                    <a:cubicBezTo>
                      <a:pt x="2011" y="0"/>
                      <a:pt x="2032" y="22"/>
                      <a:pt x="2032" y="48"/>
                    </a:cubicBezTo>
                    <a:lnTo>
                      <a:pt x="2032" y="4160"/>
                    </a:lnTo>
                    <a:cubicBezTo>
                      <a:pt x="2032" y="4187"/>
                      <a:pt x="2011" y="4208"/>
                      <a:pt x="1984" y="4208"/>
                    </a:cubicBezTo>
                    <a:lnTo>
                      <a:pt x="48" y="4208"/>
                    </a:lnTo>
                    <a:cubicBezTo>
                      <a:pt x="22" y="4208"/>
                      <a:pt x="0" y="4187"/>
                      <a:pt x="0" y="4160"/>
                    </a:cubicBezTo>
                    <a:lnTo>
                      <a:pt x="0" y="48"/>
                    </a:lnTo>
                    <a:close/>
                    <a:moveTo>
                      <a:pt x="96" y="4160"/>
                    </a:moveTo>
                    <a:lnTo>
                      <a:pt x="48" y="4112"/>
                    </a:lnTo>
                    <a:lnTo>
                      <a:pt x="1984" y="4112"/>
                    </a:lnTo>
                    <a:lnTo>
                      <a:pt x="1936" y="4160"/>
                    </a:lnTo>
                    <a:lnTo>
                      <a:pt x="1936" y="48"/>
                    </a:lnTo>
                    <a:lnTo>
                      <a:pt x="1984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416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Rectangle 20"/>
              <p:cNvSpPr>
                <a:spLocks noChangeArrowheads="1"/>
              </p:cNvSpPr>
              <p:nvPr/>
            </p:nvSpPr>
            <p:spPr bwMode="auto">
              <a:xfrm>
                <a:off x="5173663" y="2557463"/>
                <a:ext cx="184150" cy="179387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Freeform 21"/>
              <p:cNvSpPr>
                <a:spLocks noEditPoints="1"/>
              </p:cNvSpPr>
              <p:nvPr/>
            </p:nvSpPr>
            <p:spPr bwMode="auto">
              <a:xfrm>
                <a:off x="5168900" y="2552700"/>
                <a:ext cx="193675" cy="1803400"/>
              </a:xfrm>
              <a:custGeom>
                <a:avLst/>
                <a:gdLst>
                  <a:gd name="T0" fmla="*/ 0 w 2032"/>
                  <a:gd name="T1" fmla="*/ 48 h 18928"/>
                  <a:gd name="T2" fmla="*/ 48 w 2032"/>
                  <a:gd name="T3" fmla="*/ 0 h 18928"/>
                  <a:gd name="T4" fmla="*/ 1984 w 2032"/>
                  <a:gd name="T5" fmla="*/ 0 h 18928"/>
                  <a:gd name="T6" fmla="*/ 2032 w 2032"/>
                  <a:gd name="T7" fmla="*/ 48 h 18928"/>
                  <a:gd name="T8" fmla="*/ 2032 w 2032"/>
                  <a:gd name="T9" fmla="*/ 18880 h 18928"/>
                  <a:gd name="T10" fmla="*/ 1984 w 2032"/>
                  <a:gd name="T11" fmla="*/ 18928 h 18928"/>
                  <a:gd name="T12" fmla="*/ 48 w 2032"/>
                  <a:gd name="T13" fmla="*/ 18928 h 18928"/>
                  <a:gd name="T14" fmla="*/ 0 w 2032"/>
                  <a:gd name="T15" fmla="*/ 18880 h 18928"/>
                  <a:gd name="T16" fmla="*/ 0 w 2032"/>
                  <a:gd name="T17" fmla="*/ 48 h 18928"/>
                  <a:gd name="T18" fmla="*/ 96 w 2032"/>
                  <a:gd name="T19" fmla="*/ 18880 h 18928"/>
                  <a:gd name="T20" fmla="*/ 48 w 2032"/>
                  <a:gd name="T21" fmla="*/ 18832 h 18928"/>
                  <a:gd name="T22" fmla="*/ 1984 w 2032"/>
                  <a:gd name="T23" fmla="*/ 18832 h 18928"/>
                  <a:gd name="T24" fmla="*/ 1936 w 2032"/>
                  <a:gd name="T25" fmla="*/ 18880 h 18928"/>
                  <a:gd name="T26" fmla="*/ 1936 w 2032"/>
                  <a:gd name="T27" fmla="*/ 48 h 18928"/>
                  <a:gd name="T28" fmla="*/ 1984 w 2032"/>
                  <a:gd name="T29" fmla="*/ 96 h 18928"/>
                  <a:gd name="T30" fmla="*/ 48 w 2032"/>
                  <a:gd name="T31" fmla="*/ 96 h 18928"/>
                  <a:gd name="T32" fmla="*/ 96 w 2032"/>
                  <a:gd name="T33" fmla="*/ 48 h 18928"/>
                  <a:gd name="T34" fmla="*/ 96 w 2032"/>
                  <a:gd name="T35" fmla="*/ 18880 h 189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2032" h="18928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1984" y="0"/>
                    </a:lnTo>
                    <a:cubicBezTo>
                      <a:pt x="2011" y="0"/>
                      <a:pt x="2032" y="22"/>
                      <a:pt x="2032" y="48"/>
                    </a:cubicBezTo>
                    <a:lnTo>
                      <a:pt x="2032" y="18880"/>
                    </a:lnTo>
                    <a:cubicBezTo>
                      <a:pt x="2032" y="18907"/>
                      <a:pt x="2011" y="18928"/>
                      <a:pt x="1984" y="18928"/>
                    </a:cubicBezTo>
                    <a:lnTo>
                      <a:pt x="48" y="18928"/>
                    </a:lnTo>
                    <a:cubicBezTo>
                      <a:pt x="22" y="18928"/>
                      <a:pt x="0" y="18907"/>
                      <a:pt x="0" y="18880"/>
                    </a:cubicBezTo>
                    <a:lnTo>
                      <a:pt x="0" y="48"/>
                    </a:lnTo>
                    <a:close/>
                    <a:moveTo>
                      <a:pt x="96" y="18880"/>
                    </a:moveTo>
                    <a:lnTo>
                      <a:pt x="48" y="18832"/>
                    </a:lnTo>
                    <a:lnTo>
                      <a:pt x="1984" y="18832"/>
                    </a:lnTo>
                    <a:lnTo>
                      <a:pt x="1936" y="18880"/>
                    </a:lnTo>
                    <a:lnTo>
                      <a:pt x="1936" y="48"/>
                    </a:lnTo>
                    <a:lnTo>
                      <a:pt x="1984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1888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Rectangle 22"/>
              <p:cNvSpPr>
                <a:spLocks noChangeArrowheads="1"/>
              </p:cNvSpPr>
              <p:nvPr/>
            </p:nvSpPr>
            <p:spPr bwMode="auto">
              <a:xfrm>
                <a:off x="5819775" y="3594100"/>
                <a:ext cx="184150" cy="7572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Freeform 23"/>
              <p:cNvSpPr>
                <a:spLocks noEditPoints="1"/>
              </p:cNvSpPr>
              <p:nvPr/>
            </p:nvSpPr>
            <p:spPr bwMode="auto">
              <a:xfrm>
                <a:off x="5816600" y="3589338"/>
                <a:ext cx="190500" cy="766763"/>
              </a:xfrm>
              <a:custGeom>
                <a:avLst/>
                <a:gdLst>
                  <a:gd name="T0" fmla="*/ 0 w 1008"/>
                  <a:gd name="T1" fmla="*/ 24 h 4024"/>
                  <a:gd name="T2" fmla="*/ 24 w 1008"/>
                  <a:gd name="T3" fmla="*/ 0 h 4024"/>
                  <a:gd name="T4" fmla="*/ 984 w 1008"/>
                  <a:gd name="T5" fmla="*/ 0 h 4024"/>
                  <a:gd name="T6" fmla="*/ 1008 w 1008"/>
                  <a:gd name="T7" fmla="*/ 24 h 4024"/>
                  <a:gd name="T8" fmla="*/ 1008 w 1008"/>
                  <a:gd name="T9" fmla="*/ 4000 h 4024"/>
                  <a:gd name="T10" fmla="*/ 984 w 1008"/>
                  <a:gd name="T11" fmla="*/ 4024 h 4024"/>
                  <a:gd name="T12" fmla="*/ 24 w 1008"/>
                  <a:gd name="T13" fmla="*/ 4024 h 4024"/>
                  <a:gd name="T14" fmla="*/ 0 w 1008"/>
                  <a:gd name="T15" fmla="*/ 4000 h 4024"/>
                  <a:gd name="T16" fmla="*/ 0 w 1008"/>
                  <a:gd name="T17" fmla="*/ 24 h 4024"/>
                  <a:gd name="T18" fmla="*/ 48 w 1008"/>
                  <a:gd name="T19" fmla="*/ 4000 h 4024"/>
                  <a:gd name="T20" fmla="*/ 24 w 1008"/>
                  <a:gd name="T21" fmla="*/ 3976 h 4024"/>
                  <a:gd name="T22" fmla="*/ 984 w 1008"/>
                  <a:gd name="T23" fmla="*/ 3976 h 4024"/>
                  <a:gd name="T24" fmla="*/ 960 w 1008"/>
                  <a:gd name="T25" fmla="*/ 4000 h 4024"/>
                  <a:gd name="T26" fmla="*/ 960 w 1008"/>
                  <a:gd name="T27" fmla="*/ 24 h 4024"/>
                  <a:gd name="T28" fmla="*/ 984 w 1008"/>
                  <a:gd name="T29" fmla="*/ 48 h 4024"/>
                  <a:gd name="T30" fmla="*/ 24 w 1008"/>
                  <a:gd name="T31" fmla="*/ 48 h 4024"/>
                  <a:gd name="T32" fmla="*/ 48 w 1008"/>
                  <a:gd name="T33" fmla="*/ 24 h 4024"/>
                  <a:gd name="T34" fmla="*/ 48 w 1008"/>
                  <a:gd name="T35" fmla="*/ 4000 h 40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008" h="4024">
                    <a:moveTo>
                      <a:pt x="0" y="24"/>
                    </a:moveTo>
                    <a:cubicBezTo>
                      <a:pt x="0" y="11"/>
                      <a:pt x="11" y="0"/>
                      <a:pt x="24" y="0"/>
                    </a:cubicBezTo>
                    <a:lnTo>
                      <a:pt x="984" y="0"/>
                    </a:lnTo>
                    <a:cubicBezTo>
                      <a:pt x="998" y="0"/>
                      <a:pt x="1008" y="11"/>
                      <a:pt x="1008" y="24"/>
                    </a:cubicBezTo>
                    <a:lnTo>
                      <a:pt x="1008" y="4000"/>
                    </a:lnTo>
                    <a:cubicBezTo>
                      <a:pt x="1008" y="4014"/>
                      <a:pt x="998" y="4024"/>
                      <a:pt x="984" y="4024"/>
                    </a:cubicBezTo>
                    <a:lnTo>
                      <a:pt x="24" y="4024"/>
                    </a:lnTo>
                    <a:cubicBezTo>
                      <a:pt x="11" y="4024"/>
                      <a:pt x="0" y="4014"/>
                      <a:pt x="0" y="4000"/>
                    </a:cubicBezTo>
                    <a:lnTo>
                      <a:pt x="0" y="24"/>
                    </a:lnTo>
                    <a:close/>
                    <a:moveTo>
                      <a:pt x="48" y="4000"/>
                    </a:moveTo>
                    <a:lnTo>
                      <a:pt x="24" y="3976"/>
                    </a:lnTo>
                    <a:lnTo>
                      <a:pt x="984" y="3976"/>
                    </a:lnTo>
                    <a:lnTo>
                      <a:pt x="960" y="4000"/>
                    </a:lnTo>
                    <a:lnTo>
                      <a:pt x="960" y="24"/>
                    </a:lnTo>
                    <a:lnTo>
                      <a:pt x="984" y="48"/>
                    </a:lnTo>
                    <a:lnTo>
                      <a:pt x="24" y="48"/>
                    </a:lnTo>
                    <a:lnTo>
                      <a:pt x="48" y="24"/>
                    </a:lnTo>
                    <a:lnTo>
                      <a:pt x="48" y="400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Freeform 24"/>
              <p:cNvSpPr>
                <a:spLocks noEditPoints="1"/>
              </p:cNvSpPr>
              <p:nvPr/>
            </p:nvSpPr>
            <p:spPr bwMode="auto">
              <a:xfrm>
                <a:off x="3948113" y="2643188"/>
                <a:ext cx="57150" cy="76200"/>
              </a:xfrm>
              <a:custGeom>
                <a:avLst/>
                <a:gdLst>
                  <a:gd name="T0" fmla="*/ 15 w 36"/>
                  <a:gd name="T1" fmla="*/ 48 h 48"/>
                  <a:gd name="T2" fmla="*/ 15 w 36"/>
                  <a:gd name="T3" fmla="*/ 3 h 48"/>
                  <a:gd name="T4" fmla="*/ 20 w 36"/>
                  <a:gd name="T5" fmla="*/ 3 h 48"/>
                  <a:gd name="T6" fmla="*/ 20 w 36"/>
                  <a:gd name="T7" fmla="*/ 48 h 48"/>
                  <a:gd name="T8" fmla="*/ 15 w 36"/>
                  <a:gd name="T9" fmla="*/ 48 h 48"/>
                  <a:gd name="T10" fmla="*/ 0 w 36"/>
                  <a:gd name="T11" fmla="*/ 0 h 48"/>
                  <a:gd name="T12" fmla="*/ 36 w 36"/>
                  <a:gd name="T13" fmla="*/ 0 h 48"/>
                  <a:gd name="T14" fmla="*/ 36 w 36"/>
                  <a:gd name="T15" fmla="*/ 5 h 48"/>
                  <a:gd name="T16" fmla="*/ 0 w 36"/>
                  <a:gd name="T17" fmla="*/ 5 h 48"/>
                  <a:gd name="T18" fmla="*/ 0 w 36"/>
                  <a:gd name="T19" fmla="*/ 0 h 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48">
                    <a:moveTo>
                      <a:pt x="15" y="48"/>
                    </a:moveTo>
                    <a:lnTo>
                      <a:pt x="15" y="3"/>
                    </a:lnTo>
                    <a:lnTo>
                      <a:pt x="20" y="3"/>
                    </a:lnTo>
                    <a:lnTo>
                      <a:pt x="20" y="48"/>
                    </a:lnTo>
                    <a:lnTo>
                      <a:pt x="15" y="48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Freeform 25"/>
              <p:cNvSpPr>
                <a:spLocks noEditPoints="1"/>
              </p:cNvSpPr>
              <p:nvPr/>
            </p:nvSpPr>
            <p:spPr bwMode="auto">
              <a:xfrm>
                <a:off x="4592638" y="3944938"/>
                <a:ext cx="57150" cy="14288"/>
              </a:xfrm>
              <a:custGeom>
                <a:avLst/>
                <a:gdLst>
                  <a:gd name="T0" fmla="*/ 16 w 36"/>
                  <a:gd name="T1" fmla="*/ 9 h 9"/>
                  <a:gd name="T2" fmla="*/ 16 w 36"/>
                  <a:gd name="T3" fmla="*/ 3 h 9"/>
                  <a:gd name="T4" fmla="*/ 22 w 36"/>
                  <a:gd name="T5" fmla="*/ 3 h 9"/>
                  <a:gd name="T6" fmla="*/ 22 w 36"/>
                  <a:gd name="T7" fmla="*/ 9 h 9"/>
                  <a:gd name="T8" fmla="*/ 16 w 36"/>
                  <a:gd name="T9" fmla="*/ 9 h 9"/>
                  <a:gd name="T10" fmla="*/ 0 w 36"/>
                  <a:gd name="T11" fmla="*/ 0 h 9"/>
                  <a:gd name="T12" fmla="*/ 36 w 36"/>
                  <a:gd name="T13" fmla="*/ 0 h 9"/>
                  <a:gd name="T14" fmla="*/ 36 w 36"/>
                  <a:gd name="T15" fmla="*/ 6 h 9"/>
                  <a:gd name="T16" fmla="*/ 0 w 36"/>
                  <a:gd name="T17" fmla="*/ 6 h 9"/>
                  <a:gd name="T18" fmla="*/ 0 w 36"/>
                  <a:gd name="T19" fmla="*/ 0 h 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9">
                    <a:moveTo>
                      <a:pt x="16" y="9"/>
                    </a:moveTo>
                    <a:lnTo>
                      <a:pt x="16" y="3"/>
                    </a:lnTo>
                    <a:lnTo>
                      <a:pt x="22" y="3"/>
                    </a:lnTo>
                    <a:lnTo>
                      <a:pt x="22" y="9"/>
                    </a:lnTo>
                    <a:lnTo>
                      <a:pt x="16" y="9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Freeform 26"/>
              <p:cNvSpPr>
                <a:spLocks noEditPoints="1"/>
              </p:cNvSpPr>
              <p:nvPr/>
            </p:nvSpPr>
            <p:spPr bwMode="auto">
              <a:xfrm>
                <a:off x="5238750" y="2422525"/>
                <a:ext cx="57150" cy="134938"/>
              </a:xfrm>
              <a:custGeom>
                <a:avLst/>
                <a:gdLst>
                  <a:gd name="T0" fmla="*/ 15 w 36"/>
                  <a:gd name="T1" fmla="*/ 85 h 85"/>
                  <a:gd name="T2" fmla="*/ 15 w 36"/>
                  <a:gd name="T3" fmla="*/ 3 h 85"/>
                  <a:gd name="T4" fmla="*/ 21 w 36"/>
                  <a:gd name="T5" fmla="*/ 3 h 85"/>
                  <a:gd name="T6" fmla="*/ 21 w 36"/>
                  <a:gd name="T7" fmla="*/ 85 h 85"/>
                  <a:gd name="T8" fmla="*/ 15 w 36"/>
                  <a:gd name="T9" fmla="*/ 85 h 85"/>
                  <a:gd name="T10" fmla="*/ 0 w 36"/>
                  <a:gd name="T11" fmla="*/ 0 h 85"/>
                  <a:gd name="T12" fmla="*/ 36 w 36"/>
                  <a:gd name="T13" fmla="*/ 0 h 85"/>
                  <a:gd name="T14" fmla="*/ 36 w 36"/>
                  <a:gd name="T15" fmla="*/ 6 h 85"/>
                  <a:gd name="T16" fmla="*/ 0 w 36"/>
                  <a:gd name="T17" fmla="*/ 6 h 85"/>
                  <a:gd name="T18" fmla="*/ 0 w 36"/>
                  <a:gd name="T19" fmla="*/ 0 h 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85">
                    <a:moveTo>
                      <a:pt x="15" y="85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85"/>
                    </a:lnTo>
                    <a:lnTo>
                      <a:pt x="15" y="85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Freeform 27"/>
              <p:cNvSpPr>
                <a:spLocks noEditPoints="1"/>
              </p:cNvSpPr>
              <p:nvPr/>
            </p:nvSpPr>
            <p:spPr bwMode="auto">
              <a:xfrm>
                <a:off x="5883275" y="3497263"/>
                <a:ext cx="57150" cy="96838"/>
              </a:xfrm>
              <a:custGeom>
                <a:avLst/>
                <a:gdLst>
                  <a:gd name="T0" fmla="*/ 15 w 36"/>
                  <a:gd name="T1" fmla="*/ 61 h 61"/>
                  <a:gd name="T2" fmla="*/ 15 w 36"/>
                  <a:gd name="T3" fmla="*/ 3 h 61"/>
                  <a:gd name="T4" fmla="*/ 21 w 36"/>
                  <a:gd name="T5" fmla="*/ 3 h 61"/>
                  <a:gd name="T6" fmla="*/ 21 w 36"/>
                  <a:gd name="T7" fmla="*/ 61 h 61"/>
                  <a:gd name="T8" fmla="*/ 15 w 36"/>
                  <a:gd name="T9" fmla="*/ 61 h 61"/>
                  <a:gd name="T10" fmla="*/ 0 w 36"/>
                  <a:gd name="T11" fmla="*/ 0 h 61"/>
                  <a:gd name="T12" fmla="*/ 36 w 36"/>
                  <a:gd name="T13" fmla="*/ 0 h 61"/>
                  <a:gd name="T14" fmla="*/ 36 w 36"/>
                  <a:gd name="T15" fmla="*/ 6 h 61"/>
                  <a:gd name="T16" fmla="*/ 0 w 36"/>
                  <a:gd name="T17" fmla="*/ 6 h 61"/>
                  <a:gd name="T18" fmla="*/ 0 w 36"/>
                  <a:gd name="T19" fmla="*/ 0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61">
                    <a:moveTo>
                      <a:pt x="15" y="61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61"/>
                    </a:lnTo>
                    <a:lnTo>
                      <a:pt x="15" y="61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Rectangle 28"/>
              <p:cNvSpPr>
                <a:spLocks noChangeArrowheads="1"/>
              </p:cNvSpPr>
              <p:nvPr/>
            </p:nvSpPr>
            <p:spPr bwMode="auto">
              <a:xfrm>
                <a:off x="3556000" y="2332038"/>
                <a:ext cx="9525" cy="2019300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Freeform 29"/>
              <p:cNvSpPr>
                <a:spLocks noEditPoints="1"/>
              </p:cNvSpPr>
              <p:nvPr/>
            </p:nvSpPr>
            <p:spPr bwMode="auto">
              <a:xfrm>
                <a:off x="3516313" y="2327275"/>
                <a:ext cx="44450" cy="2028825"/>
              </a:xfrm>
              <a:custGeom>
                <a:avLst/>
                <a:gdLst>
                  <a:gd name="T0" fmla="*/ 0 w 28"/>
                  <a:gd name="T1" fmla="*/ 1272 h 1278"/>
                  <a:gd name="T2" fmla="*/ 28 w 28"/>
                  <a:gd name="T3" fmla="*/ 1272 h 1278"/>
                  <a:gd name="T4" fmla="*/ 28 w 28"/>
                  <a:gd name="T5" fmla="*/ 1278 h 1278"/>
                  <a:gd name="T6" fmla="*/ 0 w 28"/>
                  <a:gd name="T7" fmla="*/ 1278 h 1278"/>
                  <a:gd name="T8" fmla="*/ 0 w 28"/>
                  <a:gd name="T9" fmla="*/ 1272 h 1278"/>
                  <a:gd name="T10" fmla="*/ 0 w 28"/>
                  <a:gd name="T11" fmla="*/ 1060 h 1278"/>
                  <a:gd name="T12" fmla="*/ 28 w 28"/>
                  <a:gd name="T13" fmla="*/ 1060 h 1278"/>
                  <a:gd name="T14" fmla="*/ 28 w 28"/>
                  <a:gd name="T15" fmla="*/ 1065 h 1278"/>
                  <a:gd name="T16" fmla="*/ 0 w 28"/>
                  <a:gd name="T17" fmla="*/ 1065 h 1278"/>
                  <a:gd name="T18" fmla="*/ 0 w 28"/>
                  <a:gd name="T19" fmla="*/ 1060 h 1278"/>
                  <a:gd name="T20" fmla="*/ 0 w 28"/>
                  <a:gd name="T21" fmla="*/ 848 h 1278"/>
                  <a:gd name="T22" fmla="*/ 28 w 28"/>
                  <a:gd name="T23" fmla="*/ 848 h 1278"/>
                  <a:gd name="T24" fmla="*/ 28 w 28"/>
                  <a:gd name="T25" fmla="*/ 853 h 1278"/>
                  <a:gd name="T26" fmla="*/ 0 w 28"/>
                  <a:gd name="T27" fmla="*/ 853 h 1278"/>
                  <a:gd name="T28" fmla="*/ 0 w 28"/>
                  <a:gd name="T29" fmla="*/ 848 h 1278"/>
                  <a:gd name="T30" fmla="*/ 0 w 28"/>
                  <a:gd name="T31" fmla="*/ 635 h 1278"/>
                  <a:gd name="T32" fmla="*/ 28 w 28"/>
                  <a:gd name="T33" fmla="*/ 635 h 1278"/>
                  <a:gd name="T34" fmla="*/ 28 w 28"/>
                  <a:gd name="T35" fmla="*/ 641 h 1278"/>
                  <a:gd name="T36" fmla="*/ 0 w 28"/>
                  <a:gd name="T37" fmla="*/ 641 h 1278"/>
                  <a:gd name="T38" fmla="*/ 0 w 28"/>
                  <a:gd name="T39" fmla="*/ 635 h 1278"/>
                  <a:gd name="T40" fmla="*/ 0 w 28"/>
                  <a:gd name="T41" fmla="*/ 423 h 1278"/>
                  <a:gd name="T42" fmla="*/ 28 w 28"/>
                  <a:gd name="T43" fmla="*/ 423 h 1278"/>
                  <a:gd name="T44" fmla="*/ 28 w 28"/>
                  <a:gd name="T45" fmla="*/ 429 h 1278"/>
                  <a:gd name="T46" fmla="*/ 0 w 28"/>
                  <a:gd name="T47" fmla="*/ 429 h 1278"/>
                  <a:gd name="T48" fmla="*/ 0 w 28"/>
                  <a:gd name="T49" fmla="*/ 423 h 1278"/>
                  <a:gd name="T50" fmla="*/ 0 w 28"/>
                  <a:gd name="T51" fmla="*/ 211 h 1278"/>
                  <a:gd name="T52" fmla="*/ 28 w 28"/>
                  <a:gd name="T53" fmla="*/ 211 h 1278"/>
                  <a:gd name="T54" fmla="*/ 28 w 28"/>
                  <a:gd name="T55" fmla="*/ 217 h 1278"/>
                  <a:gd name="T56" fmla="*/ 0 w 28"/>
                  <a:gd name="T57" fmla="*/ 217 h 1278"/>
                  <a:gd name="T58" fmla="*/ 0 w 28"/>
                  <a:gd name="T59" fmla="*/ 211 h 1278"/>
                  <a:gd name="T60" fmla="*/ 0 w 28"/>
                  <a:gd name="T61" fmla="*/ 0 h 1278"/>
                  <a:gd name="T62" fmla="*/ 28 w 28"/>
                  <a:gd name="T63" fmla="*/ 0 h 1278"/>
                  <a:gd name="T64" fmla="*/ 28 w 28"/>
                  <a:gd name="T65" fmla="*/ 6 h 1278"/>
                  <a:gd name="T66" fmla="*/ 0 w 28"/>
                  <a:gd name="T67" fmla="*/ 6 h 1278"/>
                  <a:gd name="T68" fmla="*/ 0 w 28"/>
                  <a:gd name="T69" fmla="*/ 0 h 12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</a:cxnLst>
                <a:rect l="0" t="0" r="r" b="b"/>
                <a:pathLst>
                  <a:path w="28" h="1278">
                    <a:moveTo>
                      <a:pt x="0" y="1272"/>
                    </a:moveTo>
                    <a:lnTo>
                      <a:pt x="28" y="1272"/>
                    </a:lnTo>
                    <a:lnTo>
                      <a:pt x="28" y="1278"/>
                    </a:lnTo>
                    <a:lnTo>
                      <a:pt x="0" y="1278"/>
                    </a:lnTo>
                    <a:lnTo>
                      <a:pt x="0" y="1272"/>
                    </a:lnTo>
                    <a:close/>
                    <a:moveTo>
                      <a:pt x="0" y="1060"/>
                    </a:moveTo>
                    <a:lnTo>
                      <a:pt x="28" y="1060"/>
                    </a:lnTo>
                    <a:lnTo>
                      <a:pt x="28" y="1065"/>
                    </a:lnTo>
                    <a:lnTo>
                      <a:pt x="0" y="1065"/>
                    </a:lnTo>
                    <a:lnTo>
                      <a:pt x="0" y="1060"/>
                    </a:lnTo>
                    <a:close/>
                    <a:moveTo>
                      <a:pt x="0" y="848"/>
                    </a:moveTo>
                    <a:lnTo>
                      <a:pt x="28" y="848"/>
                    </a:lnTo>
                    <a:lnTo>
                      <a:pt x="28" y="853"/>
                    </a:lnTo>
                    <a:lnTo>
                      <a:pt x="0" y="853"/>
                    </a:lnTo>
                    <a:lnTo>
                      <a:pt x="0" y="848"/>
                    </a:lnTo>
                    <a:close/>
                    <a:moveTo>
                      <a:pt x="0" y="635"/>
                    </a:moveTo>
                    <a:lnTo>
                      <a:pt x="28" y="635"/>
                    </a:lnTo>
                    <a:lnTo>
                      <a:pt x="28" y="641"/>
                    </a:lnTo>
                    <a:lnTo>
                      <a:pt x="0" y="641"/>
                    </a:lnTo>
                    <a:lnTo>
                      <a:pt x="0" y="635"/>
                    </a:lnTo>
                    <a:close/>
                    <a:moveTo>
                      <a:pt x="0" y="423"/>
                    </a:moveTo>
                    <a:lnTo>
                      <a:pt x="28" y="423"/>
                    </a:lnTo>
                    <a:lnTo>
                      <a:pt x="28" y="429"/>
                    </a:lnTo>
                    <a:lnTo>
                      <a:pt x="0" y="429"/>
                    </a:lnTo>
                    <a:lnTo>
                      <a:pt x="0" y="423"/>
                    </a:lnTo>
                    <a:close/>
                    <a:moveTo>
                      <a:pt x="0" y="211"/>
                    </a:moveTo>
                    <a:lnTo>
                      <a:pt x="28" y="211"/>
                    </a:lnTo>
                    <a:lnTo>
                      <a:pt x="28" y="217"/>
                    </a:lnTo>
                    <a:lnTo>
                      <a:pt x="0" y="217"/>
                    </a:lnTo>
                    <a:lnTo>
                      <a:pt x="0" y="211"/>
                    </a:lnTo>
                    <a:close/>
                    <a:moveTo>
                      <a:pt x="0" y="0"/>
                    </a:moveTo>
                    <a:lnTo>
                      <a:pt x="28" y="0"/>
                    </a:lnTo>
                    <a:lnTo>
                      <a:pt x="28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Rectangle 30"/>
              <p:cNvSpPr>
                <a:spLocks noChangeArrowheads="1"/>
              </p:cNvSpPr>
              <p:nvPr/>
            </p:nvSpPr>
            <p:spPr bwMode="auto">
              <a:xfrm>
                <a:off x="3560763" y="4346575"/>
                <a:ext cx="2581275" cy="9525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Rectangle 31"/>
              <p:cNvSpPr>
                <a:spLocks noChangeArrowheads="1"/>
              </p:cNvSpPr>
              <p:nvPr/>
            </p:nvSpPr>
            <p:spPr bwMode="auto">
              <a:xfrm>
                <a:off x="3315716" y="4262438"/>
                <a:ext cx="119608" cy="220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Rectangle 32"/>
              <p:cNvSpPr>
                <a:spLocks noChangeArrowheads="1"/>
              </p:cNvSpPr>
              <p:nvPr/>
            </p:nvSpPr>
            <p:spPr bwMode="auto">
              <a:xfrm>
                <a:off x="3315716" y="3925888"/>
                <a:ext cx="119608" cy="220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4" name="Rectangle 33"/>
              <p:cNvSpPr>
                <a:spLocks noChangeArrowheads="1"/>
              </p:cNvSpPr>
              <p:nvPr/>
            </p:nvSpPr>
            <p:spPr bwMode="auto">
              <a:xfrm>
                <a:off x="3214256" y="3589337"/>
                <a:ext cx="239215" cy="220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5" name="Rectangle 34"/>
              <p:cNvSpPr>
                <a:spLocks noChangeArrowheads="1"/>
              </p:cNvSpPr>
              <p:nvPr/>
            </p:nvSpPr>
            <p:spPr bwMode="auto">
              <a:xfrm>
                <a:off x="3214256" y="3252787"/>
                <a:ext cx="239215" cy="220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7" name="Rectangle 35"/>
              <p:cNvSpPr>
                <a:spLocks noChangeArrowheads="1"/>
              </p:cNvSpPr>
              <p:nvPr/>
            </p:nvSpPr>
            <p:spPr bwMode="auto">
              <a:xfrm>
                <a:off x="3214256" y="2916238"/>
                <a:ext cx="239215" cy="220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8" name="Rectangle 36"/>
              <p:cNvSpPr>
                <a:spLocks noChangeArrowheads="1"/>
              </p:cNvSpPr>
              <p:nvPr/>
            </p:nvSpPr>
            <p:spPr bwMode="auto">
              <a:xfrm>
                <a:off x="3214256" y="2579688"/>
                <a:ext cx="239215" cy="220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9" name="Rectangle 37"/>
              <p:cNvSpPr>
                <a:spLocks noChangeArrowheads="1"/>
              </p:cNvSpPr>
              <p:nvPr/>
            </p:nvSpPr>
            <p:spPr bwMode="auto">
              <a:xfrm>
                <a:off x="3214256" y="2244725"/>
                <a:ext cx="239215" cy="220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0" name="Rectangle 38"/>
              <p:cNvSpPr>
                <a:spLocks noChangeArrowheads="1"/>
              </p:cNvSpPr>
              <p:nvPr/>
            </p:nvSpPr>
            <p:spPr bwMode="auto">
              <a:xfrm>
                <a:off x="3700257" y="4399475"/>
                <a:ext cx="372362" cy="220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IL</a:t>
                </a:r>
                <a:r>
                  <a:rPr kumimoji="1" lang="en-US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1" name="Rectangle 39"/>
              <p:cNvSpPr>
                <a:spLocks noChangeArrowheads="1"/>
              </p:cNvSpPr>
              <p:nvPr/>
            </p:nvSpPr>
            <p:spPr bwMode="auto">
              <a:xfrm>
                <a:off x="4344780" y="4399476"/>
                <a:ext cx="372362" cy="220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IL</a:t>
                </a:r>
                <a:r>
                  <a:rPr kumimoji="1" lang="en-US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2" name="Rectangle 40"/>
              <p:cNvSpPr>
                <a:spLocks noChangeArrowheads="1"/>
              </p:cNvSpPr>
              <p:nvPr/>
            </p:nvSpPr>
            <p:spPr bwMode="auto">
              <a:xfrm>
                <a:off x="4930707" y="4399476"/>
                <a:ext cx="491971" cy="220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IL</a:t>
                </a:r>
                <a:r>
                  <a:rPr kumimoji="1" lang="en-US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3" name="Rectangle 41"/>
              <p:cNvSpPr>
                <a:spLocks noChangeArrowheads="1"/>
              </p:cNvSpPr>
              <p:nvPr/>
            </p:nvSpPr>
            <p:spPr bwMode="auto">
              <a:xfrm>
                <a:off x="5567965" y="4399476"/>
                <a:ext cx="510023" cy="220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IFN</a:t>
                </a:r>
                <a:r>
                  <a:rPr kumimoji="1" lang="en-US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Symbol" panose="05050102010706020507" pitchFamily="18" charset="2"/>
                    <a:cs typeface="Arial" panose="020B0604020202020204" pitchFamily="34" charset="0"/>
                  </a:rPr>
                  <a:t>g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Symbol" panose="05050102010706020507" pitchFamily="18" charset="2"/>
                  <a:cs typeface="Arial" panose="020B0604020202020204" pitchFamily="34" charset="0"/>
                </a:endParaRPr>
              </a:p>
            </p:txBody>
          </p:sp>
          <p:sp>
            <p:nvSpPr>
              <p:cNvPr id="1034" name="Rectangle 42"/>
              <p:cNvSpPr>
                <a:spLocks noChangeArrowheads="1"/>
              </p:cNvSpPr>
              <p:nvPr/>
            </p:nvSpPr>
            <p:spPr bwMode="auto">
              <a:xfrm rot="16200000">
                <a:off x="1727797" y="3244325"/>
                <a:ext cx="2543829" cy="2599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Relative cytokine </a:t>
                </a:r>
                <a:r>
                  <a:rPr kumimoji="1" lang="en-US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expression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5" name="Rectangle 43"/>
              <p:cNvSpPr>
                <a:spLocks noChangeArrowheads="1"/>
              </p:cNvSpPr>
              <p:nvPr/>
            </p:nvSpPr>
            <p:spPr bwMode="auto">
              <a:xfrm>
                <a:off x="5614988" y="2438400"/>
                <a:ext cx="106431" cy="762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6" name="Freeform 44"/>
              <p:cNvSpPr>
                <a:spLocks noEditPoints="1"/>
              </p:cNvSpPr>
              <p:nvPr/>
            </p:nvSpPr>
            <p:spPr bwMode="auto">
              <a:xfrm>
                <a:off x="5610226" y="2433639"/>
                <a:ext cx="106431" cy="77427"/>
              </a:xfrm>
              <a:custGeom>
                <a:avLst/>
                <a:gdLst>
                  <a:gd name="T0" fmla="*/ 0 w 896"/>
                  <a:gd name="T1" fmla="*/ 48 h 896"/>
                  <a:gd name="T2" fmla="*/ 48 w 896"/>
                  <a:gd name="T3" fmla="*/ 0 h 896"/>
                  <a:gd name="T4" fmla="*/ 848 w 896"/>
                  <a:gd name="T5" fmla="*/ 0 h 896"/>
                  <a:gd name="T6" fmla="*/ 896 w 896"/>
                  <a:gd name="T7" fmla="*/ 48 h 896"/>
                  <a:gd name="T8" fmla="*/ 896 w 896"/>
                  <a:gd name="T9" fmla="*/ 848 h 896"/>
                  <a:gd name="T10" fmla="*/ 848 w 896"/>
                  <a:gd name="T11" fmla="*/ 896 h 896"/>
                  <a:gd name="T12" fmla="*/ 48 w 896"/>
                  <a:gd name="T13" fmla="*/ 896 h 896"/>
                  <a:gd name="T14" fmla="*/ 0 w 896"/>
                  <a:gd name="T15" fmla="*/ 848 h 896"/>
                  <a:gd name="T16" fmla="*/ 0 w 896"/>
                  <a:gd name="T17" fmla="*/ 48 h 896"/>
                  <a:gd name="T18" fmla="*/ 96 w 896"/>
                  <a:gd name="T19" fmla="*/ 848 h 896"/>
                  <a:gd name="T20" fmla="*/ 48 w 896"/>
                  <a:gd name="T21" fmla="*/ 800 h 896"/>
                  <a:gd name="T22" fmla="*/ 848 w 896"/>
                  <a:gd name="T23" fmla="*/ 800 h 896"/>
                  <a:gd name="T24" fmla="*/ 800 w 896"/>
                  <a:gd name="T25" fmla="*/ 848 h 896"/>
                  <a:gd name="T26" fmla="*/ 800 w 896"/>
                  <a:gd name="T27" fmla="*/ 48 h 896"/>
                  <a:gd name="T28" fmla="*/ 848 w 896"/>
                  <a:gd name="T29" fmla="*/ 96 h 896"/>
                  <a:gd name="T30" fmla="*/ 48 w 896"/>
                  <a:gd name="T31" fmla="*/ 96 h 896"/>
                  <a:gd name="T32" fmla="*/ 96 w 896"/>
                  <a:gd name="T33" fmla="*/ 48 h 896"/>
                  <a:gd name="T34" fmla="*/ 96 w 896"/>
                  <a:gd name="T35" fmla="*/ 848 h 8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896" h="896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848" y="0"/>
                    </a:lnTo>
                    <a:cubicBezTo>
                      <a:pt x="875" y="0"/>
                      <a:pt x="896" y="22"/>
                      <a:pt x="896" y="48"/>
                    </a:cubicBezTo>
                    <a:lnTo>
                      <a:pt x="896" y="848"/>
                    </a:lnTo>
                    <a:cubicBezTo>
                      <a:pt x="896" y="875"/>
                      <a:pt x="875" y="896"/>
                      <a:pt x="848" y="896"/>
                    </a:cubicBezTo>
                    <a:lnTo>
                      <a:pt x="48" y="896"/>
                    </a:lnTo>
                    <a:cubicBezTo>
                      <a:pt x="22" y="896"/>
                      <a:pt x="0" y="875"/>
                      <a:pt x="0" y="848"/>
                    </a:cubicBezTo>
                    <a:lnTo>
                      <a:pt x="0" y="48"/>
                    </a:lnTo>
                    <a:close/>
                    <a:moveTo>
                      <a:pt x="96" y="848"/>
                    </a:moveTo>
                    <a:lnTo>
                      <a:pt x="48" y="800"/>
                    </a:lnTo>
                    <a:lnTo>
                      <a:pt x="848" y="800"/>
                    </a:lnTo>
                    <a:lnTo>
                      <a:pt x="800" y="848"/>
                    </a:lnTo>
                    <a:lnTo>
                      <a:pt x="800" y="48"/>
                    </a:lnTo>
                    <a:lnTo>
                      <a:pt x="848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84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7" name="Rectangle 45"/>
              <p:cNvSpPr>
                <a:spLocks noChangeArrowheads="1"/>
              </p:cNvSpPr>
              <p:nvPr/>
            </p:nvSpPr>
            <p:spPr bwMode="auto">
              <a:xfrm>
                <a:off x="5757543" y="2355046"/>
                <a:ext cx="695075" cy="220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ormal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8" name="Rectangle 46"/>
              <p:cNvSpPr>
                <a:spLocks noChangeArrowheads="1"/>
              </p:cNvSpPr>
              <p:nvPr/>
            </p:nvSpPr>
            <p:spPr bwMode="auto">
              <a:xfrm>
                <a:off x="5614988" y="2682875"/>
                <a:ext cx="76200" cy="7778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9" name="Freeform 47"/>
              <p:cNvSpPr>
                <a:spLocks noEditPoints="1"/>
              </p:cNvSpPr>
              <p:nvPr/>
            </p:nvSpPr>
            <p:spPr bwMode="auto">
              <a:xfrm>
                <a:off x="5610226" y="2678112"/>
                <a:ext cx="106431" cy="77427"/>
              </a:xfrm>
              <a:custGeom>
                <a:avLst/>
                <a:gdLst>
                  <a:gd name="T0" fmla="*/ 0 w 896"/>
                  <a:gd name="T1" fmla="*/ 48 h 912"/>
                  <a:gd name="T2" fmla="*/ 48 w 896"/>
                  <a:gd name="T3" fmla="*/ 0 h 912"/>
                  <a:gd name="T4" fmla="*/ 848 w 896"/>
                  <a:gd name="T5" fmla="*/ 0 h 912"/>
                  <a:gd name="T6" fmla="*/ 896 w 896"/>
                  <a:gd name="T7" fmla="*/ 48 h 912"/>
                  <a:gd name="T8" fmla="*/ 896 w 896"/>
                  <a:gd name="T9" fmla="*/ 864 h 912"/>
                  <a:gd name="T10" fmla="*/ 848 w 896"/>
                  <a:gd name="T11" fmla="*/ 912 h 912"/>
                  <a:gd name="T12" fmla="*/ 48 w 896"/>
                  <a:gd name="T13" fmla="*/ 912 h 912"/>
                  <a:gd name="T14" fmla="*/ 0 w 896"/>
                  <a:gd name="T15" fmla="*/ 864 h 912"/>
                  <a:gd name="T16" fmla="*/ 0 w 896"/>
                  <a:gd name="T17" fmla="*/ 48 h 912"/>
                  <a:gd name="T18" fmla="*/ 96 w 896"/>
                  <a:gd name="T19" fmla="*/ 864 h 912"/>
                  <a:gd name="T20" fmla="*/ 48 w 896"/>
                  <a:gd name="T21" fmla="*/ 816 h 912"/>
                  <a:gd name="T22" fmla="*/ 848 w 896"/>
                  <a:gd name="T23" fmla="*/ 816 h 912"/>
                  <a:gd name="T24" fmla="*/ 800 w 896"/>
                  <a:gd name="T25" fmla="*/ 864 h 912"/>
                  <a:gd name="T26" fmla="*/ 800 w 896"/>
                  <a:gd name="T27" fmla="*/ 48 h 912"/>
                  <a:gd name="T28" fmla="*/ 848 w 896"/>
                  <a:gd name="T29" fmla="*/ 96 h 912"/>
                  <a:gd name="T30" fmla="*/ 48 w 896"/>
                  <a:gd name="T31" fmla="*/ 96 h 912"/>
                  <a:gd name="T32" fmla="*/ 96 w 896"/>
                  <a:gd name="T33" fmla="*/ 48 h 912"/>
                  <a:gd name="T34" fmla="*/ 96 w 896"/>
                  <a:gd name="T35" fmla="*/ 864 h 9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896" h="912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848" y="0"/>
                    </a:lnTo>
                    <a:cubicBezTo>
                      <a:pt x="875" y="0"/>
                      <a:pt x="896" y="22"/>
                      <a:pt x="896" y="48"/>
                    </a:cubicBezTo>
                    <a:lnTo>
                      <a:pt x="896" y="864"/>
                    </a:lnTo>
                    <a:cubicBezTo>
                      <a:pt x="896" y="891"/>
                      <a:pt x="875" y="912"/>
                      <a:pt x="848" y="912"/>
                    </a:cubicBezTo>
                    <a:lnTo>
                      <a:pt x="48" y="912"/>
                    </a:lnTo>
                    <a:cubicBezTo>
                      <a:pt x="22" y="912"/>
                      <a:pt x="0" y="891"/>
                      <a:pt x="0" y="864"/>
                    </a:cubicBezTo>
                    <a:lnTo>
                      <a:pt x="0" y="48"/>
                    </a:lnTo>
                    <a:close/>
                    <a:moveTo>
                      <a:pt x="96" y="864"/>
                    </a:moveTo>
                    <a:lnTo>
                      <a:pt x="48" y="816"/>
                    </a:lnTo>
                    <a:lnTo>
                      <a:pt x="848" y="816"/>
                    </a:lnTo>
                    <a:lnTo>
                      <a:pt x="800" y="864"/>
                    </a:lnTo>
                    <a:lnTo>
                      <a:pt x="800" y="48"/>
                    </a:lnTo>
                    <a:lnTo>
                      <a:pt x="848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864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0" name="Rectangle 48"/>
              <p:cNvSpPr>
                <a:spLocks noChangeArrowheads="1"/>
              </p:cNvSpPr>
              <p:nvPr/>
            </p:nvSpPr>
            <p:spPr bwMode="auto">
              <a:xfrm>
                <a:off x="5776506" y="2599520"/>
                <a:ext cx="300147" cy="220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AD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1" name="TextBox 50"/>
            <p:cNvSpPr txBox="1"/>
            <p:nvPr/>
          </p:nvSpPr>
          <p:spPr>
            <a:xfrm>
              <a:off x="1746828" y="1988840"/>
              <a:ext cx="304892" cy="3372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92" name="꺾인 연결선 91"/>
            <p:cNvCxnSpPr/>
            <p:nvPr/>
          </p:nvCxnSpPr>
          <p:spPr>
            <a:xfrm rot="16200000">
              <a:off x="1910988" y="3306936"/>
              <a:ext cx="1260001" cy="126000"/>
            </a:xfrm>
            <a:prstGeom prst="bentConnector3">
              <a:avLst>
                <a:gd name="adj1" fmla="val 103625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꺾인 연결선 94"/>
            <p:cNvCxnSpPr/>
            <p:nvPr/>
          </p:nvCxnSpPr>
          <p:spPr>
            <a:xfrm rot="16200000">
              <a:off x="2708531" y="3246312"/>
              <a:ext cx="1512000" cy="126000"/>
            </a:xfrm>
            <a:prstGeom prst="bentConnector3">
              <a:avLst>
                <a:gd name="adj1" fmla="val 103625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꺾인 연결선 95"/>
            <p:cNvCxnSpPr/>
            <p:nvPr/>
          </p:nvCxnSpPr>
          <p:spPr>
            <a:xfrm rot="16200000">
              <a:off x="2878955" y="3895362"/>
              <a:ext cx="252001" cy="126000"/>
            </a:xfrm>
            <a:prstGeom prst="bentConnector3">
              <a:avLst>
                <a:gd name="adj1" fmla="val 128949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꺾인 연결선 98"/>
            <p:cNvCxnSpPr/>
            <p:nvPr/>
          </p:nvCxnSpPr>
          <p:spPr>
            <a:xfrm rot="16200000">
              <a:off x="3609676" y="3715362"/>
              <a:ext cx="612001" cy="126000"/>
            </a:xfrm>
            <a:prstGeom prst="bentConnector3">
              <a:avLst>
                <a:gd name="adj1" fmla="val 108505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68"/>
            <p:cNvSpPr txBox="1"/>
            <p:nvPr/>
          </p:nvSpPr>
          <p:spPr>
            <a:xfrm>
              <a:off x="2393941" y="2505437"/>
              <a:ext cx="3032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2822600" y="3573611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3313649" y="2320540"/>
              <a:ext cx="3032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3793708" y="3233042"/>
              <a:ext cx="2439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1" name="그룹 70"/>
          <p:cNvGrpSpPr/>
          <p:nvPr/>
        </p:nvGrpSpPr>
        <p:grpSpPr>
          <a:xfrm>
            <a:off x="5076058" y="886068"/>
            <a:ext cx="2221917" cy="2209352"/>
            <a:chOff x="5259354" y="1996480"/>
            <a:chExt cx="2651111" cy="2424397"/>
          </a:xfrm>
        </p:grpSpPr>
        <p:grpSp>
          <p:nvGrpSpPr>
            <p:cNvPr id="57" name="그룹 56"/>
            <p:cNvGrpSpPr/>
            <p:nvPr/>
          </p:nvGrpSpPr>
          <p:grpSpPr>
            <a:xfrm>
              <a:off x="5368414" y="2426865"/>
              <a:ext cx="2542051" cy="1994012"/>
              <a:chOff x="3935078" y="2001838"/>
              <a:chExt cx="5821491" cy="2646890"/>
            </a:xfrm>
          </p:grpSpPr>
          <p:sp>
            <p:nvSpPr>
              <p:cNvPr id="1047" name="Rectangle 56"/>
              <p:cNvSpPr>
                <a:spLocks noChangeArrowheads="1"/>
              </p:cNvSpPr>
              <p:nvPr/>
            </p:nvSpPr>
            <p:spPr bwMode="auto">
              <a:xfrm>
                <a:off x="5391150" y="4367213"/>
                <a:ext cx="381000" cy="793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8" name="Freeform 57"/>
              <p:cNvSpPr>
                <a:spLocks noEditPoints="1"/>
              </p:cNvSpPr>
              <p:nvPr/>
            </p:nvSpPr>
            <p:spPr bwMode="auto">
              <a:xfrm>
                <a:off x="5386388" y="4362450"/>
                <a:ext cx="390525" cy="17463"/>
              </a:xfrm>
              <a:custGeom>
                <a:avLst/>
                <a:gdLst>
                  <a:gd name="T0" fmla="*/ 0 w 4096"/>
                  <a:gd name="T1" fmla="*/ 48 h 176"/>
                  <a:gd name="T2" fmla="*/ 48 w 4096"/>
                  <a:gd name="T3" fmla="*/ 0 h 176"/>
                  <a:gd name="T4" fmla="*/ 4048 w 4096"/>
                  <a:gd name="T5" fmla="*/ 0 h 176"/>
                  <a:gd name="T6" fmla="*/ 4096 w 4096"/>
                  <a:gd name="T7" fmla="*/ 48 h 176"/>
                  <a:gd name="T8" fmla="*/ 4096 w 4096"/>
                  <a:gd name="T9" fmla="*/ 128 h 176"/>
                  <a:gd name="T10" fmla="*/ 4048 w 4096"/>
                  <a:gd name="T11" fmla="*/ 176 h 176"/>
                  <a:gd name="T12" fmla="*/ 48 w 4096"/>
                  <a:gd name="T13" fmla="*/ 176 h 176"/>
                  <a:gd name="T14" fmla="*/ 0 w 4096"/>
                  <a:gd name="T15" fmla="*/ 128 h 176"/>
                  <a:gd name="T16" fmla="*/ 0 w 4096"/>
                  <a:gd name="T17" fmla="*/ 48 h 176"/>
                  <a:gd name="T18" fmla="*/ 96 w 4096"/>
                  <a:gd name="T19" fmla="*/ 128 h 176"/>
                  <a:gd name="T20" fmla="*/ 48 w 4096"/>
                  <a:gd name="T21" fmla="*/ 80 h 176"/>
                  <a:gd name="T22" fmla="*/ 4048 w 4096"/>
                  <a:gd name="T23" fmla="*/ 80 h 176"/>
                  <a:gd name="T24" fmla="*/ 4000 w 4096"/>
                  <a:gd name="T25" fmla="*/ 128 h 176"/>
                  <a:gd name="T26" fmla="*/ 4000 w 4096"/>
                  <a:gd name="T27" fmla="*/ 48 h 176"/>
                  <a:gd name="T28" fmla="*/ 4048 w 4096"/>
                  <a:gd name="T29" fmla="*/ 96 h 176"/>
                  <a:gd name="T30" fmla="*/ 48 w 4096"/>
                  <a:gd name="T31" fmla="*/ 96 h 176"/>
                  <a:gd name="T32" fmla="*/ 96 w 4096"/>
                  <a:gd name="T33" fmla="*/ 48 h 176"/>
                  <a:gd name="T34" fmla="*/ 96 w 4096"/>
                  <a:gd name="T35" fmla="*/ 128 h 1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4096" h="176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4048" y="0"/>
                    </a:lnTo>
                    <a:cubicBezTo>
                      <a:pt x="4075" y="0"/>
                      <a:pt x="4096" y="22"/>
                      <a:pt x="4096" y="48"/>
                    </a:cubicBezTo>
                    <a:lnTo>
                      <a:pt x="4096" y="128"/>
                    </a:lnTo>
                    <a:cubicBezTo>
                      <a:pt x="4096" y="155"/>
                      <a:pt x="4075" y="176"/>
                      <a:pt x="4048" y="176"/>
                    </a:cubicBezTo>
                    <a:lnTo>
                      <a:pt x="48" y="176"/>
                    </a:lnTo>
                    <a:cubicBezTo>
                      <a:pt x="22" y="176"/>
                      <a:pt x="0" y="155"/>
                      <a:pt x="0" y="128"/>
                    </a:cubicBezTo>
                    <a:lnTo>
                      <a:pt x="0" y="48"/>
                    </a:lnTo>
                    <a:close/>
                    <a:moveTo>
                      <a:pt x="96" y="128"/>
                    </a:moveTo>
                    <a:lnTo>
                      <a:pt x="48" y="80"/>
                    </a:lnTo>
                    <a:lnTo>
                      <a:pt x="4048" y="80"/>
                    </a:lnTo>
                    <a:lnTo>
                      <a:pt x="4000" y="128"/>
                    </a:lnTo>
                    <a:lnTo>
                      <a:pt x="4000" y="48"/>
                    </a:lnTo>
                    <a:lnTo>
                      <a:pt x="4048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12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9" name="Rectangle 58"/>
              <p:cNvSpPr>
                <a:spLocks noChangeArrowheads="1"/>
              </p:cNvSpPr>
              <p:nvPr/>
            </p:nvSpPr>
            <p:spPr bwMode="auto">
              <a:xfrm>
                <a:off x="6723063" y="4298950"/>
                <a:ext cx="381000" cy="762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0" name="Freeform 59"/>
              <p:cNvSpPr>
                <a:spLocks noEditPoints="1"/>
              </p:cNvSpPr>
              <p:nvPr/>
            </p:nvSpPr>
            <p:spPr bwMode="auto">
              <a:xfrm>
                <a:off x="6718300" y="4294188"/>
                <a:ext cx="390525" cy="85725"/>
              </a:xfrm>
              <a:custGeom>
                <a:avLst/>
                <a:gdLst>
                  <a:gd name="T0" fmla="*/ 0 w 4096"/>
                  <a:gd name="T1" fmla="*/ 48 h 896"/>
                  <a:gd name="T2" fmla="*/ 48 w 4096"/>
                  <a:gd name="T3" fmla="*/ 0 h 896"/>
                  <a:gd name="T4" fmla="*/ 4048 w 4096"/>
                  <a:gd name="T5" fmla="*/ 0 h 896"/>
                  <a:gd name="T6" fmla="*/ 4096 w 4096"/>
                  <a:gd name="T7" fmla="*/ 48 h 896"/>
                  <a:gd name="T8" fmla="*/ 4096 w 4096"/>
                  <a:gd name="T9" fmla="*/ 848 h 896"/>
                  <a:gd name="T10" fmla="*/ 4048 w 4096"/>
                  <a:gd name="T11" fmla="*/ 896 h 896"/>
                  <a:gd name="T12" fmla="*/ 48 w 4096"/>
                  <a:gd name="T13" fmla="*/ 896 h 896"/>
                  <a:gd name="T14" fmla="*/ 0 w 4096"/>
                  <a:gd name="T15" fmla="*/ 848 h 896"/>
                  <a:gd name="T16" fmla="*/ 0 w 4096"/>
                  <a:gd name="T17" fmla="*/ 48 h 896"/>
                  <a:gd name="T18" fmla="*/ 96 w 4096"/>
                  <a:gd name="T19" fmla="*/ 848 h 896"/>
                  <a:gd name="T20" fmla="*/ 48 w 4096"/>
                  <a:gd name="T21" fmla="*/ 800 h 896"/>
                  <a:gd name="T22" fmla="*/ 4048 w 4096"/>
                  <a:gd name="T23" fmla="*/ 800 h 896"/>
                  <a:gd name="T24" fmla="*/ 4000 w 4096"/>
                  <a:gd name="T25" fmla="*/ 848 h 896"/>
                  <a:gd name="T26" fmla="*/ 4000 w 4096"/>
                  <a:gd name="T27" fmla="*/ 48 h 896"/>
                  <a:gd name="T28" fmla="*/ 4048 w 4096"/>
                  <a:gd name="T29" fmla="*/ 96 h 896"/>
                  <a:gd name="T30" fmla="*/ 48 w 4096"/>
                  <a:gd name="T31" fmla="*/ 96 h 896"/>
                  <a:gd name="T32" fmla="*/ 96 w 4096"/>
                  <a:gd name="T33" fmla="*/ 48 h 896"/>
                  <a:gd name="T34" fmla="*/ 96 w 4096"/>
                  <a:gd name="T35" fmla="*/ 848 h 8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4096" h="896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4048" y="0"/>
                    </a:lnTo>
                    <a:cubicBezTo>
                      <a:pt x="4075" y="0"/>
                      <a:pt x="4096" y="22"/>
                      <a:pt x="4096" y="48"/>
                    </a:cubicBezTo>
                    <a:lnTo>
                      <a:pt x="4096" y="848"/>
                    </a:lnTo>
                    <a:cubicBezTo>
                      <a:pt x="4096" y="875"/>
                      <a:pt x="4075" y="896"/>
                      <a:pt x="4048" y="896"/>
                    </a:cubicBezTo>
                    <a:lnTo>
                      <a:pt x="48" y="896"/>
                    </a:lnTo>
                    <a:cubicBezTo>
                      <a:pt x="22" y="896"/>
                      <a:pt x="0" y="875"/>
                      <a:pt x="0" y="848"/>
                    </a:cubicBezTo>
                    <a:lnTo>
                      <a:pt x="0" y="48"/>
                    </a:lnTo>
                    <a:close/>
                    <a:moveTo>
                      <a:pt x="96" y="848"/>
                    </a:moveTo>
                    <a:lnTo>
                      <a:pt x="48" y="800"/>
                    </a:lnTo>
                    <a:lnTo>
                      <a:pt x="4048" y="800"/>
                    </a:lnTo>
                    <a:lnTo>
                      <a:pt x="4000" y="848"/>
                    </a:lnTo>
                    <a:lnTo>
                      <a:pt x="4000" y="48"/>
                    </a:lnTo>
                    <a:lnTo>
                      <a:pt x="4048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84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1" name="Rectangle 60"/>
              <p:cNvSpPr>
                <a:spLocks noChangeArrowheads="1"/>
              </p:cNvSpPr>
              <p:nvPr/>
            </p:nvSpPr>
            <p:spPr bwMode="auto">
              <a:xfrm>
                <a:off x="5772150" y="4202113"/>
                <a:ext cx="379413" cy="17303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2" name="Freeform 61"/>
              <p:cNvSpPr>
                <a:spLocks noEditPoints="1"/>
              </p:cNvSpPr>
              <p:nvPr/>
            </p:nvSpPr>
            <p:spPr bwMode="auto">
              <a:xfrm>
                <a:off x="5767388" y="4198938"/>
                <a:ext cx="388938" cy="180975"/>
              </a:xfrm>
              <a:custGeom>
                <a:avLst/>
                <a:gdLst>
                  <a:gd name="T0" fmla="*/ 0 w 4080"/>
                  <a:gd name="T1" fmla="*/ 48 h 1904"/>
                  <a:gd name="T2" fmla="*/ 48 w 4080"/>
                  <a:gd name="T3" fmla="*/ 0 h 1904"/>
                  <a:gd name="T4" fmla="*/ 4032 w 4080"/>
                  <a:gd name="T5" fmla="*/ 0 h 1904"/>
                  <a:gd name="T6" fmla="*/ 4080 w 4080"/>
                  <a:gd name="T7" fmla="*/ 48 h 1904"/>
                  <a:gd name="T8" fmla="*/ 4080 w 4080"/>
                  <a:gd name="T9" fmla="*/ 1856 h 1904"/>
                  <a:gd name="T10" fmla="*/ 4032 w 4080"/>
                  <a:gd name="T11" fmla="*/ 1904 h 1904"/>
                  <a:gd name="T12" fmla="*/ 48 w 4080"/>
                  <a:gd name="T13" fmla="*/ 1904 h 1904"/>
                  <a:gd name="T14" fmla="*/ 0 w 4080"/>
                  <a:gd name="T15" fmla="*/ 1856 h 1904"/>
                  <a:gd name="T16" fmla="*/ 0 w 4080"/>
                  <a:gd name="T17" fmla="*/ 48 h 1904"/>
                  <a:gd name="T18" fmla="*/ 96 w 4080"/>
                  <a:gd name="T19" fmla="*/ 1856 h 1904"/>
                  <a:gd name="T20" fmla="*/ 48 w 4080"/>
                  <a:gd name="T21" fmla="*/ 1808 h 1904"/>
                  <a:gd name="T22" fmla="*/ 4032 w 4080"/>
                  <a:gd name="T23" fmla="*/ 1808 h 1904"/>
                  <a:gd name="T24" fmla="*/ 3984 w 4080"/>
                  <a:gd name="T25" fmla="*/ 1856 h 1904"/>
                  <a:gd name="T26" fmla="*/ 3984 w 4080"/>
                  <a:gd name="T27" fmla="*/ 48 h 1904"/>
                  <a:gd name="T28" fmla="*/ 4032 w 4080"/>
                  <a:gd name="T29" fmla="*/ 96 h 1904"/>
                  <a:gd name="T30" fmla="*/ 48 w 4080"/>
                  <a:gd name="T31" fmla="*/ 96 h 1904"/>
                  <a:gd name="T32" fmla="*/ 96 w 4080"/>
                  <a:gd name="T33" fmla="*/ 48 h 1904"/>
                  <a:gd name="T34" fmla="*/ 96 w 4080"/>
                  <a:gd name="T35" fmla="*/ 1856 h 19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4080" h="1904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4032" y="0"/>
                    </a:lnTo>
                    <a:cubicBezTo>
                      <a:pt x="4059" y="0"/>
                      <a:pt x="4080" y="22"/>
                      <a:pt x="4080" y="48"/>
                    </a:cubicBezTo>
                    <a:lnTo>
                      <a:pt x="4080" y="1856"/>
                    </a:lnTo>
                    <a:cubicBezTo>
                      <a:pt x="4080" y="1883"/>
                      <a:pt x="4059" y="1904"/>
                      <a:pt x="4032" y="1904"/>
                    </a:cubicBezTo>
                    <a:lnTo>
                      <a:pt x="48" y="1904"/>
                    </a:lnTo>
                    <a:cubicBezTo>
                      <a:pt x="22" y="1904"/>
                      <a:pt x="0" y="1883"/>
                      <a:pt x="0" y="1856"/>
                    </a:cubicBezTo>
                    <a:lnTo>
                      <a:pt x="0" y="48"/>
                    </a:lnTo>
                    <a:close/>
                    <a:moveTo>
                      <a:pt x="96" y="1856"/>
                    </a:moveTo>
                    <a:lnTo>
                      <a:pt x="48" y="1808"/>
                    </a:lnTo>
                    <a:lnTo>
                      <a:pt x="4032" y="1808"/>
                    </a:lnTo>
                    <a:lnTo>
                      <a:pt x="3984" y="1856"/>
                    </a:lnTo>
                    <a:lnTo>
                      <a:pt x="3984" y="48"/>
                    </a:lnTo>
                    <a:lnTo>
                      <a:pt x="4032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1856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3" name="Rectangle 62"/>
              <p:cNvSpPr>
                <a:spLocks noChangeArrowheads="1"/>
              </p:cNvSpPr>
              <p:nvPr/>
            </p:nvSpPr>
            <p:spPr bwMode="auto">
              <a:xfrm>
                <a:off x="7104063" y="2613025"/>
                <a:ext cx="381000" cy="176212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4" name="Freeform 63"/>
              <p:cNvSpPr>
                <a:spLocks noEditPoints="1"/>
              </p:cNvSpPr>
              <p:nvPr/>
            </p:nvSpPr>
            <p:spPr bwMode="auto">
              <a:xfrm>
                <a:off x="7099300" y="2608263"/>
                <a:ext cx="390525" cy="1771650"/>
              </a:xfrm>
              <a:custGeom>
                <a:avLst/>
                <a:gdLst>
                  <a:gd name="T0" fmla="*/ 0 w 2048"/>
                  <a:gd name="T1" fmla="*/ 24 h 9296"/>
                  <a:gd name="T2" fmla="*/ 24 w 2048"/>
                  <a:gd name="T3" fmla="*/ 0 h 9296"/>
                  <a:gd name="T4" fmla="*/ 2024 w 2048"/>
                  <a:gd name="T5" fmla="*/ 0 h 9296"/>
                  <a:gd name="T6" fmla="*/ 2048 w 2048"/>
                  <a:gd name="T7" fmla="*/ 24 h 9296"/>
                  <a:gd name="T8" fmla="*/ 2048 w 2048"/>
                  <a:gd name="T9" fmla="*/ 9272 h 9296"/>
                  <a:gd name="T10" fmla="*/ 2024 w 2048"/>
                  <a:gd name="T11" fmla="*/ 9296 h 9296"/>
                  <a:gd name="T12" fmla="*/ 24 w 2048"/>
                  <a:gd name="T13" fmla="*/ 9296 h 9296"/>
                  <a:gd name="T14" fmla="*/ 0 w 2048"/>
                  <a:gd name="T15" fmla="*/ 9272 h 9296"/>
                  <a:gd name="T16" fmla="*/ 0 w 2048"/>
                  <a:gd name="T17" fmla="*/ 24 h 9296"/>
                  <a:gd name="T18" fmla="*/ 48 w 2048"/>
                  <a:gd name="T19" fmla="*/ 9272 h 9296"/>
                  <a:gd name="T20" fmla="*/ 24 w 2048"/>
                  <a:gd name="T21" fmla="*/ 9248 h 9296"/>
                  <a:gd name="T22" fmla="*/ 2024 w 2048"/>
                  <a:gd name="T23" fmla="*/ 9248 h 9296"/>
                  <a:gd name="T24" fmla="*/ 2000 w 2048"/>
                  <a:gd name="T25" fmla="*/ 9272 h 9296"/>
                  <a:gd name="T26" fmla="*/ 2000 w 2048"/>
                  <a:gd name="T27" fmla="*/ 24 h 9296"/>
                  <a:gd name="T28" fmla="*/ 2024 w 2048"/>
                  <a:gd name="T29" fmla="*/ 48 h 9296"/>
                  <a:gd name="T30" fmla="*/ 24 w 2048"/>
                  <a:gd name="T31" fmla="*/ 48 h 9296"/>
                  <a:gd name="T32" fmla="*/ 48 w 2048"/>
                  <a:gd name="T33" fmla="*/ 24 h 9296"/>
                  <a:gd name="T34" fmla="*/ 48 w 2048"/>
                  <a:gd name="T35" fmla="*/ 9272 h 92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2048" h="9296">
                    <a:moveTo>
                      <a:pt x="0" y="24"/>
                    </a:moveTo>
                    <a:cubicBezTo>
                      <a:pt x="0" y="11"/>
                      <a:pt x="11" y="0"/>
                      <a:pt x="24" y="0"/>
                    </a:cubicBezTo>
                    <a:lnTo>
                      <a:pt x="2024" y="0"/>
                    </a:lnTo>
                    <a:cubicBezTo>
                      <a:pt x="2038" y="0"/>
                      <a:pt x="2048" y="11"/>
                      <a:pt x="2048" y="24"/>
                    </a:cubicBezTo>
                    <a:lnTo>
                      <a:pt x="2048" y="9272"/>
                    </a:lnTo>
                    <a:cubicBezTo>
                      <a:pt x="2048" y="9286"/>
                      <a:pt x="2038" y="9296"/>
                      <a:pt x="2024" y="9296"/>
                    </a:cubicBezTo>
                    <a:lnTo>
                      <a:pt x="24" y="9296"/>
                    </a:lnTo>
                    <a:cubicBezTo>
                      <a:pt x="11" y="9296"/>
                      <a:pt x="0" y="9286"/>
                      <a:pt x="0" y="9272"/>
                    </a:cubicBezTo>
                    <a:lnTo>
                      <a:pt x="0" y="24"/>
                    </a:lnTo>
                    <a:close/>
                    <a:moveTo>
                      <a:pt x="48" y="9272"/>
                    </a:moveTo>
                    <a:lnTo>
                      <a:pt x="24" y="9248"/>
                    </a:lnTo>
                    <a:lnTo>
                      <a:pt x="2024" y="9248"/>
                    </a:lnTo>
                    <a:lnTo>
                      <a:pt x="2000" y="9272"/>
                    </a:lnTo>
                    <a:lnTo>
                      <a:pt x="2000" y="24"/>
                    </a:lnTo>
                    <a:lnTo>
                      <a:pt x="2024" y="48"/>
                    </a:lnTo>
                    <a:lnTo>
                      <a:pt x="24" y="48"/>
                    </a:lnTo>
                    <a:lnTo>
                      <a:pt x="48" y="24"/>
                    </a:lnTo>
                    <a:lnTo>
                      <a:pt x="48" y="9272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5" name="Freeform 64"/>
              <p:cNvSpPr>
                <a:spLocks noEditPoints="1"/>
              </p:cNvSpPr>
              <p:nvPr/>
            </p:nvSpPr>
            <p:spPr bwMode="auto">
              <a:xfrm>
                <a:off x="5553075" y="4359275"/>
                <a:ext cx="55563" cy="9525"/>
              </a:xfrm>
              <a:custGeom>
                <a:avLst/>
                <a:gdLst>
                  <a:gd name="T0" fmla="*/ 15 w 35"/>
                  <a:gd name="T1" fmla="*/ 5 h 6"/>
                  <a:gd name="T2" fmla="*/ 15 w 35"/>
                  <a:gd name="T3" fmla="*/ 3 h 6"/>
                  <a:gd name="T4" fmla="*/ 21 w 35"/>
                  <a:gd name="T5" fmla="*/ 3 h 6"/>
                  <a:gd name="T6" fmla="*/ 21 w 35"/>
                  <a:gd name="T7" fmla="*/ 5 h 6"/>
                  <a:gd name="T8" fmla="*/ 15 w 35"/>
                  <a:gd name="T9" fmla="*/ 5 h 6"/>
                  <a:gd name="T10" fmla="*/ 0 w 35"/>
                  <a:gd name="T11" fmla="*/ 0 h 6"/>
                  <a:gd name="T12" fmla="*/ 35 w 35"/>
                  <a:gd name="T13" fmla="*/ 0 h 6"/>
                  <a:gd name="T14" fmla="*/ 35 w 35"/>
                  <a:gd name="T15" fmla="*/ 6 h 6"/>
                  <a:gd name="T16" fmla="*/ 0 w 35"/>
                  <a:gd name="T17" fmla="*/ 6 h 6"/>
                  <a:gd name="T18" fmla="*/ 0 w 35"/>
                  <a:gd name="T19" fmla="*/ 0 h 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5" h="6">
                    <a:moveTo>
                      <a:pt x="15" y="5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5"/>
                    </a:lnTo>
                    <a:lnTo>
                      <a:pt x="15" y="5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Freeform 65"/>
              <p:cNvSpPr>
                <a:spLocks noEditPoints="1"/>
              </p:cNvSpPr>
              <p:nvPr/>
            </p:nvSpPr>
            <p:spPr bwMode="auto">
              <a:xfrm>
                <a:off x="6884988" y="4276725"/>
                <a:ext cx="57150" cy="22225"/>
              </a:xfrm>
              <a:custGeom>
                <a:avLst/>
                <a:gdLst>
                  <a:gd name="T0" fmla="*/ 15 w 36"/>
                  <a:gd name="T1" fmla="*/ 14 h 14"/>
                  <a:gd name="T2" fmla="*/ 15 w 36"/>
                  <a:gd name="T3" fmla="*/ 3 h 14"/>
                  <a:gd name="T4" fmla="*/ 21 w 36"/>
                  <a:gd name="T5" fmla="*/ 3 h 14"/>
                  <a:gd name="T6" fmla="*/ 21 w 36"/>
                  <a:gd name="T7" fmla="*/ 14 h 14"/>
                  <a:gd name="T8" fmla="*/ 15 w 36"/>
                  <a:gd name="T9" fmla="*/ 14 h 14"/>
                  <a:gd name="T10" fmla="*/ 0 w 36"/>
                  <a:gd name="T11" fmla="*/ 0 h 14"/>
                  <a:gd name="T12" fmla="*/ 36 w 36"/>
                  <a:gd name="T13" fmla="*/ 0 h 14"/>
                  <a:gd name="T14" fmla="*/ 36 w 36"/>
                  <a:gd name="T15" fmla="*/ 6 h 14"/>
                  <a:gd name="T16" fmla="*/ 0 w 36"/>
                  <a:gd name="T17" fmla="*/ 6 h 14"/>
                  <a:gd name="T18" fmla="*/ 0 w 36"/>
                  <a:gd name="T19" fmla="*/ 0 h 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14">
                    <a:moveTo>
                      <a:pt x="15" y="14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14"/>
                    </a:lnTo>
                    <a:lnTo>
                      <a:pt x="15" y="14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Freeform 66"/>
              <p:cNvSpPr>
                <a:spLocks noEditPoints="1"/>
              </p:cNvSpPr>
              <p:nvPr/>
            </p:nvSpPr>
            <p:spPr bwMode="auto">
              <a:xfrm>
                <a:off x="5934075" y="4184650"/>
                <a:ext cx="55563" cy="17463"/>
              </a:xfrm>
              <a:custGeom>
                <a:avLst/>
                <a:gdLst>
                  <a:gd name="T0" fmla="*/ 14 w 35"/>
                  <a:gd name="T1" fmla="*/ 11 h 11"/>
                  <a:gd name="T2" fmla="*/ 14 w 35"/>
                  <a:gd name="T3" fmla="*/ 3 h 11"/>
                  <a:gd name="T4" fmla="*/ 20 w 35"/>
                  <a:gd name="T5" fmla="*/ 3 h 11"/>
                  <a:gd name="T6" fmla="*/ 20 w 35"/>
                  <a:gd name="T7" fmla="*/ 11 h 11"/>
                  <a:gd name="T8" fmla="*/ 14 w 35"/>
                  <a:gd name="T9" fmla="*/ 11 h 11"/>
                  <a:gd name="T10" fmla="*/ 0 w 35"/>
                  <a:gd name="T11" fmla="*/ 0 h 11"/>
                  <a:gd name="T12" fmla="*/ 35 w 35"/>
                  <a:gd name="T13" fmla="*/ 0 h 11"/>
                  <a:gd name="T14" fmla="*/ 35 w 35"/>
                  <a:gd name="T15" fmla="*/ 6 h 11"/>
                  <a:gd name="T16" fmla="*/ 0 w 35"/>
                  <a:gd name="T17" fmla="*/ 6 h 11"/>
                  <a:gd name="T18" fmla="*/ 0 w 35"/>
                  <a:gd name="T19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5" h="11">
                    <a:moveTo>
                      <a:pt x="14" y="11"/>
                    </a:moveTo>
                    <a:lnTo>
                      <a:pt x="14" y="3"/>
                    </a:lnTo>
                    <a:lnTo>
                      <a:pt x="20" y="3"/>
                    </a:lnTo>
                    <a:lnTo>
                      <a:pt x="20" y="11"/>
                    </a:lnTo>
                    <a:lnTo>
                      <a:pt x="14" y="11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Freeform 67"/>
              <p:cNvSpPr>
                <a:spLocks noEditPoints="1"/>
              </p:cNvSpPr>
              <p:nvPr/>
            </p:nvSpPr>
            <p:spPr bwMode="auto">
              <a:xfrm>
                <a:off x="7265988" y="2424113"/>
                <a:ext cx="57150" cy="188913"/>
              </a:xfrm>
              <a:custGeom>
                <a:avLst/>
                <a:gdLst>
                  <a:gd name="T0" fmla="*/ 15 w 36"/>
                  <a:gd name="T1" fmla="*/ 119 h 119"/>
                  <a:gd name="T2" fmla="*/ 15 w 36"/>
                  <a:gd name="T3" fmla="*/ 3 h 119"/>
                  <a:gd name="T4" fmla="*/ 21 w 36"/>
                  <a:gd name="T5" fmla="*/ 3 h 119"/>
                  <a:gd name="T6" fmla="*/ 21 w 36"/>
                  <a:gd name="T7" fmla="*/ 119 h 119"/>
                  <a:gd name="T8" fmla="*/ 15 w 36"/>
                  <a:gd name="T9" fmla="*/ 119 h 119"/>
                  <a:gd name="T10" fmla="*/ 0 w 36"/>
                  <a:gd name="T11" fmla="*/ 0 h 119"/>
                  <a:gd name="T12" fmla="*/ 36 w 36"/>
                  <a:gd name="T13" fmla="*/ 0 h 119"/>
                  <a:gd name="T14" fmla="*/ 36 w 36"/>
                  <a:gd name="T15" fmla="*/ 6 h 119"/>
                  <a:gd name="T16" fmla="*/ 0 w 36"/>
                  <a:gd name="T17" fmla="*/ 6 h 119"/>
                  <a:gd name="T18" fmla="*/ 0 w 36"/>
                  <a:gd name="T19" fmla="*/ 0 h 1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119">
                    <a:moveTo>
                      <a:pt x="15" y="119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119"/>
                    </a:lnTo>
                    <a:lnTo>
                      <a:pt x="15" y="119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Rectangle 68"/>
              <p:cNvSpPr>
                <a:spLocks noChangeArrowheads="1"/>
              </p:cNvSpPr>
              <p:nvPr/>
            </p:nvSpPr>
            <p:spPr bwMode="auto">
              <a:xfrm>
                <a:off x="5100638" y="2092325"/>
                <a:ext cx="9525" cy="2282825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Freeform 69"/>
              <p:cNvSpPr>
                <a:spLocks noEditPoints="1"/>
              </p:cNvSpPr>
              <p:nvPr/>
            </p:nvSpPr>
            <p:spPr bwMode="auto">
              <a:xfrm>
                <a:off x="5059363" y="2087563"/>
                <a:ext cx="46038" cy="2292350"/>
              </a:xfrm>
              <a:custGeom>
                <a:avLst/>
                <a:gdLst>
                  <a:gd name="T0" fmla="*/ 0 w 29"/>
                  <a:gd name="T1" fmla="*/ 1438 h 1444"/>
                  <a:gd name="T2" fmla="*/ 29 w 29"/>
                  <a:gd name="T3" fmla="*/ 1438 h 1444"/>
                  <a:gd name="T4" fmla="*/ 29 w 29"/>
                  <a:gd name="T5" fmla="*/ 1444 h 1444"/>
                  <a:gd name="T6" fmla="*/ 0 w 29"/>
                  <a:gd name="T7" fmla="*/ 1444 h 1444"/>
                  <a:gd name="T8" fmla="*/ 0 w 29"/>
                  <a:gd name="T9" fmla="*/ 1438 h 1444"/>
                  <a:gd name="T10" fmla="*/ 0 w 29"/>
                  <a:gd name="T11" fmla="*/ 1233 h 1444"/>
                  <a:gd name="T12" fmla="*/ 29 w 29"/>
                  <a:gd name="T13" fmla="*/ 1233 h 1444"/>
                  <a:gd name="T14" fmla="*/ 29 w 29"/>
                  <a:gd name="T15" fmla="*/ 1238 h 1444"/>
                  <a:gd name="T16" fmla="*/ 0 w 29"/>
                  <a:gd name="T17" fmla="*/ 1238 h 1444"/>
                  <a:gd name="T18" fmla="*/ 0 w 29"/>
                  <a:gd name="T19" fmla="*/ 1233 h 1444"/>
                  <a:gd name="T20" fmla="*/ 0 w 29"/>
                  <a:gd name="T21" fmla="*/ 1027 h 1444"/>
                  <a:gd name="T22" fmla="*/ 29 w 29"/>
                  <a:gd name="T23" fmla="*/ 1027 h 1444"/>
                  <a:gd name="T24" fmla="*/ 29 w 29"/>
                  <a:gd name="T25" fmla="*/ 1033 h 1444"/>
                  <a:gd name="T26" fmla="*/ 0 w 29"/>
                  <a:gd name="T27" fmla="*/ 1033 h 1444"/>
                  <a:gd name="T28" fmla="*/ 0 w 29"/>
                  <a:gd name="T29" fmla="*/ 1027 h 1444"/>
                  <a:gd name="T30" fmla="*/ 0 w 29"/>
                  <a:gd name="T31" fmla="*/ 822 h 1444"/>
                  <a:gd name="T32" fmla="*/ 29 w 29"/>
                  <a:gd name="T33" fmla="*/ 822 h 1444"/>
                  <a:gd name="T34" fmla="*/ 29 w 29"/>
                  <a:gd name="T35" fmla="*/ 827 h 1444"/>
                  <a:gd name="T36" fmla="*/ 0 w 29"/>
                  <a:gd name="T37" fmla="*/ 827 h 1444"/>
                  <a:gd name="T38" fmla="*/ 0 w 29"/>
                  <a:gd name="T39" fmla="*/ 822 h 1444"/>
                  <a:gd name="T40" fmla="*/ 0 w 29"/>
                  <a:gd name="T41" fmla="*/ 616 h 1444"/>
                  <a:gd name="T42" fmla="*/ 29 w 29"/>
                  <a:gd name="T43" fmla="*/ 616 h 1444"/>
                  <a:gd name="T44" fmla="*/ 29 w 29"/>
                  <a:gd name="T45" fmla="*/ 622 h 1444"/>
                  <a:gd name="T46" fmla="*/ 0 w 29"/>
                  <a:gd name="T47" fmla="*/ 622 h 1444"/>
                  <a:gd name="T48" fmla="*/ 0 w 29"/>
                  <a:gd name="T49" fmla="*/ 616 h 1444"/>
                  <a:gd name="T50" fmla="*/ 0 w 29"/>
                  <a:gd name="T51" fmla="*/ 411 h 1444"/>
                  <a:gd name="T52" fmla="*/ 29 w 29"/>
                  <a:gd name="T53" fmla="*/ 411 h 1444"/>
                  <a:gd name="T54" fmla="*/ 29 w 29"/>
                  <a:gd name="T55" fmla="*/ 416 h 1444"/>
                  <a:gd name="T56" fmla="*/ 0 w 29"/>
                  <a:gd name="T57" fmla="*/ 416 h 1444"/>
                  <a:gd name="T58" fmla="*/ 0 w 29"/>
                  <a:gd name="T59" fmla="*/ 411 h 1444"/>
                  <a:gd name="T60" fmla="*/ 0 w 29"/>
                  <a:gd name="T61" fmla="*/ 205 h 1444"/>
                  <a:gd name="T62" fmla="*/ 29 w 29"/>
                  <a:gd name="T63" fmla="*/ 205 h 1444"/>
                  <a:gd name="T64" fmla="*/ 29 w 29"/>
                  <a:gd name="T65" fmla="*/ 211 h 1444"/>
                  <a:gd name="T66" fmla="*/ 0 w 29"/>
                  <a:gd name="T67" fmla="*/ 211 h 1444"/>
                  <a:gd name="T68" fmla="*/ 0 w 29"/>
                  <a:gd name="T69" fmla="*/ 205 h 1444"/>
                  <a:gd name="T70" fmla="*/ 0 w 29"/>
                  <a:gd name="T71" fmla="*/ 0 h 1444"/>
                  <a:gd name="T72" fmla="*/ 29 w 29"/>
                  <a:gd name="T73" fmla="*/ 0 h 1444"/>
                  <a:gd name="T74" fmla="*/ 29 w 29"/>
                  <a:gd name="T75" fmla="*/ 6 h 1444"/>
                  <a:gd name="T76" fmla="*/ 0 w 29"/>
                  <a:gd name="T77" fmla="*/ 6 h 1444"/>
                  <a:gd name="T78" fmla="*/ 0 w 29"/>
                  <a:gd name="T79" fmla="*/ 0 h 14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</a:cxnLst>
                <a:rect l="0" t="0" r="r" b="b"/>
                <a:pathLst>
                  <a:path w="29" h="1444">
                    <a:moveTo>
                      <a:pt x="0" y="1438"/>
                    </a:moveTo>
                    <a:lnTo>
                      <a:pt x="29" y="1438"/>
                    </a:lnTo>
                    <a:lnTo>
                      <a:pt x="29" y="1444"/>
                    </a:lnTo>
                    <a:lnTo>
                      <a:pt x="0" y="1444"/>
                    </a:lnTo>
                    <a:lnTo>
                      <a:pt x="0" y="1438"/>
                    </a:lnTo>
                    <a:close/>
                    <a:moveTo>
                      <a:pt x="0" y="1233"/>
                    </a:moveTo>
                    <a:lnTo>
                      <a:pt x="29" y="1233"/>
                    </a:lnTo>
                    <a:lnTo>
                      <a:pt x="29" y="1238"/>
                    </a:lnTo>
                    <a:lnTo>
                      <a:pt x="0" y="1238"/>
                    </a:lnTo>
                    <a:lnTo>
                      <a:pt x="0" y="1233"/>
                    </a:lnTo>
                    <a:close/>
                    <a:moveTo>
                      <a:pt x="0" y="1027"/>
                    </a:moveTo>
                    <a:lnTo>
                      <a:pt x="29" y="1027"/>
                    </a:lnTo>
                    <a:lnTo>
                      <a:pt x="29" y="1033"/>
                    </a:lnTo>
                    <a:lnTo>
                      <a:pt x="0" y="1033"/>
                    </a:lnTo>
                    <a:lnTo>
                      <a:pt x="0" y="1027"/>
                    </a:lnTo>
                    <a:close/>
                    <a:moveTo>
                      <a:pt x="0" y="822"/>
                    </a:moveTo>
                    <a:lnTo>
                      <a:pt x="29" y="822"/>
                    </a:lnTo>
                    <a:lnTo>
                      <a:pt x="29" y="827"/>
                    </a:lnTo>
                    <a:lnTo>
                      <a:pt x="0" y="827"/>
                    </a:lnTo>
                    <a:lnTo>
                      <a:pt x="0" y="822"/>
                    </a:lnTo>
                    <a:close/>
                    <a:moveTo>
                      <a:pt x="0" y="616"/>
                    </a:moveTo>
                    <a:lnTo>
                      <a:pt x="29" y="616"/>
                    </a:lnTo>
                    <a:lnTo>
                      <a:pt x="29" y="622"/>
                    </a:lnTo>
                    <a:lnTo>
                      <a:pt x="0" y="622"/>
                    </a:lnTo>
                    <a:lnTo>
                      <a:pt x="0" y="616"/>
                    </a:lnTo>
                    <a:close/>
                    <a:moveTo>
                      <a:pt x="0" y="411"/>
                    </a:moveTo>
                    <a:lnTo>
                      <a:pt x="29" y="411"/>
                    </a:lnTo>
                    <a:lnTo>
                      <a:pt x="29" y="416"/>
                    </a:lnTo>
                    <a:lnTo>
                      <a:pt x="0" y="416"/>
                    </a:lnTo>
                    <a:lnTo>
                      <a:pt x="0" y="411"/>
                    </a:lnTo>
                    <a:close/>
                    <a:moveTo>
                      <a:pt x="0" y="205"/>
                    </a:moveTo>
                    <a:lnTo>
                      <a:pt x="29" y="205"/>
                    </a:lnTo>
                    <a:lnTo>
                      <a:pt x="29" y="211"/>
                    </a:lnTo>
                    <a:lnTo>
                      <a:pt x="0" y="211"/>
                    </a:lnTo>
                    <a:lnTo>
                      <a:pt x="0" y="205"/>
                    </a:lnTo>
                    <a:close/>
                    <a:moveTo>
                      <a:pt x="0" y="0"/>
                    </a:moveTo>
                    <a:lnTo>
                      <a:pt x="29" y="0"/>
                    </a:lnTo>
                    <a:lnTo>
                      <a:pt x="29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Rectangle 70"/>
              <p:cNvSpPr>
                <a:spLocks noChangeArrowheads="1"/>
              </p:cNvSpPr>
              <p:nvPr/>
            </p:nvSpPr>
            <p:spPr bwMode="auto">
              <a:xfrm>
                <a:off x="5105400" y="4370388"/>
                <a:ext cx="2665413" cy="9525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Rectangle 71"/>
              <p:cNvSpPr>
                <a:spLocks noChangeArrowheads="1"/>
              </p:cNvSpPr>
              <p:nvPr/>
            </p:nvSpPr>
            <p:spPr bwMode="auto">
              <a:xfrm>
                <a:off x="4732407" y="4287837"/>
                <a:ext cx="179964" cy="2451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Rectangle 72"/>
              <p:cNvSpPr>
                <a:spLocks noChangeArrowheads="1"/>
              </p:cNvSpPr>
              <p:nvPr/>
            </p:nvSpPr>
            <p:spPr bwMode="auto">
              <a:xfrm>
                <a:off x="4600769" y="3962401"/>
                <a:ext cx="359925" cy="2451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Rectangle 73"/>
              <p:cNvSpPr>
                <a:spLocks noChangeArrowheads="1"/>
              </p:cNvSpPr>
              <p:nvPr/>
            </p:nvSpPr>
            <p:spPr bwMode="auto">
              <a:xfrm>
                <a:off x="4600769" y="3635376"/>
                <a:ext cx="359925" cy="2451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Rectangle 74"/>
              <p:cNvSpPr>
                <a:spLocks noChangeArrowheads="1"/>
              </p:cNvSpPr>
              <p:nvPr/>
            </p:nvSpPr>
            <p:spPr bwMode="auto">
              <a:xfrm>
                <a:off x="4600769" y="3308351"/>
                <a:ext cx="359925" cy="2451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Rectangle 75"/>
              <p:cNvSpPr>
                <a:spLocks noChangeArrowheads="1"/>
              </p:cNvSpPr>
              <p:nvPr/>
            </p:nvSpPr>
            <p:spPr bwMode="auto">
              <a:xfrm>
                <a:off x="4600769" y="2982912"/>
                <a:ext cx="359925" cy="2451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Rectangle 76"/>
              <p:cNvSpPr>
                <a:spLocks noChangeArrowheads="1"/>
              </p:cNvSpPr>
              <p:nvPr/>
            </p:nvSpPr>
            <p:spPr bwMode="auto">
              <a:xfrm>
                <a:off x="4600769" y="2655889"/>
                <a:ext cx="359925" cy="2451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Rectangle 77"/>
              <p:cNvSpPr>
                <a:spLocks noChangeArrowheads="1"/>
              </p:cNvSpPr>
              <p:nvPr/>
            </p:nvSpPr>
            <p:spPr bwMode="auto">
              <a:xfrm>
                <a:off x="4600769" y="2330450"/>
                <a:ext cx="359925" cy="2451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Rectangle 78"/>
              <p:cNvSpPr>
                <a:spLocks noChangeArrowheads="1"/>
              </p:cNvSpPr>
              <p:nvPr/>
            </p:nvSpPr>
            <p:spPr bwMode="auto">
              <a:xfrm>
                <a:off x="4600769" y="2001838"/>
                <a:ext cx="359925" cy="2451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Rectangle 79"/>
              <p:cNvSpPr>
                <a:spLocks noChangeArrowheads="1"/>
              </p:cNvSpPr>
              <p:nvPr/>
            </p:nvSpPr>
            <p:spPr bwMode="auto">
              <a:xfrm>
                <a:off x="5431751" y="4379737"/>
                <a:ext cx="652637" cy="268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w/o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Rectangle 80"/>
              <p:cNvSpPr>
                <a:spLocks noChangeArrowheads="1"/>
              </p:cNvSpPr>
              <p:nvPr/>
            </p:nvSpPr>
            <p:spPr bwMode="auto">
              <a:xfrm>
                <a:off x="6274579" y="4379740"/>
                <a:ext cx="1633781" cy="268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LPS/IL</a:t>
                </a:r>
                <a:r>
                  <a:rPr kumimoji="1" lang="en-US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Rectangle 81"/>
              <p:cNvSpPr>
                <a:spLocks noChangeArrowheads="1"/>
              </p:cNvSpPr>
              <p:nvPr/>
            </p:nvSpPr>
            <p:spPr bwMode="auto">
              <a:xfrm rot="16200000">
                <a:off x="3639822" y="2926247"/>
                <a:ext cx="1095100" cy="5045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IgE (ng/ml)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Rectangle 82"/>
              <p:cNvSpPr>
                <a:spLocks noChangeArrowheads="1"/>
              </p:cNvSpPr>
              <p:nvPr/>
            </p:nvSpPr>
            <p:spPr bwMode="auto">
              <a:xfrm>
                <a:off x="8159110" y="2166096"/>
                <a:ext cx="160137" cy="8601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Freeform 83"/>
              <p:cNvSpPr>
                <a:spLocks noEditPoints="1"/>
              </p:cNvSpPr>
              <p:nvPr/>
            </p:nvSpPr>
            <p:spPr bwMode="auto">
              <a:xfrm>
                <a:off x="8152960" y="2168126"/>
                <a:ext cx="160137" cy="84137"/>
              </a:xfrm>
              <a:custGeom>
                <a:avLst/>
                <a:gdLst>
                  <a:gd name="T0" fmla="*/ 0 w 912"/>
                  <a:gd name="T1" fmla="*/ 48 h 896"/>
                  <a:gd name="T2" fmla="*/ 48 w 912"/>
                  <a:gd name="T3" fmla="*/ 0 h 896"/>
                  <a:gd name="T4" fmla="*/ 864 w 912"/>
                  <a:gd name="T5" fmla="*/ 0 h 896"/>
                  <a:gd name="T6" fmla="*/ 912 w 912"/>
                  <a:gd name="T7" fmla="*/ 48 h 896"/>
                  <a:gd name="T8" fmla="*/ 912 w 912"/>
                  <a:gd name="T9" fmla="*/ 848 h 896"/>
                  <a:gd name="T10" fmla="*/ 864 w 912"/>
                  <a:gd name="T11" fmla="*/ 896 h 896"/>
                  <a:gd name="T12" fmla="*/ 48 w 912"/>
                  <a:gd name="T13" fmla="*/ 896 h 896"/>
                  <a:gd name="T14" fmla="*/ 0 w 912"/>
                  <a:gd name="T15" fmla="*/ 848 h 896"/>
                  <a:gd name="T16" fmla="*/ 0 w 912"/>
                  <a:gd name="T17" fmla="*/ 48 h 896"/>
                  <a:gd name="T18" fmla="*/ 96 w 912"/>
                  <a:gd name="T19" fmla="*/ 848 h 896"/>
                  <a:gd name="T20" fmla="*/ 48 w 912"/>
                  <a:gd name="T21" fmla="*/ 800 h 896"/>
                  <a:gd name="T22" fmla="*/ 864 w 912"/>
                  <a:gd name="T23" fmla="*/ 800 h 896"/>
                  <a:gd name="T24" fmla="*/ 816 w 912"/>
                  <a:gd name="T25" fmla="*/ 848 h 896"/>
                  <a:gd name="T26" fmla="*/ 816 w 912"/>
                  <a:gd name="T27" fmla="*/ 48 h 896"/>
                  <a:gd name="T28" fmla="*/ 864 w 912"/>
                  <a:gd name="T29" fmla="*/ 96 h 896"/>
                  <a:gd name="T30" fmla="*/ 48 w 912"/>
                  <a:gd name="T31" fmla="*/ 96 h 896"/>
                  <a:gd name="T32" fmla="*/ 96 w 912"/>
                  <a:gd name="T33" fmla="*/ 48 h 896"/>
                  <a:gd name="T34" fmla="*/ 96 w 912"/>
                  <a:gd name="T35" fmla="*/ 848 h 8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912" h="896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864" y="0"/>
                    </a:lnTo>
                    <a:cubicBezTo>
                      <a:pt x="891" y="0"/>
                      <a:pt x="912" y="22"/>
                      <a:pt x="912" y="48"/>
                    </a:cubicBezTo>
                    <a:lnTo>
                      <a:pt x="912" y="848"/>
                    </a:lnTo>
                    <a:cubicBezTo>
                      <a:pt x="912" y="875"/>
                      <a:pt x="891" y="896"/>
                      <a:pt x="864" y="896"/>
                    </a:cubicBezTo>
                    <a:lnTo>
                      <a:pt x="48" y="896"/>
                    </a:lnTo>
                    <a:cubicBezTo>
                      <a:pt x="22" y="896"/>
                      <a:pt x="0" y="875"/>
                      <a:pt x="0" y="848"/>
                    </a:cubicBezTo>
                    <a:lnTo>
                      <a:pt x="0" y="48"/>
                    </a:lnTo>
                    <a:close/>
                    <a:moveTo>
                      <a:pt x="96" y="848"/>
                    </a:moveTo>
                    <a:lnTo>
                      <a:pt x="48" y="800"/>
                    </a:lnTo>
                    <a:lnTo>
                      <a:pt x="864" y="800"/>
                    </a:lnTo>
                    <a:lnTo>
                      <a:pt x="816" y="848"/>
                    </a:lnTo>
                    <a:lnTo>
                      <a:pt x="816" y="48"/>
                    </a:lnTo>
                    <a:lnTo>
                      <a:pt x="864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84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Rectangle 84"/>
              <p:cNvSpPr>
                <a:spLocks noChangeArrowheads="1"/>
              </p:cNvSpPr>
              <p:nvPr/>
            </p:nvSpPr>
            <p:spPr bwMode="auto">
              <a:xfrm>
                <a:off x="8407494" y="2062123"/>
                <a:ext cx="1349075" cy="268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ormal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Rectangle 85"/>
              <p:cNvSpPr>
                <a:spLocks noChangeArrowheads="1"/>
              </p:cNvSpPr>
              <p:nvPr/>
            </p:nvSpPr>
            <p:spPr bwMode="auto">
              <a:xfrm>
                <a:off x="5283200" y="2455863"/>
                <a:ext cx="77788" cy="7620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Freeform 86"/>
              <p:cNvSpPr>
                <a:spLocks noEditPoints="1"/>
              </p:cNvSpPr>
              <p:nvPr/>
            </p:nvSpPr>
            <p:spPr bwMode="auto">
              <a:xfrm>
                <a:off x="8144355" y="2402852"/>
                <a:ext cx="160137" cy="86016"/>
              </a:xfrm>
              <a:custGeom>
                <a:avLst/>
                <a:gdLst>
                  <a:gd name="T0" fmla="*/ 0 w 912"/>
                  <a:gd name="T1" fmla="*/ 48 h 896"/>
                  <a:gd name="T2" fmla="*/ 48 w 912"/>
                  <a:gd name="T3" fmla="*/ 0 h 896"/>
                  <a:gd name="T4" fmla="*/ 864 w 912"/>
                  <a:gd name="T5" fmla="*/ 0 h 896"/>
                  <a:gd name="T6" fmla="*/ 912 w 912"/>
                  <a:gd name="T7" fmla="*/ 48 h 896"/>
                  <a:gd name="T8" fmla="*/ 912 w 912"/>
                  <a:gd name="T9" fmla="*/ 848 h 896"/>
                  <a:gd name="T10" fmla="*/ 864 w 912"/>
                  <a:gd name="T11" fmla="*/ 896 h 896"/>
                  <a:gd name="T12" fmla="*/ 48 w 912"/>
                  <a:gd name="T13" fmla="*/ 896 h 896"/>
                  <a:gd name="T14" fmla="*/ 0 w 912"/>
                  <a:gd name="T15" fmla="*/ 848 h 896"/>
                  <a:gd name="T16" fmla="*/ 0 w 912"/>
                  <a:gd name="T17" fmla="*/ 48 h 896"/>
                  <a:gd name="T18" fmla="*/ 96 w 912"/>
                  <a:gd name="T19" fmla="*/ 848 h 896"/>
                  <a:gd name="T20" fmla="*/ 48 w 912"/>
                  <a:gd name="T21" fmla="*/ 800 h 896"/>
                  <a:gd name="T22" fmla="*/ 864 w 912"/>
                  <a:gd name="T23" fmla="*/ 800 h 896"/>
                  <a:gd name="T24" fmla="*/ 816 w 912"/>
                  <a:gd name="T25" fmla="*/ 848 h 896"/>
                  <a:gd name="T26" fmla="*/ 816 w 912"/>
                  <a:gd name="T27" fmla="*/ 48 h 896"/>
                  <a:gd name="T28" fmla="*/ 864 w 912"/>
                  <a:gd name="T29" fmla="*/ 96 h 896"/>
                  <a:gd name="T30" fmla="*/ 48 w 912"/>
                  <a:gd name="T31" fmla="*/ 96 h 896"/>
                  <a:gd name="T32" fmla="*/ 96 w 912"/>
                  <a:gd name="T33" fmla="*/ 48 h 896"/>
                  <a:gd name="T34" fmla="*/ 96 w 912"/>
                  <a:gd name="T35" fmla="*/ 848 h 8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912" h="896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864" y="0"/>
                    </a:lnTo>
                    <a:cubicBezTo>
                      <a:pt x="891" y="0"/>
                      <a:pt x="912" y="22"/>
                      <a:pt x="912" y="48"/>
                    </a:cubicBezTo>
                    <a:lnTo>
                      <a:pt x="912" y="848"/>
                    </a:lnTo>
                    <a:cubicBezTo>
                      <a:pt x="912" y="875"/>
                      <a:pt x="891" y="896"/>
                      <a:pt x="864" y="896"/>
                    </a:cubicBezTo>
                    <a:lnTo>
                      <a:pt x="48" y="896"/>
                    </a:lnTo>
                    <a:cubicBezTo>
                      <a:pt x="22" y="896"/>
                      <a:pt x="0" y="875"/>
                      <a:pt x="0" y="848"/>
                    </a:cubicBezTo>
                    <a:lnTo>
                      <a:pt x="0" y="48"/>
                    </a:lnTo>
                    <a:close/>
                    <a:moveTo>
                      <a:pt x="96" y="848"/>
                    </a:moveTo>
                    <a:lnTo>
                      <a:pt x="48" y="800"/>
                    </a:lnTo>
                    <a:lnTo>
                      <a:pt x="864" y="800"/>
                    </a:lnTo>
                    <a:lnTo>
                      <a:pt x="816" y="848"/>
                    </a:lnTo>
                    <a:lnTo>
                      <a:pt x="816" y="48"/>
                    </a:lnTo>
                    <a:lnTo>
                      <a:pt x="864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84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ko-KR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Rectangle 87"/>
              <p:cNvSpPr>
                <a:spLocks noChangeArrowheads="1"/>
              </p:cNvSpPr>
              <p:nvPr/>
            </p:nvSpPr>
            <p:spPr bwMode="auto">
              <a:xfrm>
                <a:off x="8477382" y="2306597"/>
                <a:ext cx="582555" cy="268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ctr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AD</a:t>
                </a:r>
                <a:endPara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1" name="TextBox 90"/>
            <p:cNvSpPr txBox="1"/>
            <p:nvPr/>
          </p:nvSpPr>
          <p:spPr>
            <a:xfrm>
              <a:off x="5259354" y="1996480"/>
              <a:ext cx="304892" cy="337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02" name="꺾인 연결선 101"/>
            <p:cNvCxnSpPr/>
            <p:nvPr/>
          </p:nvCxnSpPr>
          <p:spPr>
            <a:xfrm rot="16200000">
              <a:off x="6120889" y="4020989"/>
              <a:ext cx="108000" cy="150339"/>
            </a:xfrm>
            <a:prstGeom prst="bentConnector3">
              <a:avLst>
                <a:gd name="adj1" fmla="val 128949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꺾인 연결선 105"/>
            <p:cNvCxnSpPr/>
            <p:nvPr/>
          </p:nvCxnSpPr>
          <p:spPr>
            <a:xfrm rot="16200000">
              <a:off x="6106236" y="3284438"/>
              <a:ext cx="1296000" cy="150339"/>
            </a:xfrm>
            <a:prstGeom prst="bentConnector3">
              <a:avLst>
                <a:gd name="adj1" fmla="val 10376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TextBox 113"/>
            <p:cNvSpPr txBox="1"/>
            <p:nvPr/>
          </p:nvSpPr>
          <p:spPr>
            <a:xfrm>
              <a:off x="6018481" y="3835399"/>
              <a:ext cx="3032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6632177" y="2492095"/>
              <a:ext cx="2439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4" name="TextBox 93"/>
          <p:cNvSpPr txBox="1"/>
          <p:nvPr/>
        </p:nvSpPr>
        <p:spPr>
          <a:xfrm>
            <a:off x="7999033" y="188640"/>
            <a:ext cx="10374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Hwang et al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35496" y="44624"/>
            <a:ext cx="18722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Supplement Fig 3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8" name="직사각형 97"/>
          <p:cNvSpPr/>
          <p:nvPr/>
        </p:nvSpPr>
        <p:spPr>
          <a:xfrm>
            <a:off x="2366905" y="3478356"/>
            <a:ext cx="4572000" cy="2862322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3. Characteristics of CD4+ T cells and CD19+ B cells from normal and AD induced mice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) Draining lymph node CD4+ T cells from normal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ice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or AD-induced mice were stimulated with PMA (50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/ml)/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ionomycin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(1 </a:t>
            </a:r>
            <a:r>
              <a:rPr lang="en-US" altLang="ko-KR" sz="1200" dirty="0" err="1">
                <a:latin typeface="Symbol"/>
                <a:ea typeface="바탕"/>
                <a:cs typeface="Arial"/>
              </a:rPr>
              <a:t>m</a:t>
            </a:r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for 4 hrs. Relative expression levels of IL-4, IL-5,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L-13,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nd IFN-</a:t>
            </a:r>
            <a:r>
              <a:rPr lang="en-US" altLang="ko-KR" sz="1200" dirty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D4+ T cells from AD-induced mice were compared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o cytokine expression in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D4+ T cells from normal mice by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PCR. Expression level of HPRT was used as an internal control. (B) Draining lymph node CD19+ B cells isolated from normal mice or AD-induced mice were either </a:t>
            </a:r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stimulated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w/o)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or stimulated with LPS (10 </a:t>
            </a:r>
            <a:r>
              <a:rPr lang="en-US" altLang="ko-KR" sz="1200" dirty="0">
                <a:latin typeface="Symbol"/>
                <a:ea typeface="바탕"/>
                <a:cs typeface="Arial"/>
              </a:rPr>
              <a:t>m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/IL-4 (5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/ml) for 72 hrs. Mouse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IgE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levels in the culture supernatant of B cells were measured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sing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ELISA. Error bars indicate SD. One (*), two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**),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nd three (***) indicate p&lt;0.05,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&lt;0.01,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nd p&lt;0.001 respectively. Data are representative of three independent experiments.</a:t>
            </a:r>
            <a:endParaRPr lang="ko-KR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84138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2</TotalTime>
  <Words>694</Words>
  <Application>Microsoft Office PowerPoint</Application>
  <PresentationFormat>화면 슬라이드 쇼(4:3)</PresentationFormat>
  <Paragraphs>159</Paragraphs>
  <Slides>3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4" baseType="lpstr"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wang Ji Sun</dc:creator>
  <cp:lastModifiedBy>Sin-Hyeog IM</cp:lastModifiedBy>
  <cp:revision>18</cp:revision>
  <cp:lastPrinted>2013-09-25T11:10:11Z</cp:lastPrinted>
  <dcterms:created xsi:type="dcterms:W3CDTF">2013-05-29T11:03:24Z</dcterms:created>
  <dcterms:modified xsi:type="dcterms:W3CDTF">2013-11-02T08:41:10Z</dcterms:modified>
</cp:coreProperties>
</file>